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280" y="-1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dzaichinyengetere:Documents:Microsoft%20User%20Data:Office%202011%20AutoRecovery:growth%20curves%20JSI-124-1%20(version%201).xlsb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24 hours</c:v>
          </c:tx>
          <c:cat>
            <c:numRef>
              <c:f>'[growth%20curves%20JSI-124-1 (version 1).xlsb]Sheet1'!$H$3:$H$10</c:f>
              <c:numCache>
                <c:formatCode>General</c:formatCode>
                <c:ptCount val="8"/>
                <c:pt idx="0">
                  <c:v>0.0</c:v>
                </c:pt>
                <c:pt idx="1">
                  <c:v>0.1</c:v>
                </c:pt>
                <c:pt idx="2">
                  <c:v>0.2</c:v>
                </c:pt>
                <c:pt idx="3">
                  <c:v>0.5</c:v>
                </c:pt>
                <c:pt idx="4">
                  <c:v>1.0</c:v>
                </c:pt>
                <c:pt idx="5">
                  <c:v>2.0</c:v>
                </c:pt>
                <c:pt idx="6">
                  <c:v>5.0</c:v>
                </c:pt>
                <c:pt idx="7">
                  <c:v>10.0</c:v>
                </c:pt>
              </c:numCache>
            </c:numRef>
          </c:cat>
          <c:val>
            <c:numRef>
              <c:f>'[growth%20curves%20JSI-124-1 (version 1).xlsb]Sheet1'!$L$3:$L$10</c:f>
              <c:numCache>
                <c:formatCode>0.0</c:formatCode>
                <c:ptCount val="8"/>
                <c:pt idx="0">
                  <c:v>100.0</c:v>
                </c:pt>
                <c:pt idx="1">
                  <c:v>44.43204868154157</c:v>
                </c:pt>
                <c:pt idx="2">
                  <c:v>27.4290060851927</c:v>
                </c:pt>
                <c:pt idx="3">
                  <c:v>17.74340770791075</c:v>
                </c:pt>
                <c:pt idx="4">
                  <c:v>8.8184584178499</c:v>
                </c:pt>
                <c:pt idx="5">
                  <c:v>5.131845841784989</c:v>
                </c:pt>
                <c:pt idx="6">
                  <c:v>6.105476673427964</c:v>
                </c:pt>
                <c:pt idx="7">
                  <c:v>3.682555780933063</c:v>
                </c:pt>
              </c:numCache>
            </c:numRef>
          </c:val>
          <c:smooth val="0"/>
        </c:ser>
        <c:ser>
          <c:idx val="1"/>
          <c:order val="1"/>
          <c:tx>
            <c:v>48 hours</c:v>
          </c:tx>
          <c:cat>
            <c:numRef>
              <c:f>'[growth%20curves%20JSI-124-1 (version 1).xlsb]Sheet1'!$H$3:$H$10</c:f>
              <c:numCache>
                <c:formatCode>General</c:formatCode>
                <c:ptCount val="8"/>
                <c:pt idx="0">
                  <c:v>0.0</c:v>
                </c:pt>
                <c:pt idx="1">
                  <c:v>0.1</c:v>
                </c:pt>
                <c:pt idx="2">
                  <c:v>0.2</c:v>
                </c:pt>
                <c:pt idx="3">
                  <c:v>0.5</c:v>
                </c:pt>
                <c:pt idx="4">
                  <c:v>1.0</c:v>
                </c:pt>
                <c:pt idx="5">
                  <c:v>2.0</c:v>
                </c:pt>
                <c:pt idx="6">
                  <c:v>5.0</c:v>
                </c:pt>
                <c:pt idx="7">
                  <c:v>10.0</c:v>
                </c:pt>
              </c:numCache>
            </c:numRef>
          </c:cat>
          <c:val>
            <c:numRef>
              <c:f>'[growth%20curves%20JSI-124-1 (version 1).xlsb]Sheet1'!$M$3:$M$10</c:f>
              <c:numCache>
                <c:formatCode>0.0</c:formatCode>
                <c:ptCount val="8"/>
                <c:pt idx="0">
                  <c:v>100.0</c:v>
                </c:pt>
                <c:pt idx="1">
                  <c:v>39.36609402050872</c:v>
                </c:pt>
                <c:pt idx="2">
                  <c:v>20.94819549873485</c:v>
                </c:pt>
                <c:pt idx="3">
                  <c:v>5.145825009988005</c:v>
                </c:pt>
                <c:pt idx="4">
                  <c:v>3.265414835530696</c:v>
                </c:pt>
                <c:pt idx="5">
                  <c:v>3.433213477160741</c:v>
                </c:pt>
                <c:pt idx="6">
                  <c:v>3.402583566387002</c:v>
                </c:pt>
                <c:pt idx="7">
                  <c:v>2.646157943800772</c:v>
                </c:pt>
              </c:numCache>
            </c:numRef>
          </c:val>
          <c:smooth val="0"/>
        </c:ser>
        <c:ser>
          <c:idx val="2"/>
          <c:order val="2"/>
          <c:tx>
            <c:v>72 hours</c:v>
          </c:tx>
          <c:val>
            <c:numRef>
              <c:f>'[growth%20curves%20JSI-124-1 (version 1).xlsb]Sheet1'!$N$3:$N$10</c:f>
              <c:numCache>
                <c:formatCode>0.0</c:formatCode>
                <c:ptCount val="8"/>
                <c:pt idx="0">
                  <c:v>100.0</c:v>
                </c:pt>
                <c:pt idx="1">
                  <c:v>54.93975903614457</c:v>
                </c:pt>
                <c:pt idx="2">
                  <c:v>30.32339885859227</c:v>
                </c:pt>
                <c:pt idx="3">
                  <c:v>6.535193405199747</c:v>
                </c:pt>
                <c:pt idx="4">
                  <c:v>2.999365884590996</c:v>
                </c:pt>
                <c:pt idx="5">
                  <c:v>2.911857958148383</c:v>
                </c:pt>
                <c:pt idx="6">
                  <c:v>3.250475586556754</c:v>
                </c:pt>
                <c:pt idx="7">
                  <c:v>2.34876347495244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79835544"/>
        <c:axId val="-2079829608"/>
      </c:lineChart>
      <c:catAx>
        <c:axId val="-20798355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50">
                    <a:latin typeface="Helvetica"/>
                    <a:cs typeface="Helvetica"/>
                  </a:defRPr>
                </a:pPr>
                <a:r>
                  <a:rPr lang="en-US" sz="1050">
                    <a:latin typeface="Helvetica"/>
                    <a:cs typeface="Helvetica"/>
                  </a:rPr>
                  <a:t>JSI-124 (u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-2079829608"/>
        <c:crossesAt val="0.0"/>
        <c:auto val="1"/>
        <c:lblAlgn val="ctr"/>
        <c:lblOffset val="100"/>
        <c:noMultiLvlLbl val="0"/>
      </c:catAx>
      <c:valAx>
        <c:axId val="-2079829608"/>
        <c:scaling>
          <c:orientation val="minMax"/>
          <c:max val="10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50">
                    <a:latin typeface="Helvetica"/>
                    <a:cs typeface="Helvetica"/>
                  </a:defRPr>
                </a:pPr>
                <a:r>
                  <a:rPr lang="en-US" sz="1050" dirty="0">
                    <a:latin typeface="Helvetica"/>
                    <a:cs typeface="Helvetica"/>
                  </a:rPr>
                  <a:t>Relative </a:t>
                </a:r>
                <a:r>
                  <a:rPr lang="en-US" sz="1050" dirty="0" smtClean="0">
                    <a:latin typeface="Helvetica"/>
                    <a:cs typeface="Helvetica"/>
                  </a:rPr>
                  <a:t>growth </a:t>
                </a:r>
                <a:r>
                  <a:rPr lang="en-US" sz="1050" dirty="0">
                    <a:latin typeface="Helvetica"/>
                    <a:cs typeface="Helvetica"/>
                  </a:rPr>
                  <a:t>rate</a:t>
                </a:r>
              </a:p>
              <a:p>
                <a:pPr>
                  <a:defRPr sz="1050">
                    <a:latin typeface="Helvetica"/>
                    <a:cs typeface="Helvetica"/>
                  </a:defRPr>
                </a:pPr>
                <a:r>
                  <a:rPr lang="en-US" sz="1050" dirty="0">
                    <a:latin typeface="Helvetica"/>
                    <a:cs typeface="Helvetica"/>
                  </a:rPr>
                  <a:t>(% contro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  <a:cs typeface="Arial" pitchFamily="34" charset="0"/>
              </a:defRPr>
            </a:pPr>
            <a:endParaRPr lang="en-US"/>
          </a:p>
        </c:txPr>
        <c:crossAx val="-2079835544"/>
        <c:crossesAt val="1.0"/>
        <c:crossBetween val="midCat"/>
        <c:majorUnit val="20.0"/>
      </c:valAx>
    </c:plotArea>
    <c:legend>
      <c:legendPos val="r"/>
      <c:layout>
        <c:manualLayout>
          <c:xMode val="edge"/>
          <c:yMode val="edge"/>
          <c:x val="0.491053960739595"/>
          <c:y val="0.244748375085468"/>
          <c:w val="0.173366237510954"/>
          <c:h val="0.191420355160871"/>
        </c:manualLayout>
      </c:layout>
      <c:overlay val="0"/>
      <c:txPr>
        <a:bodyPr/>
        <a:lstStyle/>
        <a:p>
          <a:pPr>
            <a:defRPr sz="1050" b="1">
              <a:latin typeface="Helvetica"/>
              <a:cs typeface="Helvetica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9AC621-20E0-A148-B728-C7A30ADBAE81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9C324-CB8D-4743-A87D-0766ABAE2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4929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A46BA5-B875-5A48-91DE-BBFB33908C1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1122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57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48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074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904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099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901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824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136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892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098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304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4B9A1-2AA5-6A43-A0F8-5BA8664C752A}" type="datetimeFigureOut">
              <a:rPr lang="en-US" smtClean="0"/>
              <a:t>10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A6E48-05D0-164D-8A40-CCAFB10C7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31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chart" Target="../charts/chart1.xml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4803714"/>
              </p:ext>
            </p:extLst>
          </p:nvPr>
        </p:nvGraphicFramePr>
        <p:xfrm>
          <a:off x="1765300" y="2628904"/>
          <a:ext cx="4622800" cy="2589367"/>
        </p:xfrm>
        <a:graphic>
          <a:graphicData uri="http://schemas.openxmlformats.org/drawingml/2006/table">
            <a:tbl>
              <a:tblPr/>
              <a:tblGrid>
                <a:gridCol w="1968500"/>
                <a:gridCol w="1215736"/>
                <a:gridCol w="1438564"/>
              </a:tblGrid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ntibody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atalog #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ompany 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Desmin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152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ca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mooth muscle actin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569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ca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10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86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ca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ytokeration(AE1/AE3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96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ca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5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c-624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anta Cruz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alponin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4679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bcam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USP1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481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ell Signaling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MYC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560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ell Signaling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pStat3(Y705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914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Cell Signaling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3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Actin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c-161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</a:rPr>
                        <a:t>Santa Cruz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6146" y="1417638"/>
            <a:ext cx="8470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Supplementary Table 1: Antibodies used for immunohistochemistry studies.</a:t>
            </a:r>
            <a:endParaRPr lang="en-US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695054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174673" y="-412899"/>
            <a:ext cx="8850793" cy="1143000"/>
          </a:xfrm>
        </p:spPr>
        <p:txBody>
          <a:bodyPr>
            <a:normAutofit/>
          </a:bodyPr>
          <a:lstStyle/>
          <a:p>
            <a:pPr algn="just"/>
            <a:r>
              <a:rPr lang="en-US" sz="1400" b="1" dirty="0" smtClean="0">
                <a:latin typeface="Helvetica" pitchFamily="34" charset="0"/>
                <a:cs typeface="Helvetica" pitchFamily="34" charset="0"/>
              </a:rPr>
              <a:t>Supplementary Table 2: </a:t>
            </a:r>
            <a:r>
              <a:rPr lang="en-US" sz="1400" b="1" dirty="0" err="1" smtClean="0">
                <a:latin typeface="Helvetica" pitchFamily="34" charset="0"/>
                <a:cs typeface="Helvetica" pitchFamily="34" charset="0"/>
              </a:rPr>
              <a:t>Immunohistochemical</a:t>
            </a:r>
            <a:r>
              <a:rPr lang="en-US" sz="1400" b="1" dirty="0" smtClean="0">
                <a:latin typeface="Helvetica" pitchFamily="34" charset="0"/>
                <a:cs typeface="Helvetica" pitchFamily="34" charset="0"/>
              </a:rPr>
              <a:t> staining of USP18 in clinical </a:t>
            </a:r>
            <a:r>
              <a:rPr lang="en-US" sz="1400" b="1" dirty="0" err="1" smtClean="0">
                <a:latin typeface="Helvetica" pitchFamily="34" charset="0"/>
                <a:cs typeface="Helvetica" pitchFamily="34" charset="0"/>
              </a:rPr>
              <a:t>leiomyosarcoma</a:t>
            </a:r>
            <a:r>
              <a:rPr lang="en-US" sz="1400" b="1" dirty="0" smtClean="0">
                <a:latin typeface="Helvetica" pitchFamily="34" charset="0"/>
                <a:cs typeface="Helvetica" pitchFamily="34" charset="0"/>
              </a:rPr>
              <a:t> samples.</a:t>
            </a:r>
            <a:endParaRPr lang="en-US" sz="1400" b="1" dirty="0">
              <a:latin typeface="Helvetica" pitchFamily="34" charset="0"/>
              <a:cs typeface="Helvetica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2637000"/>
              </p:ext>
            </p:extLst>
          </p:nvPr>
        </p:nvGraphicFramePr>
        <p:xfrm>
          <a:off x="493889" y="471660"/>
          <a:ext cx="8128000" cy="62170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8001"/>
                <a:gridCol w="728384"/>
                <a:gridCol w="755487"/>
                <a:gridCol w="1428661"/>
                <a:gridCol w="1642536"/>
                <a:gridCol w="1642531"/>
                <a:gridCol w="1422400"/>
              </a:tblGrid>
              <a:tr h="348571"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Case 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USP18 intensity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% cells positive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Histologic grade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pecimen site</a:t>
                      </a:r>
                      <a:endParaRPr lang="en-US" sz="120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rimary site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rimary vs. recurrence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852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4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Intraperitoneal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Uterin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astasi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92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Small bowel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Abdomen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recurrenc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553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Uterin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Uterin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elvi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Uterin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recurrenc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148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Hip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Reptroperitoneum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astasis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2628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8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Colon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Uterin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astasis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924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Right flank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Flank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92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9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intermediat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T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Subcuti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553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8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Skin, abdomen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Subcuti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2948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T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Soft tissu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7867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9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intermediat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Lower leg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Cutaneou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recurrence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93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intermediat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Skin fac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Venou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astasis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061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3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Jejunum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Small bowel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1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Retroperitoneum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Retroperitoneum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5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intermediat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elvi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Uterine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astasis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7846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5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Fascia, abdomen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GI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astasis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0154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8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Colon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Colon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rimary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93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9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Jejunum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Jejunum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astasis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Small bowel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Small bowel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met/recurrence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33027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8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Dermis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Dermis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997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1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Retroperitoneum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Retroperitoneum</a:t>
                      </a:r>
                      <a:endParaRPr lang="en-US" sz="1100" dirty="0" smtClean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primary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474962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V="1">
            <a:off x="2105073" y="1471783"/>
            <a:ext cx="1529147" cy="1968239"/>
          </a:xfrm>
          <a:prstGeom prst="rect">
            <a:avLst/>
          </a:prstGeom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994" r="3486" b="9001"/>
          <a:stretch/>
        </p:blipFill>
        <p:spPr bwMode="auto">
          <a:xfrm>
            <a:off x="4869787" y="1538641"/>
            <a:ext cx="2492831" cy="493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31"/>
          <a:stretch/>
        </p:blipFill>
        <p:spPr bwMode="auto">
          <a:xfrm>
            <a:off x="4869789" y="2095400"/>
            <a:ext cx="2492831" cy="493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6382275"/>
              </p:ext>
            </p:extLst>
          </p:nvPr>
        </p:nvGraphicFramePr>
        <p:xfrm>
          <a:off x="4956875" y="2608956"/>
          <a:ext cx="2362200" cy="274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4800"/>
                <a:gridCol w="293913"/>
                <a:gridCol w="287112"/>
                <a:gridCol w="295275"/>
                <a:gridCol w="295275"/>
                <a:gridCol w="295275"/>
                <a:gridCol w="295275"/>
                <a:gridCol w="295275"/>
              </a:tblGrid>
              <a:tr h="27432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sz="1200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374488" y="2611579"/>
            <a:ext cx="9144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smtClean="0">
                <a:latin typeface="Helvetica" pitchFamily="34" charset="0"/>
                <a:cs typeface="Helvetica" pitchFamily="34" charset="0"/>
              </a:rPr>
              <a:t>USP18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12039" y="1666921"/>
            <a:ext cx="6858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smtClean="0">
                <a:latin typeface="Helvetica" pitchFamily="34" charset="0"/>
                <a:cs typeface="Helvetica" pitchFamily="34" charset="0"/>
              </a:rPr>
              <a:t>USP18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74488" y="2185226"/>
            <a:ext cx="990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Actin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14501" y="1269062"/>
            <a:ext cx="348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Helvetica" pitchFamily="34" charset="0"/>
                <a:cs typeface="Helvetica" pitchFamily="34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482460" y="126906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10" name="Rectangle 9"/>
          <p:cNvSpPr/>
          <p:nvPr/>
        </p:nvSpPr>
        <p:spPr>
          <a:xfrm>
            <a:off x="1718049" y="3608756"/>
            <a:ext cx="6041651" cy="2862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latin typeface="Arial"/>
                <a:ea typeface="ＭＳ 明朝"/>
              </a:rPr>
              <a:t>Supplementary </a:t>
            </a:r>
            <a:r>
              <a:rPr lang="en-US" b="1" dirty="0">
                <a:latin typeface="Arial"/>
                <a:ea typeface="ＭＳ 明朝"/>
              </a:rPr>
              <a:t>Figure 1: </a:t>
            </a:r>
            <a:r>
              <a:rPr lang="en-US" b="1" dirty="0" smtClean="0">
                <a:latin typeface="Arial"/>
                <a:ea typeface="ＭＳ 明朝"/>
              </a:rPr>
              <a:t>A</a:t>
            </a:r>
            <a:r>
              <a:rPr lang="en-US" dirty="0" smtClean="0">
                <a:latin typeface="Arial"/>
                <a:ea typeface="ＭＳ 明朝"/>
              </a:rPr>
              <a:t>: </a:t>
            </a:r>
            <a:r>
              <a:rPr lang="en-US" dirty="0">
                <a:latin typeface="Arial"/>
                <a:ea typeface="ＭＳ 明朝"/>
              </a:rPr>
              <a:t>Dystrophic calcifications in USP18 null mice.  </a:t>
            </a:r>
            <a:r>
              <a:rPr lang="en-US" dirty="0" smtClean="0">
                <a:latin typeface="Arial"/>
                <a:ea typeface="ＭＳ 明朝"/>
              </a:rPr>
              <a:t>A </a:t>
            </a:r>
            <a:r>
              <a:rPr lang="en-US" dirty="0">
                <a:latin typeface="Arial"/>
                <a:ea typeface="ＭＳ 明朝"/>
              </a:rPr>
              <a:t>representative image of a USP18-/- mouse is shown. </a:t>
            </a:r>
            <a:r>
              <a:rPr lang="en-US" b="1" dirty="0" smtClean="0">
                <a:latin typeface="Arial"/>
                <a:ea typeface="ＭＳ 明朝"/>
              </a:rPr>
              <a:t>B</a:t>
            </a:r>
            <a:r>
              <a:rPr lang="en-US" dirty="0">
                <a:latin typeface="Arial"/>
                <a:ea typeface="ＭＳ 明朝"/>
              </a:rPr>
              <a:t>: KHC-2 cells with reconstituted USP18 expression maintained expression for the </a:t>
            </a:r>
            <a:r>
              <a:rPr lang="en-US" dirty="0" smtClean="0">
                <a:latin typeface="Arial"/>
                <a:ea typeface="ＭＳ 明朝"/>
              </a:rPr>
              <a:t>duration of </a:t>
            </a:r>
            <a:r>
              <a:rPr lang="en-US" dirty="0">
                <a:latin typeface="Arial"/>
                <a:ea typeface="ＭＳ 明朝"/>
              </a:rPr>
              <a:t>growth in mice.  Immunoblot analysis of </a:t>
            </a:r>
            <a:r>
              <a:rPr lang="en-US" dirty="0" smtClean="0">
                <a:latin typeface="Arial"/>
                <a:ea typeface="ＭＳ 明朝"/>
              </a:rPr>
              <a:t>protein isolated </a:t>
            </a:r>
            <a:r>
              <a:rPr lang="en-US" dirty="0">
                <a:latin typeface="Arial"/>
                <a:ea typeface="ＭＳ 明朝"/>
              </a:rPr>
              <a:t>from 4 control </a:t>
            </a:r>
            <a:r>
              <a:rPr lang="en-US" dirty="0" smtClean="0">
                <a:latin typeface="Arial"/>
                <a:ea typeface="ＭＳ 明朝"/>
              </a:rPr>
              <a:t>and </a:t>
            </a:r>
            <a:r>
              <a:rPr lang="en-US" dirty="0">
                <a:latin typeface="Arial"/>
                <a:ea typeface="ＭＳ 明朝"/>
              </a:rPr>
              <a:t>4 USP18 overexpressing independent </a:t>
            </a:r>
            <a:r>
              <a:rPr lang="en-US" dirty="0" err="1">
                <a:latin typeface="Arial"/>
                <a:ea typeface="ＭＳ 明朝"/>
              </a:rPr>
              <a:t>orthotopic</a:t>
            </a:r>
            <a:r>
              <a:rPr lang="en-US" dirty="0">
                <a:latin typeface="Arial"/>
                <a:ea typeface="ＭＳ 明朝"/>
              </a:rPr>
              <a:t> sarcomas harvested from mice. </a:t>
            </a:r>
            <a:r>
              <a:rPr lang="en-US" dirty="0" smtClean="0">
                <a:latin typeface="Arial"/>
                <a:ea typeface="ＭＳ 明朝"/>
              </a:rPr>
              <a:t>The </a:t>
            </a:r>
            <a:r>
              <a:rPr lang="en-US" dirty="0">
                <a:latin typeface="Arial"/>
                <a:ea typeface="ＭＳ 明朝"/>
              </a:rPr>
              <a:t>immunoblot showed representative analysis of KHC-2 cells and this finding was </a:t>
            </a:r>
            <a:r>
              <a:rPr lang="en-US" dirty="0" smtClean="0">
                <a:latin typeface="Arial"/>
                <a:ea typeface="ＭＳ 明朝"/>
              </a:rPr>
              <a:t>also </a:t>
            </a:r>
            <a:r>
              <a:rPr lang="en-US" dirty="0">
                <a:latin typeface="Arial"/>
                <a:ea typeface="ＭＳ 明朝"/>
              </a:rPr>
              <a:t>seen in KHC-1 cells (data not shown). </a:t>
            </a:r>
            <a:r>
              <a:rPr lang="en-US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31088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215901" y="5528926"/>
            <a:ext cx="8623300" cy="1430673"/>
          </a:xfrm>
        </p:spPr>
        <p:txBody>
          <a:bodyPr>
            <a:normAutofit/>
          </a:bodyPr>
          <a:lstStyle/>
          <a:p>
            <a:pPr algn="just"/>
            <a:r>
              <a:rPr lang="en-US" sz="1200" b="1" dirty="0"/>
              <a:t>Supplementary Figure 2</a:t>
            </a:r>
            <a:r>
              <a:rPr lang="en-US" sz="1200" dirty="0"/>
              <a:t>: USP18 null leiomyosarcoma cell lines are sensitive to treatment with the JAK2-STAT3 inhibitor, JSI-124. A: Immunoblot analysis of pSTAT3, STAT3, CDK4 and USP18 levels in KHC-1 </a:t>
            </a:r>
            <a:r>
              <a:rPr lang="en-US" sz="1200" dirty="0" smtClean="0"/>
              <a:t>cells </a:t>
            </a:r>
            <a:r>
              <a:rPr lang="en-US" sz="1200" dirty="0"/>
              <a:t>with and without stably restored USP18 activity. B: Growth analysis of KHC-1 cells with JAK2-STAT3 inhibitor, JSI-</a:t>
            </a:r>
            <a:r>
              <a:rPr lang="en-US" sz="1200" dirty="0" smtClean="0"/>
              <a:t>124.  </a:t>
            </a:r>
            <a:r>
              <a:rPr lang="en-US" sz="1200" dirty="0"/>
              <a:t>Similar effects were seen in KHC-2 cells (data not shown). Validation of JSI-124 repression of JAK2-STAT3 pathway C: Immunoblot analyses of phosphorylated JAK2 (pJAK2), JAK2, and actin with relative level of pJAK2/JAK2 calculated relative to control. D: Immunoblot analysis of phosphorylated STAT3 (pSTAT3), STAT3, cyclin D1 and actin levels. </a:t>
            </a:r>
            <a:endParaRPr lang="en-US" sz="1200" b="1" dirty="0">
              <a:latin typeface="Helvetica"/>
              <a:cs typeface="Helvetica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85809" y="209402"/>
            <a:ext cx="81544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 smtClean="0">
                <a:latin typeface="Helvetica"/>
                <a:cs typeface="Helvetica"/>
              </a:rPr>
              <a:t>pSTAT3</a:t>
            </a:r>
            <a:endParaRPr lang="en-US" sz="1050" b="1" dirty="0">
              <a:latin typeface="Helvetica"/>
              <a:cs typeface="Helvetic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34070" y="1573292"/>
            <a:ext cx="667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smtClean="0">
                <a:latin typeface="Helvetica"/>
                <a:cs typeface="Helvetica"/>
              </a:rPr>
              <a:t>USP18</a:t>
            </a:r>
            <a:endParaRPr lang="en-US" sz="1050" b="1" dirty="0">
              <a:latin typeface="Helvetica"/>
              <a:cs typeface="Helvetica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159940" y="620028"/>
            <a:ext cx="7413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 smtClean="0">
                <a:latin typeface="Helvetica"/>
                <a:cs typeface="Helvetica"/>
              </a:rPr>
              <a:t>STAT3</a:t>
            </a:r>
            <a:endParaRPr lang="en-US" sz="1050" b="1" dirty="0">
              <a:latin typeface="Helvetica"/>
              <a:cs typeface="Helvetic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59940" y="1038745"/>
            <a:ext cx="7413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 smtClean="0">
                <a:latin typeface="Helvetica"/>
                <a:cs typeface="Helvetica"/>
              </a:rPr>
              <a:t>CDK4</a:t>
            </a:r>
            <a:endParaRPr lang="en-US" sz="1050" b="1" dirty="0">
              <a:latin typeface="Helvetica"/>
              <a:cs typeface="Helvetica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34070" y="1998888"/>
            <a:ext cx="667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 smtClean="0">
                <a:latin typeface="Helvetica"/>
                <a:cs typeface="Helvetica"/>
              </a:rPr>
              <a:t>Actin</a:t>
            </a:r>
            <a:endParaRPr lang="en-US" sz="1050" b="1" dirty="0">
              <a:latin typeface="Helvetica"/>
              <a:cs typeface="Helvetica"/>
            </a:endParaRPr>
          </a:p>
        </p:txBody>
      </p:sp>
      <p:pic>
        <p:nvPicPr>
          <p:cNvPr id="1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0279" y="152071"/>
            <a:ext cx="1226655" cy="21389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" name="Straight Connector 3"/>
          <p:cNvCxnSpPr/>
          <p:nvPr/>
        </p:nvCxnSpPr>
        <p:spPr>
          <a:xfrm flipH="1">
            <a:off x="5658955" y="5305790"/>
            <a:ext cx="1377043" cy="146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3304734"/>
              </p:ext>
            </p:extLst>
          </p:nvPr>
        </p:nvGraphicFramePr>
        <p:xfrm>
          <a:off x="380897" y="2857500"/>
          <a:ext cx="5209065" cy="2913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36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580" y="232807"/>
            <a:ext cx="2705100" cy="168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4744554" y="273199"/>
            <a:ext cx="16002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         pJAK2</a:t>
            </a:r>
          </a:p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(Y1007/1008)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201754" y="948729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JAK2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5201754" y="1524084"/>
            <a:ext cx="6858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Actin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846048" y="1986189"/>
            <a:ext cx="8630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Time (min)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044903" y="2228563"/>
            <a:ext cx="6165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100nM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492703" y="2240105"/>
            <a:ext cx="60374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200nM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>
            <a:off x="5732157" y="2237129"/>
            <a:ext cx="1338943" cy="2977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7227593" y="2237128"/>
            <a:ext cx="990600" cy="2977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7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9963" y="2857500"/>
            <a:ext cx="2962275" cy="213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8" name="TextBox 67"/>
          <p:cNvSpPr txBox="1"/>
          <p:nvPr/>
        </p:nvSpPr>
        <p:spPr>
          <a:xfrm>
            <a:off x="4970837" y="2857500"/>
            <a:ext cx="11430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pSTAT3</a:t>
            </a:r>
          </a:p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(Y701)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902398" y="3496087"/>
            <a:ext cx="11375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Cyclin D1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105597" y="4076700"/>
            <a:ext cx="7565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/>
                <a:cs typeface="Arial"/>
              </a:rPr>
              <a:t>STAT3</a:t>
            </a:r>
            <a:endParaRPr lang="en-US" sz="1050" b="1" dirty="0">
              <a:latin typeface="Arial"/>
              <a:cs typeface="Arial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174541" y="4533900"/>
            <a:ext cx="7565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/>
                <a:cs typeface="Arial"/>
              </a:rPr>
              <a:t>Actin</a:t>
            </a:r>
            <a:endParaRPr lang="en-US" sz="1050" b="1" dirty="0">
              <a:latin typeface="Arial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778957" y="5012658"/>
            <a:ext cx="8405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Time(min</a:t>
            </a:r>
            <a:r>
              <a:rPr lang="en-US" sz="1400" b="1" dirty="0" smtClean="0">
                <a:latin typeface="Arial"/>
                <a:cs typeface="Arial"/>
              </a:rPr>
              <a:t>)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658954" y="5067300"/>
            <a:ext cx="3048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0   15    30   60   120          15    30    60    120  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6121103" y="5313111"/>
            <a:ext cx="6078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/>
                <a:cs typeface="Arial"/>
              </a:rPr>
              <a:t>100nM</a:t>
            </a:r>
            <a:endParaRPr lang="en-US" sz="1050" b="1" dirty="0"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7545460" y="5324319"/>
            <a:ext cx="60374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200nM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87" name="Straight Connector 86"/>
          <p:cNvCxnSpPr/>
          <p:nvPr/>
        </p:nvCxnSpPr>
        <p:spPr>
          <a:xfrm>
            <a:off x="7337779" y="5321216"/>
            <a:ext cx="1113891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658956" y="1986189"/>
            <a:ext cx="277898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0    15    30     60   120   15    30    60   120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0221783"/>
              </p:ext>
            </p:extLst>
          </p:nvPr>
        </p:nvGraphicFramePr>
        <p:xfrm>
          <a:off x="1896478" y="2292476"/>
          <a:ext cx="944572" cy="6285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3420"/>
                <a:gridCol w="273084"/>
                <a:gridCol w="328068"/>
              </a:tblGrid>
              <a:tr h="314262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314262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30215" y="2295326"/>
            <a:ext cx="10377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Empty vector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91419" y="2598766"/>
            <a:ext cx="8765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 smtClean="0">
                <a:latin typeface="Helvetica" pitchFamily="34" charset="0"/>
                <a:cs typeface="Helvetica" pitchFamily="34" charset="0"/>
              </a:rPr>
              <a:t>USP18</a:t>
            </a:r>
            <a:endParaRPr lang="en-US" sz="105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24472" y="4814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53554" y="273633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68871" y="3090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C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363402" y="255078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D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700531" y="696029"/>
            <a:ext cx="27789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900" b="1" dirty="0" smtClean="0">
                <a:latin typeface="Helvetica" pitchFamily="34" charset="0"/>
                <a:cs typeface="Helvetica" pitchFamily="34" charset="0"/>
              </a:rPr>
              <a:t>0.77   0.67  0.72   0.85  0.34  0.23 0.49   0.1</a:t>
            </a:r>
            <a:endParaRPr lang="en-US" sz="9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789004" y="707429"/>
            <a:ext cx="8699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Helvetica" pitchFamily="34" charset="0"/>
                <a:cs typeface="Helvetica" pitchFamily="34" charset="0"/>
              </a:rPr>
              <a:t>pJAK2/JAK2</a:t>
            </a:r>
            <a:r>
              <a:rPr lang="en-US" sz="900" dirty="0" smtClean="0"/>
              <a:t> 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0398208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1670" y="5769921"/>
            <a:ext cx="8344679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Supplementary Figure 3: </a:t>
            </a:r>
            <a:r>
              <a:rPr lang="en-US" sz="1400" dirty="0">
                <a:latin typeface="Helvetica"/>
                <a:cs typeface="Helvetica"/>
              </a:rPr>
              <a:t>USP18 null leiomyosarcoma cell line KHC-1 and </a:t>
            </a:r>
            <a:r>
              <a:rPr lang="en-US" sz="1400" dirty="0" smtClean="0">
                <a:latin typeface="Helvetica"/>
                <a:cs typeface="Helvetica"/>
              </a:rPr>
              <a:t>human </a:t>
            </a:r>
            <a:r>
              <a:rPr lang="en-US" sz="1400" dirty="0">
                <a:latin typeface="Helvetica"/>
                <a:cs typeface="Helvetica"/>
              </a:rPr>
              <a:t>leiomyosarcoma cell line SK-LMS-1 growth in response to interferon-β </a:t>
            </a:r>
            <a:r>
              <a:rPr lang="en-US" sz="1400" dirty="0" smtClean="0">
                <a:latin typeface="Helvetica"/>
                <a:cs typeface="Helvetica"/>
              </a:rPr>
              <a:t>(</a:t>
            </a:r>
            <a:r>
              <a:rPr lang="en-US" sz="1400" dirty="0">
                <a:latin typeface="Helvetica"/>
                <a:cs typeface="Helvetica"/>
              </a:rPr>
              <a:t>500Units/ml IFNB) or doxycycline (0.2μM </a:t>
            </a:r>
            <a:r>
              <a:rPr lang="en-US" sz="1400" dirty="0" err="1">
                <a:latin typeface="Helvetica"/>
                <a:cs typeface="Helvetica"/>
              </a:rPr>
              <a:t>Dox</a:t>
            </a:r>
            <a:r>
              <a:rPr lang="en-US" sz="1400" dirty="0">
                <a:latin typeface="Helvetica"/>
                <a:cs typeface="Helvetica"/>
              </a:rPr>
              <a:t>) treatment over 3 days.  </a:t>
            </a:r>
            <a:r>
              <a:rPr lang="en-US" sz="1400" dirty="0" smtClean="0">
                <a:latin typeface="Helvetica"/>
                <a:cs typeface="Helvetica"/>
              </a:rPr>
              <a:t>Results </a:t>
            </a:r>
            <a:r>
              <a:rPr lang="en-US" sz="1400" dirty="0">
                <a:latin typeface="Helvetica"/>
                <a:cs typeface="Helvetica"/>
              </a:rPr>
              <a:t>expressed as fold relative to vehicle treated cells.  Each experiment </a:t>
            </a:r>
            <a:endParaRPr lang="en-US" sz="1400" dirty="0" smtClean="0">
              <a:latin typeface="Helvetica"/>
              <a:cs typeface="Helvetica"/>
            </a:endParaRPr>
          </a:p>
          <a:p>
            <a:r>
              <a:rPr lang="en-US" sz="1400" dirty="0" smtClean="0">
                <a:latin typeface="Helvetica"/>
                <a:cs typeface="Helvetica"/>
              </a:rPr>
              <a:t>was </a:t>
            </a:r>
            <a:r>
              <a:rPr lang="en-US" sz="1400" dirty="0">
                <a:latin typeface="Helvetica"/>
                <a:cs typeface="Helvetica"/>
              </a:rPr>
              <a:t>performed in triplicate 3 separate times.</a:t>
            </a:r>
            <a:endParaRPr lang="en-US" sz="1400" dirty="0">
              <a:latin typeface="Helvetica"/>
              <a:cs typeface="Helvetica"/>
            </a:endParaRPr>
          </a:p>
        </p:txBody>
      </p:sp>
      <p:grpSp>
        <p:nvGrpSpPr>
          <p:cNvPr id="153" name="グループ化 152"/>
          <p:cNvGrpSpPr/>
          <p:nvPr/>
        </p:nvGrpSpPr>
        <p:grpSpPr>
          <a:xfrm>
            <a:off x="1261578" y="3649662"/>
            <a:ext cx="2880000" cy="1620000"/>
            <a:chOff x="1261578" y="4297362"/>
            <a:chExt cx="2880000" cy="1620000"/>
          </a:xfrm>
        </p:grpSpPr>
        <p:sp>
          <p:nvSpPr>
            <p:cNvPr id="4" name="Rectangle 3"/>
            <p:cNvSpPr>
              <a:spLocks noChangeArrowheads="1"/>
            </p:cNvSpPr>
            <p:nvPr/>
          </p:nvSpPr>
          <p:spPr bwMode="auto">
            <a:xfrm>
              <a:off x="1545240" y="4306014"/>
              <a:ext cx="213580" cy="1602696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" name="Freeform 7"/>
            <p:cNvSpPr>
              <a:spLocks noEditPoints="1"/>
            </p:cNvSpPr>
            <p:nvPr/>
          </p:nvSpPr>
          <p:spPr bwMode="auto">
            <a:xfrm>
              <a:off x="1538565" y="4297362"/>
              <a:ext cx="226929" cy="1619999"/>
            </a:xfrm>
            <a:custGeom>
              <a:avLst/>
              <a:gdLst>
                <a:gd name="T0" fmla="*/ 0 w 1600"/>
                <a:gd name="T1" fmla="*/ 48 h 8864"/>
                <a:gd name="T2" fmla="*/ 48 w 1600"/>
                <a:gd name="T3" fmla="*/ 0 h 8864"/>
                <a:gd name="T4" fmla="*/ 1552 w 1600"/>
                <a:gd name="T5" fmla="*/ 0 h 8864"/>
                <a:gd name="T6" fmla="*/ 1600 w 1600"/>
                <a:gd name="T7" fmla="*/ 48 h 8864"/>
                <a:gd name="T8" fmla="*/ 1600 w 1600"/>
                <a:gd name="T9" fmla="*/ 8816 h 8864"/>
                <a:gd name="T10" fmla="*/ 1552 w 1600"/>
                <a:gd name="T11" fmla="*/ 8864 h 8864"/>
                <a:gd name="T12" fmla="*/ 48 w 1600"/>
                <a:gd name="T13" fmla="*/ 8864 h 8864"/>
                <a:gd name="T14" fmla="*/ 0 w 1600"/>
                <a:gd name="T15" fmla="*/ 8816 h 8864"/>
                <a:gd name="T16" fmla="*/ 0 w 1600"/>
                <a:gd name="T17" fmla="*/ 48 h 8864"/>
                <a:gd name="T18" fmla="*/ 96 w 1600"/>
                <a:gd name="T19" fmla="*/ 8816 h 8864"/>
                <a:gd name="T20" fmla="*/ 48 w 1600"/>
                <a:gd name="T21" fmla="*/ 8768 h 8864"/>
                <a:gd name="T22" fmla="*/ 1552 w 1600"/>
                <a:gd name="T23" fmla="*/ 8768 h 8864"/>
                <a:gd name="T24" fmla="*/ 1504 w 1600"/>
                <a:gd name="T25" fmla="*/ 8816 h 8864"/>
                <a:gd name="T26" fmla="*/ 1504 w 1600"/>
                <a:gd name="T27" fmla="*/ 48 h 8864"/>
                <a:gd name="T28" fmla="*/ 1552 w 1600"/>
                <a:gd name="T29" fmla="*/ 96 h 8864"/>
                <a:gd name="T30" fmla="*/ 48 w 1600"/>
                <a:gd name="T31" fmla="*/ 96 h 8864"/>
                <a:gd name="T32" fmla="*/ 96 w 1600"/>
                <a:gd name="T33" fmla="*/ 48 h 8864"/>
                <a:gd name="T34" fmla="*/ 96 w 1600"/>
                <a:gd name="T35" fmla="*/ 8816 h 88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0" h="886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52" y="0"/>
                  </a:lnTo>
                  <a:cubicBezTo>
                    <a:pt x="1579" y="0"/>
                    <a:pt x="1600" y="22"/>
                    <a:pt x="1600" y="48"/>
                  </a:cubicBezTo>
                  <a:lnTo>
                    <a:pt x="1600" y="8816"/>
                  </a:lnTo>
                  <a:cubicBezTo>
                    <a:pt x="1600" y="8843"/>
                    <a:pt x="1579" y="8864"/>
                    <a:pt x="1552" y="8864"/>
                  </a:cubicBezTo>
                  <a:lnTo>
                    <a:pt x="48" y="8864"/>
                  </a:lnTo>
                  <a:cubicBezTo>
                    <a:pt x="22" y="8864"/>
                    <a:pt x="0" y="8843"/>
                    <a:pt x="0" y="8816"/>
                  </a:cubicBezTo>
                  <a:lnTo>
                    <a:pt x="0" y="48"/>
                  </a:lnTo>
                  <a:close/>
                  <a:moveTo>
                    <a:pt x="96" y="8816"/>
                  </a:moveTo>
                  <a:lnTo>
                    <a:pt x="48" y="8768"/>
                  </a:lnTo>
                  <a:lnTo>
                    <a:pt x="1552" y="8768"/>
                  </a:lnTo>
                  <a:lnTo>
                    <a:pt x="1504" y="8816"/>
                  </a:lnTo>
                  <a:lnTo>
                    <a:pt x="1504" y="48"/>
                  </a:lnTo>
                  <a:lnTo>
                    <a:pt x="1552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881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" name="Rectangle 8"/>
            <p:cNvSpPr>
              <a:spLocks noChangeArrowheads="1"/>
            </p:cNvSpPr>
            <p:nvPr/>
          </p:nvSpPr>
          <p:spPr bwMode="auto">
            <a:xfrm>
              <a:off x="2486328" y="4306014"/>
              <a:ext cx="213580" cy="1602696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" name="Freeform 9"/>
            <p:cNvSpPr>
              <a:spLocks noEditPoints="1"/>
            </p:cNvSpPr>
            <p:nvPr/>
          </p:nvSpPr>
          <p:spPr bwMode="auto">
            <a:xfrm>
              <a:off x="2479654" y="4297362"/>
              <a:ext cx="226929" cy="1619999"/>
            </a:xfrm>
            <a:custGeom>
              <a:avLst/>
              <a:gdLst>
                <a:gd name="T0" fmla="*/ 0 w 1600"/>
                <a:gd name="T1" fmla="*/ 48 h 8864"/>
                <a:gd name="T2" fmla="*/ 48 w 1600"/>
                <a:gd name="T3" fmla="*/ 0 h 8864"/>
                <a:gd name="T4" fmla="*/ 1552 w 1600"/>
                <a:gd name="T5" fmla="*/ 0 h 8864"/>
                <a:gd name="T6" fmla="*/ 1600 w 1600"/>
                <a:gd name="T7" fmla="*/ 48 h 8864"/>
                <a:gd name="T8" fmla="*/ 1600 w 1600"/>
                <a:gd name="T9" fmla="*/ 8816 h 8864"/>
                <a:gd name="T10" fmla="*/ 1552 w 1600"/>
                <a:gd name="T11" fmla="*/ 8864 h 8864"/>
                <a:gd name="T12" fmla="*/ 48 w 1600"/>
                <a:gd name="T13" fmla="*/ 8864 h 8864"/>
                <a:gd name="T14" fmla="*/ 0 w 1600"/>
                <a:gd name="T15" fmla="*/ 8816 h 8864"/>
                <a:gd name="T16" fmla="*/ 0 w 1600"/>
                <a:gd name="T17" fmla="*/ 48 h 8864"/>
                <a:gd name="T18" fmla="*/ 96 w 1600"/>
                <a:gd name="T19" fmla="*/ 8816 h 8864"/>
                <a:gd name="T20" fmla="*/ 48 w 1600"/>
                <a:gd name="T21" fmla="*/ 8768 h 8864"/>
                <a:gd name="T22" fmla="*/ 1552 w 1600"/>
                <a:gd name="T23" fmla="*/ 8768 h 8864"/>
                <a:gd name="T24" fmla="*/ 1504 w 1600"/>
                <a:gd name="T25" fmla="*/ 8816 h 8864"/>
                <a:gd name="T26" fmla="*/ 1504 w 1600"/>
                <a:gd name="T27" fmla="*/ 48 h 8864"/>
                <a:gd name="T28" fmla="*/ 1552 w 1600"/>
                <a:gd name="T29" fmla="*/ 96 h 8864"/>
                <a:gd name="T30" fmla="*/ 48 w 1600"/>
                <a:gd name="T31" fmla="*/ 96 h 8864"/>
                <a:gd name="T32" fmla="*/ 96 w 1600"/>
                <a:gd name="T33" fmla="*/ 48 h 8864"/>
                <a:gd name="T34" fmla="*/ 96 w 1600"/>
                <a:gd name="T35" fmla="*/ 8816 h 88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0" h="886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52" y="0"/>
                  </a:lnTo>
                  <a:cubicBezTo>
                    <a:pt x="1579" y="0"/>
                    <a:pt x="1600" y="22"/>
                    <a:pt x="1600" y="48"/>
                  </a:cubicBezTo>
                  <a:lnTo>
                    <a:pt x="1600" y="8816"/>
                  </a:lnTo>
                  <a:cubicBezTo>
                    <a:pt x="1600" y="8843"/>
                    <a:pt x="1579" y="8864"/>
                    <a:pt x="1552" y="8864"/>
                  </a:cubicBezTo>
                  <a:lnTo>
                    <a:pt x="48" y="8864"/>
                  </a:lnTo>
                  <a:cubicBezTo>
                    <a:pt x="22" y="8864"/>
                    <a:pt x="0" y="8843"/>
                    <a:pt x="0" y="8816"/>
                  </a:cubicBezTo>
                  <a:lnTo>
                    <a:pt x="0" y="48"/>
                  </a:lnTo>
                  <a:close/>
                  <a:moveTo>
                    <a:pt x="96" y="8816"/>
                  </a:moveTo>
                  <a:lnTo>
                    <a:pt x="48" y="8768"/>
                  </a:lnTo>
                  <a:lnTo>
                    <a:pt x="1552" y="8768"/>
                  </a:lnTo>
                  <a:lnTo>
                    <a:pt x="1504" y="8816"/>
                  </a:lnTo>
                  <a:lnTo>
                    <a:pt x="1504" y="48"/>
                  </a:lnTo>
                  <a:lnTo>
                    <a:pt x="1552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881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3430754" y="4306014"/>
              <a:ext cx="210243" cy="1602696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Freeform 11"/>
            <p:cNvSpPr>
              <a:spLocks noEditPoints="1"/>
            </p:cNvSpPr>
            <p:nvPr/>
          </p:nvSpPr>
          <p:spPr bwMode="auto">
            <a:xfrm>
              <a:off x="3424080" y="4297362"/>
              <a:ext cx="223592" cy="1619999"/>
            </a:xfrm>
            <a:custGeom>
              <a:avLst/>
              <a:gdLst>
                <a:gd name="T0" fmla="*/ 0 w 1584"/>
                <a:gd name="T1" fmla="*/ 48 h 8864"/>
                <a:gd name="T2" fmla="*/ 48 w 1584"/>
                <a:gd name="T3" fmla="*/ 0 h 8864"/>
                <a:gd name="T4" fmla="*/ 1536 w 1584"/>
                <a:gd name="T5" fmla="*/ 0 h 8864"/>
                <a:gd name="T6" fmla="*/ 1584 w 1584"/>
                <a:gd name="T7" fmla="*/ 48 h 8864"/>
                <a:gd name="T8" fmla="*/ 1584 w 1584"/>
                <a:gd name="T9" fmla="*/ 8816 h 8864"/>
                <a:gd name="T10" fmla="*/ 1536 w 1584"/>
                <a:gd name="T11" fmla="*/ 8864 h 8864"/>
                <a:gd name="T12" fmla="*/ 48 w 1584"/>
                <a:gd name="T13" fmla="*/ 8864 h 8864"/>
                <a:gd name="T14" fmla="*/ 0 w 1584"/>
                <a:gd name="T15" fmla="*/ 8816 h 8864"/>
                <a:gd name="T16" fmla="*/ 0 w 1584"/>
                <a:gd name="T17" fmla="*/ 48 h 8864"/>
                <a:gd name="T18" fmla="*/ 96 w 1584"/>
                <a:gd name="T19" fmla="*/ 8816 h 8864"/>
                <a:gd name="T20" fmla="*/ 48 w 1584"/>
                <a:gd name="T21" fmla="*/ 8768 h 8864"/>
                <a:gd name="T22" fmla="*/ 1536 w 1584"/>
                <a:gd name="T23" fmla="*/ 8768 h 8864"/>
                <a:gd name="T24" fmla="*/ 1488 w 1584"/>
                <a:gd name="T25" fmla="*/ 8816 h 8864"/>
                <a:gd name="T26" fmla="*/ 1488 w 1584"/>
                <a:gd name="T27" fmla="*/ 48 h 8864"/>
                <a:gd name="T28" fmla="*/ 1536 w 1584"/>
                <a:gd name="T29" fmla="*/ 96 h 8864"/>
                <a:gd name="T30" fmla="*/ 48 w 1584"/>
                <a:gd name="T31" fmla="*/ 96 h 8864"/>
                <a:gd name="T32" fmla="*/ 96 w 1584"/>
                <a:gd name="T33" fmla="*/ 48 h 8864"/>
                <a:gd name="T34" fmla="*/ 96 w 1584"/>
                <a:gd name="T35" fmla="*/ 8816 h 88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584" h="886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36" y="0"/>
                  </a:lnTo>
                  <a:cubicBezTo>
                    <a:pt x="1563" y="0"/>
                    <a:pt x="1584" y="22"/>
                    <a:pt x="1584" y="48"/>
                  </a:cubicBezTo>
                  <a:lnTo>
                    <a:pt x="1584" y="8816"/>
                  </a:lnTo>
                  <a:cubicBezTo>
                    <a:pt x="1584" y="8843"/>
                    <a:pt x="1563" y="8864"/>
                    <a:pt x="1536" y="8864"/>
                  </a:cubicBezTo>
                  <a:lnTo>
                    <a:pt x="48" y="8864"/>
                  </a:lnTo>
                  <a:cubicBezTo>
                    <a:pt x="22" y="8864"/>
                    <a:pt x="0" y="8843"/>
                    <a:pt x="0" y="8816"/>
                  </a:cubicBezTo>
                  <a:lnTo>
                    <a:pt x="0" y="48"/>
                  </a:lnTo>
                  <a:close/>
                  <a:moveTo>
                    <a:pt x="96" y="8816"/>
                  </a:moveTo>
                  <a:lnTo>
                    <a:pt x="48" y="8768"/>
                  </a:lnTo>
                  <a:lnTo>
                    <a:pt x="1536" y="8768"/>
                  </a:lnTo>
                  <a:lnTo>
                    <a:pt x="1488" y="8816"/>
                  </a:lnTo>
                  <a:lnTo>
                    <a:pt x="1488" y="48"/>
                  </a:lnTo>
                  <a:lnTo>
                    <a:pt x="1536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881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1813884" y="4626120"/>
              <a:ext cx="210243" cy="128258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Freeform 13"/>
            <p:cNvSpPr>
              <a:spLocks noEditPoints="1"/>
            </p:cNvSpPr>
            <p:nvPr/>
          </p:nvSpPr>
          <p:spPr bwMode="auto">
            <a:xfrm>
              <a:off x="1807210" y="4617469"/>
              <a:ext cx="223592" cy="1299892"/>
            </a:xfrm>
            <a:custGeom>
              <a:avLst/>
              <a:gdLst>
                <a:gd name="T0" fmla="*/ 0 w 1584"/>
                <a:gd name="T1" fmla="*/ 48 h 7104"/>
                <a:gd name="T2" fmla="*/ 48 w 1584"/>
                <a:gd name="T3" fmla="*/ 0 h 7104"/>
                <a:gd name="T4" fmla="*/ 1536 w 1584"/>
                <a:gd name="T5" fmla="*/ 0 h 7104"/>
                <a:gd name="T6" fmla="*/ 1584 w 1584"/>
                <a:gd name="T7" fmla="*/ 48 h 7104"/>
                <a:gd name="T8" fmla="*/ 1584 w 1584"/>
                <a:gd name="T9" fmla="*/ 7056 h 7104"/>
                <a:gd name="T10" fmla="*/ 1536 w 1584"/>
                <a:gd name="T11" fmla="*/ 7104 h 7104"/>
                <a:gd name="T12" fmla="*/ 48 w 1584"/>
                <a:gd name="T13" fmla="*/ 7104 h 7104"/>
                <a:gd name="T14" fmla="*/ 0 w 1584"/>
                <a:gd name="T15" fmla="*/ 7056 h 7104"/>
                <a:gd name="T16" fmla="*/ 0 w 1584"/>
                <a:gd name="T17" fmla="*/ 48 h 7104"/>
                <a:gd name="T18" fmla="*/ 96 w 1584"/>
                <a:gd name="T19" fmla="*/ 7056 h 7104"/>
                <a:gd name="T20" fmla="*/ 48 w 1584"/>
                <a:gd name="T21" fmla="*/ 7008 h 7104"/>
                <a:gd name="T22" fmla="*/ 1536 w 1584"/>
                <a:gd name="T23" fmla="*/ 7008 h 7104"/>
                <a:gd name="T24" fmla="*/ 1488 w 1584"/>
                <a:gd name="T25" fmla="*/ 7056 h 7104"/>
                <a:gd name="T26" fmla="*/ 1488 w 1584"/>
                <a:gd name="T27" fmla="*/ 48 h 7104"/>
                <a:gd name="T28" fmla="*/ 1536 w 1584"/>
                <a:gd name="T29" fmla="*/ 96 h 7104"/>
                <a:gd name="T30" fmla="*/ 48 w 1584"/>
                <a:gd name="T31" fmla="*/ 96 h 7104"/>
                <a:gd name="T32" fmla="*/ 96 w 1584"/>
                <a:gd name="T33" fmla="*/ 48 h 7104"/>
                <a:gd name="T34" fmla="*/ 96 w 1584"/>
                <a:gd name="T35" fmla="*/ 7056 h 7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584" h="710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36" y="0"/>
                  </a:lnTo>
                  <a:cubicBezTo>
                    <a:pt x="1563" y="0"/>
                    <a:pt x="1584" y="22"/>
                    <a:pt x="1584" y="48"/>
                  </a:cubicBezTo>
                  <a:lnTo>
                    <a:pt x="1584" y="7056"/>
                  </a:lnTo>
                  <a:cubicBezTo>
                    <a:pt x="1584" y="7083"/>
                    <a:pt x="1563" y="7104"/>
                    <a:pt x="1536" y="7104"/>
                  </a:cubicBezTo>
                  <a:lnTo>
                    <a:pt x="48" y="7104"/>
                  </a:lnTo>
                  <a:cubicBezTo>
                    <a:pt x="22" y="7104"/>
                    <a:pt x="0" y="7083"/>
                    <a:pt x="0" y="7056"/>
                  </a:cubicBezTo>
                  <a:lnTo>
                    <a:pt x="0" y="48"/>
                  </a:lnTo>
                  <a:close/>
                  <a:moveTo>
                    <a:pt x="96" y="7056"/>
                  </a:moveTo>
                  <a:lnTo>
                    <a:pt x="48" y="7008"/>
                  </a:lnTo>
                  <a:lnTo>
                    <a:pt x="1536" y="7008"/>
                  </a:lnTo>
                  <a:lnTo>
                    <a:pt x="1488" y="7056"/>
                  </a:lnTo>
                  <a:lnTo>
                    <a:pt x="1488" y="48"/>
                  </a:lnTo>
                  <a:lnTo>
                    <a:pt x="1536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05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Rectangle 14"/>
            <p:cNvSpPr>
              <a:spLocks noChangeArrowheads="1"/>
            </p:cNvSpPr>
            <p:nvPr/>
          </p:nvSpPr>
          <p:spPr bwMode="auto">
            <a:xfrm>
              <a:off x="2754973" y="5383129"/>
              <a:ext cx="213580" cy="52558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Freeform 15"/>
            <p:cNvSpPr>
              <a:spLocks noEditPoints="1"/>
            </p:cNvSpPr>
            <p:nvPr/>
          </p:nvSpPr>
          <p:spPr bwMode="auto">
            <a:xfrm>
              <a:off x="2748299" y="5374478"/>
              <a:ext cx="226929" cy="542883"/>
            </a:xfrm>
            <a:custGeom>
              <a:avLst/>
              <a:gdLst>
                <a:gd name="T0" fmla="*/ 0 w 1600"/>
                <a:gd name="T1" fmla="*/ 48 h 2976"/>
                <a:gd name="T2" fmla="*/ 48 w 1600"/>
                <a:gd name="T3" fmla="*/ 0 h 2976"/>
                <a:gd name="T4" fmla="*/ 1552 w 1600"/>
                <a:gd name="T5" fmla="*/ 0 h 2976"/>
                <a:gd name="T6" fmla="*/ 1600 w 1600"/>
                <a:gd name="T7" fmla="*/ 48 h 2976"/>
                <a:gd name="T8" fmla="*/ 1600 w 1600"/>
                <a:gd name="T9" fmla="*/ 2928 h 2976"/>
                <a:gd name="T10" fmla="*/ 1552 w 1600"/>
                <a:gd name="T11" fmla="*/ 2976 h 2976"/>
                <a:gd name="T12" fmla="*/ 48 w 1600"/>
                <a:gd name="T13" fmla="*/ 2976 h 2976"/>
                <a:gd name="T14" fmla="*/ 0 w 1600"/>
                <a:gd name="T15" fmla="*/ 2928 h 2976"/>
                <a:gd name="T16" fmla="*/ 0 w 1600"/>
                <a:gd name="T17" fmla="*/ 48 h 2976"/>
                <a:gd name="T18" fmla="*/ 96 w 1600"/>
                <a:gd name="T19" fmla="*/ 2928 h 2976"/>
                <a:gd name="T20" fmla="*/ 48 w 1600"/>
                <a:gd name="T21" fmla="*/ 2880 h 2976"/>
                <a:gd name="T22" fmla="*/ 1552 w 1600"/>
                <a:gd name="T23" fmla="*/ 2880 h 2976"/>
                <a:gd name="T24" fmla="*/ 1504 w 1600"/>
                <a:gd name="T25" fmla="*/ 2928 h 2976"/>
                <a:gd name="T26" fmla="*/ 1504 w 1600"/>
                <a:gd name="T27" fmla="*/ 48 h 2976"/>
                <a:gd name="T28" fmla="*/ 1552 w 1600"/>
                <a:gd name="T29" fmla="*/ 96 h 2976"/>
                <a:gd name="T30" fmla="*/ 48 w 1600"/>
                <a:gd name="T31" fmla="*/ 96 h 2976"/>
                <a:gd name="T32" fmla="*/ 96 w 1600"/>
                <a:gd name="T33" fmla="*/ 48 h 2976"/>
                <a:gd name="T34" fmla="*/ 96 w 1600"/>
                <a:gd name="T35" fmla="*/ 2928 h 29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0" h="2976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52" y="0"/>
                  </a:lnTo>
                  <a:cubicBezTo>
                    <a:pt x="1579" y="0"/>
                    <a:pt x="1600" y="22"/>
                    <a:pt x="1600" y="48"/>
                  </a:cubicBezTo>
                  <a:lnTo>
                    <a:pt x="1600" y="2928"/>
                  </a:lnTo>
                  <a:cubicBezTo>
                    <a:pt x="1600" y="2955"/>
                    <a:pt x="1579" y="2976"/>
                    <a:pt x="1552" y="2976"/>
                  </a:cubicBezTo>
                  <a:lnTo>
                    <a:pt x="48" y="2976"/>
                  </a:lnTo>
                  <a:cubicBezTo>
                    <a:pt x="22" y="2976"/>
                    <a:pt x="0" y="2955"/>
                    <a:pt x="0" y="2928"/>
                  </a:cubicBezTo>
                  <a:lnTo>
                    <a:pt x="0" y="48"/>
                  </a:lnTo>
                  <a:close/>
                  <a:moveTo>
                    <a:pt x="96" y="2928"/>
                  </a:moveTo>
                  <a:lnTo>
                    <a:pt x="48" y="2880"/>
                  </a:lnTo>
                  <a:lnTo>
                    <a:pt x="1552" y="2880"/>
                  </a:lnTo>
                  <a:lnTo>
                    <a:pt x="1504" y="2928"/>
                  </a:lnTo>
                  <a:lnTo>
                    <a:pt x="1504" y="48"/>
                  </a:lnTo>
                  <a:lnTo>
                    <a:pt x="1552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292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3696062" y="5709725"/>
              <a:ext cx="211912" cy="19898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Freeform 17"/>
            <p:cNvSpPr>
              <a:spLocks noEditPoints="1"/>
            </p:cNvSpPr>
            <p:nvPr/>
          </p:nvSpPr>
          <p:spPr bwMode="auto">
            <a:xfrm>
              <a:off x="3689388" y="5701074"/>
              <a:ext cx="226929" cy="216288"/>
            </a:xfrm>
            <a:custGeom>
              <a:avLst/>
              <a:gdLst>
                <a:gd name="T0" fmla="*/ 0 w 1600"/>
                <a:gd name="T1" fmla="*/ 48 h 1184"/>
                <a:gd name="T2" fmla="*/ 48 w 1600"/>
                <a:gd name="T3" fmla="*/ 0 h 1184"/>
                <a:gd name="T4" fmla="*/ 1552 w 1600"/>
                <a:gd name="T5" fmla="*/ 0 h 1184"/>
                <a:gd name="T6" fmla="*/ 1600 w 1600"/>
                <a:gd name="T7" fmla="*/ 48 h 1184"/>
                <a:gd name="T8" fmla="*/ 1600 w 1600"/>
                <a:gd name="T9" fmla="*/ 1136 h 1184"/>
                <a:gd name="T10" fmla="*/ 1552 w 1600"/>
                <a:gd name="T11" fmla="*/ 1184 h 1184"/>
                <a:gd name="T12" fmla="*/ 48 w 1600"/>
                <a:gd name="T13" fmla="*/ 1184 h 1184"/>
                <a:gd name="T14" fmla="*/ 0 w 1600"/>
                <a:gd name="T15" fmla="*/ 1136 h 1184"/>
                <a:gd name="T16" fmla="*/ 0 w 1600"/>
                <a:gd name="T17" fmla="*/ 48 h 1184"/>
                <a:gd name="T18" fmla="*/ 96 w 1600"/>
                <a:gd name="T19" fmla="*/ 1136 h 1184"/>
                <a:gd name="T20" fmla="*/ 48 w 1600"/>
                <a:gd name="T21" fmla="*/ 1088 h 1184"/>
                <a:gd name="T22" fmla="*/ 1552 w 1600"/>
                <a:gd name="T23" fmla="*/ 1088 h 1184"/>
                <a:gd name="T24" fmla="*/ 1504 w 1600"/>
                <a:gd name="T25" fmla="*/ 1136 h 1184"/>
                <a:gd name="T26" fmla="*/ 1504 w 1600"/>
                <a:gd name="T27" fmla="*/ 48 h 1184"/>
                <a:gd name="T28" fmla="*/ 1552 w 1600"/>
                <a:gd name="T29" fmla="*/ 96 h 1184"/>
                <a:gd name="T30" fmla="*/ 48 w 1600"/>
                <a:gd name="T31" fmla="*/ 96 h 1184"/>
                <a:gd name="T32" fmla="*/ 96 w 1600"/>
                <a:gd name="T33" fmla="*/ 48 h 1184"/>
                <a:gd name="T34" fmla="*/ 96 w 1600"/>
                <a:gd name="T35" fmla="*/ 1136 h 11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0" h="118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52" y="0"/>
                  </a:lnTo>
                  <a:cubicBezTo>
                    <a:pt x="1579" y="0"/>
                    <a:pt x="1600" y="22"/>
                    <a:pt x="1600" y="48"/>
                  </a:cubicBezTo>
                  <a:lnTo>
                    <a:pt x="1600" y="1136"/>
                  </a:lnTo>
                  <a:cubicBezTo>
                    <a:pt x="1600" y="1163"/>
                    <a:pt x="1579" y="1184"/>
                    <a:pt x="1552" y="1184"/>
                  </a:cubicBezTo>
                  <a:lnTo>
                    <a:pt x="48" y="1184"/>
                  </a:lnTo>
                  <a:cubicBezTo>
                    <a:pt x="22" y="1184"/>
                    <a:pt x="0" y="1163"/>
                    <a:pt x="0" y="1136"/>
                  </a:cubicBezTo>
                  <a:lnTo>
                    <a:pt x="0" y="48"/>
                  </a:lnTo>
                  <a:close/>
                  <a:moveTo>
                    <a:pt x="96" y="1136"/>
                  </a:moveTo>
                  <a:lnTo>
                    <a:pt x="48" y="1088"/>
                  </a:lnTo>
                  <a:lnTo>
                    <a:pt x="1552" y="1088"/>
                  </a:lnTo>
                  <a:lnTo>
                    <a:pt x="1504" y="1136"/>
                  </a:lnTo>
                  <a:lnTo>
                    <a:pt x="1504" y="48"/>
                  </a:lnTo>
                  <a:lnTo>
                    <a:pt x="1552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13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Freeform 18"/>
            <p:cNvSpPr>
              <a:spLocks noEditPoints="1"/>
            </p:cNvSpPr>
            <p:nvPr/>
          </p:nvSpPr>
          <p:spPr bwMode="auto">
            <a:xfrm>
              <a:off x="1877291" y="4572049"/>
              <a:ext cx="83430" cy="108144"/>
            </a:xfrm>
            <a:custGeom>
              <a:avLst/>
              <a:gdLst>
                <a:gd name="T0" fmla="*/ 30 w 50"/>
                <a:gd name="T1" fmla="*/ 25 h 50"/>
                <a:gd name="T2" fmla="*/ 30 w 50"/>
                <a:gd name="T3" fmla="*/ 46 h 50"/>
                <a:gd name="T4" fmla="*/ 22 w 50"/>
                <a:gd name="T5" fmla="*/ 46 h 50"/>
                <a:gd name="T6" fmla="*/ 22 w 50"/>
                <a:gd name="T7" fmla="*/ 25 h 50"/>
                <a:gd name="T8" fmla="*/ 30 w 50"/>
                <a:gd name="T9" fmla="*/ 25 h 50"/>
                <a:gd name="T10" fmla="*/ 22 w 50"/>
                <a:gd name="T11" fmla="*/ 25 h 50"/>
                <a:gd name="T12" fmla="*/ 22 w 50"/>
                <a:gd name="T13" fmla="*/ 4 h 50"/>
                <a:gd name="T14" fmla="*/ 30 w 50"/>
                <a:gd name="T15" fmla="*/ 4 h 50"/>
                <a:gd name="T16" fmla="*/ 30 w 50"/>
                <a:gd name="T17" fmla="*/ 25 h 50"/>
                <a:gd name="T18" fmla="*/ 22 w 50"/>
                <a:gd name="T19" fmla="*/ 25 h 50"/>
                <a:gd name="T20" fmla="*/ 0 w 50"/>
                <a:gd name="T21" fmla="*/ 42 h 50"/>
                <a:gd name="T22" fmla="*/ 50 w 50"/>
                <a:gd name="T23" fmla="*/ 42 h 50"/>
                <a:gd name="T24" fmla="*/ 50 w 50"/>
                <a:gd name="T25" fmla="*/ 50 h 50"/>
                <a:gd name="T26" fmla="*/ 0 w 50"/>
                <a:gd name="T27" fmla="*/ 50 h 50"/>
                <a:gd name="T28" fmla="*/ 0 w 50"/>
                <a:gd name="T29" fmla="*/ 42 h 50"/>
                <a:gd name="T30" fmla="*/ 0 w 50"/>
                <a:gd name="T31" fmla="*/ 0 h 50"/>
                <a:gd name="T32" fmla="*/ 50 w 50"/>
                <a:gd name="T33" fmla="*/ 0 h 50"/>
                <a:gd name="T34" fmla="*/ 50 w 50"/>
                <a:gd name="T35" fmla="*/ 8 h 50"/>
                <a:gd name="T36" fmla="*/ 0 w 50"/>
                <a:gd name="T37" fmla="*/ 8 h 50"/>
                <a:gd name="T38" fmla="*/ 0 w 50"/>
                <a:gd name="T39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50" h="50">
                  <a:moveTo>
                    <a:pt x="30" y="25"/>
                  </a:moveTo>
                  <a:lnTo>
                    <a:pt x="30" y="46"/>
                  </a:lnTo>
                  <a:lnTo>
                    <a:pt x="22" y="46"/>
                  </a:lnTo>
                  <a:lnTo>
                    <a:pt x="22" y="25"/>
                  </a:lnTo>
                  <a:lnTo>
                    <a:pt x="30" y="25"/>
                  </a:lnTo>
                  <a:close/>
                  <a:moveTo>
                    <a:pt x="22" y="25"/>
                  </a:moveTo>
                  <a:lnTo>
                    <a:pt x="22" y="4"/>
                  </a:lnTo>
                  <a:lnTo>
                    <a:pt x="30" y="4"/>
                  </a:lnTo>
                  <a:lnTo>
                    <a:pt x="30" y="25"/>
                  </a:lnTo>
                  <a:lnTo>
                    <a:pt x="22" y="25"/>
                  </a:lnTo>
                  <a:close/>
                  <a:moveTo>
                    <a:pt x="0" y="42"/>
                  </a:moveTo>
                  <a:lnTo>
                    <a:pt x="50" y="42"/>
                  </a:lnTo>
                  <a:lnTo>
                    <a:pt x="50" y="50"/>
                  </a:lnTo>
                  <a:lnTo>
                    <a:pt x="0" y="50"/>
                  </a:lnTo>
                  <a:lnTo>
                    <a:pt x="0" y="42"/>
                  </a:lnTo>
                  <a:close/>
                  <a:moveTo>
                    <a:pt x="0" y="0"/>
                  </a:moveTo>
                  <a:lnTo>
                    <a:pt x="50" y="0"/>
                  </a:lnTo>
                  <a:lnTo>
                    <a:pt x="50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Freeform 19"/>
            <p:cNvSpPr>
              <a:spLocks noEditPoints="1"/>
            </p:cNvSpPr>
            <p:nvPr/>
          </p:nvSpPr>
          <p:spPr bwMode="auto">
            <a:xfrm>
              <a:off x="2818380" y="5307429"/>
              <a:ext cx="86767" cy="149238"/>
            </a:xfrm>
            <a:custGeom>
              <a:avLst/>
              <a:gdLst>
                <a:gd name="T0" fmla="*/ 30 w 52"/>
                <a:gd name="T1" fmla="*/ 35 h 69"/>
                <a:gd name="T2" fmla="*/ 30 w 52"/>
                <a:gd name="T3" fmla="*/ 65 h 69"/>
                <a:gd name="T4" fmla="*/ 22 w 52"/>
                <a:gd name="T5" fmla="*/ 65 h 69"/>
                <a:gd name="T6" fmla="*/ 22 w 52"/>
                <a:gd name="T7" fmla="*/ 35 h 69"/>
                <a:gd name="T8" fmla="*/ 30 w 52"/>
                <a:gd name="T9" fmla="*/ 35 h 69"/>
                <a:gd name="T10" fmla="*/ 22 w 52"/>
                <a:gd name="T11" fmla="*/ 35 h 69"/>
                <a:gd name="T12" fmla="*/ 22 w 52"/>
                <a:gd name="T13" fmla="*/ 4 h 69"/>
                <a:gd name="T14" fmla="*/ 30 w 52"/>
                <a:gd name="T15" fmla="*/ 4 h 69"/>
                <a:gd name="T16" fmla="*/ 30 w 52"/>
                <a:gd name="T17" fmla="*/ 35 h 69"/>
                <a:gd name="T18" fmla="*/ 22 w 52"/>
                <a:gd name="T19" fmla="*/ 35 h 69"/>
                <a:gd name="T20" fmla="*/ 0 w 52"/>
                <a:gd name="T21" fmla="*/ 60 h 69"/>
                <a:gd name="T22" fmla="*/ 52 w 52"/>
                <a:gd name="T23" fmla="*/ 60 h 69"/>
                <a:gd name="T24" fmla="*/ 52 w 52"/>
                <a:gd name="T25" fmla="*/ 69 h 69"/>
                <a:gd name="T26" fmla="*/ 0 w 52"/>
                <a:gd name="T27" fmla="*/ 69 h 69"/>
                <a:gd name="T28" fmla="*/ 0 w 52"/>
                <a:gd name="T29" fmla="*/ 60 h 69"/>
                <a:gd name="T30" fmla="*/ 0 w 52"/>
                <a:gd name="T31" fmla="*/ 0 h 69"/>
                <a:gd name="T32" fmla="*/ 52 w 52"/>
                <a:gd name="T33" fmla="*/ 0 h 69"/>
                <a:gd name="T34" fmla="*/ 52 w 52"/>
                <a:gd name="T35" fmla="*/ 8 h 69"/>
                <a:gd name="T36" fmla="*/ 0 w 52"/>
                <a:gd name="T37" fmla="*/ 8 h 69"/>
                <a:gd name="T38" fmla="*/ 0 w 52"/>
                <a:gd name="T39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52" h="69">
                  <a:moveTo>
                    <a:pt x="30" y="35"/>
                  </a:moveTo>
                  <a:lnTo>
                    <a:pt x="30" y="65"/>
                  </a:lnTo>
                  <a:lnTo>
                    <a:pt x="22" y="65"/>
                  </a:lnTo>
                  <a:lnTo>
                    <a:pt x="22" y="35"/>
                  </a:lnTo>
                  <a:lnTo>
                    <a:pt x="30" y="35"/>
                  </a:lnTo>
                  <a:close/>
                  <a:moveTo>
                    <a:pt x="22" y="35"/>
                  </a:moveTo>
                  <a:lnTo>
                    <a:pt x="22" y="4"/>
                  </a:lnTo>
                  <a:lnTo>
                    <a:pt x="30" y="4"/>
                  </a:lnTo>
                  <a:lnTo>
                    <a:pt x="30" y="35"/>
                  </a:lnTo>
                  <a:lnTo>
                    <a:pt x="22" y="35"/>
                  </a:lnTo>
                  <a:close/>
                  <a:moveTo>
                    <a:pt x="0" y="60"/>
                  </a:moveTo>
                  <a:lnTo>
                    <a:pt x="52" y="60"/>
                  </a:lnTo>
                  <a:lnTo>
                    <a:pt x="52" y="69"/>
                  </a:lnTo>
                  <a:lnTo>
                    <a:pt x="0" y="69"/>
                  </a:lnTo>
                  <a:lnTo>
                    <a:pt x="0" y="60"/>
                  </a:lnTo>
                  <a:close/>
                  <a:moveTo>
                    <a:pt x="0" y="0"/>
                  </a:moveTo>
                  <a:lnTo>
                    <a:pt x="52" y="0"/>
                  </a:lnTo>
                  <a:lnTo>
                    <a:pt x="52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Freeform 20"/>
            <p:cNvSpPr>
              <a:spLocks noEditPoints="1"/>
            </p:cNvSpPr>
            <p:nvPr/>
          </p:nvSpPr>
          <p:spPr bwMode="auto">
            <a:xfrm>
              <a:off x="3762806" y="5659978"/>
              <a:ext cx="83430" cy="97329"/>
            </a:xfrm>
            <a:custGeom>
              <a:avLst/>
              <a:gdLst>
                <a:gd name="T0" fmla="*/ 28 w 50"/>
                <a:gd name="T1" fmla="*/ 23 h 45"/>
                <a:gd name="T2" fmla="*/ 28 w 50"/>
                <a:gd name="T3" fmla="*/ 41 h 45"/>
                <a:gd name="T4" fmla="*/ 20 w 50"/>
                <a:gd name="T5" fmla="*/ 41 h 45"/>
                <a:gd name="T6" fmla="*/ 20 w 50"/>
                <a:gd name="T7" fmla="*/ 23 h 45"/>
                <a:gd name="T8" fmla="*/ 28 w 50"/>
                <a:gd name="T9" fmla="*/ 23 h 45"/>
                <a:gd name="T10" fmla="*/ 20 w 50"/>
                <a:gd name="T11" fmla="*/ 23 h 45"/>
                <a:gd name="T12" fmla="*/ 20 w 50"/>
                <a:gd name="T13" fmla="*/ 4 h 45"/>
                <a:gd name="T14" fmla="*/ 28 w 50"/>
                <a:gd name="T15" fmla="*/ 4 h 45"/>
                <a:gd name="T16" fmla="*/ 28 w 50"/>
                <a:gd name="T17" fmla="*/ 23 h 45"/>
                <a:gd name="T18" fmla="*/ 20 w 50"/>
                <a:gd name="T19" fmla="*/ 23 h 45"/>
                <a:gd name="T20" fmla="*/ 0 w 50"/>
                <a:gd name="T21" fmla="*/ 37 h 45"/>
                <a:gd name="T22" fmla="*/ 50 w 50"/>
                <a:gd name="T23" fmla="*/ 37 h 45"/>
                <a:gd name="T24" fmla="*/ 50 w 50"/>
                <a:gd name="T25" fmla="*/ 45 h 45"/>
                <a:gd name="T26" fmla="*/ 0 w 50"/>
                <a:gd name="T27" fmla="*/ 45 h 45"/>
                <a:gd name="T28" fmla="*/ 0 w 50"/>
                <a:gd name="T29" fmla="*/ 37 h 45"/>
                <a:gd name="T30" fmla="*/ 0 w 50"/>
                <a:gd name="T31" fmla="*/ 0 h 45"/>
                <a:gd name="T32" fmla="*/ 50 w 50"/>
                <a:gd name="T33" fmla="*/ 0 h 45"/>
                <a:gd name="T34" fmla="*/ 50 w 50"/>
                <a:gd name="T35" fmla="*/ 8 h 45"/>
                <a:gd name="T36" fmla="*/ 0 w 50"/>
                <a:gd name="T37" fmla="*/ 8 h 45"/>
                <a:gd name="T38" fmla="*/ 0 w 50"/>
                <a:gd name="T3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50" h="45">
                  <a:moveTo>
                    <a:pt x="28" y="23"/>
                  </a:moveTo>
                  <a:lnTo>
                    <a:pt x="28" y="41"/>
                  </a:lnTo>
                  <a:lnTo>
                    <a:pt x="20" y="41"/>
                  </a:lnTo>
                  <a:lnTo>
                    <a:pt x="20" y="23"/>
                  </a:lnTo>
                  <a:lnTo>
                    <a:pt x="28" y="23"/>
                  </a:lnTo>
                  <a:close/>
                  <a:moveTo>
                    <a:pt x="20" y="23"/>
                  </a:moveTo>
                  <a:lnTo>
                    <a:pt x="20" y="4"/>
                  </a:lnTo>
                  <a:lnTo>
                    <a:pt x="28" y="4"/>
                  </a:lnTo>
                  <a:lnTo>
                    <a:pt x="28" y="23"/>
                  </a:lnTo>
                  <a:lnTo>
                    <a:pt x="20" y="23"/>
                  </a:lnTo>
                  <a:close/>
                  <a:moveTo>
                    <a:pt x="0" y="37"/>
                  </a:moveTo>
                  <a:lnTo>
                    <a:pt x="50" y="37"/>
                  </a:lnTo>
                  <a:lnTo>
                    <a:pt x="50" y="45"/>
                  </a:lnTo>
                  <a:lnTo>
                    <a:pt x="0" y="45"/>
                  </a:lnTo>
                  <a:lnTo>
                    <a:pt x="0" y="37"/>
                  </a:lnTo>
                  <a:close/>
                  <a:moveTo>
                    <a:pt x="0" y="0"/>
                  </a:moveTo>
                  <a:lnTo>
                    <a:pt x="50" y="0"/>
                  </a:lnTo>
                  <a:lnTo>
                    <a:pt x="50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Rectangle 21"/>
            <p:cNvSpPr>
              <a:spLocks noChangeArrowheads="1"/>
            </p:cNvSpPr>
            <p:nvPr/>
          </p:nvSpPr>
          <p:spPr bwMode="auto">
            <a:xfrm>
              <a:off x="1306631" y="4306014"/>
              <a:ext cx="13349" cy="1602696"/>
            </a:xfrm>
            <a:prstGeom prst="rect">
              <a:avLst/>
            </a:pr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Freeform 22"/>
            <p:cNvSpPr>
              <a:spLocks noEditPoints="1"/>
            </p:cNvSpPr>
            <p:nvPr/>
          </p:nvSpPr>
          <p:spPr bwMode="auto">
            <a:xfrm>
              <a:off x="1261578" y="4297362"/>
              <a:ext cx="51727" cy="1619999"/>
            </a:xfrm>
            <a:custGeom>
              <a:avLst/>
              <a:gdLst>
                <a:gd name="T0" fmla="*/ 0 w 31"/>
                <a:gd name="T1" fmla="*/ 741 h 749"/>
                <a:gd name="T2" fmla="*/ 31 w 31"/>
                <a:gd name="T3" fmla="*/ 741 h 749"/>
                <a:gd name="T4" fmla="*/ 31 w 31"/>
                <a:gd name="T5" fmla="*/ 749 h 749"/>
                <a:gd name="T6" fmla="*/ 0 w 31"/>
                <a:gd name="T7" fmla="*/ 749 h 749"/>
                <a:gd name="T8" fmla="*/ 0 w 31"/>
                <a:gd name="T9" fmla="*/ 741 h 749"/>
                <a:gd name="T10" fmla="*/ 0 w 31"/>
                <a:gd name="T11" fmla="*/ 594 h 749"/>
                <a:gd name="T12" fmla="*/ 31 w 31"/>
                <a:gd name="T13" fmla="*/ 594 h 749"/>
                <a:gd name="T14" fmla="*/ 31 w 31"/>
                <a:gd name="T15" fmla="*/ 602 h 749"/>
                <a:gd name="T16" fmla="*/ 0 w 31"/>
                <a:gd name="T17" fmla="*/ 602 h 749"/>
                <a:gd name="T18" fmla="*/ 0 w 31"/>
                <a:gd name="T19" fmla="*/ 594 h 749"/>
                <a:gd name="T20" fmla="*/ 0 w 31"/>
                <a:gd name="T21" fmla="*/ 445 h 749"/>
                <a:gd name="T22" fmla="*/ 31 w 31"/>
                <a:gd name="T23" fmla="*/ 445 h 749"/>
                <a:gd name="T24" fmla="*/ 31 w 31"/>
                <a:gd name="T25" fmla="*/ 453 h 749"/>
                <a:gd name="T26" fmla="*/ 0 w 31"/>
                <a:gd name="T27" fmla="*/ 453 h 749"/>
                <a:gd name="T28" fmla="*/ 0 w 31"/>
                <a:gd name="T29" fmla="*/ 445 h 749"/>
                <a:gd name="T30" fmla="*/ 0 w 31"/>
                <a:gd name="T31" fmla="*/ 296 h 749"/>
                <a:gd name="T32" fmla="*/ 31 w 31"/>
                <a:gd name="T33" fmla="*/ 296 h 749"/>
                <a:gd name="T34" fmla="*/ 31 w 31"/>
                <a:gd name="T35" fmla="*/ 304 h 749"/>
                <a:gd name="T36" fmla="*/ 0 w 31"/>
                <a:gd name="T37" fmla="*/ 304 h 749"/>
                <a:gd name="T38" fmla="*/ 0 w 31"/>
                <a:gd name="T39" fmla="*/ 296 h 749"/>
                <a:gd name="T40" fmla="*/ 0 w 31"/>
                <a:gd name="T41" fmla="*/ 148 h 749"/>
                <a:gd name="T42" fmla="*/ 31 w 31"/>
                <a:gd name="T43" fmla="*/ 148 h 749"/>
                <a:gd name="T44" fmla="*/ 31 w 31"/>
                <a:gd name="T45" fmla="*/ 157 h 749"/>
                <a:gd name="T46" fmla="*/ 0 w 31"/>
                <a:gd name="T47" fmla="*/ 157 h 749"/>
                <a:gd name="T48" fmla="*/ 0 w 31"/>
                <a:gd name="T49" fmla="*/ 148 h 749"/>
                <a:gd name="T50" fmla="*/ 0 w 31"/>
                <a:gd name="T51" fmla="*/ 0 h 749"/>
                <a:gd name="T52" fmla="*/ 31 w 31"/>
                <a:gd name="T53" fmla="*/ 0 h 749"/>
                <a:gd name="T54" fmla="*/ 31 w 31"/>
                <a:gd name="T55" fmla="*/ 8 h 749"/>
                <a:gd name="T56" fmla="*/ 0 w 31"/>
                <a:gd name="T57" fmla="*/ 8 h 749"/>
                <a:gd name="T58" fmla="*/ 0 w 31"/>
                <a:gd name="T59" fmla="*/ 0 h 7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31" h="749">
                  <a:moveTo>
                    <a:pt x="0" y="741"/>
                  </a:moveTo>
                  <a:lnTo>
                    <a:pt x="31" y="741"/>
                  </a:lnTo>
                  <a:lnTo>
                    <a:pt x="31" y="749"/>
                  </a:lnTo>
                  <a:lnTo>
                    <a:pt x="0" y="749"/>
                  </a:lnTo>
                  <a:lnTo>
                    <a:pt x="0" y="741"/>
                  </a:lnTo>
                  <a:close/>
                  <a:moveTo>
                    <a:pt x="0" y="594"/>
                  </a:moveTo>
                  <a:lnTo>
                    <a:pt x="31" y="594"/>
                  </a:lnTo>
                  <a:lnTo>
                    <a:pt x="31" y="602"/>
                  </a:lnTo>
                  <a:lnTo>
                    <a:pt x="0" y="602"/>
                  </a:lnTo>
                  <a:lnTo>
                    <a:pt x="0" y="594"/>
                  </a:lnTo>
                  <a:close/>
                  <a:moveTo>
                    <a:pt x="0" y="445"/>
                  </a:moveTo>
                  <a:lnTo>
                    <a:pt x="31" y="445"/>
                  </a:lnTo>
                  <a:lnTo>
                    <a:pt x="31" y="453"/>
                  </a:lnTo>
                  <a:lnTo>
                    <a:pt x="0" y="453"/>
                  </a:lnTo>
                  <a:lnTo>
                    <a:pt x="0" y="445"/>
                  </a:lnTo>
                  <a:close/>
                  <a:moveTo>
                    <a:pt x="0" y="296"/>
                  </a:moveTo>
                  <a:lnTo>
                    <a:pt x="31" y="296"/>
                  </a:lnTo>
                  <a:lnTo>
                    <a:pt x="31" y="304"/>
                  </a:lnTo>
                  <a:lnTo>
                    <a:pt x="0" y="304"/>
                  </a:lnTo>
                  <a:lnTo>
                    <a:pt x="0" y="296"/>
                  </a:lnTo>
                  <a:close/>
                  <a:moveTo>
                    <a:pt x="0" y="148"/>
                  </a:moveTo>
                  <a:lnTo>
                    <a:pt x="31" y="148"/>
                  </a:lnTo>
                  <a:lnTo>
                    <a:pt x="31" y="157"/>
                  </a:lnTo>
                  <a:lnTo>
                    <a:pt x="0" y="157"/>
                  </a:lnTo>
                  <a:lnTo>
                    <a:pt x="0" y="148"/>
                  </a:lnTo>
                  <a:close/>
                  <a:moveTo>
                    <a:pt x="0" y="0"/>
                  </a:moveTo>
                  <a:lnTo>
                    <a:pt x="31" y="0"/>
                  </a:lnTo>
                  <a:lnTo>
                    <a:pt x="31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Rectangle 23"/>
            <p:cNvSpPr>
              <a:spLocks noChangeArrowheads="1"/>
            </p:cNvSpPr>
            <p:nvPr/>
          </p:nvSpPr>
          <p:spPr bwMode="auto">
            <a:xfrm>
              <a:off x="1313305" y="5900059"/>
              <a:ext cx="2828273" cy="17303"/>
            </a:xfrm>
            <a:prstGeom prst="rect">
              <a:avLst/>
            </a:pr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22" name="テキスト ボックス 46"/>
          <p:cNvSpPr txBox="1"/>
          <p:nvPr/>
        </p:nvSpPr>
        <p:spPr>
          <a:xfrm>
            <a:off x="2187419" y="469049"/>
            <a:ext cx="12271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HC-1</a:t>
            </a:r>
            <a:endParaRPr kumimoji="1" lang="ja-JP" altLang="en-US" sz="2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" name="テキスト ボックス 47"/>
          <p:cNvSpPr txBox="1"/>
          <p:nvPr/>
        </p:nvSpPr>
        <p:spPr>
          <a:xfrm>
            <a:off x="6084148" y="469049"/>
            <a:ext cx="15789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K-LMS-1</a:t>
            </a:r>
            <a:endParaRPr kumimoji="1" lang="ja-JP" altLang="en-US" sz="2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151" name="グループ化 150"/>
          <p:cNvGrpSpPr/>
          <p:nvPr/>
        </p:nvGrpSpPr>
        <p:grpSpPr>
          <a:xfrm>
            <a:off x="1261578" y="1111296"/>
            <a:ext cx="2880000" cy="1620000"/>
            <a:chOff x="1261578" y="1758996"/>
            <a:chExt cx="2880000" cy="1620000"/>
          </a:xfrm>
        </p:grpSpPr>
        <p:sp>
          <p:nvSpPr>
            <p:cNvPr id="25" name="Rectangle 47"/>
            <p:cNvSpPr>
              <a:spLocks noChangeArrowheads="1"/>
            </p:cNvSpPr>
            <p:nvPr/>
          </p:nvSpPr>
          <p:spPr bwMode="auto">
            <a:xfrm>
              <a:off x="1546823" y="1768627"/>
              <a:ext cx="210692" cy="1602664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Freeform 48"/>
            <p:cNvSpPr>
              <a:spLocks noEditPoints="1"/>
            </p:cNvSpPr>
            <p:nvPr/>
          </p:nvSpPr>
          <p:spPr bwMode="auto">
            <a:xfrm>
              <a:off x="1540340" y="1758996"/>
              <a:ext cx="225279" cy="1620000"/>
            </a:xfrm>
            <a:custGeom>
              <a:avLst/>
              <a:gdLst>
                <a:gd name="T0" fmla="*/ 0 w 1632"/>
                <a:gd name="T1" fmla="*/ 48 h 8544"/>
                <a:gd name="T2" fmla="*/ 48 w 1632"/>
                <a:gd name="T3" fmla="*/ 0 h 8544"/>
                <a:gd name="T4" fmla="*/ 1584 w 1632"/>
                <a:gd name="T5" fmla="*/ 0 h 8544"/>
                <a:gd name="T6" fmla="*/ 1632 w 1632"/>
                <a:gd name="T7" fmla="*/ 48 h 8544"/>
                <a:gd name="T8" fmla="*/ 1632 w 1632"/>
                <a:gd name="T9" fmla="*/ 8496 h 8544"/>
                <a:gd name="T10" fmla="*/ 1584 w 1632"/>
                <a:gd name="T11" fmla="*/ 8544 h 8544"/>
                <a:gd name="T12" fmla="*/ 48 w 1632"/>
                <a:gd name="T13" fmla="*/ 8544 h 8544"/>
                <a:gd name="T14" fmla="*/ 0 w 1632"/>
                <a:gd name="T15" fmla="*/ 8496 h 8544"/>
                <a:gd name="T16" fmla="*/ 0 w 1632"/>
                <a:gd name="T17" fmla="*/ 48 h 8544"/>
                <a:gd name="T18" fmla="*/ 96 w 1632"/>
                <a:gd name="T19" fmla="*/ 8496 h 8544"/>
                <a:gd name="T20" fmla="*/ 48 w 1632"/>
                <a:gd name="T21" fmla="*/ 8448 h 8544"/>
                <a:gd name="T22" fmla="*/ 1584 w 1632"/>
                <a:gd name="T23" fmla="*/ 8448 h 8544"/>
                <a:gd name="T24" fmla="*/ 1536 w 1632"/>
                <a:gd name="T25" fmla="*/ 8496 h 8544"/>
                <a:gd name="T26" fmla="*/ 1536 w 1632"/>
                <a:gd name="T27" fmla="*/ 48 h 8544"/>
                <a:gd name="T28" fmla="*/ 1584 w 1632"/>
                <a:gd name="T29" fmla="*/ 96 h 8544"/>
                <a:gd name="T30" fmla="*/ 48 w 1632"/>
                <a:gd name="T31" fmla="*/ 96 h 8544"/>
                <a:gd name="T32" fmla="*/ 96 w 1632"/>
                <a:gd name="T33" fmla="*/ 48 h 8544"/>
                <a:gd name="T34" fmla="*/ 96 w 1632"/>
                <a:gd name="T35" fmla="*/ 8496 h 85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854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8496"/>
                  </a:lnTo>
                  <a:cubicBezTo>
                    <a:pt x="1632" y="8523"/>
                    <a:pt x="1611" y="8544"/>
                    <a:pt x="1584" y="8544"/>
                  </a:cubicBezTo>
                  <a:lnTo>
                    <a:pt x="48" y="8544"/>
                  </a:lnTo>
                  <a:cubicBezTo>
                    <a:pt x="22" y="8544"/>
                    <a:pt x="0" y="8523"/>
                    <a:pt x="0" y="8496"/>
                  </a:cubicBezTo>
                  <a:lnTo>
                    <a:pt x="0" y="48"/>
                  </a:lnTo>
                  <a:close/>
                  <a:moveTo>
                    <a:pt x="96" y="8496"/>
                  </a:moveTo>
                  <a:lnTo>
                    <a:pt x="48" y="8448"/>
                  </a:lnTo>
                  <a:lnTo>
                    <a:pt x="1584" y="8448"/>
                  </a:lnTo>
                  <a:lnTo>
                    <a:pt x="1536" y="8496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849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Rectangle 49"/>
            <p:cNvSpPr>
              <a:spLocks noChangeArrowheads="1"/>
            </p:cNvSpPr>
            <p:nvPr/>
          </p:nvSpPr>
          <p:spPr bwMode="auto">
            <a:xfrm>
              <a:off x="2488455" y="1768627"/>
              <a:ext cx="210692" cy="1602664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Freeform 50"/>
            <p:cNvSpPr>
              <a:spLocks noEditPoints="1"/>
            </p:cNvSpPr>
            <p:nvPr/>
          </p:nvSpPr>
          <p:spPr bwMode="auto">
            <a:xfrm>
              <a:off x="2480351" y="1758996"/>
              <a:ext cx="225279" cy="1620000"/>
            </a:xfrm>
            <a:custGeom>
              <a:avLst/>
              <a:gdLst>
                <a:gd name="T0" fmla="*/ 0 w 1632"/>
                <a:gd name="T1" fmla="*/ 48 h 8544"/>
                <a:gd name="T2" fmla="*/ 48 w 1632"/>
                <a:gd name="T3" fmla="*/ 0 h 8544"/>
                <a:gd name="T4" fmla="*/ 1584 w 1632"/>
                <a:gd name="T5" fmla="*/ 0 h 8544"/>
                <a:gd name="T6" fmla="*/ 1632 w 1632"/>
                <a:gd name="T7" fmla="*/ 48 h 8544"/>
                <a:gd name="T8" fmla="*/ 1632 w 1632"/>
                <a:gd name="T9" fmla="*/ 8496 h 8544"/>
                <a:gd name="T10" fmla="*/ 1584 w 1632"/>
                <a:gd name="T11" fmla="*/ 8544 h 8544"/>
                <a:gd name="T12" fmla="*/ 48 w 1632"/>
                <a:gd name="T13" fmla="*/ 8544 h 8544"/>
                <a:gd name="T14" fmla="*/ 0 w 1632"/>
                <a:gd name="T15" fmla="*/ 8496 h 8544"/>
                <a:gd name="T16" fmla="*/ 0 w 1632"/>
                <a:gd name="T17" fmla="*/ 48 h 8544"/>
                <a:gd name="T18" fmla="*/ 96 w 1632"/>
                <a:gd name="T19" fmla="*/ 8496 h 8544"/>
                <a:gd name="T20" fmla="*/ 48 w 1632"/>
                <a:gd name="T21" fmla="*/ 8448 h 8544"/>
                <a:gd name="T22" fmla="*/ 1584 w 1632"/>
                <a:gd name="T23" fmla="*/ 8448 h 8544"/>
                <a:gd name="T24" fmla="*/ 1536 w 1632"/>
                <a:gd name="T25" fmla="*/ 8496 h 8544"/>
                <a:gd name="T26" fmla="*/ 1536 w 1632"/>
                <a:gd name="T27" fmla="*/ 48 h 8544"/>
                <a:gd name="T28" fmla="*/ 1584 w 1632"/>
                <a:gd name="T29" fmla="*/ 96 h 8544"/>
                <a:gd name="T30" fmla="*/ 48 w 1632"/>
                <a:gd name="T31" fmla="*/ 96 h 8544"/>
                <a:gd name="T32" fmla="*/ 96 w 1632"/>
                <a:gd name="T33" fmla="*/ 48 h 8544"/>
                <a:gd name="T34" fmla="*/ 96 w 1632"/>
                <a:gd name="T35" fmla="*/ 8496 h 85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854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8496"/>
                  </a:lnTo>
                  <a:cubicBezTo>
                    <a:pt x="1632" y="8523"/>
                    <a:pt x="1611" y="8544"/>
                    <a:pt x="1584" y="8544"/>
                  </a:cubicBezTo>
                  <a:lnTo>
                    <a:pt x="48" y="8544"/>
                  </a:lnTo>
                  <a:cubicBezTo>
                    <a:pt x="22" y="8544"/>
                    <a:pt x="0" y="8523"/>
                    <a:pt x="0" y="8496"/>
                  </a:cubicBezTo>
                  <a:lnTo>
                    <a:pt x="0" y="48"/>
                  </a:lnTo>
                  <a:close/>
                  <a:moveTo>
                    <a:pt x="96" y="8496"/>
                  </a:moveTo>
                  <a:lnTo>
                    <a:pt x="48" y="8448"/>
                  </a:lnTo>
                  <a:lnTo>
                    <a:pt x="1584" y="8448"/>
                  </a:lnTo>
                  <a:lnTo>
                    <a:pt x="1536" y="8496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849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Rectangle 51"/>
            <p:cNvSpPr>
              <a:spLocks noChangeArrowheads="1"/>
            </p:cNvSpPr>
            <p:nvPr/>
          </p:nvSpPr>
          <p:spPr bwMode="auto">
            <a:xfrm>
              <a:off x="3431708" y="1768627"/>
              <a:ext cx="209072" cy="1602664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Freeform 52"/>
            <p:cNvSpPr>
              <a:spLocks noEditPoints="1"/>
            </p:cNvSpPr>
            <p:nvPr/>
          </p:nvSpPr>
          <p:spPr bwMode="auto">
            <a:xfrm>
              <a:off x="3425225" y="1758996"/>
              <a:ext cx="222038" cy="1620000"/>
            </a:xfrm>
            <a:custGeom>
              <a:avLst/>
              <a:gdLst>
                <a:gd name="T0" fmla="*/ 0 w 1616"/>
                <a:gd name="T1" fmla="*/ 48 h 8544"/>
                <a:gd name="T2" fmla="*/ 48 w 1616"/>
                <a:gd name="T3" fmla="*/ 0 h 8544"/>
                <a:gd name="T4" fmla="*/ 1568 w 1616"/>
                <a:gd name="T5" fmla="*/ 0 h 8544"/>
                <a:gd name="T6" fmla="*/ 1616 w 1616"/>
                <a:gd name="T7" fmla="*/ 48 h 8544"/>
                <a:gd name="T8" fmla="*/ 1616 w 1616"/>
                <a:gd name="T9" fmla="*/ 8496 h 8544"/>
                <a:gd name="T10" fmla="*/ 1568 w 1616"/>
                <a:gd name="T11" fmla="*/ 8544 h 8544"/>
                <a:gd name="T12" fmla="*/ 48 w 1616"/>
                <a:gd name="T13" fmla="*/ 8544 h 8544"/>
                <a:gd name="T14" fmla="*/ 0 w 1616"/>
                <a:gd name="T15" fmla="*/ 8496 h 8544"/>
                <a:gd name="T16" fmla="*/ 0 w 1616"/>
                <a:gd name="T17" fmla="*/ 48 h 8544"/>
                <a:gd name="T18" fmla="*/ 96 w 1616"/>
                <a:gd name="T19" fmla="*/ 8496 h 8544"/>
                <a:gd name="T20" fmla="*/ 48 w 1616"/>
                <a:gd name="T21" fmla="*/ 8448 h 8544"/>
                <a:gd name="T22" fmla="*/ 1568 w 1616"/>
                <a:gd name="T23" fmla="*/ 8448 h 8544"/>
                <a:gd name="T24" fmla="*/ 1520 w 1616"/>
                <a:gd name="T25" fmla="*/ 8496 h 8544"/>
                <a:gd name="T26" fmla="*/ 1520 w 1616"/>
                <a:gd name="T27" fmla="*/ 48 h 8544"/>
                <a:gd name="T28" fmla="*/ 1568 w 1616"/>
                <a:gd name="T29" fmla="*/ 96 h 8544"/>
                <a:gd name="T30" fmla="*/ 48 w 1616"/>
                <a:gd name="T31" fmla="*/ 96 h 8544"/>
                <a:gd name="T32" fmla="*/ 96 w 1616"/>
                <a:gd name="T33" fmla="*/ 48 h 8544"/>
                <a:gd name="T34" fmla="*/ 96 w 1616"/>
                <a:gd name="T35" fmla="*/ 8496 h 85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16" h="854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68" y="0"/>
                  </a:lnTo>
                  <a:cubicBezTo>
                    <a:pt x="1595" y="0"/>
                    <a:pt x="1616" y="22"/>
                    <a:pt x="1616" y="48"/>
                  </a:cubicBezTo>
                  <a:lnTo>
                    <a:pt x="1616" y="8496"/>
                  </a:lnTo>
                  <a:cubicBezTo>
                    <a:pt x="1616" y="8523"/>
                    <a:pt x="1595" y="8544"/>
                    <a:pt x="1568" y="8544"/>
                  </a:cubicBezTo>
                  <a:lnTo>
                    <a:pt x="48" y="8544"/>
                  </a:lnTo>
                  <a:cubicBezTo>
                    <a:pt x="22" y="8544"/>
                    <a:pt x="0" y="8523"/>
                    <a:pt x="0" y="8496"/>
                  </a:cubicBezTo>
                  <a:lnTo>
                    <a:pt x="0" y="48"/>
                  </a:lnTo>
                  <a:close/>
                  <a:moveTo>
                    <a:pt x="96" y="8496"/>
                  </a:moveTo>
                  <a:lnTo>
                    <a:pt x="48" y="8448"/>
                  </a:lnTo>
                  <a:lnTo>
                    <a:pt x="1568" y="8448"/>
                  </a:lnTo>
                  <a:lnTo>
                    <a:pt x="1520" y="8496"/>
                  </a:lnTo>
                  <a:lnTo>
                    <a:pt x="1520" y="48"/>
                  </a:lnTo>
                  <a:lnTo>
                    <a:pt x="156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849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Rectangle 53"/>
            <p:cNvSpPr>
              <a:spLocks noChangeArrowheads="1"/>
            </p:cNvSpPr>
            <p:nvPr/>
          </p:nvSpPr>
          <p:spPr bwMode="auto">
            <a:xfrm>
              <a:off x="1812619" y="2090316"/>
              <a:ext cx="212313" cy="1280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Freeform 54"/>
            <p:cNvSpPr>
              <a:spLocks noEditPoints="1"/>
            </p:cNvSpPr>
            <p:nvPr/>
          </p:nvSpPr>
          <p:spPr bwMode="auto">
            <a:xfrm>
              <a:off x="1806136" y="2080684"/>
              <a:ext cx="225279" cy="1298312"/>
            </a:xfrm>
            <a:custGeom>
              <a:avLst/>
              <a:gdLst>
                <a:gd name="T0" fmla="*/ 0 w 1632"/>
                <a:gd name="T1" fmla="*/ 48 h 6848"/>
                <a:gd name="T2" fmla="*/ 48 w 1632"/>
                <a:gd name="T3" fmla="*/ 0 h 6848"/>
                <a:gd name="T4" fmla="*/ 1584 w 1632"/>
                <a:gd name="T5" fmla="*/ 0 h 6848"/>
                <a:gd name="T6" fmla="*/ 1632 w 1632"/>
                <a:gd name="T7" fmla="*/ 48 h 6848"/>
                <a:gd name="T8" fmla="*/ 1632 w 1632"/>
                <a:gd name="T9" fmla="*/ 6800 h 6848"/>
                <a:gd name="T10" fmla="*/ 1584 w 1632"/>
                <a:gd name="T11" fmla="*/ 6848 h 6848"/>
                <a:gd name="T12" fmla="*/ 48 w 1632"/>
                <a:gd name="T13" fmla="*/ 6848 h 6848"/>
                <a:gd name="T14" fmla="*/ 0 w 1632"/>
                <a:gd name="T15" fmla="*/ 6800 h 6848"/>
                <a:gd name="T16" fmla="*/ 0 w 1632"/>
                <a:gd name="T17" fmla="*/ 48 h 6848"/>
                <a:gd name="T18" fmla="*/ 96 w 1632"/>
                <a:gd name="T19" fmla="*/ 6800 h 6848"/>
                <a:gd name="T20" fmla="*/ 48 w 1632"/>
                <a:gd name="T21" fmla="*/ 6752 h 6848"/>
                <a:gd name="T22" fmla="*/ 1584 w 1632"/>
                <a:gd name="T23" fmla="*/ 6752 h 6848"/>
                <a:gd name="T24" fmla="*/ 1536 w 1632"/>
                <a:gd name="T25" fmla="*/ 6800 h 6848"/>
                <a:gd name="T26" fmla="*/ 1536 w 1632"/>
                <a:gd name="T27" fmla="*/ 48 h 6848"/>
                <a:gd name="T28" fmla="*/ 1584 w 1632"/>
                <a:gd name="T29" fmla="*/ 96 h 6848"/>
                <a:gd name="T30" fmla="*/ 48 w 1632"/>
                <a:gd name="T31" fmla="*/ 96 h 6848"/>
                <a:gd name="T32" fmla="*/ 96 w 1632"/>
                <a:gd name="T33" fmla="*/ 48 h 6848"/>
                <a:gd name="T34" fmla="*/ 96 w 1632"/>
                <a:gd name="T35" fmla="*/ 6800 h 68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6848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6800"/>
                  </a:lnTo>
                  <a:cubicBezTo>
                    <a:pt x="1632" y="6827"/>
                    <a:pt x="1611" y="6848"/>
                    <a:pt x="1584" y="6848"/>
                  </a:cubicBezTo>
                  <a:lnTo>
                    <a:pt x="48" y="6848"/>
                  </a:lnTo>
                  <a:cubicBezTo>
                    <a:pt x="22" y="6848"/>
                    <a:pt x="0" y="6827"/>
                    <a:pt x="0" y="6800"/>
                  </a:cubicBezTo>
                  <a:lnTo>
                    <a:pt x="0" y="48"/>
                  </a:lnTo>
                  <a:close/>
                  <a:moveTo>
                    <a:pt x="96" y="6800"/>
                  </a:moveTo>
                  <a:lnTo>
                    <a:pt x="48" y="6752"/>
                  </a:lnTo>
                  <a:lnTo>
                    <a:pt x="1584" y="6752"/>
                  </a:lnTo>
                  <a:lnTo>
                    <a:pt x="1536" y="6800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680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Rectangle 55"/>
            <p:cNvSpPr>
              <a:spLocks noChangeArrowheads="1"/>
            </p:cNvSpPr>
            <p:nvPr/>
          </p:nvSpPr>
          <p:spPr bwMode="auto">
            <a:xfrm>
              <a:off x="2755871" y="2718283"/>
              <a:ext cx="212313" cy="65300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Freeform 56"/>
            <p:cNvSpPr>
              <a:spLocks noEditPoints="1"/>
            </p:cNvSpPr>
            <p:nvPr/>
          </p:nvSpPr>
          <p:spPr bwMode="auto">
            <a:xfrm>
              <a:off x="2749389" y="2708651"/>
              <a:ext cx="225279" cy="670345"/>
            </a:xfrm>
            <a:custGeom>
              <a:avLst/>
              <a:gdLst>
                <a:gd name="T0" fmla="*/ 0 w 1632"/>
                <a:gd name="T1" fmla="*/ 48 h 3536"/>
                <a:gd name="T2" fmla="*/ 48 w 1632"/>
                <a:gd name="T3" fmla="*/ 0 h 3536"/>
                <a:gd name="T4" fmla="*/ 1584 w 1632"/>
                <a:gd name="T5" fmla="*/ 0 h 3536"/>
                <a:gd name="T6" fmla="*/ 1632 w 1632"/>
                <a:gd name="T7" fmla="*/ 48 h 3536"/>
                <a:gd name="T8" fmla="*/ 1632 w 1632"/>
                <a:gd name="T9" fmla="*/ 3488 h 3536"/>
                <a:gd name="T10" fmla="*/ 1584 w 1632"/>
                <a:gd name="T11" fmla="*/ 3536 h 3536"/>
                <a:gd name="T12" fmla="*/ 48 w 1632"/>
                <a:gd name="T13" fmla="*/ 3536 h 3536"/>
                <a:gd name="T14" fmla="*/ 0 w 1632"/>
                <a:gd name="T15" fmla="*/ 3488 h 3536"/>
                <a:gd name="T16" fmla="*/ 0 w 1632"/>
                <a:gd name="T17" fmla="*/ 48 h 3536"/>
                <a:gd name="T18" fmla="*/ 96 w 1632"/>
                <a:gd name="T19" fmla="*/ 3488 h 3536"/>
                <a:gd name="T20" fmla="*/ 48 w 1632"/>
                <a:gd name="T21" fmla="*/ 3440 h 3536"/>
                <a:gd name="T22" fmla="*/ 1584 w 1632"/>
                <a:gd name="T23" fmla="*/ 3440 h 3536"/>
                <a:gd name="T24" fmla="*/ 1536 w 1632"/>
                <a:gd name="T25" fmla="*/ 3488 h 3536"/>
                <a:gd name="T26" fmla="*/ 1536 w 1632"/>
                <a:gd name="T27" fmla="*/ 48 h 3536"/>
                <a:gd name="T28" fmla="*/ 1584 w 1632"/>
                <a:gd name="T29" fmla="*/ 96 h 3536"/>
                <a:gd name="T30" fmla="*/ 48 w 1632"/>
                <a:gd name="T31" fmla="*/ 96 h 3536"/>
                <a:gd name="T32" fmla="*/ 96 w 1632"/>
                <a:gd name="T33" fmla="*/ 48 h 3536"/>
                <a:gd name="T34" fmla="*/ 96 w 1632"/>
                <a:gd name="T35" fmla="*/ 3488 h 35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3536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3488"/>
                  </a:lnTo>
                  <a:cubicBezTo>
                    <a:pt x="1632" y="3515"/>
                    <a:pt x="1611" y="3536"/>
                    <a:pt x="1584" y="3536"/>
                  </a:cubicBezTo>
                  <a:lnTo>
                    <a:pt x="48" y="3536"/>
                  </a:lnTo>
                  <a:cubicBezTo>
                    <a:pt x="22" y="3536"/>
                    <a:pt x="0" y="3515"/>
                    <a:pt x="0" y="3488"/>
                  </a:cubicBezTo>
                  <a:lnTo>
                    <a:pt x="0" y="48"/>
                  </a:lnTo>
                  <a:close/>
                  <a:moveTo>
                    <a:pt x="96" y="3488"/>
                  </a:moveTo>
                  <a:lnTo>
                    <a:pt x="48" y="3440"/>
                  </a:lnTo>
                  <a:lnTo>
                    <a:pt x="1584" y="3440"/>
                  </a:lnTo>
                  <a:lnTo>
                    <a:pt x="1536" y="3488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348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Rectangle 57"/>
            <p:cNvSpPr>
              <a:spLocks noChangeArrowheads="1"/>
            </p:cNvSpPr>
            <p:nvPr/>
          </p:nvSpPr>
          <p:spPr bwMode="auto">
            <a:xfrm>
              <a:off x="3697504" y="3039971"/>
              <a:ext cx="212313" cy="33132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Freeform 58"/>
            <p:cNvSpPr>
              <a:spLocks noEditPoints="1"/>
            </p:cNvSpPr>
            <p:nvPr/>
          </p:nvSpPr>
          <p:spPr bwMode="auto">
            <a:xfrm>
              <a:off x="3691021" y="3030340"/>
              <a:ext cx="225279" cy="348656"/>
            </a:xfrm>
            <a:custGeom>
              <a:avLst/>
              <a:gdLst>
                <a:gd name="T0" fmla="*/ 0 w 1632"/>
                <a:gd name="T1" fmla="*/ 48 h 1840"/>
                <a:gd name="T2" fmla="*/ 48 w 1632"/>
                <a:gd name="T3" fmla="*/ 0 h 1840"/>
                <a:gd name="T4" fmla="*/ 1584 w 1632"/>
                <a:gd name="T5" fmla="*/ 0 h 1840"/>
                <a:gd name="T6" fmla="*/ 1632 w 1632"/>
                <a:gd name="T7" fmla="*/ 48 h 1840"/>
                <a:gd name="T8" fmla="*/ 1632 w 1632"/>
                <a:gd name="T9" fmla="*/ 1792 h 1840"/>
                <a:gd name="T10" fmla="*/ 1584 w 1632"/>
                <a:gd name="T11" fmla="*/ 1840 h 1840"/>
                <a:gd name="T12" fmla="*/ 48 w 1632"/>
                <a:gd name="T13" fmla="*/ 1840 h 1840"/>
                <a:gd name="T14" fmla="*/ 0 w 1632"/>
                <a:gd name="T15" fmla="*/ 1792 h 1840"/>
                <a:gd name="T16" fmla="*/ 0 w 1632"/>
                <a:gd name="T17" fmla="*/ 48 h 1840"/>
                <a:gd name="T18" fmla="*/ 96 w 1632"/>
                <a:gd name="T19" fmla="*/ 1792 h 1840"/>
                <a:gd name="T20" fmla="*/ 48 w 1632"/>
                <a:gd name="T21" fmla="*/ 1744 h 1840"/>
                <a:gd name="T22" fmla="*/ 1584 w 1632"/>
                <a:gd name="T23" fmla="*/ 1744 h 1840"/>
                <a:gd name="T24" fmla="*/ 1536 w 1632"/>
                <a:gd name="T25" fmla="*/ 1792 h 1840"/>
                <a:gd name="T26" fmla="*/ 1536 w 1632"/>
                <a:gd name="T27" fmla="*/ 48 h 1840"/>
                <a:gd name="T28" fmla="*/ 1584 w 1632"/>
                <a:gd name="T29" fmla="*/ 96 h 1840"/>
                <a:gd name="T30" fmla="*/ 48 w 1632"/>
                <a:gd name="T31" fmla="*/ 96 h 1840"/>
                <a:gd name="T32" fmla="*/ 96 w 1632"/>
                <a:gd name="T33" fmla="*/ 48 h 1840"/>
                <a:gd name="T34" fmla="*/ 96 w 1632"/>
                <a:gd name="T35" fmla="*/ 1792 h 18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1840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1792"/>
                  </a:lnTo>
                  <a:cubicBezTo>
                    <a:pt x="1632" y="1819"/>
                    <a:pt x="1611" y="1840"/>
                    <a:pt x="1584" y="1840"/>
                  </a:cubicBezTo>
                  <a:lnTo>
                    <a:pt x="48" y="1840"/>
                  </a:lnTo>
                  <a:cubicBezTo>
                    <a:pt x="22" y="1840"/>
                    <a:pt x="0" y="1819"/>
                    <a:pt x="0" y="1792"/>
                  </a:cubicBezTo>
                  <a:lnTo>
                    <a:pt x="0" y="48"/>
                  </a:lnTo>
                  <a:close/>
                  <a:moveTo>
                    <a:pt x="96" y="1792"/>
                  </a:moveTo>
                  <a:lnTo>
                    <a:pt x="48" y="1744"/>
                  </a:lnTo>
                  <a:lnTo>
                    <a:pt x="1584" y="1744"/>
                  </a:lnTo>
                  <a:lnTo>
                    <a:pt x="1536" y="1792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7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Freeform 59"/>
            <p:cNvSpPr>
              <a:spLocks noEditPoints="1"/>
            </p:cNvSpPr>
            <p:nvPr/>
          </p:nvSpPr>
          <p:spPr bwMode="auto">
            <a:xfrm>
              <a:off x="1879069" y="1965107"/>
              <a:ext cx="82657" cy="248489"/>
            </a:xfrm>
            <a:custGeom>
              <a:avLst/>
              <a:gdLst>
                <a:gd name="T0" fmla="*/ 29 w 51"/>
                <a:gd name="T1" fmla="*/ 65 h 129"/>
                <a:gd name="T2" fmla="*/ 29 w 51"/>
                <a:gd name="T3" fmla="*/ 125 h 129"/>
                <a:gd name="T4" fmla="*/ 21 w 51"/>
                <a:gd name="T5" fmla="*/ 125 h 129"/>
                <a:gd name="T6" fmla="*/ 21 w 51"/>
                <a:gd name="T7" fmla="*/ 65 h 129"/>
                <a:gd name="T8" fmla="*/ 29 w 51"/>
                <a:gd name="T9" fmla="*/ 65 h 129"/>
                <a:gd name="T10" fmla="*/ 21 w 51"/>
                <a:gd name="T11" fmla="*/ 65 h 129"/>
                <a:gd name="T12" fmla="*/ 21 w 51"/>
                <a:gd name="T13" fmla="*/ 5 h 129"/>
                <a:gd name="T14" fmla="*/ 29 w 51"/>
                <a:gd name="T15" fmla="*/ 5 h 129"/>
                <a:gd name="T16" fmla="*/ 29 w 51"/>
                <a:gd name="T17" fmla="*/ 65 h 129"/>
                <a:gd name="T18" fmla="*/ 21 w 51"/>
                <a:gd name="T19" fmla="*/ 65 h 129"/>
                <a:gd name="T20" fmla="*/ 0 w 51"/>
                <a:gd name="T21" fmla="*/ 120 h 129"/>
                <a:gd name="T22" fmla="*/ 51 w 51"/>
                <a:gd name="T23" fmla="*/ 120 h 129"/>
                <a:gd name="T24" fmla="*/ 51 w 51"/>
                <a:gd name="T25" fmla="*/ 129 h 129"/>
                <a:gd name="T26" fmla="*/ 0 w 51"/>
                <a:gd name="T27" fmla="*/ 129 h 129"/>
                <a:gd name="T28" fmla="*/ 0 w 51"/>
                <a:gd name="T29" fmla="*/ 120 h 129"/>
                <a:gd name="T30" fmla="*/ 0 w 51"/>
                <a:gd name="T31" fmla="*/ 0 h 129"/>
                <a:gd name="T32" fmla="*/ 51 w 51"/>
                <a:gd name="T33" fmla="*/ 0 h 129"/>
                <a:gd name="T34" fmla="*/ 51 w 51"/>
                <a:gd name="T35" fmla="*/ 10 h 129"/>
                <a:gd name="T36" fmla="*/ 0 w 51"/>
                <a:gd name="T37" fmla="*/ 10 h 129"/>
                <a:gd name="T38" fmla="*/ 0 w 51"/>
                <a:gd name="T39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51" h="129">
                  <a:moveTo>
                    <a:pt x="29" y="65"/>
                  </a:moveTo>
                  <a:lnTo>
                    <a:pt x="29" y="125"/>
                  </a:lnTo>
                  <a:lnTo>
                    <a:pt x="21" y="125"/>
                  </a:lnTo>
                  <a:lnTo>
                    <a:pt x="21" y="65"/>
                  </a:lnTo>
                  <a:lnTo>
                    <a:pt x="29" y="65"/>
                  </a:lnTo>
                  <a:close/>
                  <a:moveTo>
                    <a:pt x="21" y="65"/>
                  </a:moveTo>
                  <a:lnTo>
                    <a:pt x="21" y="5"/>
                  </a:lnTo>
                  <a:lnTo>
                    <a:pt x="29" y="5"/>
                  </a:lnTo>
                  <a:lnTo>
                    <a:pt x="29" y="65"/>
                  </a:lnTo>
                  <a:lnTo>
                    <a:pt x="21" y="65"/>
                  </a:lnTo>
                  <a:close/>
                  <a:moveTo>
                    <a:pt x="0" y="120"/>
                  </a:moveTo>
                  <a:lnTo>
                    <a:pt x="51" y="120"/>
                  </a:lnTo>
                  <a:lnTo>
                    <a:pt x="51" y="129"/>
                  </a:lnTo>
                  <a:lnTo>
                    <a:pt x="0" y="129"/>
                  </a:lnTo>
                  <a:lnTo>
                    <a:pt x="0" y="120"/>
                  </a:lnTo>
                  <a:close/>
                  <a:moveTo>
                    <a:pt x="0" y="0"/>
                  </a:moveTo>
                  <a:lnTo>
                    <a:pt x="51" y="0"/>
                  </a:lnTo>
                  <a:lnTo>
                    <a:pt x="51" y="10"/>
                  </a:lnTo>
                  <a:lnTo>
                    <a:pt x="0" y="1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Freeform 60"/>
            <p:cNvSpPr>
              <a:spLocks noEditPoints="1"/>
            </p:cNvSpPr>
            <p:nvPr/>
          </p:nvSpPr>
          <p:spPr bwMode="auto">
            <a:xfrm>
              <a:off x="2820700" y="2648937"/>
              <a:ext cx="81035" cy="138692"/>
            </a:xfrm>
            <a:custGeom>
              <a:avLst/>
              <a:gdLst>
                <a:gd name="T0" fmla="*/ 30 w 50"/>
                <a:gd name="T1" fmla="*/ 36 h 72"/>
                <a:gd name="T2" fmla="*/ 30 w 50"/>
                <a:gd name="T3" fmla="*/ 67 h 72"/>
                <a:gd name="T4" fmla="*/ 22 w 50"/>
                <a:gd name="T5" fmla="*/ 67 h 72"/>
                <a:gd name="T6" fmla="*/ 22 w 50"/>
                <a:gd name="T7" fmla="*/ 36 h 72"/>
                <a:gd name="T8" fmla="*/ 30 w 50"/>
                <a:gd name="T9" fmla="*/ 36 h 72"/>
                <a:gd name="T10" fmla="*/ 22 w 50"/>
                <a:gd name="T11" fmla="*/ 36 h 72"/>
                <a:gd name="T12" fmla="*/ 22 w 50"/>
                <a:gd name="T13" fmla="*/ 4 h 72"/>
                <a:gd name="T14" fmla="*/ 30 w 50"/>
                <a:gd name="T15" fmla="*/ 4 h 72"/>
                <a:gd name="T16" fmla="*/ 30 w 50"/>
                <a:gd name="T17" fmla="*/ 36 h 72"/>
                <a:gd name="T18" fmla="*/ 22 w 50"/>
                <a:gd name="T19" fmla="*/ 36 h 72"/>
                <a:gd name="T20" fmla="*/ 0 w 50"/>
                <a:gd name="T21" fmla="*/ 63 h 72"/>
                <a:gd name="T22" fmla="*/ 50 w 50"/>
                <a:gd name="T23" fmla="*/ 63 h 72"/>
                <a:gd name="T24" fmla="*/ 50 w 50"/>
                <a:gd name="T25" fmla="*/ 72 h 72"/>
                <a:gd name="T26" fmla="*/ 0 w 50"/>
                <a:gd name="T27" fmla="*/ 72 h 72"/>
                <a:gd name="T28" fmla="*/ 0 w 50"/>
                <a:gd name="T29" fmla="*/ 63 h 72"/>
                <a:gd name="T30" fmla="*/ 0 w 50"/>
                <a:gd name="T31" fmla="*/ 0 h 72"/>
                <a:gd name="T32" fmla="*/ 50 w 50"/>
                <a:gd name="T33" fmla="*/ 0 h 72"/>
                <a:gd name="T34" fmla="*/ 50 w 50"/>
                <a:gd name="T35" fmla="*/ 9 h 72"/>
                <a:gd name="T36" fmla="*/ 0 w 50"/>
                <a:gd name="T37" fmla="*/ 9 h 72"/>
                <a:gd name="T38" fmla="*/ 0 w 50"/>
                <a:gd name="T39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50" h="72">
                  <a:moveTo>
                    <a:pt x="30" y="36"/>
                  </a:moveTo>
                  <a:lnTo>
                    <a:pt x="30" y="67"/>
                  </a:lnTo>
                  <a:lnTo>
                    <a:pt x="22" y="67"/>
                  </a:lnTo>
                  <a:lnTo>
                    <a:pt x="22" y="36"/>
                  </a:lnTo>
                  <a:lnTo>
                    <a:pt x="30" y="36"/>
                  </a:lnTo>
                  <a:close/>
                  <a:moveTo>
                    <a:pt x="22" y="36"/>
                  </a:moveTo>
                  <a:lnTo>
                    <a:pt x="22" y="4"/>
                  </a:lnTo>
                  <a:lnTo>
                    <a:pt x="30" y="4"/>
                  </a:lnTo>
                  <a:lnTo>
                    <a:pt x="30" y="36"/>
                  </a:lnTo>
                  <a:lnTo>
                    <a:pt x="22" y="36"/>
                  </a:lnTo>
                  <a:close/>
                  <a:moveTo>
                    <a:pt x="0" y="63"/>
                  </a:moveTo>
                  <a:lnTo>
                    <a:pt x="50" y="63"/>
                  </a:lnTo>
                  <a:lnTo>
                    <a:pt x="50" y="72"/>
                  </a:lnTo>
                  <a:lnTo>
                    <a:pt x="0" y="72"/>
                  </a:lnTo>
                  <a:lnTo>
                    <a:pt x="0" y="63"/>
                  </a:lnTo>
                  <a:close/>
                  <a:moveTo>
                    <a:pt x="0" y="0"/>
                  </a:moveTo>
                  <a:lnTo>
                    <a:pt x="50" y="0"/>
                  </a:lnTo>
                  <a:lnTo>
                    <a:pt x="50" y="9"/>
                  </a:lnTo>
                  <a:lnTo>
                    <a:pt x="0" y="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Freeform 61"/>
            <p:cNvSpPr>
              <a:spLocks noEditPoints="1"/>
            </p:cNvSpPr>
            <p:nvPr/>
          </p:nvSpPr>
          <p:spPr bwMode="auto">
            <a:xfrm>
              <a:off x="3762332" y="2978330"/>
              <a:ext cx="82657" cy="121355"/>
            </a:xfrm>
            <a:custGeom>
              <a:avLst/>
              <a:gdLst>
                <a:gd name="T0" fmla="*/ 30 w 51"/>
                <a:gd name="T1" fmla="*/ 32 h 63"/>
                <a:gd name="T2" fmla="*/ 30 w 51"/>
                <a:gd name="T3" fmla="*/ 59 h 63"/>
                <a:gd name="T4" fmla="*/ 21 w 51"/>
                <a:gd name="T5" fmla="*/ 59 h 63"/>
                <a:gd name="T6" fmla="*/ 21 w 51"/>
                <a:gd name="T7" fmla="*/ 32 h 63"/>
                <a:gd name="T8" fmla="*/ 30 w 51"/>
                <a:gd name="T9" fmla="*/ 32 h 63"/>
                <a:gd name="T10" fmla="*/ 21 w 51"/>
                <a:gd name="T11" fmla="*/ 32 h 63"/>
                <a:gd name="T12" fmla="*/ 21 w 51"/>
                <a:gd name="T13" fmla="*/ 5 h 63"/>
                <a:gd name="T14" fmla="*/ 30 w 51"/>
                <a:gd name="T15" fmla="*/ 5 h 63"/>
                <a:gd name="T16" fmla="*/ 30 w 51"/>
                <a:gd name="T17" fmla="*/ 32 h 63"/>
                <a:gd name="T18" fmla="*/ 21 w 51"/>
                <a:gd name="T19" fmla="*/ 32 h 63"/>
                <a:gd name="T20" fmla="*/ 0 w 51"/>
                <a:gd name="T21" fmla="*/ 54 h 63"/>
                <a:gd name="T22" fmla="*/ 51 w 51"/>
                <a:gd name="T23" fmla="*/ 54 h 63"/>
                <a:gd name="T24" fmla="*/ 51 w 51"/>
                <a:gd name="T25" fmla="*/ 63 h 63"/>
                <a:gd name="T26" fmla="*/ 0 w 51"/>
                <a:gd name="T27" fmla="*/ 63 h 63"/>
                <a:gd name="T28" fmla="*/ 0 w 51"/>
                <a:gd name="T29" fmla="*/ 54 h 63"/>
                <a:gd name="T30" fmla="*/ 0 w 51"/>
                <a:gd name="T31" fmla="*/ 0 h 63"/>
                <a:gd name="T32" fmla="*/ 51 w 51"/>
                <a:gd name="T33" fmla="*/ 0 h 63"/>
                <a:gd name="T34" fmla="*/ 51 w 51"/>
                <a:gd name="T35" fmla="*/ 10 h 63"/>
                <a:gd name="T36" fmla="*/ 0 w 51"/>
                <a:gd name="T37" fmla="*/ 10 h 63"/>
                <a:gd name="T38" fmla="*/ 0 w 51"/>
                <a:gd name="T39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51" h="63">
                  <a:moveTo>
                    <a:pt x="30" y="32"/>
                  </a:moveTo>
                  <a:lnTo>
                    <a:pt x="30" y="59"/>
                  </a:lnTo>
                  <a:lnTo>
                    <a:pt x="21" y="59"/>
                  </a:lnTo>
                  <a:lnTo>
                    <a:pt x="21" y="32"/>
                  </a:lnTo>
                  <a:lnTo>
                    <a:pt x="30" y="32"/>
                  </a:lnTo>
                  <a:close/>
                  <a:moveTo>
                    <a:pt x="21" y="32"/>
                  </a:moveTo>
                  <a:lnTo>
                    <a:pt x="21" y="5"/>
                  </a:lnTo>
                  <a:lnTo>
                    <a:pt x="30" y="5"/>
                  </a:lnTo>
                  <a:lnTo>
                    <a:pt x="30" y="32"/>
                  </a:lnTo>
                  <a:lnTo>
                    <a:pt x="21" y="32"/>
                  </a:lnTo>
                  <a:close/>
                  <a:moveTo>
                    <a:pt x="0" y="54"/>
                  </a:moveTo>
                  <a:lnTo>
                    <a:pt x="51" y="54"/>
                  </a:lnTo>
                  <a:lnTo>
                    <a:pt x="51" y="63"/>
                  </a:lnTo>
                  <a:lnTo>
                    <a:pt x="0" y="63"/>
                  </a:lnTo>
                  <a:lnTo>
                    <a:pt x="0" y="54"/>
                  </a:lnTo>
                  <a:close/>
                  <a:moveTo>
                    <a:pt x="0" y="0"/>
                  </a:moveTo>
                  <a:lnTo>
                    <a:pt x="51" y="0"/>
                  </a:lnTo>
                  <a:lnTo>
                    <a:pt x="51" y="10"/>
                  </a:lnTo>
                  <a:lnTo>
                    <a:pt x="0" y="1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Rectangle 62"/>
            <p:cNvSpPr>
              <a:spLocks noChangeArrowheads="1"/>
            </p:cNvSpPr>
            <p:nvPr/>
          </p:nvSpPr>
          <p:spPr bwMode="auto">
            <a:xfrm>
              <a:off x="1308579" y="1768627"/>
              <a:ext cx="12966" cy="1602664"/>
            </a:xfrm>
            <a:prstGeom prst="rect">
              <a:avLst/>
            </a:pr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Freeform 63"/>
            <p:cNvSpPr>
              <a:spLocks noEditPoints="1"/>
            </p:cNvSpPr>
            <p:nvPr/>
          </p:nvSpPr>
          <p:spPr bwMode="auto">
            <a:xfrm>
              <a:off x="1261578" y="1758996"/>
              <a:ext cx="53484" cy="1620000"/>
            </a:xfrm>
            <a:custGeom>
              <a:avLst/>
              <a:gdLst>
                <a:gd name="T0" fmla="*/ 0 w 33"/>
                <a:gd name="T1" fmla="*/ 832 h 841"/>
                <a:gd name="T2" fmla="*/ 33 w 33"/>
                <a:gd name="T3" fmla="*/ 832 h 841"/>
                <a:gd name="T4" fmla="*/ 33 w 33"/>
                <a:gd name="T5" fmla="*/ 841 h 841"/>
                <a:gd name="T6" fmla="*/ 0 w 33"/>
                <a:gd name="T7" fmla="*/ 841 h 841"/>
                <a:gd name="T8" fmla="*/ 0 w 33"/>
                <a:gd name="T9" fmla="*/ 832 h 841"/>
                <a:gd name="T10" fmla="*/ 0 w 33"/>
                <a:gd name="T11" fmla="*/ 666 h 841"/>
                <a:gd name="T12" fmla="*/ 33 w 33"/>
                <a:gd name="T13" fmla="*/ 666 h 841"/>
                <a:gd name="T14" fmla="*/ 33 w 33"/>
                <a:gd name="T15" fmla="*/ 676 h 841"/>
                <a:gd name="T16" fmla="*/ 0 w 33"/>
                <a:gd name="T17" fmla="*/ 676 h 841"/>
                <a:gd name="T18" fmla="*/ 0 w 33"/>
                <a:gd name="T19" fmla="*/ 666 h 841"/>
                <a:gd name="T20" fmla="*/ 0 w 33"/>
                <a:gd name="T21" fmla="*/ 499 h 841"/>
                <a:gd name="T22" fmla="*/ 33 w 33"/>
                <a:gd name="T23" fmla="*/ 499 h 841"/>
                <a:gd name="T24" fmla="*/ 33 w 33"/>
                <a:gd name="T25" fmla="*/ 509 h 841"/>
                <a:gd name="T26" fmla="*/ 0 w 33"/>
                <a:gd name="T27" fmla="*/ 509 h 841"/>
                <a:gd name="T28" fmla="*/ 0 w 33"/>
                <a:gd name="T29" fmla="*/ 499 h 841"/>
                <a:gd name="T30" fmla="*/ 0 w 33"/>
                <a:gd name="T31" fmla="*/ 334 h 841"/>
                <a:gd name="T32" fmla="*/ 33 w 33"/>
                <a:gd name="T33" fmla="*/ 334 h 841"/>
                <a:gd name="T34" fmla="*/ 33 w 33"/>
                <a:gd name="T35" fmla="*/ 343 h 841"/>
                <a:gd name="T36" fmla="*/ 0 w 33"/>
                <a:gd name="T37" fmla="*/ 343 h 841"/>
                <a:gd name="T38" fmla="*/ 0 w 33"/>
                <a:gd name="T39" fmla="*/ 334 h 841"/>
                <a:gd name="T40" fmla="*/ 0 w 33"/>
                <a:gd name="T41" fmla="*/ 167 h 841"/>
                <a:gd name="T42" fmla="*/ 33 w 33"/>
                <a:gd name="T43" fmla="*/ 167 h 841"/>
                <a:gd name="T44" fmla="*/ 33 w 33"/>
                <a:gd name="T45" fmla="*/ 176 h 841"/>
                <a:gd name="T46" fmla="*/ 0 w 33"/>
                <a:gd name="T47" fmla="*/ 176 h 841"/>
                <a:gd name="T48" fmla="*/ 0 w 33"/>
                <a:gd name="T49" fmla="*/ 167 h 841"/>
                <a:gd name="T50" fmla="*/ 0 w 33"/>
                <a:gd name="T51" fmla="*/ 0 h 841"/>
                <a:gd name="T52" fmla="*/ 33 w 33"/>
                <a:gd name="T53" fmla="*/ 0 h 841"/>
                <a:gd name="T54" fmla="*/ 33 w 33"/>
                <a:gd name="T55" fmla="*/ 9 h 841"/>
                <a:gd name="T56" fmla="*/ 0 w 33"/>
                <a:gd name="T57" fmla="*/ 9 h 841"/>
                <a:gd name="T58" fmla="*/ 0 w 33"/>
                <a:gd name="T59" fmla="*/ 0 h 8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33" h="841">
                  <a:moveTo>
                    <a:pt x="0" y="832"/>
                  </a:moveTo>
                  <a:lnTo>
                    <a:pt x="33" y="832"/>
                  </a:lnTo>
                  <a:lnTo>
                    <a:pt x="33" y="841"/>
                  </a:lnTo>
                  <a:lnTo>
                    <a:pt x="0" y="841"/>
                  </a:lnTo>
                  <a:lnTo>
                    <a:pt x="0" y="832"/>
                  </a:lnTo>
                  <a:close/>
                  <a:moveTo>
                    <a:pt x="0" y="666"/>
                  </a:moveTo>
                  <a:lnTo>
                    <a:pt x="33" y="666"/>
                  </a:lnTo>
                  <a:lnTo>
                    <a:pt x="33" y="676"/>
                  </a:lnTo>
                  <a:lnTo>
                    <a:pt x="0" y="676"/>
                  </a:lnTo>
                  <a:lnTo>
                    <a:pt x="0" y="666"/>
                  </a:lnTo>
                  <a:close/>
                  <a:moveTo>
                    <a:pt x="0" y="499"/>
                  </a:moveTo>
                  <a:lnTo>
                    <a:pt x="33" y="499"/>
                  </a:lnTo>
                  <a:lnTo>
                    <a:pt x="33" y="509"/>
                  </a:lnTo>
                  <a:lnTo>
                    <a:pt x="0" y="509"/>
                  </a:lnTo>
                  <a:lnTo>
                    <a:pt x="0" y="499"/>
                  </a:lnTo>
                  <a:close/>
                  <a:moveTo>
                    <a:pt x="0" y="334"/>
                  </a:moveTo>
                  <a:lnTo>
                    <a:pt x="33" y="334"/>
                  </a:lnTo>
                  <a:lnTo>
                    <a:pt x="33" y="343"/>
                  </a:lnTo>
                  <a:lnTo>
                    <a:pt x="0" y="343"/>
                  </a:lnTo>
                  <a:lnTo>
                    <a:pt x="0" y="334"/>
                  </a:lnTo>
                  <a:close/>
                  <a:moveTo>
                    <a:pt x="0" y="167"/>
                  </a:moveTo>
                  <a:lnTo>
                    <a:pt x="33" y="167"/>
                  </a:lnTo>
                  <a:lnTo>
                    <a:pt x="33" y="176"/>
                  </a:lnTo>
                  <a:lnTo>
                    <a:pt x="0" y="176"/>
                  </a:lnTo>
                  <a:lnTo>
                    <a:pt x="0" y="167"/>
                  </a:lnTo>
                  <a:close/>
                  <a:moveTo>
                    <a:pt x="0" y="0"/>
                  </a:moveTo>
                  <a:lnTo>
                    <a:pt x="33" y="0"/>
                  </a:lnTo>
                  <a:lnTo>
                    <a:pt x="33" y="9"/>
                  </a:lnTo>
                  <a:lnTo>
                    <a:pt x="0" y="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Rectangle 64"/>
            <p:cNvSpPr>
              <a:spLocks noChangeArrowheads="1"/>
            </p:cNvSpPr>
            <p:nvPr/>
          </p:nvSpPr>
          <p:spPr bwMode="auto">
            <a:xfrm>
              <a:off x="1315062" y="3361660"/>
              <a:ext cx="2826516" cy="17336"/>
            </a:xfrm>
            <a:prstGeom prst="rect">
              <a:avLst/>
            </a:prstGeom>
            <a:solidFill>
              <a:srgbClr val="D9D9D9"/>
            </a:solidFill>
            <a:ln w="1588" cap="flat">
              <a:solidFill>
                <a:srgbClr val="D9D9D9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43" name="グループ化 175"/>
          <p:cNvGrpSpPr/>
          <p:nvPr/>
        </p:nvGrpSpPr>
        <p:grpSpPr>
          <a:xfrm>
            <a:off x="887293" y="1047375"/>
            <a:ext cx="256480" cy="1787444"/>
            <a:chOff x="993100" y="1479175"/>
            <a:chExt cx="256479" cy="1787444"/>
          </a:xfrm>
        </p:grpSpPr>
        <p:sp>
          <p:nvSpPr>
            <p:cNvPr id="44" name="Rectangle 65"/>
            <p:cNvSpPr>
              <a:spLocks noChangeArrowheads="1"/>
            </p:cNvSpPr>
            <p:nvPr/>
          </p:nvSpPr>
          <p:spPr bwMode="auto">
            <a:xfrm>
              <a:off x="1142180" y="3051175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</a:t>
              </a:r>
            </a:p>
          </p:txBody>
        </p:sp>
        <p:sp>
          <p:nvSpPr>
            <p:cNvPr id="45" name="Rectangle 66"/>
            <p:cNvSpPr>
              <a:spLocks noChangeArrowheads="1"/>
            </p:cNvSpPr>
            <p:nvPr/>
          </p:nvSpPr>
          <p:spPr bwMode="auto">
            <a:xfrm>
              <a:off x="993100" y="272895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6" name="Rectangle 67"/>
            <p:cNvSpPr>
              <a:spLocks noChangeArrowheads="1"/>
            </p:cNvSpPr>
            <p:nvPr/>
          </p:nvSpPr>
          <p:spPr bwMode="auto">
            <a:xfrm>
              <a:off x="993100" y="241201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4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7" name="Rectangle 68"/>
            <p:cNvSpPr>
              <a:spLocks noChangeArrowheads="1"/>
            </p:cNvSpPr>
            <p:nvPr/>
          </p:nvSpPr>
          <p:spPr bwMode="auto">
            <a:xfrm>
              <a:off x="993100" y="2109880"/>
              <a:ext cx="2564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6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8" name="Rectangle 69"/>
            <p:cNvSpPr>
              <a:spLocks noChangeArrowheads="1"/>
            </p:cNvSpPr>
            <p:nvPr/>
          </p:nvSpPr>
          <p:spPr bwMode="auto">
            <a:xfrm>
              <a:off x="993100" y="1786067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.8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9" name="Rectangle 70"/>
            <p:cNvSpPr>
              <a:spLocks noChangeArrowheads="1"/>
            </p:cNvSpPr>
            <p:nvPr/>
          </p:nvSpPr>
          <p:spPr bwMode="auto">
            <a:xfrm>
              <a:off x="1142180" y="1479175"/>
              <a:ext cx="998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50" name="グループ化 176"/>
          <p:cNvGrpSpPr/>
          <p:nvPr/>
        </p:nvGrpSpPr>
        <p:grpSpPr>
          <a:xfrm>
            <a:off x="1628778" y="2744504"/>
            <a:ext cx="2118027" cy="215444"/>
            <a:chOff x="1734584" y="3277904"/>
            <a:chExt cx="2118027" cy="215444"/>
          </a:xfrm>
        </p:grpSpPr>
        <p:sp>
          <p:nvSpPr>
            <p:cNvPr id="51" name="Rectangle 71"/>
            <p:cNvSpPr>
              <a:spLocks noChangeArrowheads="1"/>
            </p:cNvSpPr>
            <p:nvPr/>
          </p:nvSpPr>
          <p:spPr bwMode="auto">
            <a:xfrm>
              <a:off x="1734584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24</a:t>
              </a:r>
            </a:p>
          </p:txBody>
        </p:sp>
        <p:sp>
          <p:nvSpPr>
            <p:cNvPr id="52" name="Rectangle 72"/>
            <p:cNvSpPr>
              <a:spLocks noChangeArrowheads="1"/>
            </p:cNvSpPr>
            <p:nvPr/>
          </p:nvSpPr>
          <p:spPr bwMode="auto">
            <a:xfrm>
              <a:off x="2676584" y="3277904"/>
              <a:ext cx="23083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48</a:t>
              </a:r>
            </a:p>
          </p:txBody>
        </p:sp>
        <p:sp>
          <p:nvSpPr>
            <p:cNvPr id="53" name="Rectangle 73"/>
            <p:cNvSpPr>
              <a:spLocks noChangeArrowheads="1"/>
            </p:cNvSpPr>
            <p:nvPr/>
          </p:nvSpPr>
          <p:spPr bwMode="auto">
            <a:xfrm>
              <a:off x="3621779" y="3277904"/>
              <a:ext cx="23083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72</a:t>
              </a:r>
            </a:p>
          </p:txBody>
        </p:sp>
      </p:grpSp>
      <p:grpSp>
        <p:nvGrpSpPr>
          <p:cNvPr id="54" name="グループ化 190"/>
          <p:cNvGrpSpPr/>
          <p:nvPr/>
        </p:nvGrpSpPr>
        <p:grpSpPr>
          <a:xfrm>
            <a:off x="3875298" y="855150"/>
            <a:ext cx="805020" cy="428839"/>
            <a:chOff x="4232990" y="1375247"/>
            <a:chExt cx="805019" cy="613216"/>
          </a:xfrm>
        </p:grpSpPr>
        <p:sp>
          <p:nvSpPr>
            <p:cNvPr id="55" name="Rectangle 79"/>
            <p:cNvSpPr>
              <a:spLocks noChangeArrowheads="1"/>
            </p:cNvSpPr>
            <p:nvPr/>
          </p:nvSpPr>
          <p:spPr bwMode="auto">
            <a:xfrm>
              <a:off x="4512225" y="1375247"/>
              <a:ext cx="525784" cy="3080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vehicle</a:t>
              </a:r>
            </a:p>
          </p:txBody>
        </p:sp>
        <p:grpSp>
          <p:nvGrpSpPr>
            <p:cNvPr id="56" name="グループ化 131"/>
            <p:cNvGrpSpPr/>
            <p:nvPr/>
          </p:nvGrpSpPr>
          <p:grpSpPr>
            <a:xfrm>
              <a:off x="4232990" y="1512485"/>
              <a:ext cx="160283" cy="423564"/>
              <a:chOff x="4685714" y="1679575"/>
              <a:chExt cx="103188" cy="354101"/>
            </a:xfrm>
          </p:grpSpPr>
          <p:sp>
            <p:nvSpPr>
              <p:cNvPr id="58" name="Rectangle 77"/>
              <p:cNvSpPr>
                <a:spLocks noChangeArrowheads="1"/>
              </p:cNvSpPr>
              <p:nvPr/>
            </p:nvSpPr>
            <p:spPr bwMode="auto">
              <a:xfrm>
                <a:off x="4692064" y="1685925"/>
                <a:ext cx="90488" cy="10318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9" name="Freeform 78"/>
              <p:cNvSpPr>
                <a:spLocks noEditPoints="1"/>
              </p:cNvSpPr>
              <p:nvPr/>
            </p:nvSpPr>
            <p:spPr bwMode="auto">
              <a:xfrm>
                <a:off x="4685714" y="1679575"/>
                <a:ext cx="103188" cy="117475"/>
              </a:xfrm>
              <a:custGeom>
                <a:avLst/>
                <a:gdLst>
                  <a:gd name="T0" fmla="*/ 0 w 768"/>
                  <a:gd name="T1" fmla="*/ 48 h 752"/>
                  <a:gd name="T2" fmla="*/ 48 w 768"/>
                  <a:gd name="T3" fmla="*/ 0 h 752"/>
                  <a:gd name="T4" fmla="*/ 720 w 768"/>
                  <a:gd name="T5" fmla="*/ 0 h 752"/>
                  <a:gd name="T6" fmla="*/ 768 w 768"/>
                  <a:gd name="T7" fmla="*/ 48 h 752"/>
                  <a:gd name="T8" fmla="*/ 768 w 768"/>
                  <a:gd name="T9" fmla="*/ 704 h 752"/>
                  <a:gd name="T10" fmla="*/ 720 w 768"/>
                  <a:gd name="T11" fmla="*/ 752 h 752"/>
                  <a:gd name="T12" fmla="*/ 48 w 768"/>
                  <a:gd name="T13" fmla="*/ 752 h 752"/>
                  <a:gd name="T14" fmla="*/ 0 w 768"/>
                  <a:gd name="T15" fmla="*/ 704 h 752"/>
                  <a:gd name="T16" fmla="*/ 0 w 768"/>
                  <a:gd name="T17" fmla="*/ 48 h 752"/>
                  <a:gd name="T18" fmla="*/ 96 w 768"/>
                  <a:gd name="T19" fmla="*/ 704 h 752"/>
                  <a:gd name="T20" fmla="*/ 48 w 768"/>
                  <a:gd name="T21" fmla="*/ 656 h 752"/>
                  <a:gd name="T22" fmla="*/ 720 w 768"/>
                  <a:gd name="T23" fmla="*/ 656 h 752"/>
                  <a:gd name="T24" fmla="*/ 672 w 768"/>
                  <a:gd name="T25" fmla="*/ 704 h 752"/>
                  <a:gd name="T26" fmla="*/ 672 w 768"/>
                  <a:gd name="T27" fmla="*/ 48 h 752"/>
                  <a:gd name="T28" fmla="*/ 720 w 768"/>
                  <a:gd name="T29" fmla="*/ 96 h 752"/>
                  <a:gd name="T30" fmla="*/ 48 w 768"/>
                  <a:gd name="T31" fmla="*/ 96 h 752"/>
                  <a:gd name="T32" fmla="*/ 96 w 768"/>
                  <a:gd name="T33" fmla="*/ 48 h 752"/>
                  <a:gd name="T34" fmla="*/ 96 w 768"/>
                  <a:gd name="T35" fmla="*/ 704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768" h="75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720" y="0"/>
                    </a:lnTo>
                    <a:cubicBezTo>
                      <a:pt x="747" y="0"/>
                      <a:pt x="768" y="22"/>
                      <a:pt x="768" y="48"/>
                    </a:cubicBezTo>
                    <a:lnTo>
                      <a:pt x="768" y="704"/>
                    </a:lnTo>
                    <a:cubicBezTo>
                      <a:pt x="768" y="731"/>
                      <a:pt x="747" y="752"/>
                      <a:pt x="720" y="752"/>
                    </a:cubicBezTo>
                    <a:lnTo>
                      <a:pt x="48" y="752"/>
                    </a:lnTo>
                    <a:cubicBezTo>
                      <a:pt x="22" y="752"/>
                      <a:pt x="0" y="731"/>
                      <a:pt x="0" y="704"/>
                    </a:cubicBezTo>
                    <a:lnTo>
                      <a:pt x="0" y="48"/>
                    </a:lnTo>
                    <a:close/>
                    <a:moveTo>
                      <a:pt x="96" y="704"/>
                    </a:moveTo>
                    <a:lnTo>
                      <a:pt x="48" y="656"/>
                    </a:lnTo>
                    <a:lnTo>
                      <a:pt x="720" y="656"/>
                    </a:lnTo>
                    <a:lnTo>
                      <a:pt x="672" y="704"/>
                    </a:lnTo>
                    <a:lnTo>
                      <a:pt x="672" y="48"/>
                    </a:lnTo>
                    <a:lnTo>
                      <a:pt x="72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0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0" name="Rectangle 80"/>
              <p:cNvSpPr>
                <a:spLocks noChangeArrowheads="1"/>
              </p:cNvSpPr>
              <p:nvPr/>
            </p:nvSpPr>
            <p:spPr bwMode="auto">
              <a:xfrm>
                <a:off x="4692064" y="1930489"/>
                <a:ext cx="90488" cy="10318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1" name="Freeform 81"/>
              <p:cNvSpPr>
                <a:spLocks noEditPoints="1"/>
              </p:cNvSpPr>
              <p:nvPr/>
            </p:nvSpPr>
            <p:spPr bwMode="auto">
              <a:xfrm>
                <a:off x="4685714" y="1907369"/>
                <a:ext cx="103188" cy="117475"/>
              </a:xfrm>
              <a:custGeom>
                <a:avLst/>
                <a:gdLst>
                  <a:gd name="T0" fmla="*/ 0 w 768"/>
                  <a:gd name="T1" fmla="*/ 48 h 752"/>
                  <a:gd name="T2" fmla="*/ 48 w 768"/>
                  <a:gd name="T3" fmla="*/ 0 h 752"/>
                  <a:gd name="T4" fmla="*/ 720 w 768"/>
                  <a:gd name="T5" fmla="*/ 0 h 752"/>
                  <a:gd name="T6" fmla="*/ 768 w 768"/>
                  <a:gd name="T7" fmla="*/ 48 h 752"/>
                  <a:gd name="T8" fmla="*/ 768 w 768"/>
                  <a:gd name="T9" fmla="*/ 704 h 752"/>
                  <a:gd name="T10" fmla="*/ 720 w 768"/>
                  <a:gd name="T11" fmla="*/ 752 h 752"/>
                  <a:gd name="T12" fmla="*/ 48 w 768"/>
                  <a:gd name="T13" fmla="*/ 752 h 752"/>
                  <a:gd name="T14" fmla="*/ 0 w 768"/>
                  <a:gd name="T15" fmla="*/ 704 h 752"/>
                  <a:gd name="T16" fmla="*/ 0 w 768"/>
                  <a:gd name="T17" fmla="*/ 48 h 752"/>
                  <a:gd name="T18" fmla="*/ 96 w 768"/>
                  <a:gd name="T19" fmla="*/ 704 h 752"/>
                  <a:gd name="T20" fmla="*/ 48 w 768"/>
                  <a:gd name="T21" fmla="*/ 656 h 752"/>
                  <a:gd name="T22" fmla="*/ 720 w 768"/>
                  <a:gd name="T23" fmla="*/ 656 h 752"/>
                  <a:gd name="T24" fmla="*/ 672 w 768"/>
                  <a:gd name="T25" fmla="*/ 704 h 752"/>
                  <a:gd name="T26" fmla="*/ 672 w 768"/>
                  <a:gd name="T27" fmla="*/ 48 h 752"/>
                  <a:gd name="T28" fmla="*/ 720 w 768"/>
                  <a:gd name="T29" fmla="*/ 96 h 752"/>
                  <a:gd name="T30" fmla="*/ 48 w 768"/>
                  <a:gd name="T31" fmla="*/ 96 h 752"/>
                  <a:gd name="T32" fmla="*/ 96 w 768"/>
                  <a:gd name="T33" fmla="*/ 48 h 752"/>
                  <a:gd name="T34" fmla="*/ 96 w 768"/>
                  <a:gd name="T35" fmla="*/ 704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768" h="75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720" y="0"/>
                    </a:lnTo>
                    <a:cubicBezTo>
                      <a:pt x="747" y="0"/>
                      <a:pt x="768" y="22"/>
                      <a:pt x="768" y="48"/>
                    </a:cubicBezTo>
                    <a:lnTo>
                      <a:pt x="768" y="704"/>
                    </a:lnTo>
                    <a:cubicBezTo>
                      <a:pt x="768" y="731"/>
                      <a:pt x="747" y="752"/>
                      <a:pt x="720" y="752"/>
                    </a:cubicBezTo>
                    <a:lnTo>
                      <a:pt x="48" y="752"/>
                    </a:lnTo>
                    <a:cubicBezTo>
                      <a:pt x="22" y="752"/>
                      <a:pt x="0" y="731"/>
                      <a:pt x="0" y="704"/>
                    </a:cubicBezTo>
                    <a:lnTo>
                      <a:pt x="0" y="48"/>
                    </a:lnTo>
                    <a:close/>
                    <a:moveTo>
                      <a:pt x="96" y="704"/>
                    </a:moveTo>
                    <a:lnTo>
                      <a:pt x="48" y="656"/>
                    </a:lnTo>
                    <a:lnTo>
                      <a:pt x="720" y="656"/>
                    </a:lnTo>
                    <a:lnTo>
                      <a:pt x="672" y="704"/>
                    </a:lnTo>
                    <a:lnTo>
                      <a:pt x="672" y="48"/>
                    </a:lnTo>
                    <a:lnTo>
                      <a:pt x="72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0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57" name="Rectangle 82"/>
            <p:cNvSpPr>
              <a:spLocks noChangeArrowheads="1"/>
            </p:cNvSpPr>
            <p:nvPr/>
          </p:nvSpPr>
          <p:spPr bwMode="auto">
            <a:xfrm>
              <a:off x="4512225" y="1680390"/>
              <a:ext cx="377833" cy="3080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IFN</a:t>
              </a: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52" name="グループ化 151"/>
          <p:cNvGrpSpPr/>
          <p:nvPr/>
        </p:nvGrpSpPr>
        <p:grpSpPr>
          <a:xfrm>
            <a:off x="5412342" y="1111296"/>
            <a:ext cx="2880000" cy="1620000"/>
            <a:chOff x="5412342" y="1758996"/>
            <a:chExt cx="2880000" cy="1620000"/>
          </a:xfrm>
        </p:grpSpPr>
        <p:sp>
          <p:nvSpPr>
            <p:cNvPr id="63" name="Rectangle 88"/>
            <p:cNvSpPr>
              <a:spLocks noChangeArrowheads="1"/>
            </p:cNvSpPr>
            <p:nvPr/>
          </p:nvSpPr>
          <p:spPr bwMode="auto">
            <a:xfrm>
              <a:off x="5693808" y="1768201"/>
              <a:ext cx="212775" cy="160389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Freeform 89"/>
            <p:cNvSpPr>
              <a:spLocks noEditPoints="1"/>
            </p:cNvSpPr>
            <p:nvPr/>
          </p:nvSpPr>
          <p:spPr bwMode="auto">
            <a:xfrm>
              <a:off x="5688782" y="1758996"/>
              <a:ext cx="222828" cy="1620000"/>
            </a:xfrm>
            <a:custGeom>
              <a:avLst/>
              <a:gdLst>
                <a:gd name="T0" fmla="*/ 0 w 1728"/>
                <a:gd name="T1" fmla="*/ 48 h 9104"/>
                <a:gd name="T2" fmla="*/ 48 w 1728"/>
                <a:gd name="T3" fmla="*/ 0 h 9104"/>
                <a:gd name="T4" fmla="*/ 1680 w 1728"/>
                <a:gd name="T5" fmla="*/ 0 h 9104"/>
                <a:gd name="T6" fmla="*/ 1728 w 1728"/>
                <a:gd name="T7" fmla="*/ 48 h 9104"/>
                <a:gd name="T8" fmla="*/ 1728 w 1728"/>
                <a:gd name="T9" fmla="*/ 9056 h 9104"/>
                <a:gd name="T10" fmla="*/ 1680 w 1728"/>
                <a:gd name="T11" fmla="*/ 9104 h 9104"/>
                <a:gd name="T12" fmla="*/ 48 w 1728"/>
                <a:gd name="T13" fmla="*/ 9104 h 9104"/>
                <a:gd name="T14" fmla="*/ 0 w 1728"/>
                <a:gd name="T15" fmla="*/ 9056 h 9104"/>
                <a:gd name="T16" fmla="*/ 0 w 1728"/>
                <a:gd name="T17" fmla="*/ 48 h 9104"/>
                <a:gd name="T18" fmla="*/ 96 w 1728"/>
                <a:gd name="T19" fmla="*/ 9056 h 9104"/>
                <a:gd name="T20" fmla="*/ 48 w 1728"/>
                <a:gd name="T21" fmla="*/ 9008 h 9104"/>
                <a:gd name="T22" fmla="*/ 1680 w 1728"/>
                <a:gd name="T23" fmla="*/ 9008 h 9104"/>
                <a:gd name="T24" fmla="*/ 1632 w 1728"/>
                <a:gd name="T25" fmla="*/ 9056 h 9104"/>
                <a:gd name="T26" fmla="*/ 1632 w 1728"/>
                <a:gd name="T27" fmla="*/ 48 h 9104"/>
                <a:gd name="T28" fmla="*/ 1680 w 1728"/>
                <a:gd name="T29" fmla="*/ 96 h 9104"/>
                <a:gd name="T30" fmla="*/ 48 w 1728"/>
                <a:gd name="T31" fmla="*/ 96 h 9104"/>
                <a:gd name="T32" fmla="*/ 96 w 1728"/>
                <a:gd name="T33" fmla="*/ 48 h 9104"/>
                <a:gd name="T34" fmla="*/ 96 w 1728"/>
                <a:gd name="T35" fmla="*/ 9056 h 9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728" h="910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680" y="0"/>
                  </a:lnTo>
                  <a:cubicBezTo>
                    <a:pt x="1707" y="0"/>
                    <a:pt x="1728" y="22"/>
                    <a:pt x="1728" y="48"/>
                  </a:cubicBezTo>
                  <a:lnTo>
                    <a:pt x="1728" y="9056"/>
                  </a:lnTo>
                  <a:cubicBezTo>
                    <a:pt x="1728" y="9083"/>
                    <a:pt x="1707" y="9104"/>
                    <a:pt x="1680" y="9104"/>
                  </a:cubicBezTo>
                  <a:lnTo>
                    <a:pt x="48" y="9104"/>
                  </a:lnTo>
                  <a:cubicBezTo>
                    <a:pt x="22" y="9104"/>
                    <a:pt x="0" y="9083"/>
                    <a:pt x="0" y="9056"/>
                  </a:cubicBezTo>
                  <a:lnTo>
                    <a:pt x="0" y="48"/>
                  </a:lnTo>
                  <a:close/>
                  <a:moveTo>
                    <a:pt x="96" y="9056"/>
                  </a:moveTo>
                  <a:lnTo>
                    <a:pt x="48" y="9008"/>
                  </a:lnTo>
                  <a:lnTo>
                    <a:pt x="1680" y="9008"/>
                  </a:lnTo>
                  <a:lnTo>
                    <a:pt x="1632" y="9056"/>
                  </a:lnTo>
                  <a:lnTo>
                    <a:pt x="1632" y="48"/>
                  </a:lnTo>
                  <a:lnTo>
                    <a:pt x="1680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905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Rectangle 90"/>
            <p:cNvSpPr>
              <a:spLocks noChangeArrowheads="1"/>
            </p:cNvSpPr>
            <p:nvPr/>
          </p:nvSpPr>
          <p:spPr bwMode="auto">
            <a:xfrm>
              <a:off x="6637054" y="1768201"/>
              <a:ext cx="212775" cy="160389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Freeform 91"/>
            <p:cNvSpPr>
              <a:spLocks noEditPoints="1"/>
            </p:cNvSpPr>
            <p:nvPr/>
          </p:nvSpPr>
          <p:spPr bwMode="auto">
            <a:xfrm>
              <a:off x="6632028" y="1758996"/>
              <a:ext cx="222828" cy="1620000"/>
            </a:xfrm>
            <a:custGeom>
              <a:avLst/>
              <a:gdLst>
                <a:gd name="T0" fmla="*/ 0 w 1728"/>
                <a:gd name="T1" fmla="*/ 48 h 9104"/>
                <a:gd name="T2" fmla="*/ 48 w 1728"/>
                <a:gd name="T3" fmla="*/ 0 h 9104"/>
                <a:gd name="T4" fmla="*/ 1680 w 1728"/>
                <a:gd name="T5" fmla="*/ 0 h 9104"/>
                <a:gd name="T6" fmla="*/ 1728 w 1728"/>
                <a:gd name="T7" fmla="*/ 48 h 9104"/>
                <a:gd name="T8" fmla="*/ 1728 w 1728"/>
                <a:gd name="T9" fmla="*/ 9056 h 9104"/>
                <a:gd name="T10" fmla="*/ 1680 w 1728"/>
                <a:gd name="T11" fmla="*/ 9104 h 9104"/>
                <a:gd name="T12" fmla="*/ 48 w 1728"/>
                <a:gd name="T13" fmla="*/ 9104 h 9104"/>
                <a:gd name="T14" fmla="*/ 0 w 1728"/>
                <a:gd name="T15" fmla="*/ 9056 h 9104"/>
                <a:gd name="T16" fmla="*/ 0 w 1728"/>
                <a:gd name="T17" fmla="*/ 48 h 9104"/>
                <a:gd name="T18" fmla="*/ 96 w 1728"/>
                <a:gd name="T19" fmla="*/ 9056 h 9104"/>
                <a:gd name="T20" fmla="*/ 48 w 1728"/>
                <a:gd name="T21" fmla="*/ 9008 h 9104"/>
                <a:gd name="T22" fmla="*/ 1680 w 1728"/>
                <a:gd name="T23" fmla="*/ 9008 h 9104"/>
                <a:gd name="T24" fmla="*/ 1632 w 1728"/>
                <a:gd name="T25" fmla="*/ 9056 h 9104"/>
                <a:gd name="T26" fmla="*/ 1632 w 1728"/>
                <a:gd name="T27" fmla="*/ 48 h 9104"/>
                <a:gd name="T28" fmla="*/ 1680 w 1728"/>
                <a:gd name="T29" fmla="*/ 96 h 9104"/>
                <a:gd name="T30" fmla="*/ 48 w 1728"/>
                <a:gd name="T31" fmla="*/ 96 h 9104"/>
                <a:gd name="T32" fmla="*/ 96 w 1728"/>
                <a:gd name="T33" fmla="*/ 48 h 9104"/>
                <a:gd name="T34" fmla="*/ 96 w 1728"/>
                <a:gd name="T35" fmla="*/ 9056 h 9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728" h="910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680" y="0"/>
                  </a:lnTo>
                  <a:cubicBezTo>
                    <a:pt x="1707" y="0"/>
                    <a:pt x="1728" y="22"/>
                    <a:pt x="1728" y="48"/>
                  </a:cubicBezTo>
                  <a:lnTo>
                    <a:pt x="1728" y="9056"/>
                  </a:lnTo>
                  <a:cubicBezTo>
                    <a:pt x="1728" y="9083"/>
                    <a:pt x="1707" y="9104"/>
                    <a:pt x="1680" y="9104"/>
                  </a:cubicBezTo>
                  <a:lnTo>
                    <a:pt x="48" y="9104"/>
                  </a:lnTo>
                  <a:cubicBezTo>
                    <a:pt x="22" y="9104"/>
                    <a:pt x="0" y="9083"/>
                    <a:pt x="0" y="9056"/>
                  </a:cubicBezTo>
                  <a:lnTo>
                    <a:pt x="0" y="48"/>
                  </a:lnTo>
                  <a:close/>
                  <a:moveTo>
                    <a:pt x="96" y="9056"/>
                  </a:moveTo>
                  <a:lnTo>
                    <a:pt x="48" y="9008"/>
                  </a:lnTo>
                  <a:lnTo>
                    <a:pt x="1680" y="9008"/>
                  </a:lnTo>
                  <a:lnTo>
                    <a:pt x="1632" y="9056"/>
                  </a:lnTo>
                  <a:lnTo>
                    <a:pt x="1632" y="48"/>
                  </a:lnTo>
                  <a:lnTo>
                    <a:pt x="1680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905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Rectangle 92"/>
            <p:cNvSpPr>
              <a:spLocks noChangeArrowheads="1"/>
            </p:cNvSpPr>
            <p:nvPr/>
          </p:nvSpPr>
          <p:spPr bwMode="auto">
            <a:xfrm>
              <a:off x="7581976" y="1768201"/>
              <a:ext cx="211099" cy="160389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Freeform 93"/>
            <p:cNvSpPr>
              <a:spLocks noEditPoints="1"/>
            </p:cNvSpPr>
            <p:nvPr/>
          </p:nvSpPr>
          <p:spPr bwMode="auto">
            <a:xfrm>
              <a:off x="7575274" y="1758996"/>
              <a:ext cx="224503" cy="1620000"/>
            </a:xfrm>
            <a:custGeom>
              <a:avLst/>
              <a:gdLst>
                <a:gd name="T0" fmla="*/ 0 w 1728"/>
                <a:gd name="T1" fmla="*/ 48 h 9104"/>
                <a:gd name="T2" fmla="*/ 48 w 1728"/>
                <a:gd name="T3" fmla="*/ 0 h 9104"/>
                <a:gd name="T4" fmla="*/ 1680 w 1728"/>
                <a:gd name="T5" fmla="*/ 0 h 9104"/>
                <a:gd name="T6" fmla="*/ 1728 w 1728"/>
                <a:gd name="T7" fmla="*/ 48 h 9104"/>
                <a:gd name="T8" fmla="*/ 1728 w 1728"/>
                <a:gd name="T9" fmla="*/ 9056 h 9104"/>
                <a:gd name="T10" fmla="*/ 1680 w 1728"/>
                <a:gd name="T11" fmla="*/ 9104 h 9104"/>
                <a:gd name="T12" fmla="*/ 48 w 1728"/>
                <a:gd name="T13" fmla="*/ 9104 h 9104"/>
                <a:gd name="T14" fmla="*/ 0 w 1728"/>
                <a:gd name="T15" fmla="*/ 9056 h 9104"/>
                <a:gd name="T16" fmla="*/ 0 w 1728"/>
                <a:gd name="T17" fmla="*/ 48 h 9104"/>
                <a:gd name="T18" fmla="*/ 96 w 1728"/>
                <a:gd name="T19" fmla="*/ 9056 h 9104"/>
                <a:gd name="T20" fmla="*/ 48 w 1728"/>
                <a:gd name="T21" fmla="*/ 9008 h 9104"/>
                <a:gd name="T22" fmla="*/ 1680 w 1728"/>
                <a:gd name="T23" fmla="*/ 9008 h 9104"/>
                <a:gd name="T24" fmla="*/ 1632 w 1728"/>
                <a:gd name="T25" fmla="*/ 9056 h 9104"/>
                <a:gd name="T26" fmla="*/ 1632 w 1728"/>
                <a:gd name="T27" fmla="*/ 48 h 9104"/>
                <a:gd name="T28" fmla="*/ 1680 w 1728"/>
                <a:gd name="T29" fmla="*/ 96 h 9104"/>
                <a:gd name="T30" fmla="*/ 48 w 1728"/>
                <a:gd name="T31" fmla="*/ 96 h 9104"/>
                <a:gd name="T32" fmla="*/ 96 w 1728"/>
                <a:gd name="T33" fmla="*/ 48 h 9104"/>
                <a:gd name="T34" fmla="*/ 96 w 1728"/>
                <a:gd name="T35" fmla="*/ 9056 h 9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728" h="910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680" y="0"/>
                  </a:lnTo>
                  <a:cubicBezTo>
                    <a:pt x="1707" y="0"/>
                    <a:pt x="1728" y="22"/>
                    <a:pt x="1728" y="48"/>
                  </a:cubicBezTo>
                  <a:lnTo>
                    <a:pt x="1728" y="9056"/>
                  </a:lnTo>
                  <a:cubicBezTo>
                    <a:pt x="1728" y="9083"/>
                    <a:pt x="1707" y="9104"/>
                    <a:pt x="1680" y="9104"/>
                  </a:cubicBezTo>
                  <a:lnTo>
                    <a:pt x="48" y="9104"/>
                  </a:lnTo>
                  <a:cubicBezTo>
                    <a:pt x="22" y="9104"/>
                    <a:pt x="0" y="9083"/>
                    <a:pt x="0" y="9056"/>
                  </a:cubicBezTo>
                  <a:lnTo>
                    <a:pt x="0" y="48"/>
                  </a:lnTo>
                  <a:close/>
                  <a:moveTo>
                    <a:pt x="96" y="9056"/>
                  </a:moveTo>
                  <a:lnTo>
                    <a:pt x="48" y="9008"/>
                  </a:lnTo>
                  <a:lnTo>
                    <a:pt x="1680" y="9008"/>
                  </a:lnTo>
                  <a:lnTo>
                    <a:pt x="1632" y="9056"/>
                  </a:lnTo>
                  <a:lnTo>
                    <a:pt x="1632" y="48"/>
                  </a:lnTo>
                  <a:lnTo>
                    <a:pt x="1680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905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Rectangle 94"/>
            <p:cNvSpPr>
              <a:spLocks noChangeArrowheads="1"/>
            </p:cNvSpPr>
            <p:nvPr/>
          </p:nvSpPr>
          <p:spPr bwMode="auto">
            <a:xfrm>
              <a:off x="5961871" y="1876353"/>
              <a:ext cx="211099" cy="149573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Freeform 95"/>
            <p:cNvSpPr>
              <a:spLocks noEditPoints="1"/>
            </p:cNvSpPr>
            <p:nvPr/>
          </p:nvSpPr>
          <p:spPr bwMode="auto">
            <a:xfrm>
              <a:off x="5955169" y="1867149"/>
              <a:ext cx="224503" cy="1511847"/>
            </a:xfrm>
            <a:custGeom>
              <a:avLst/>
              <a:gdLst>
                <a:gd name="T0" fmla="*/ 0 w 1728"/>
                <a:gd name="T1" fmla="*/ 48 h 8496"/>
                <a:gd name="T2" fmla="*/ 48 w 1728"/>
                <a:gd name="T3" fmla="*/ 0 h 8496"/>
                <a:gd name="T4" fmla="*/ 1680 w 1728"/>
                <a:gd name="T5" fmla="*/ 0 h 8496"/>
                <a:gd name="T6" fmla="*/ 1728 w 1728"/>
                <a:gd name="T7" fmla="*/ 48 h 8496"/>
                <a:gd name="T8" fmla="*/ 1728 w 1728"/>
                <a:gd name="T9" fmla="*/ 8448 h 8496"/>
                <a:gd name="T10" fmla="*/ 1680 w 1728"/>
                <a:gd name="T11" fmla="*/ 8496 h 8496"/>
                <a:gd name="T12" fmla="*/ 48 w 1728"/>
                <a:gd name="T13" fmla="*/ 8496 h 8496"/>
                <a:gd name="T14" fmla="*/ 0 w 1728"/>
                <a:gd name="T15" fmla="*/ 8448 h 8496"/>
                <a:gd name="T16" fmla="*/ 0 w 1728"/>
                <a:gd name="T17" fmla="*/ 48 h 8496"/>
                <a:gd name="T18" fmla="*/ 96 w 1728"/>
                <a:gd name="T19" fmla="*/ 8448 h 8496"/>
                <a:gd name="T20" fmla="*/ 48 w 1728"/>
                <a:gd name="T21" fmla="*/ 8400 h 8496"/>
                <a:gd name="T22" fmla="*/ 1680 w 1728"/>
                <a:gd name="T23" fmla="*/ 8400 h 8496"/>
                <a:gd name="T24" fmla="*/ 1632 w 1728"/>
                <a:gd name="T25" fmla="*/ 8448 h 8496"/>
                <a:gd name="T26" fmla="*/ 1632 w 1728"/>
                <a:gd name="T27" fmla="*/ 48 h 8496"/>
                <a:gd name="T28" fmla="*/ 1680 w 1728"/>
                <a:gd name="T29" fmla="*/ 96 h 8496"/>
                <a:gd name="T30" fmla="*/ 48 w 1728"/>
                <a:gd name="T31" fmla="*/ 96 h 8496"/>
                <a:gd name="T32" fmla="*/ 96 w 1728"/>
                <a:gd name="T33" fmla="*/ 48 h 8496"/>
                <a:gd name="T34" fmla="*/ 96 w 1728"/>
                <a:gd name="T35" fmla="*/ 8448 h 84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728" h="8496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680" y="0"/>
                  </a:lnTo>
                  <a:cubicBezTo>
                    <a:pt x="1707" y="0"/>
                    <a:pt x="1728" y="22"/>
                    <a:pt x="1728" y="48"/>
                  </a:cubicBezTo>
                  <a:lnTo>
                    <a:pt x="1728" y="8448"/>
                  </a:lnTo>
                  <a:cubicBezTo>
                    <a:pt x="1728" y="8475"/>
                    <a:pt x="1707" y="8496"/>
                    <a:pt x="1680" y="8496"/>
                  </a:cubicBezTo>
                  <a:lnTo>
                    <a:pt x="48" y="8496"/>
                  </a:lnTo>
                  <a:cubicBezTo>
                    <a:pt x="22" y="8496"/>
                    <a:pt x="0" y="8475"/>
                    <a:pt x="0" y="8448"/>
                  </a:cubicBezTo>
                  <a:lnTo>
                    <a:pt x="0" y="48"/>
                  </a:lnTo>
                  <a:close/>
                  <a:moveTo>
                    <a:pt x="96" y="8448"/>
                  </a:moveTo>
                  <a:lnTo>
                    <a:pt x="48" y="8400"/>
                  </a:lnTo>
                  <a:lnTo>
                    <a:pt x="1680" y="8400"/>
                  </a:lnTo>
                  <a:lnTo>
                    <a:pt x="1632" y="8448"/>
                  </a:lnTo>
                  <a:lnTo>
                    <a:pt x="1632" y="48"/>
                  </a:lnTo>
                  <a:lnTo>
                    <a:pt x="1680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844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Rectangle 96"/>
            <p:cNvSpPr>
              <a:spLocks noChangeArrowheads="1"/>
            </p:cNvSpPr>
            <p:nvPr/>
          </p:nvSpPr>
          <p:spPr bwMode="auto">
            <a:xfrm>
              <a:off x="6905117" y="2069649"/>
              <a:ext cx="211099" cy="130244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Freeform 97"/>
            <p:cNvSpPr>
              <a:spLocks noEditPoints="1"/>
            </p:cNvSpPr>
            <p:nvPr/>
          </p:nvSpPr>
          <p:spPr bwMode="auto">
            <a:xfrm>
              <a:off x="6898416" y="2060444"/>
              <a:ext cx="224503" cy="1318552"/>
            </a:xfrm>
            <a:custGeom>
              <a:avLst/>
              <a:gdLst>
                <a:gd name="T0" fmla="*/ 0 w 1728"/>
                <a:gd name="T1" fmla="*/ 48 h 7408"/>
                <a:gd name="T2" fmla="*/ 48 w 1728"/>
                <a:gd name="T3" fmla="*/ 0 h 7408"/>
                <a:gd name="T4" fmla="*/ 1680 w 1728"/>
                <a:gd name="T5" fmla="*/ 0 h 7408"/>
                <a:gd name="T6" fmla="*/ 1728 w 1728"/>
                <a:gd name="T7" fmla="*/ 48 h 7408"/>
                <a:gd name="T8" fmla="*/ 1728 w 1728"/>
                <a:gd name="T9" fmla="*/ 7360 h 7408"/>
                <a:gd name="T10" fmla="*/ 1680 w 1728"/>
                <a:gd name="T11" fmla="*/ 7408 h 7408"/>
                <a:gd name="T12" fmla="*/ 48 w 1728"/>
                <a:gd name="T13" fmla="*/ 7408 h 7408"/>
                <a:gd name="T14" fmla="*/ 0 w 1728"/>
                <a:gd name="T15" fmla="*/ 7360 h 7408"/>
                <a:gd name="T16" fmla="*/ 0 w 1728"/>
                <a:gd name="T17" fmla="*/ 48 h 7408"/>
                <a:gd name="T18" fmla="*/ 96 w 1728"/>
                <a:gd name="T19" fmla="*/ 7360 h 7408"/>
                <a:gd name="T20" fmla="*/ 48 w 1728"/>
                <a:gd name="T21" fmla="*/ 7312 h 7408"/>
                <a:gd name="T22" fmla="*/ 1680 w 1728"/>
                <a:gd name="T23" fmla="*/ 7312 h 7408"/>
                <a:gd name="T24" fmla="*/ 1632 w 1728"/>
                <a:gd name="T25" fmla="*/ 7360 h 7408"/>
                <a:gd name="T26" fmla="*/ 1632 w 1728"/>
                <a:gd name="T27" fmla="*/ 48 h 7408"/>
                <a:gd name="T28" fmla="*/ 1680 w 1728"/>
                <a:gd name="T29" fmla="*/ 96 h 7408"/>
                <a:gd name="T30" fmla="*/ 48 w 1728"/>
                <a:gd name="T31" fmla="*/ 96 h 7408"/>
                <a:gd name="T32" fmla="*/ 96 w 1728"/>
                <a:gd name="T33" fmla="*/ 48 h 7408"/>
                <a:gd name="T34" fmla="*/ 96 w 1728"/>
                <a:gd name="T35" fmla="*/ 7360 h 74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728" h="7408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680" y="0"/>
                  </a:lnTo>
                  <a:cubicBezTo>
                    <a:pt x="1707" y="0"/>
                    <a:pt x="1728" y="22"/>
                    <a:pt x="1728" y="48"/>
                  </a:cubicBezTo>
                  <a:lnTo>
                    <a:pt x="1728" y="7360"/>
                  </a:lnTo>
                  <a:cubicBezTo>
                    <a:pt x="1728" y="7387"/>
                    <a:pt x="1707" y="7408"/>
                    <a:pt x="1680" y="7408"/>
                  </a:cubicBezTo>
                  <a:lnTo>
                    <a:pt x="48" y="7408"/>
                  </a:lnTo>
                  <a:cubicBezTo>
                    <a:pt x="22" y="7408"/>
                    <a:pt x="0" y="7387"/>
                    <a:pt x="0" y="7360"/>
                  </a:cubicBezTo>
                  <a:lnTo>
                    <a:pt x="0" y="48"/>
                  </a:lnTo>
                  <a:close/>
                  <a:moveTo>
                    <a:pt x="96" y="7360"/>
                  </a:moveTo>
                  <a:lnTo>
                    <a:pt x="48" y="7312"/>
                  </a:lnTo>
                  <a:lnTo>
                    <a:pt x="1680" y="7312"/>
                  </a:lnTo>
                  <a:lnTo>
                    <a:pt x="1632" y="7360"/>
                  </a:lnTo>
                  <a:lnTo>
                    <a:pt x="1632" y="48"/>
                  </a:lnTo>
                  <a:lnTo>
                    <a:pt x="1680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36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Rectangle 98"/>
            <p:cNvSpPr>
              <a:spLocks noChangeArrowheads="1"/>
            </p:cNvSpPr>
            <p:nvPr/>
          </p:nvSpPr>
          <p:spPr bwMode="auto">
            <a:xfrm>
              <a:off x="7850038" y="2074251"/>
              <a:ext cx="212775" cy="129784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Freeform 99"/>
            <p:cNvSpPr>
              <a:spLocks noEditPoints="1"/>
            </p:cNvSpPr>
            <p:nvPr/>
          </p:nvSpPr>
          <p:spPr bwMode="auto">
            <a:xfrm>
              <a:off x="7845012" y="2067348"/>
              <a:ext cx="222828" cy="1311648"/>
            </a:xfrm>
            <a:custGeom>
              <a:avLst/>
              <a:gdLst>
                <a:gd name="T0" fmla="*/ 0 w 1728"/>
                <a:gd name="T1" fmla="*/ 48 h 7376"/>
                <a:gd name="T2" fmla="*/ 48 w 1728"/>
                <a:gd name="T3" fmla="*/ 0 h 7376"/>
                <a:gd name="T4" fmla="*/ 1680 w 1728"/>
                <a:gd name="T5" fmla="*/ 0 h 7376"/>
                <a:gd name="T6" fmla="*/ 1728 w 1728"/>
                <a:gd name="T7" fmla="*/ 48 h 7376"/>
                <a:gd name="T8" fmla="*/ 1728 w 1728"/>
                <a:gd name="T9" fmla="*/ 7328 h 7376"/>
                <a:gd name="T10" fmla="*/ 1680 w 1728"/>
                <a:gd name="T11" fmla="*/ 7376 h 7376"/>
                <a:gd name="T12" fmla="*/ 48 w 1728"/>
                <a:gd name="T13" fmla="*/ 7376 h 7376"/>
                <a:gd name="T14" fmla="*/ 0 w 1728"/>
                <a:gd name="T15" fmla="*/ 7328 h 7376"/>
                <a:gd name="T16" fmla="*/ 0 w 1728"/>
                <a:gd name="T17" fmla="*/ 48 h 7376"/>
                <a:gd name="T18" fmla="*/ 96 w 1728"/>
                <a:gd name="T19" fmla="*/ 7328 h 7376"/>
                <a:gd name="T20" fmla="*/ 48 w 1728"/>
                <a:gd name="T21" fmla="*/ 7280 h 7376"/>
                <a:gd name="T22" fmla="*/ 1680 w 1728"/>
                <a:gd name="T23" fmla="*/ 7280 h 7376"/>
                <a:gd name="T24" fmla="*/ 1632 w 1728"/>
                <a:gd name="T25" fmla="*/ 7328 h 7376"/>
                <a:gd name="T26" fmla="*/ 1632 w 1728"/>
                <a:gd name="T27" fmla="*/ 48 h 7376"/>
                <a:gd name="T28" fmla="*/ 1680 w 1728"/>
                <a:gd name="T29" fmla="*/ 96 h 7376"/>
                <a:gd name="T30" fmla="*/ 48 w 1728"/>
                <a:gd name="T31" fmla="*/ 96 h 7376"/>
                <a:gd name="T32" fmla="*/ 96 w 1728"/>
                <a:gd name="T33" fmla="*/ 48 h 7376"/>
                <a:gd name="T34" fmla="*/ 96 w 1728"/>
                <a:gd name="T35" fmla="*/ 7328 h 7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728" h="7376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680" y="0"/>
                  </a:lnTo>
                  <a:cubicBezTo>
                    <a:pt x="1707" y="0"/>
                    <a:pt x="1728" y="22"/>
                    <a:pt x="1728" y="48"/>
                  </a:cubicBezTo>
                  <a:lnTo>
                    <a:pt x="1728" y="7328"/>
                  </a:lnTo>
                  <a:cubicBezTo>
                    <a:pt x="1728" y="7355"/>
                    <a:pt x="1707" y="7376"/>
                    <a:pt x="1680" y="7376"/>
                  </a:cubicBezTo>
                  <a:lnTo>
                    <a:pt x="48" y="7376"/>
                  </a:lnTo>
                  <a:cubicBezTo>
                    <a:pt x="22" y="7376"/>
                    <a:pt x="0" y="7355"/>
                    <a:pt x="0" y="7328"/>
                  </a:cubicBezTo>
                  <a:lnTo>
                    <a:pt x="0" y="48"/>
                  </a:lnTo>
                  <a:close/>
                  <a:moveTo>
                    <a:pt x="96" y="7328"/>
                  </a:moveTo>
                  <a:lnTo>
                    <a:pt x="48" y="7280"/>
                  </a:lnTo>
                  <a:lnTo>
                    <a:pt x="1680" y="7280"/>
                  </a:lnTo>
                  <a:lnTo>
                    <a:pt x="1632" y="7328"/>
                  </a:lnTo>
                  <a:lnTo>
                    <a:pt x="1632" y="48"/>
                  </a:lnTo>
                  <a:lnTo>
                    <a:pt x="1680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732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Freeform 100"/>
            <p:cNvSpPr>
              <a:spLocks noEditPoints="1"/>
            </p:cNvSpPr>
            <p:nvPr/>
          </p:nvSpPr>
          <p:spPr bwMode="auto">
            <a:xfrm>
              <a:off x="6028886" y="1828030"/>
              <a:ext cx="78744" cy="96648"/>
            </a:xfrm>
            <a:custGeom>
              <a:avLst/>
              <a:gdLst>
                <a:gd name="T0" fmla="*/ 27 w 47"/>
                <a:gd name="T1" fmla="*/ 21 h 42"/>
                <a:gd name="T2" fmla="*/ 27 w 47"/>
                <a:gd name="T3" fmla="*/ 38 h 42"/>
                <a:gd name="T4" fmla="*/ 19 w 47"/>
                <a:gd name="T5" fmla="*/ 38 h 42"/>
                <a:gd name="T6" fmla="*/ 19 w 47"/>
                <a:gd name="T7" fmla="*/ 21 h 42"/>
                <a:gd name="T8" fmla="*/ 27 w 47"/>
                <a:gd name="T9" fmla="*/ 21 h 42"/>
                <a:gd name="T10" fmla="*/ 19 w 47"/>
                <a:gd name="T11" fmla="*/ 21 h 42"/>
                <a:gd name="T12" fmla="*/ 19 w 47"/>
                <a:gd name="T13" fmla="*/ 3 h 42"/>
                <a:gd name="T14" fmla="*/ 27 w 47"/>
                <a:gd name="T15" fmla="*/ 3 h 42"/>
                <a:gd name="T16" fmla="*/ 27 w 47"/>
                <a:gd name="T17" fmla="*/ 21 h 42"/>
                <a:gd name="T18" fmla="*/ 19 w 47"/>
                <a:gd name="T19" fmla="*/ 21 h 42"/>
                <a:gd name="T20" fmla="*/ 0 w 47"/>
                <a:gd name="T21" fmla="*/ 34 h 42"/>
                <a:gd name="T22" fmla="*/ 47 w 47"/>
                <a:gd name="T23" fmla="*/ 34 h 42"/>
                <a:gd name="T24" fmla="*/ 47 w 47"/>
                <a:gd name="T25" fmla="*/ 42 h 42"/>
                <a:gd name="T26" fmla="*/ 0 w 47"/>
                <a:gd name="T27" fmla="*/ 42 h 42"/>
                <a:gd name="T28" fmla="*/ 0 w 47"/>
                <a:gd name="T29" fmla="*/ 34 h 42"/>
                <a:gd name="T30" fmla="*/ 0 w 47"/>
                <a:gd name="T31" fmla="*/ 0 h 42"/>
                <a:gd name="T32" fmla="*/ 47 w 47"/>
                <a:gd name="T33" fmla="*/ 0 h 42"/>
                <a:gd name="T34" fmla="*/ 47 w 47"/>
                <a:gd name="T35" fmla="*/ 7 h 42"/>
                <a:gd name="T36" fmla="*/ 0 w 47"/>
                <a:gd name="T37" fmla="*/ 7 h 42"/>
                <a:gd name="T38" fmla="*/ 0 w 47"/>
                <a:gd name="T39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7" h="42">
                  <a:moveTo>
                    <a:pt x="27" y="21"/>
                  </a:moveTo>
                  <a:lnTo>
                    <a:pt x="27" y="38"/>
                  </a:lnTo>
                  <a:lnTo>
                    <a:pt x="19" y="38"/>
                  </a:lnTo>
                  <a:lnTo>
                    <a:pt x="19" y="21"/>
                  </a:lnTo>
                  <a:lnTo>
                    <a:pt x="27" y="21"/>
                  </a:lnTo>
                  <a:close/>
                  <a:moveTo>
                    <a:pt x="19" y="21"/>
                  </a:moveTo>
                  <a:lnTo>
                    <a:pt x="19" y="3"/>
                  </a:lnTo>
                  <a:lnTo>
                    <a:pt x="27" y="3"/>
                  </a:lnTo>
                  <a:lnTo>
                    <a:pt x="27" y="21"/>
                  </a:lnTo>
                  <a:lnTo>
                    <a:pt x="19" y="21"/>
                  </a:lnTo>
                  <a:close/>
                  <a:moveTo>
                    <a:pt x="0" y="34"/>
                  </a:moveTo>
                  <a:lnTo>
                    <a:pt x="47" y="34"/>
                  </a:lnTo>
                  <a:lnTo>
                    <a:pt x="47" y="42"/>
                  </a:lnTo>
                  <a:lnTo>
                    <a:pt x="0" y="42"/>
                  </a:lnTo>
                  <a:lnTo>
                    <a:pt x="0" y="34"/>
                  </a:lnTo>
                  <a:close/>
                  <a:moveTo>
                    <a:pt x="0" y="0"/>
                  </a:moveTo>
                  <a:lnTo>
                    <a:pt x="47" y="0"/>
                  </a:lnTo>
                  <a:lnTo>
                    <a:pt x="4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Freeform 101"/>
            <p:cNvSpPr>
              <a:spLocks noEditPoints="1"/>
            </p:cNvSpPr>
            <p:nvPr/>
          </p:nvSpPr>
          <p:spPr bwMode="auto">
            <a:xfrm>
              <a:off x="6973808" y="2007519"/>
              <a:ext cx="77068" cy="126563"/>
            </a:xfrm>
            <a:custGeom>
              <a:avLst/>
              <a:gdLst>
                <a:gd name="T0" fmla="*/ 26 w 46"/>
                <a:gd name="T1" fmla="*/ 27 h 55"/>
                <a:gd name="T2" fmla="*/ 26 w 46"/>
                <a:gd name="T3" fmla="*/ 52 h 55"/>
                <a:gd name="T4" fmla="*/ 18 w 46"/>
                <a:gd name="T5" fmla="*/ 52 h 55"/>
                <a:gd name="T6" fmla="*/ 18 w 46"/>
                <a:gd name="T7" fmla="*/ 27 h 55"/>
                <a:gd name="T8" fmla="*/ 26 w 46"/>
                <a:gd name="T9" fmla="*/ 27 h 55"/>
                <a:gd name="T10" fmla="*/ 18 w 46"/>
                <a:gd name="T11" fmla="*/ 27 h 55"/>
                <a:gd name="T12" fmla="*/ 18 w 46"/>
                <a:gd name="T13" fmla="*/ 3 h 55"/>
                <a:gd name="T14" fmla="*/ 26 w 46"/>
                <a:gd name="T15" fmla="*/ 3 h 55"/>
                <a:gd name="T16" fmla="*/ 26 w 46"/>
                <a:gd name="T17" fmla="*/ 27 h 55"/>
                <a:gd name="T18" fmla="*/ 18 w 46"/>
                <a:gd name="T19" fmla="*/ 27 h 55"/>
                <a:gd name="T20" fmla="*/ 0 w 46"/>
                <a:gd name="T21" fmla="*/ 48 h 55"/>
                <a:gd name="T22" fmla="*/ 46 w 46"/>
                <a:gd name="T23" fmla="*/ 48 h 55"/>
                <a:gd name="T24" fmla="*/ 46 w 46"/>
                <a:gd name="T25" fmla="*/ 55 h 55"/>
                <a:gd name="T26" fmla="*/ 0 w 46"/>
                <a:gd name="T27" fmla="*/ 55 h 55"/>
                <a:gd name="T28" fmla="*/ 0 w 46"/>
                <a:gd name="T29" fmla="*/ 48 h 55"/>
                <a:gd name="T30" fmla="*/ 0 w 46"/>
                <a:gd name="T31" fmla="*/ 0 h 55"/>
                <a:gd name="T32" fmla="*/ 46 w 46"/>
                <a:gd name="T33" fmla="*/ 0 h 55"/>
                <a:gd name="T34" fmla="*/ 46 w 46"/>
                <a:gd name="T35" fmla="*/ 7 h 55"/>
                <a:gd name="T36" fmla="*/ 0 w 46"/>
                <a:gd name="T37" fmla="*/ 7 h 55"/>
                <a:gd name="T38" fmla="*/ 0 w 46"/>
                <a:gd name="T39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6" h="55">
                  <a:moveTo>
                    <a:pt x="26" y="27"/>
                  </a:moveTo>
                  <a:lnTo>
                    <a:pt x="26" y="52"/>
                  </a:lnTo>
                  <a:lnTo>
                    <a:pt x="18" y="52"/>
                  </a:lnTo>
                  <a:lnTo>
                    <a:pt x="18" y="27"/>
                  </a:lnTo>
                  <a:lnTo>
                    <a:pt x="26" y="27"/>
                  </a:lnTo>
                  <a:close/>
                  <a:moveTo>
                    <a:pt x="18" y="27"/>
                  </a:moveTo>
                  <a:lnTo>
                    <a:pt x="18" y="3"/>
                  </a:lnTo>
                  <a:lnTo>
                    <a:pt x="26" y="3"/>
                  </a:lnTo>
                  <a:lnTo>
                    <a:pt x="26" y="27"/>
                  </a:lnTo>
                  <a:lnTo>
                    <a:pt x="18" y="27"/>
                  </a:lnTo>
                  <a:close/>
                  <a:moveTo>
                    <a:pt x="0" y="48"/>
                  </a:moveTo>
                  <a:lnTo>
                    <a:pt x="46" y="48"/>
                  </a:lnTo>
                  <a:lnTo>
                    <a:pt x="46" y="55"/>
                  </a:lnTo>
                  <a:lnTo>
                    <a:pt x="0" y="55"/>
                  </a:lnTo>
                  <a:lnTo>
                    <a:pt x="0" y="48"/>
                  </a:lnTo>
                  <a:close/>
                  <a:moveTo>
                    <a:pt x="0" y="0"/>
                  </a:moveTo>
                  <a:lnTo>
                    <a:pt x="46" y="0"/>
                  </a:lnTo>
                  <a:lnTo>
                    <a:pt x="46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Freeform 102"/>
            <p:cNvSpPr>
              <a:spLocks noEditPoints="1"/>
            </p:cNvSpPr>
            <p:nvPr/>
          </p:nvSpPr>
          <p:spPr bwMode="auto">
            <a:xfrm>
              <a:off x="7917054" y="2025928"/>
              <a:ext cx="77068" cy="101250"/>
            </a:xfrm>
            <a:custGeom>
              <a:avLst/>
              <a:gdLst>
                <a:gd name="T0" fmla="*/ 27 w 46"/>
                <a:gd name="T1" fmla="*/ 21 h 44"/>
                <a:gd name="T2" fmla="*/ 27 w 46"/>
                <a:gd name="T3" fmla="*/ 40 h 44"/>
                <a:gd name="T4" fmla="*/ 20 w 46"/>
                <a:gd name="T5" fmla="*/ 40 h 44"/>
                <a:gd name="T6" fmla="*/ 20 w 46"/>
                <a:gd name="T7" fmla="*/ 21 h 44"/>
                <a:gd name="T8" fmla="*/ 27 w 46"/>
                <a:gd name="T9" fmla="*/ 21 h 44"/>
                <a:gd name="T10" fmla="*/ 20 w 46"/>
                <a:gd name="T11" fmla="*/ 21 h 44"/>
                <a:gd name="T12" fmla="*/ 20 w 46"/>
                <a:gd name="T13" fmla="*/ 4 h 44"/>
                <a:gd name="T14" fmla="*/ 27 w 46"/>
                <a:gd name="T15" fmla="*/ 4 h 44"/>
                <a:gd name="T16" fmla="*/ 27 w 46"/>
                <a:gd name="T17" fmla="*/ 21 h 44"/>
                <a:gd name="T18" fmla="*/ 20 w 46"/>
                <a:gd name="T19" fmla="*/ 21 h 44"/>
                <a:gd name="T20" fmla="*/ 0 w 46"/>
                <a:gd name="T21" fmla="*/ 36 h 44"/>
                <a:gd name="T22" fmla="*/ 46 w 46"/>
                <a:gd name="T23" fmla="*/ 36 h 44"/>
                <a:gd name="T24" fmla="*/ 46 w 46"/>
                <a:gd name="T25" fmla="*/ 44 h 44"/>
                <a:gd name="T26" fmla="*/ 0 w 46"/>
                <a:gd name="T27" fmla="*/ 44 h 44"/>
                <a:gd name="T28" fmla="*/ 0 w 46"/>
                <a:gd name="T29" fmla="*/ 36 h 44"/>
                <a:gd name="T30" fmla="*/ 0 w 46"/>
                <a:gd name="T31" fmla="*/ 0 h 44"/>
                <a:gd name="T32" fmla="*/ 46 w 46"/>
                <a:gd name="T33" fmla="*/ 0 h 44"/>
                <a:gd name="T34" fmla="*/ 46 w 46"/>
                <a:gd name="T35" fmla="*/ 8 h 44"/>
                <a:gd name="T36" fmla="*/ 0 w 46"/>
                <a:gd name="T37" fmla="*/ 8 h 44"/>
                <a:gd name="T38" fmla="*/ 0 w 46"/>
                <a:gd name="T39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6" h="44">
                  <a:moveTo>
                    <a:pt x="27" y="21"/>
                  </a:moveTo>
                  <a:lnTo>
                    <a:pt x="27" y="40"/>
                  </a:lnTo>
                  <a:lnTo>
                    <a:pt x="20" y="40"/>
                  </a:lnTo>
                  <a:lnTo>
                    <a:pt x="20" y="21"/>
                  </a:lnTo>
                  <a:lnTo>
                    <a:pt x="27" y="21"/>
                  </a:lnTo>
                  <a:close/>
                  <a:moveTo>
                    <a:pt x="20" y="21"/>
                  </a:moveTo>
                  <a:lnTo>
                    <a:pt x="20" y="4"/>
                  </a:lnTo>
                  <a:lnTo>
                    <a:pt x="27" y="4"/>
                  </a:lnTo>
                  <a:lnTo>
                    <a:pt x="27" y="21"/>
                  </a:lnTo>
                  <a:lnTo>
                    <a:pt x="20" y="21"/>
                  </a:lnTo>
                  <a:close/>
                  <a:moveTo>
                    <a:pt x="0" y="36"/>
                  </a:moveTo>
                  <a:lnTo>
                    <a:pt x="46" y="36"/>
                  </a:lnTo>
                  <a:lnTo>
                    <a:pt x="46" y="44"/>
                  </a:lnTo>
                  <a:lnTo>
                    <a:pt x="0" y="44"/>
                  </a:lnTo>
                  <a:lnTo>
                    <a:pt x="0" y="36"/>
                  </a:lnTo>
                  <a:close/>
                  <a:moveTo>
                    <a:pt x="0" y="0"/>
                  </a:moveTo>
                  <a:lnTo>
                    <a:pt x="46" y="0"/>
                  </a:lnTo>
                  <a:lnTo>
                    <a:pt x="46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Rectangle 103"/>
            <p:cNvSpPr>
              <a:spLocks noChangeArrowheads="1"/>
            </p:cNvSpPr>
            <p:nvPr/>
          </p:nvSpPr>
          <p:spPr bwMode="auto">
            <a:xfrm>
              <a:off x="5455902" y="1768201"/>
              <a:ext cx="11728" cy="1603893"/>
            </a:xfrm>
            <a:prstGeom prst="rect">
              <a:avLst/>
            </a:pr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Freeform 104"/>
            <p:cNvSpPr>
              <a:spLocks noEditPoints="1"/>
            </p:cNvSpPr>
            <p:nvPr/>
          </p:nvSpPr>
          <p:spPr bwMode="auto">
            <a:xfrm>
              <a:off x="5412342" y="1758996"/>
              <a:ext cx="50262" cy="1620000"/>
            </a:xfrm>
            <a:custGeom>
              <a:avLst/>
              <a:gdLst>
                <a:gd name="T0" fmla="*/ 0 w 30"/>
                <a:gd name="T1" fmla="*/ 697 h 704"/>
                <a:gd name="T2" fmla="*/ 30 w 30"/>
                <a:gd name="T3" fmla="*/ 697 h 704"/>
                <a:gd name="T4" fmla="*/ 30 w 30"/>
                <a:gd name="T5" fmla="*/ 704 h 704"/>
                <a:gd name="T6" fmla="*/ 0 w 30"/>
                <a:gd name="T7" fmla="*/ 704 h 704"/>
                <a:gd name="T8" fmla="*/ 0 w 30"/>
                <a:gd name="T9" fmla="*/ 697 h 704"/>
                <a:gd name="T10" fmla="*/ 0 w 30"/>
                <a:gd name="T11" fmla="*/ 557 h 704"/>
                <a:gd name="T12" fmla="*/ 30 w 30"/>
                <a:gd name="T13" fmla="*/ 557 h 704"/>
                <a:gd name="T14" fmla="*/ 30 w 30"/>
                <a:gd name="T15" fmla="*/ 565 h 704"/>
                <a:gd name="T16" fmla="*/ 0 w 30"/>
                <a:gd name="T17" fmla="*/ 565 h 704"/>
                <a:gd name="T18" fmla="*/ 0 w 30"/>
                <a:gd name="T19" fmla="*/ 557 h 704"/>
                <a:gd name="T20" fmla="*/ 0 w 30"/>
                <a:gd name="T21" fmla="*/ 417 h 704"/>
                <a:gd name="T22" fmla="*/ 30 w 30"/>
                <a:gd name="T23" fmla="*/ 417 h 704"/>
                <a:gd name="T24" fmla="*/ 30 w 30"/>
                <a:gd name="T25" fmla="*/ 425 h 704"/>
                <a:gd name="T26" fmla="*/ 0 w 30"/>
                <a:gd name="T27" fmla="*/ 425 h 704"/>
                <a:gd name="T28" fmla="*/ 0 w 30"/>
                <a:gd name="T29" fmla="*/ 417 h 704"/>
                <a:gd name="T30" fmla="*/ 0 w 30"/>
                <a:gd name="T31" fmla="*/ 278 h 704"/>
                <a:gd name="T32" fmla="*/ 30 w 30"/>
                <a:gd name="T33" fmla="*/ 278 h 704"/>
                <a:gd name="T34" fmla="*/ 30 w 30"/>
                <a:gd name="T35" fmla="*/ 286 h 704"/>
                <a:gd name="T36" fmla="*/ 0 w 30"/>
                <a:gd name="T37" fmla="*/ 286 h 704"/>
                <a:gd name="T38" fmla="*/ 0 w 30"/>
                <a:gd name="T39" fmla="*/ 278 h 704"/>
                <a:gd name="T40" fmla="*/ 0 w 30"/>
                <a:gd name="T41" fmla="*/ 139 h 704"/>
                <a:gd name="T42" fmla="*/ 30 w 30"/>
                <a:gd name="T43" fmla="*/ 139 h 704"/>
                <a:gd name="T44" fmla="*/ 30 w 30"/>
                <a:gd name="T45" fmla="*/ 146 h 704"/>
                <a:gd name="T46" fmla="*/ 0 w 30"/>
                <a:gd name="T47" fmla="*/ 146 h 704"/>
                <a:gd name="T48" fmla="*/ 0 w 30"/>
                <a:gd name="T49" fmla="*/ 139 h 704"/>
                <a:gd name="T50" fmla="*/ 0 w 30"/>
                <a:gd name="T51" fmla="*/ 0 h 704"/>
                <a:gd name="T52" fmla="*/ 30 w 30"/>
                <a:gd name="T53" fmla="*/ 0 h 704"/>
                <a:gd name="T54" fmla="*/ 30 w 30"/>
                <a:gd name="T55" fmla="*/ 7 h 704"/>
                <a:gd name="T56" fmla="*/ 0 w 30"/>
                <a:gd name="T57" fmla="*/ 7 h 704"/>
                <a:gd name="T58" fmla="*/ 0 w 30"/>
                <a:gd name="T59" fmla="*/ 0 h 7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30" h="704">
                  <a:moveTo>
                    <a:pt x="0" y="697"/>
                  </a:moveTo>
                  <a:lnTo>
                    <a:pt x="30" y="697"/>
                  </a:lnTo>
                  <a:lnTo>
                    <a:pt x="30" y="704"/>
                  </a:lnTo>
                  <a:lnTo>
                    <a:pt x="0" y="704"/>
                  </a:lnTo>
                  <a:lnTo>
                    <a:pt x="0" y="697"/>
                  </a:lnTo>
                  <a:close/>
                  <a:moveTo>
                    <a:pt x="0" y="557"/>
                  </a:moveTo>
                  <a:lnTo>
                    <a:pt x="30" y="557"/>
                  </a:lnTo>
                  <a:lnTo>
                    <a:pt x="30" y="565"/>
                  </a:lnTo>
                  <a:lnTo>
                    <a:pt x="0" y="565"/>
                  </a:lnTo>
                  <a:lnTo>
                    <a:pt x="0" y="557"/>
                  </a:lnTo>
                  <a:close/>
                  <a:moveTo>
                    <a:pt x="0" y="417"/>
                  </a:moveTo>
                  <a:lnTo>
                    <a:pt x="30" y="417"/>
                  </a:lnTo>
                  <a:lnTo>
                    <a:pt x="30" y="425"/>
                  </a:lnTo>
                  <a:lnTo>
                    <a:pt x="0" y="425"/>
                  </a:lnTo>
                  <a:lnTo>
                    <a:pt x="0" y="417"/>
                  </a:lnTo>
                  <a:close/>
                  <a:moveTo>
                    <a:pt x="0" y="278"/>
                  </a:moveTo>
                  <a:lnTo>
                    <a:pt x="30" y="278"/>
                  </a:lnTo>
                  <a:lnTo>
                    <a:pt x="30" y="286"/>
                  </a:lnTo>
                  <a:lnTo>
                    <a:pt x="0" y="286"/>
                  </a:lnTo>
                  <a:lnTo>
                    <a:pt x="0" y="278"/>
                  </a:lnTo>
                  <a:close/>
                  <a:moveTo>
                    <a:pt x="0" y="139"/>
                  </a:moveTo>
                  <a:lnTo>
                    <a:pt x="30" y="139"/>
                  </a:lnTo>
                  <a:lnTo>
                    <a:pt x="30" y="146"/>
                  </a:lnTo>
                  <a:lnTo>
                    <a:pt x="0" y="146"/>
                  </a:lnTo>
                  <a:lnTo>
                    <a:pt x="0" y="139"/>
                  </a:lnTo>
                  <a:close/>
                  <a:moveTo>
                    <a:pt x="0" y="0"/>
                  </a:moveTo>
                  <a:lnTo>
                    <a:pt x="30" y="0"/>
                  </a:lnTo>
                  <a:lnTo>
                    <a:pt x="30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Rectangle 105"/>
            <p:cNvSpPr>
              <a:spLocks noChangeArrowheads="1"/>
            </p:cNvSpPr>
            <p:nvPr/>
          </p:nvSpPr>
          <p:spPr bwMode="auto">
            <a:xfrm>
              <a:off x="5462604" y="3362887"/>
              <a:ext cx="2829738" cy="16109"/>
            </a:xfrm>
            <a:prstGeom prst="rect">
              <a:avLst/>
            </a:pr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54" name="グループ化 153"/>
          <p:cNvGrpSpPr/>
          <p:nvPr/>
        </p:nvGrpSpPr>
        <p:grpSpPr>
          <a:xfrm>
            <a:off x="5426631" y="3649662"/>
            <a:ext cx="2880000" cy="1620000"/>
            <a:chOff x="5426631" y="4297362"/>
            <a:chExt cx="2880000" cy="1620000"/>
          </a:xfrm>
        </p:grpSpPr>
        <p:sp>
          <p:nvSpPr>
            <p:cNvPr id="82" name="Rectangle 129"/>
            <p:cNvSpPr>
              <a:spLocks noChangeArrowheads="1"/>
            </p:cNvSpPr>
            <p:nvPr/>
          </p:nvSpPr>
          <p:spPr bwMode="auto">
            <a:xfrm>
              <a:off x="5711523" y="4303072"/>
              <a:ext cx="210647" cy="1606674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Freeform 130"/>
            <p:cNvSpPr>
              <a:spLocks noEditPoints="1"/>
            </p:cNvSpPr>
            <p:nvPr/>
          </p:nvSpPr>
          <p:spPr bwMode="auto">
            <a:xfrm>
              <a:off x="5704616" y="4297362"/>
              <a:ext cx="222734" cy="1620000"/>
            </a:xfrm>
            <a:custGeom>
              <a:avLst/>
              <a:gdLst>
                <a:gd name="T0" fmla="*/ 0 w 1616"/>
                <a:gd name="T1" fmla="*/ 48 h 10640"/>
                <a:gd name="T2" fmla="*/ 48 w 1616"/>
                <a:gd name="T3" fmla="*/ 0 h 10640"/>
                <a:gd name="T4" fmla="*/ 1568 w 1616"/>
                <a:gd name="T5" fmla="*/ 0 h 10640"/>
                <a:gd name="T6" fmla="*/ 1616 w 1616"/>
                <a:gd name="T7" fmla="*/ 48 h 10640"/>
                <a:gd name="T8" fmla="*/ 1616 w 1616"/>
                <a:gd name="T9" fmla="*/ 10592 h 10640"/>
                <a:gd name="T10" fmla="*/ 1568 w 1616"/>
                <a:gd name="T11" fmla="*/ 10640 h 10640"/>
                <a:gd name="T12" fmla="*/ 48 w 1616"/>
                <a:gd name="T13" fmla="*/ 10640 h 10640"/>
                <a:gd name="T14" fmla="*/ 0 w 1616"/>
                <a:gd name="T15" fmla="*/ 10592 h 10640"/>
                <a:gd name="T16" fmla="*/ 0 w 1616"/>
                <a:gd name="T17" fmla="*/ 48 h 10640"/>
                <a:gd name="T18" fmla="*/ 96 w 1616"/>
                <a:gd name="T19" fmla="*/ 10592 h 10640"/>
                <a:gd name="T20" fmla="*/ 48 w 1616"/>
                <a:gd name="T21" fmla="*/ 10544 h 10640"/>
                <a:gd name="T22" fmla="*/ 1568 w 1616"/>
                <a:gd name="T23" fmla="*/ 10544 h 10640"/>
                <a:gd name="T24" fmla="*/ 1520 w 1616"/>
                <a:gd name="T25" fmla="*/ 10592 h 10640"/>
                <a:gd name="T26" fmla="*/ 1520 w 1616"/>
                <a:gd name="T27" fmla="*/ 48 h 10640"/>
                <a:gd name="T28" fmla="*/ 1568 w 1616"/>
                <a:gd name="T29" fmla="*/ 96 h 10640"/>
                <a:gd name="T30" fmla="*/ 48 w 1616"/>
                <a:gd name="T31" fmla="*/ 96 h 10640"/>
                <a:gd name="T32" fmla="*/ 96 w 1616"/>
                <a:gd name="T33" fmla="*/ 48 h 10640"/>
                <a:gd name="T34" fmla="*/ 96 w 1616"/>
                <a:gd name="T35" fmla="*/ 10592 h 106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16" h="10640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68" y="0"/>
                  </a:lnTo>
                  <a:cubicBezTo>
                    <a:pt x="1595" y="0"/>
                    <a:pt x="1616" y="22"/>
                    <a:pt x="1616" y="48"/>
                  </a:cubicBezTo>
                  <a:lnTo>
                    <a:pt x="1616" y="10592"/>
                  </a:lnTo>
                  <a:cubicBezTo>
                    <a:pt x="1616" y="10619"/>
                    <a:pt x="1595" y="10640"/>
                    <a:pt x="1568" y="10640"/>
                  </a:cubicBezTo>
                  <a:lnTo>
                    <a:pt x="48" y="10640"/>
                  </a:lnTo>
                  <a:cubicBezTo>
                    <a:pt x="22" y="10640"/>
                    <a:pt x="0" y="10619"/>
                    <a:pt x="0" y="10592"/>
                  </a:cubicBezTo>
                  <a:lnTo>
                    <a:pt x="0" y="48"/>
                  </a:lnTo>
                  <a:close/>
                  <a:moveTo>
                    <a:pt x="96" y="10592"/>
                  </a:moveTo>
                  <a:lnTo>
                    <a:pt x="48" y="10544"/>
                  </a:lnTo>
                  <a:lnTo>
                    <a:pt x="1568" y="10544"/>
                  </a:lnTo>
                  <a:lnTo>
                    <a:pt x="1520" y="10592"/>
                  </a:lnTo>
                  <a:lnTo>
                    <a:pt x="1520" y="48"/>
                  </a:lnTo>
                  <a:lnTo>
                    <a:pt x="1568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05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Rectangle 131"/>
            <p:cNvSpPr>
              <a:spLocks noChangeArrowheads="1"/>
            </p:cNvSpPr>
            <p:nvPr/>
          </p:nvSpPr>
          <p:spPr bwMode="auto">
            <a:xfrm>
              <a:off x="6652530" y="4303072"/>
              <a:ext cx="212375" cy="1606674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Freeform 132"/>
            <p:cNvSpPr>
              <a:spLocks noEditPoints="1"/>
            </p:cNvSpPr>
            <p:nvPr/>
          </p:nvSpPr>
          <p:spPr bwMode="auto">
            <a:xfrm>
              <a:off x="6645624" y="4297362"/>
              <a:ext cx="226188" cy="1620000"/>
            </a:xfrm>
            <a:custGeom>
              <a:avLst/>
              <a:gdLst>
                <a:gd name="T0" fmla="*/ 0 w 1632"/>
                <a:gd name="T1" fmla="*/ 48 h 10640"/>
                <a:gd name="T2" fmla="*/ 48 w 1632"/>
                <a:gd name="T3" fmla="*/ 0 h 10640"/>
                <a:gd name="T4" fmla="*/ 1584 w 1632"/>
                <a:gd name="T5" fmla="*/ 0 h 10640"/>
                <a:gd name="T6" fmla="*/ 1632 w 1632"/>
                <a:gd name="T7" fmla="*/ 48 h 10640"/>
                <a:gd name="T8" fmla="*/ 1632 w 1632"/>
                <a:gd name="T9" fmla="*/ 10592 h 10640"/>
                <a:gd name="T10" fmla="*/ 1584 w 1632"/>
                <a:gd name="T11" fmla="*/ 10640 h 10640"/>
                <a:gd name="T12" fmla="*/ 48 w 1632"/>
                <a:gd name="T13" fmla="*/ 10640 h 10640"/>
                <a:gd name="T14" fmla="*/ 0 w 1632"/>
                <a:gd name="T15" fmla="*/ 10592 h 10640"/>
                <a:gd name="T16" fmla="*/ 0 w 1632"/>
                <a:gd name="T17" fmla="*/ 48 h 10640"/>
                <a:gd name="T18" fmla="*/ 96 w 1632"/>
                <a:gd name="T19" fmla="*/ 10592 h 10640"/>
                <a:gd name="T20" fmla="*/ 48 w 1632"/>
                <a:gd name="T21" fmla="*/ 10544 h 10640"/>
                <a:gd name="T22" fmla="*/ 1584 w 1632"/>
                <a:gd name="T23" fmla="*/ 10544 h 10640"/>
                <a:gd name="T24" fmla="*/ 1536 w 1632"/>
                <a:gd name="T25" fmla="*/ 10592 h 10640"/>
                <a:gd name="T26" fmla="*/ 1536 w 1632"/>
                <a:gd name="T27" fmla="*/ 48 h 10640"/>
                <a:gd name="T28" fmla="*/ 1584 w 1632"/>
                <a:gd name="T29" fmla="*/ 96 h 10640"/>
                <a:gd name="T30" fmla="*/ 48 w 1632"/>
                <a:gd name="T31" fmla="*/ 96 h 10640"/>
                <a:gd name="T32" fmla="*/ 96 w 1632"/>
                <a:gd name="T33" fmla="*/ 48 h 10640"/>
                <a:gd name="T34" fmla="*/ 96 w 1632"/>
                <a:gd name="T35" fmla="*/ 10592 h 106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10640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10592"/>
                  </a:lnTo>
                  <a:cubicBezTo>
                    <a:pt x="1632" y="10619"/>
                    <a:pt x="1611" y="10640"/>
                    <a:pt x="1584" y="10640"/>
                  </a:cubicBezTo>
                  <a:lnTo>
                    <a:pt x="48" y="10640"/>
                  </a:lnTo>
                  <a:cubicBezTo>
                    <a:pt x="22" y="10640"/>
                    <a:pt x="0" y="10619"/>
                    <a:pt x="0" y="10592"/>
                  </a:cubicBezTo>
                  <a:lnTo>
                    <a:pt x="0" y="48"/>
                  </a:lnTo>
                  <a:close/>
                  <a:moveTo>
                    <a:pt x="96" y="10592"/>
                  </a:moveTo>
                  <a:lnTo>
                    <a:pt x="48" y="10544"/>
                  </a:lnTo>
                  <a:lnTo>
                    <a:pt x="1584" y="10544"/>
                  </a:lnTo>
                  <a:lnTo>
                    <a:pt x="1536" y="10592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05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Rectangle 133"/>
            <p:cNvSpPr>
              <a:spLocks noChangeArrowheads="1"/>
            </p:cNvSpPr>
            <p:nvPr/>
          </p:nvSpPr>
          <p:spPr bwMode="auto">
            <a:xfrm>
              <a:off x="7595264" y="4303072"/>
              <a:ext cx="212375" cy="1606674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Freeform 134"/>
            <p:cNvSpPr>
              <a:spLocks noEditPoints="1"/>
            </p:cNvSpPr>
            <p:nvPr/>
          </p:nvSpPr>
          <p:spPr bwMode="auto">
            <a:xfrm>
              <a:off x="7588358" y="4297362"/>
              <a:ext cx="226188" cy="1620000"/>
            </a:xfrm>
            <a:custGeom>
              <a:avLst/>
              <a:gdLst>
                <a:gd name="T0" fmla="*/ 0 w 1632"/>
                <a:gd name="T1" fmla="*/ 48 h 10640"/>
                <a:gd name="T2" fmla="*/ 48 w 1632"/>
                <a:gd name="T3" fmla="*/ 0 h 10640"/>
                <a:gd name="T4" fmla="*/ 1584 w 1632"/>
                <a:gd name="T5" fmla="*/ 0 h 10640"/>
                <a:gd name="T6" fmla="*/ 1632 w 1632"/>
                <a:gd name="T7" fmla="*/ 48 h 10640"/>
                <a:gd name="T8" fmla="*/ 1632 w 1632"/>
                <a:gd name="T9" fmla="*/ 10592 h 10640"/>
                <a:gd name="T10" fmla="*/ 1584 w 1632"/>
                <a:gd name="T11" fmla="*/ 10640 h 10640"/>
                <a:gd name="T12" fmla="*/ 48 w 1632"/>
                <a:gd name="T13" fmla="*/ 10640 h 10640"/>
                <a:gd name="T14" fmla="*/ 0 w 1632"/>
                <a:gd name="T15" fmla="*/ 10592 h 10640"/>
                <a:gd name="T16" fmla="*/ 0 w 1632"/>
                <a:gd name="T17" fmla="*/ 48 h 10640"/>
                <a:gd name="T18" fmla="*/ 96 w 1632"/>
                <a:gd name="T19" fmla="*/ 10592 h 10640"/>
                <a:gd name="T20" fmla="*/ 48 w 1632"/>
                <a:gd name="T21" fmla="*/ 10544 h 10640"/>
                <a:gd name="T22" fmla="*/ 1584 w 1632"/>
                <a:gd name="T23" fmla="*/ 10544 h 10640"/>
                <a:gd name="T24" fmla="*/ 1536 w 1632"/>
                <a:gd name="T25" fmla="*/ 10592 h 10640"/>
                <a:gd name="T26" fmla="*/ 1536 w 1632"/>
                <a:gd name="T27" fmla="*/ 48 h 10640"/>
                <a:gd name="T28" fmla="*/ 1584 w 1632"/>
                <a:gd name="T29" fmla="*/ 96 h 10640"/>
                <a:gd name="T30" fmla="*/ 48 w 1632"/>
                <a:gd name="T31" fmla="*/ 96 h 10640"/>
                <a:gd name="T32" fmla="*/ 96 w 1632"/>
                <a:gd name="T33" fmla="*/ 48 h 10640"/>
                <a:gd name="T34" fmla="*/ 96 w 1632"/>
                <a:gd name="T35" fmla="*/ 10592 h 106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10640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10592"/>
                  </a:lnTo>
                  <a:cubicBezTo>
                    <a:pt x="1632" y="10619"/>
                    <a:pt x="1611" y="10640"/>
                    <a:pt x="1584" y="10640"/>
                  </a:cubicBezTo>
                  <a:lnTo>
                    <a:pt x="48" y="10640"/>
                  </a:lnTo>
                  <a:cubicBezTo>
                    <a:pt x="22" y="10640"/>
                    <a:pt x="0" y="10619"/>
                    <a:pt x="0" y="10592"/>
                  </a:cubicBezTo>
                  <a:lnTo>
                    <a:pt x="0" y="48"/>
                  </a:lnTo>
                  <a:close/>
                  <a:moveTo>
                    <a:pt x="96" y="10592"/>
                  </a:moveTo>
                  <a:lnTo>
                    <a:pt x="48" y="10544"/>
                  </a:lnTo>
                  <a:lnTo>
                    <a:pt x="1584" y="10544"/>
                  </a:lnTo>
                  <a:lnTo>
                    <a:pt x="1536" y="10592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105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Rectangle 135"/>
            <p:cNvSpPr>
              <a:spLocks noChangeArrowheads="1"/>
            </p:cNvSpPr>
            <p:nvPr/>
          </p:nvSpPr>
          <p:spPr bwMode="auto">
            <a:xfrm>
              <a:off x="5979149" y="4466786"/>
              <a:ext cx="212375" cy="144296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Freeform 136"/>
            <p:cNvSpPr>
              <a:spLocks noEditPoints="1"/>
            </p:cNvSpPr>
            <p:nvPr/>
          </p:nvSpPr>
          <p:spPr bwMode="auto">
            <a:xfrm>
              <a:off x="5972243" y="4459171"/>
              <a:ext cx="224460" cy="1458190"/>
            </a:xfrm>
            <a:custGeom>
              <a:avLst/>
              <a:gdLst>
                <a:gd name="T0" fmla="*/ 0 w 1632"/>
                <a:gd name="T1" fmla="*/ 48 h 9568"/>
                <a:gd name="T2" fmla="*/ 48 w 1632"/>
                <a:gd name="T3" fmla="*/ 0 h 9568"/>
                <a:gd name="T4" fmla="*/ 1584 w 1632"/>
                <a:gd name="T5" fmla="*/ 0 h 9568"/>
                <a:gd name="T6" fmla="*/ 1632 w 1632"/>
                <a:gd name="T7" fmla="*/ 48 h 9568"/>
                <a:gd name="T8" fmla="*/ 1632 w 1632"/>
                <a:gd name="T9" fmla="*/ 9520 h 9568"/>
                <a:gd name="T10" fmla="*/ 1584 w 1632"/>
                <a:gd name="T11" fmla="*/ 9568 h 9568"/>
                <a:gd name="T12" fmla="*/ 48 w 1632"/>
                <a:gd name="T13" fmla="*/ 9568 h 9568"/>
                <a:gd name="T14" fmla="*/ 0 w 1632"/>
                <a:gd name="T15" fmla="*/ 9520 h 9568"/>
                <a:gd name="T16" fmla="*/ 0 w 1632"/>
                <a:gd name="T17" fmla="*/ 48 h 9568"/>
                <a:gd name="T18" fmla="*/ 96 w 1632"/>
                <a:gd name="T19" fmla="*/ 9520 h 9568"/>
                <a:gd name="T20" fmla="*/ 48 w 1632"/>
                <a:gd name="T21" fmla="*/ 9472 h 9568"/>
                <a:gd name="T22" fmla="*/ 1584 w 1632"/>
                <a:gd name="T23" fmla="*/ 9472 h 9568"/>
                <a:gd name="T24" fmla="*/ 1536 w 1632"/>
                <a:gd name="T25" fmla="*/ 9520 h 9568"/>
                <a:gd name="T26" fmla="*/ 1536 w 1632"/>
                <a:gd name="T27" fmla="*/ 48 h 9568"/>
                <a:gd name="T28" fmla="*/ 1584 w 1632"/>
                <a:gd name="T29" fmla="*/ 96 h 9568"/>
                <a:gd name="T30" fmla="*/ 48 w 1632"/>
                <a:gd name="T31" fmla="*/ 96 h 9568"/>
                <a:gd name="T32" fmla="*/ 96 w 1632"/>
                <a:gd name="T33" fmla="*/ 48 h 9568"/>
                <a:gd name="T34" fmla="*/ 96 w 1632"/>
                <a:gd name="T35" fmla="*/ 9520 h 95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9568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9520"/>
                  </a:lnTo>
                  <a:cubicBezTo>
                    <a:pt x="1632" y="9547"/>
                    <a:pt x="1611" y="9568"/>
                    <a:pt x="1584" y="9568"/>
                  </a:cubicBezTo>
                  <a:lnTo>
                    <a:pt x="48" y="9568"/>
                  </a:lnTo>
                  <a:cubicBezTo>
                    <a:pt x="22" y="9568"/>
                    <a:pt x="0" y="9547"/>
                    <a:pt x="0" y="9520"/>
                  </a:cubicBezTo>
                  <a:lnTo>
                    <a:pt x="0" y="48"/>
                  </a:lnTo>
                  <a:close/>
                  <a:moveTo>
                    <a:pt x="96" y="9520"/>
                  </a:moveTo>
                  <a:lnTo>
                    <a:pt x="48" y="9472"/>
                  </a:lnTo>
                  <a:lnTo>
                    <a:pt x="1584" y="9472"/>
                  </a:lnTo>
                  <a:lnTo>
                    <a:pt x="1536" y="9520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952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Rectangle 137"/>
            <p:cNvSpPr>
              <a:spLocks noChangeArrowheads="1"/>
            </p:cNvSpPr>
            <p:nvPr/>
          </p:nvSpPr>
          <p:spPr bwMode="auto">
            <a:xfrm>
              <a:off x="6921883" y="4855129"/>
              <a:ext cx="212375" cy="10546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Freeform 138"/>
            <p:cNvSpPr>
              <a:spLocks noEditPoints="1"/>
            </p:cNvSpPr>
            <p:nvPr/>
          </p:nvSpPr>
          <p:spPr bwMode="auto">
            <a:xfrm>
              <a:off x="6914976" y="4847514"/>
              <a:ext cx="226188" cy="1069847"/>
            </a:xfrm>
            <a:custGeom>
              <a:avLst/>
              <a:gdLst>
                <a:gd name="T0" fmla="*/ 0 w 1632"/>
                <a:gd name="T1" fmla="*/ 48 h 7024"/>
                <a:gd name="T2" fmla="*/ 48 w 1632"/>
                <a:gd name="T3" fmla="*/ 0 h 7024"/>
                <a:gd name="T4" fmla="*/ 1584 w 1632"/>
                <a:gd name="T5" fmla="*/ 0 h 7024"/>
                <a:gd name="T6" fmla="*/ 1632 w 1632"/>
                <a:gd name="T7" fmla="*/ 48 h 7024"/>
                <a:gd name="T8" fmla="*/ 1632 w 1632"/>
                <a:gd name="T9" fmla="*/ 6976 h 7024"/>
                <a:gd name="T10" fmla="*/ 1584 w 1632"/>
                <a:gd name="T11" fmla="*/ 7024 h 7024"/>
                <a:gd name="T12" fmla="*/ 48 w 1632"/>
                <a:gd name="T13" fmla="*/ 7024 h 7024"/>
                <a:gd name="T14" fmla="*/ 0 w 1632"/>
                <a:gd name="T15" fmla="*/ 6976 h 7024"/>
                <a:gd name="T16" fmla="*/ 0 w 1632"/>
                <a:gd name="T17" fmla="*/ 48 h 7024"/>
                <a:gd name="T18" fmla="*/ 96 w 1632"/>
                <a:gd name="T19" fmla="*/ 6976 h 7024"/>
                <a:gd name="T20" fmla="*/ 48 w 1632"/>
                <a:gd name="T21" fmla="*/ 6928 h 7024"/>
                <a:gd name="T22" fmla="*/ 1584 w 1632"/>
                <a:gd name="T23" fmla="*/ 6928 h 7024"/>
                <a:gd name="T24" fmla="*/ 1536 w 1632"/>
                <a:gd name="T25" fmla="*/ 6976 h 7024"/>
                <a:gd name="T26" fmla="*/ 1536 w 1632"/>
                <a:gd name="T27" fmla="*/ 48 h 7024"/>
                <a:gd name="T28" fmla="*/ 1584 w 1632"/>
                <a:gd name="T29" fmla="*/ 96 h 7024"/>
                <a:gd name="T30" fmla="*/ 48 w 1632"/>
                <a:gd name="T31" fmla="*/ 96 h 7024"/>
                <a:gd name="T32" fmla="*/ 96 w 1632"/>
                <a:gd name="T33" fmla="*/ 48 h 7024"/>
                <a:gd name="T34" fmla="*/ 96 w 1632"/>
                <a:gd name="T35" fmla="*/ 6976 h 70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702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6976"/>
                  </a:lnTo>
                  <a:cubicBezTo>
                    <a:pt x="1632" y="7003"/>
                    <a:pt x="1611" y="7024"/>
                    <a:pt x="1584" y="7024"/>
                  </a:cubicBezTo>
                  <a:lnTo>
                    <a:pt x="48" y="7024"/>
                  </a:lnTo>
                  <a:cubicBezTo>
                    <a:pt x="22" y="7024"/>
                    <a:pt x="0" y="7003"/>
                    <a:pt x="0" y="6976"/>
                  </a:cubicBezTo>
                  <a:lnTo>
                    <a:pt x="0" y="48"/>
                  </a:lnTo>
                  <a:close/>
                  <a:moveTo>
                    <a:pt x="96" y="6976"/>
                  </a:moveTo>
                  <a:lnTo>
                    <a:pt x="48" y="6928"/>
                  </a:lnTo>
                  <a:lnTo>
                    <a:pt x="1584" y="6928"/>
                  </a:lnTo>
                  <a:lnTo>
                    <a:pt x="1536" y="6976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697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Rectangle 139"/>
            <p:cNvSpPr>
              <a:spLocks noChangeArrowheads="1"/>
            </p:cNvSpPr>
            <p:nvPr/>
          </p:nvSpPr>
          <p:spPr bwMode="auto">
            <a:xfrm>
              <a:off x="7864617" y="5146386"/>
              <a:ext cx="212375" cy="76336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Freeform 140"/>
            <p:cNvSpPr>
              <a:spLocks noEditPoints="1"/>
            </p:cNvSpPr>
            <p:nvPr/>
          </p:nvSpPr>
          <p:spPr bwMode="auto">
            <a:xfrm>
              <a:off x="7859436" y="5140675"/>
              <a:ext cx="224460" cy="776686"/>
            </a:xfrm>
            <a:custGeom>
              <a:avLst/>
              <a:gdLst>
                <a:gd name="T0" fmla="*/ 0 w 1632"/>
                <a:gd name="T1" fmla="*/ 48 h 5104"/>
                <a:gd name="T2" fmla="*/ 48 w 1632"/>
                <a:gd name="T3" fmla="*/ 0 h 5104"/>
                <a:gd name="T4" fmla="*/ 1584 w 1632"/>
                <a:gd name="T5" fmla="*/ 0 h 5104"/>
                <a:gd name="T6" fmla="*/ 1632 w 1632"/>
                <a:gd name="T7" fmla="*/ 48 h 5104"/>
                <a:gd name="T8" fmla="*/ 1632 w 1632"/>
                <a:gd name="T9" fmla="*/ 5056 h 5104"/>
                <a:gd name="T10" fmla="*/ 1584 w 1632"/>
                <a:gd name="T11" fmla="*/ 5104 h 5104"/>
                <a:gd name="T12" fmla="*/ 48 w 1632"/>
                <a:gd name="T13" fmla="*/ 5104 h 5104"/>
                <a:gd name="T14" fmla="*/ 0 w 1632"/>
                <a:gd name="T15" fmla="*/ 5056 h 5104"/>
                <a:gd name="T16" fmla="*/ 0 w 1632"/>
                <a:gd name="T17" fmla="*/ 48 h 5104"/>
                <a:gd name="T18" fmla="*/ 96 w 1632"/>
                <a:gd name="T19" fmla="*/ 5056 h 5104"/>
                <a:gd name="T20" fmla="*/ 48 w 1632"/>
                <a:gd name="T21" fmla="*/ 5008 h 5104"/>
                <a:gd name="T22" fmla="*/ 1584 w 1632"/>
                <a:gd name="T23" fmla="*/ 5008 h 5104"/>
                <a:gd name="T24" fmla="*/ 1536 w 1632"/>
                <a:gd name="T25" fmla="*/ 5056 h 5104"/>
                <a:gd name="T26" fmla="*/ 1536 w 1632"/>
                <a:gd name="T27" fmla="*/ 48 h 5104"/>
                <a:gd name="T28" fmla="*/ 1584 w 1632"/>
                <a:gd name="T29" fmla="*/ 96 h 5104"/>
                <a:gd name="T30" fmla="*/ 48 w 1632"/>
                <a:gd name="T31" fmla="*/ 96 h 5104"/>
                <a:gd name="T32" fmla="*/ 96 w 1632"/>
                <a:gd name="T33" fmla="*/ 48 h 5104"/>
                <a:gd name="T34" fmla="*/ 96 w 1632"/>
                <a:gd name="T35" fmla="*/ 5056 h 5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32" h="5104">
                  <a:moveTo>
                    <a:pt x="0" y="48"/>
                  </a:moveTo>
                  <a:cubicBezTo>
                    <a:pt x="0" y="22"/>
                    <a:pt x="22" y="0"/>
                    <a:pt x="48" y="0"/>
                  </a:cubicBezTo>
                  <a:lnTo>
                    <a:pt x="1584" y="0"/>
                  </a:lnTo>
                  <a:cubicBezTo>
                    <a:pt x="1611" y="0"/>
                    <a:pt x="1632" y="22"/>
                    <a:pt x="1632" y="48"/>
                  </a:cubicBezTo>
                  <a:lnTo>
                    <a:pt x="1632" y="5056"/>
                  </a:lnTo>
                  <a:cubicBezTo>
                    <a:pt x="1632" y="5083"/>
                    <a:pt x="1611" y="5104"/>
                    <a:pt x="1584" y="5104"/>
                  </a:cubicBezTo>
                  <a:lnTo>
                    <a:pt x="48" y="5104"/>
                  </a:lnTo>
                  <a:cubicBezTo>
                    <a:pt x="22" y="5104"/>
                    <a:pt x="0" y="5083"/>
                    <a:pt x="0" y="5056"/>
                  </a:cubicBezTo>
                  <a:lnTo>
                    <a:pt x="0" y="48"/>
                  </a:lnTo>
                  <a:close/>
                  <a:moveTo>
                    <a:pt x="96" y="5056"/>
                  </a:moveTo>
                  <a:lnTo>
                    <a:pt x="48" y="5008"/>
                  </a:lnTo>
                  <a:lnTo>
                    <a:pt x="1584" y="5008"/>
                  </a:lnTo>
                  <a:lnTo>
                    <a:pt x="1536" y="5056"/>
                  </a:lnTo>
                  <a:lnTo>
                    <a:pt x="1536" y="48"/>
                  </a:lnTo>
                  <a:lnTo>
                    <a:pt x="1584" y="96"/>
                  </a:lnTo>
                  <a:lnTo>
                    <a:pt x="48" y="96"/>
                  </a:lnTo>
                  <a:lnTo>
                    <a:pt x="96" y="48"/>
                  </a:lnTo>
                  <a:lnTo>
                    <a:pt x="96" y="5056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Freeform 141"/>
            <p:cNvSpPr>
              <a:spLocks noEditPoints="1"/>
            </p:cNvSpPr>
            <p:nvPr/>
          </p:nvSpPr>
          <p:spPr bwMode="auto">
            <a:xfrm>
              <a:off x="6043033" y="4405869"/>
              <a:ext cx="84605" cy="121833"/>
            </a:xfrm>
            <a:custGeom>
              <a:avLst/>
              <a:gdLst>
                <a:gd name="T0" fmla="*/ 28 w 49"/>
                <a:gd name="T1" fmla="*/ 32 h 64"/>
                <a:gd name="T2" fmla="*/ 28 w 49"/>
                <a:gd name="T3" fmla="*/ 60 h 64"/>
                <a:gd name="T4" fmla="*/ 20 w 49"/>
                <a:gd name="T5" fmla="*/ 60 h 64"/>
                <a:gd name="T6" fmla="*/ 20 w 49"/>
                <a:gd name="T7" fmla="*/ 32 h 64"/>
                <a:gd name="T8" fmla="*/ 28 w 49"/>
                <a:gd name="T9" fmla="*/ 32 h 64"/>
                <a:gd name="T10" fmla="*/ 20 w 49"/>
                <a:gd name="T11" fmla="*/ 32 h 64"/>
                <a:gd name="T12" fmla="*/ 20 w 49"/>
                <a:gd name="T13" fmla="*/ 4 h 64"/>
                <a:gd name="T14" fmla="*/ 28 w 49"/>
                <a:gd name="T15" fmla="*/ 4 h 64"/>
                <a:gd name="T16" fmla="*/ 28 w 49"/>
                <a:gd name="T17" fmla="*/ 32 h 64"/>
                <a:gd name="T18" fmla="*/ 20 w 49"/>
                <a:gd name="T19" fmla="*/ 32 h 64"/>
                <a:gd name="T20" fmla="*/ 0 w 49"/>
                <a:gd name="T21" fmla="*/ 57 h 64"/>
                <a:gd name="T22" fmla="*/ 49 w 49"/>
                <a:gd name="T23" fmla="*/ 57 h 64"/>
                <a:gd name="T24" fmla="*/ 49 w 49"/>
                <a:gd name="T25" fmla="*/ 64 h 64"/>
                <a:gd name="T26" fmla="*/ 0 w 49"/>
                <a:gd name="T27" fmla="*/ 64 h 64"/>
                <a:gd name="T28" fmla="*/ 0 w 49"/>
                <a:gd name="T29" fmla="*/ 57 h 64"/>
                <a:gd name="T30" fmla="*/ 0 w 49"/>
                <a:gd name="T31" fmla="*/ 0 h 64"/>
                <a:gd name="T32" fmla="*/ 49 w 49"/>
                <a:gd name="T33" fmla="*/ 0 h 64"/>
                <a:gd name="T34" fmla="*/ 49 w 49"/>
                <a:gd name="T35" fmla="*/ 8 h 64"/>
                <a:gd name="T36" fmla="*/ 0 w 49"/>
                <a:gd name="T37" fmla="*/ 8 h 64"/>
                <a:gd name="T38" fmla="*/ 0 w 49"/>
                <a:gd name="T39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9" h="64">
                  <a:moveTo>
                    <a:pt x="28" y="32"/>
                  </a:moveTo>
                  <a:lnTo>
                    <a:pt x="28" y="60"/>
                  </a:lnTo>
                  <a:lnTo>
                    <a:pt x="20" y="60"/>
                  </a:lnTo>
                  <a:lnTo>
                    <a:pt x="20" y="32"/>
                  </a:lnTo>
                  <a:lnTo>
                    <a:pt x="28" y="32"/>
                  </a:lnTo>
                  <a:close/>
                  <a:moveTo>
                    <a:pt x="20" y="32"/>
                  </a:moveTo>
                  <a:lnTo>
                    <a:pt x="20" y="4"/>
                  </a:lnTo>
                  <a:lnTo>
                    <a:pt x="28" y="4"/>
                  </a:lnTo>
                  <a:lnTo>
                    <a:pt x="28" y="32"/>
                  </a:lnTo>
                  <a:lnTo>
                    <a:pt x="20" y="32"/>
                  </a:lnTo>
                  <a:close/>
                  <a:moveTo>
                    <a:pt x="0" y="57"/>
                  </a:moveTo>
                  <a:lnTo>
                    <a:pt x="49" y="57"/>
                  </a:lnTo>
                  <a:lnTo>
                    <a:pt x="49" y="64"/>
                  </a:lnTo>
                  <a:lnTo>
                    <a:pt x="0" y="64"/>
                  </a:lnTo>
                  <a:lnTo>
                    <a:pt x="0" y="57"/>
                  </a:lnTo>
                  <a:close/>
                  <a:moveTo>
                    <a:pt x="0" y="0"/>
                  </a:moveTo>
                  <a:lnTo>
                    <a:pt x="49" y="0"/>
                  </a:lnTo>
                  <a:lnTo>
                    <a:pt x="49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Freeform 142"/>
            <p:cNvSpPr>
              <a:spLocks noEditPoints="1"/>
            </p:cNvSpPr>
            <p:nvPr/>
          </p:nvSpPr>
          <p:spPr bwMode="auto">
            <a:xfrm>
              <a:off x="6985767" y="4803731"/>
              <a:ext cx="84605" cy="102797"/>
            </a:xfrm>
            <a:custGeom>
              <a:avLst/>
              <a:gdLst>
                <a:gd name="T0" fmla="*/ 28 w 49"/>
                <a:gd name="T1" fmla="*/ 27 h 54"/>
                <a:gd name="T2" fmla="*/ 28 w 49"/>
                <a:gd name="T3" fmla="*/ 50 h 54"/>
                <a:gd name="T4" fmla="*/ 21 w 49"/>
                <a:gd name="T5" fmla="*/ 50 h 54"/>
                <a:gd name="T6" fmla="*/ 21 w 49"/>
                <a:gd name="T7" fmla="*/ 27 h 54"/>
                <a:gd name="T8" fmla="*/ 28 w 49"/>
                <a:gd name="T9" fmla="*/ 27 h 54"/>
                <a:gd name="T10" fmla="*/ 21 w 49"/>
                <a:gd name="T11" fmla="*/ 27 h 54"/>
                <a:gd name="T12" fmla="*/ 21 w 49"/>
                <a:gd name="T13" fmla="*/ 4 h 54"/>
                <a:gd name="T14" fmla="*/ 28 w 49"/>
                <a:gd name="T15" fmla="*/ 4 h 54"/>
                <a:gd name="T16" fmla="*/ 28 w 49"/>
                <a:gd name="T17" fmla="*/ 27 h 54"/>
                <a:gd name="T18" fmla="*/ 21 w 49"/>
                <a:gd name="T19" fmla="*/ 27 h 54"/>
                <a:gd name="T20" fmla="*/ 0 w 49"/>
                <a:gd name="T21" fmla="*/ 46 h 54"/>
                <a:gd name="T22" fmla="*/ 49 w 49"/>
                <a:gd name="T23" fmla="*/ 46 h 54"/>
                <a:gd name="T24" fmla="*/ 49 w 49"/>
                <a:gd name="T25" fmla="*/ 54 h 54"/>
                <a:gd name="T26" fmla="*/ 0 w 49"/>
                <a:gd name="T27" fmla="*/ 54 h 54"/>
                <a:gd name="T28" fmla="*/ 0 w 49"/>
                <a:gd name="T29" fmla="*/ 46 h 54"/>
                <a:gd name="T30" fmla="*/ 0 w 49"/>
                <a:gd name="T31" fmla="*/ 0 h 54"/>
                <a:gd name="T32" fmla="*/ 49 w 49"/>
                <a:gd name="T33" fmla="*/ 0 h 54"/>
                <a:gd name="T34" fmla="*/ 49 w 49"/>
                <a:gd name="T35" fmla="*/ 8 h 54"/>
                <a:gd name="T36" fmla="*/ 0 w 49"/>
                <a:gd name="T37" fmla="*/ 8 h 54"/>
                <a:gd name="T38" fmla="*/ 0 w 49"/>
                <a:gd name="T39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9" h="54">
                  <a:moveTo>
                    <a:pt x="28" y="27"/>
                  </a:moveTo>
                  <a:lnTo>
                    <a:pt x="28" y="50"/>
                  </a:lnTo>
                  <a:lnTo>
                    <a:pt x="21" y="50"/>
                  </a:lnTo>
                  <a:lnTo>
                    <a:pt x="21" y="27"/>
                  </a:lnTo>
                  <a:lnTo>
                    <a:pt x="28" y="27"/>
                  </a:lnTo>
                  <a:close/>
                  <a:moveTo>
                    <a:pt x="21" y="27"/>
                  </a:moveTo>
                  <a:lnTo>
                    <a:pt x="21" y="4"/>
                  </a:lnTo>
                  <a:lnTo>
                    <a:pt x="28" y="4"/>
                  </a:lnTo>
                  <a:lnTo>
                    <a:pt x="28" y="27"/>
                  </a:lnTo>
                  <a:lnTo>
                    <a:pt x="21" y="27"/>
                  </a:lnTo>
                  <a:close/>
                  <a:moveTo>
                    <a:pt x="0" y="46"/>
                  </a:moveTo>
                  <a:lnTo>
                    <a:pt x="49" y="46"/>
                  </a:lnTo>
                  <a:lnTo>
                    <a:pt x="49" y="54"/>
                  </a:lnTo>
                  <a:lnTo>
                    <a:pt x="0" y="54"/>
                  </a:lnTo>
                  <a:lnTo>
                    <a:pt x="0" y="46"/>
                  </a:lnTo>
                  <a:close/>
                  <a:moveTo>
                    <a:pt x="0" y="0"/>
                  </a:moveTo>
                  <a:lnTo>
                    <a:pt x="49" y="0"/>
                  </a:lnTo>
                  <a:lnTo>
                    <a:pt x="49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Freeform 143"/>
            <p:cNvSpPr>
              <a:spLocks noEditPoints="1"/>
            </p:cNvSpPr>
            <p:nvPr/>
          </p:nvSpPr>
          <p:spPr bwMode="auto">
            <a:xfrm>
              <a:off x="7930228" y="5083566"/>
              <a:ext cx="81152" cy="127545"/>
            </a:xfrm>
            <a:custGeom>
              <a:avLst/>
              <a:gdLst>
                <a:gd name="T0" fmla="*/ 28 w 47"/>
                <a:gd name="T1" fmla="*/ 33 h 67"/>
                <a:gd name="T2" fmla="*/ 28 w 47"/>
                <a:gd name="T3" fmla="*/ 63 h 67"/>
                <a:gd name="T4" fmla="*/ 20 w 47"/>
                <a:gd name="T5" fmla="*/ 63 h 67"/>
                <a:gd name="T6" fmla="*/ 20 w 47"/>
                <a:gd name="T7" fmla="*/ 33 h 67"/>
                <a:gd name="T8" fmla="*/ 28 w 47"/>
                <a:gd name="T9" fmla="*/ 33 h 67"/>
                <a:gd name="T10" fmla="*/ 20 w 47"/>
                <a:gd name="T11" fmla="*/ 33 h 67"/>
                <a:gd name="T12" fmla="*/ 20 w 47"/>
                <a:gd name="T13" fmla="*/ 4 h 67"/>
                <a:gd name="T14" fmla="*/ 28 w 47"/>
                <a:gd name="T15" fmla="*/ 4 h 67"/>
                <a:gd name="T16" fmla="*/ 28 w 47"/>
                <a:gd name="T17" fmla="*/ 33 h 67"/>
                <a:gd name="T18" fmla="*/ 20 w 47"/>
                <a:gd name="T19" fmla="*/ 33 h 67"/>
                <a:gd name="T20" fmla="*/ 0 w 47"/>
                <a:gd name="T21" fmla="*/ 59 h 67"/>
                <a:gd name="T22" fmla="*/ 47 w 47"/>
                <a:gd name="T23" fmla="*/ 59 h 67"/>
                <a:gd name="T24" fmla="*/ 47 w 47"/>
                <a:gd name="T25" fmla="*/ 67 h 67"/>
                <a:gd name="T26" fmla="*/ 0 w 47"/>
                <a:gd name="T27" fmla="*/ 67 h 67"/>
                <a:gd name="T28" fmla="*/ 0 w 47"/>
                <a:gd name="T29" fmla="*/ 59 h 67"/>
                <a:gd name="T30" fmla="*/ 0 w 47"/>
                <a:gd name="T31" fmla="*/ 0 h 67"/>
                <a:gd name="T32" fmla="*/ 47 w 47"/>
                <a:gd name="T33" fmla="*/ 0 h 67"/>
                <a:gd name="T34" fmla="*/ 47 w 47"/>
                <a:gd name="T35" fmla="*/ 8 h 67"/>
                <a:gd name="T36" fmla="*/ 0 w 47"/>
                <a:gd name="T37" fmla="*/ 8 h 67"/>
                <a:gd name="T38" fmla="*/ 0 w 47"/>
                <a:gd name="T39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7" h="67">
                  <a:moveTo>
                    <a:pt x="28" y="33"/>
                  </a:moveTo>
                  <a:lnTo>
                    <a:pt x="28" y="63"/>
                  </a:lnTo>
                  <a:lnTo>
                    <a:pt x="20" y="63"/>
                  </a:lnTo>
                  <a:lnTo>
                    <a:pt x="20" y="33"/>
                  </a:lnTo>
                  <a:lnTo>
                    <a:pt x="28" y="33"/>
                  </a:lnTo>
                  <a:close/>
                  <a:moveTo>
                    <a:pt x="20" y="33"/>
                  </a:moveTo>
                  <a:lnTo>
                    <a:pt x="20" y="4"/>
                  </a:lnTo>
                  <a:lnTo>
                    <a:pt x="28" y="4"/>
                  </a:lnTo>
                  <a:lnTo>
                    <a:pt x="28" y="33"/>
                  </a:lnTo>
                  <a:lnTo>
                    <a:pt x="20" y="33"/>
                  </a:lnTo>
                  <a:close/>
                  <a:moveTo>
                    <a:pt x="0" y="59"/>
                  </a:moveTo>
                  <a:lnTo>
                    <a:pt x="47" y="59"/>
                  </a:lnTo>
                  <a:lnTo>
                    <a:pt x="47" y="67"/>
                  </a:lnTo>
                  <a:lnTo>
                    <a:pt x="0" y="67"/>
                  </a:lnTo>
                  <a:lnTo>
                    <a:pt x="0" y="59"/>
                  </a:lnTo>
                  <a:close/>
                  <a:moveTo>
                    <a:pt x="0" y="0"/>
                  </a:moveTo>
                  <a:lnTo>
                    <a:pt x="47" y="0"/>
                  </a:lnTo>
                  <a:lnTo>
                    <a:pt x="47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Rectangle 144"/>
            <p:cNvSpPr>
              <a:spLocks noChangeArrowheads="1"/>
            </p:cNvSpPr>
            <p:nvPr/>
          </p:nvSpPr>
          <p:spPr bwMode="auto">
            <a:xfrm>
              <a:off x="5473249" y="4303072"/>
              <a:ext cx="13813" cy="1606674"/>
            </a:xfrm>
            <a:prstGeom prst="rect">
              <a:avLst/>
            </a:pr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Freeform 145"/>
            <p:cNvSpPr>
              <a:spLocks noEditPoints="1"/>
            </p:cNvSpPr>
            <p:nvPr/>
          </p:nvSpPr>
          <p:spPr bwMode="auto">
            <a:xfrm>
              <a:off x="5426631" y="4297362"/>
              <a:ext cx="53526" cy="1620000"/>
            </a:xfrm>
            <a:custGeom>
              <a:avLst/>
              <a:gdLst>
                <a:gd name="T0" fmla="*/ 0 w 31"/>
                <a:gd name="T1" fmla="*/ 843 h 851"/>
                <a:gd name="T2" fmla="*/ 31 w 31"/>
                <a:gd name="T3" fmla="*/ 843 h 851"/>
                <a:gd name="T4" fmla="*/ 31 w 31"/>
                <a:gd name="T5" fmla="*/ 851 h 851"/>
                <a:gd name="T6" fmla="*/ 0 w 31"/>
                <a:gd name="T7" fmla="*/ 851 h 851"/>
                <a:gd name="T8" fmla="*/ 0 w 31"/>
                <a:gd name="T9" fmla="*/ 843 h 851"/>
                <a:gd name="T10" fmla="*/ 0 w 31"/>
                <a:gd name="T11" fmla="*/ 674 h 851"/>
                <a:gd name="T12" fmla="*/ 31 w 31"/>
                <a:gd name="T13" fmla="*/ 674 h 851"/>
                <a:gd name="T14" fmla="*/ 31 w 31"/>
                <a:gd name="T15" fmla="*/ 682 h 851"/>
                <a:gd name="T16" fmla="*/ 0 w 31"/>
                <a:gd name="T17" fmla="*/ 682 h 851"/>
                <a:gd name="T18" fmla="*/ 0 w 31"/>
                <a:gd name="T19" fmla="*/ 674 h 851"/>
                <a:gd name="T20" fmla="*/ 0 w 31"/>
                <a:gd name="T21" fmla="*/ 505 h 851"/>
                <a:gd name="T22" fmla="*/ 31 w 31"/>
                <a:gd name="T23" fmla="*/ 505 h 851"/>
                <a:gd name="T24" fmla="*/ 31 w 31"/>
                <a:gd name="T25" fmla="*/ 513 h 851"/>
                <a:gd name="T26" fmla="*/ 0 w 31"/>
                <a:gd name="T27" fmla="*/ 513 h 851"/>
                <a:gd name="T28" fmla="*/ 0 w 31"/>
                <a:gd name="T29" fmla="*/ 505 h 851"/>
                <a:gd name="T30" fmla="*/ 0 w 31"/>
                <a:gd name="T31" fmla="*/ 336 h 851"/>
                <a:gd name="T32" fmla="*/ 31 w 31"/>
                <a:gd name="T33" fmla="*/ 336 h 851"/>
                <a:gd name="T34" fmla="*/ 31 w 31"/>
                <a:gd name="T35" fmla="*/ 344 h 851"/>
                <a:gd name="T36" fmla="*/ 0 w 31"/>
                <a:gd name="T37" fmla="*/ 344 h 851"/>
                <a:gd name="T38" fmla="*/ 0 w 31"/>
                <a:gd name="T39" fmla="*/ 336 h 851"/>
                <a:gd name="T40" fmla="*/ 0 w 31"/>
                <a:gd name="T41" fmla="*/ 169 h 851"/>
                <a:gd name="T42" fmla="*/ 31 w 31"/>
                <a:gd name="T43" fmla="*/ 169 h 851"/>
                <a:gd name="T44" fmla="*/ 31 w 31"/>
                <a:gd name="T45" fmla="*/ 176 h 851"/>
                <a:gd name="T46" fmla="*/ 0 w 31"/>
                <a:gd name="T47" fmla="*/ 176 h 851"/>
                <a:gd name="T48" fmla="*/ 0 w 31"/>
                <a:gd name="T49" fmla="*/ 169 h 851"/>
                <a:gd name="T50" fmla="*/ 0 w 31"/>
                <a:gd name="T51" fmla="*/ 0 h 851"/>
                <a:gd name="T52" fmla="*/ 31 w 31"/>
                <a:gd name="T53" fmla="*/ 0 h 851"/>
                <a:gd name="T54" fmla="*/ 31 w 31"/>
                <a:gd name="T55" fmla="*/ 7 h 851"/>
                <a:gd name="T56" fmla="*/ 0 w 31"/>
                <a:gd name="T57" fmla="*/ 7 h 851"/>
                <a:gd name="T58" fmla="*/ 0 w 31"/>
                <a:gd name="T59" fmla="*/ 0 h 8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31" h="851">
                  <a:moveTo>
                    <a:pt x="0" y="843"/>
                  </a:moveTo>
                  <a:lnTo>
                    <a:pt x="31" y="843"/>
                  </a:lnTo>
                  <a:lnTo>
                    <a:pt x="31" y="851"/>
                  </a:lnTo>
                  <a:lnTo>
                    <a:pt x="0" y="851"/>
                  </a:lnTo>
                  <a:lnTo>
                    <a:pt x="0" y="843"/>
                  </a:lnTo>
                  <a:close/>
                  <a:moveTo>
                    <a:pt x="0" y="674"/>
                  </a:moveTo>
                  <a:lnTo>
                    <a:pt x="31" y="674"/>
                  </a:lnTo>
                  <a:lnTo>
                    <a:pt x="31" y="682"/>
                  </a:lnTo>
                  <a:lnTo>
                    <a:pt x="0" y="682"/>
                  </a:lnTo>
                  <a:lnTo>
                    <a:pt x="0" y="674"/>
                  </a:lnTo>
                  <a:close/>
                  <a:moveTo>
                    <a:pt x="0" y="505"/>
                  </a:moveTo>
                  <a:lnTo>
                    <a:pt x="31" y="505"/>
                  </a:lnTo>
                  <a:lnTo>
                    <a:pt x="31" y="513"/>
                  </a:lnTo>
                  <a:lnTo>
                    <a:pt x="0" y="513"/>
                  </a:lnTo>
                  <a:lnTo>
                    <a:pt x="0" y="505"/>
                  </a:lnTo>
                  <a:close/>
                  <a:moveTo>
                    <a:pt x="0" y="336"/>
                  </a:moveTo>
                  <a:lnTo>
                    <a:pt x="31" y="336"/>
                  </a:lnTo>
                  <a:lnTo>
                    <a:pt x="31" y="344"/>
                  </a:lnTo>
                  <a:lnTo>
                    <a:pt x="0" y="344"/>
                  </a:lnTo>
                  <a:lnTo>
                    <a:pt x="0" y="336"/>
                  </a:lnTo>
                  <a:close/>
                  <a:moveTo>
                    <a:pt x="0" y="169"/>
                  </a:moveTo>
                  <a:lnTo>
                    <a:pt x="31" y="169"/>
                  </a:lnTo>
                  <a:lnTo>
                    <a:pt x="31" y="176"/>
                  </a:lnTo>
                  <a:lnTo>
                    <a:pt x="0" y="176"/>
                  </a:lnTo>
                  <a:lnTo>
                    <a:pt x="0" y="169"/>
                  </a:lnTo>
                  <a:close/>
                  <a:moveTo>
                    <a:pt x="0" y="0"/>
                  </a:moveTo>
                  <a:lnTo>
                    <a:pt x="31" y="0"/>
                  </a:lnTo>
                  <a:lnTo>
                    <a:pt x="31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Rectangle 146"/>
            <p:cNvSpPr>
              <a:spLocks noChangeArrowheads="1"/>
            </p:cNvSpPr>
            <p:nvPr/>
          </p:nvSpPr>
          <p:spPr bwMode="auto">
            <a:xfrm>
              <a:off x="5480156" y="5902132"/>
              <a:ext cx="2826475" cy="15229"/>
            </a:xfrm>
            <a:prstGeom prst="rect">
              <a:avLst/>
            </a:prstGeom>
            <a:solidFill>
              <a:srgbClr val="A6A6A6"/>
            </a:solidFill>
            <a:ln w="1588" cap="flat">
              <a:solidFill>
                <a:srgbClr val="A6A6A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00" name="テキスト ボックス 173"/>
          <p:cNvSpPr txBox="1"/>
          <p:nvPr/>
        </p:nvSpPr>
        <p:spPr>
          <a:xfrm rot="16200000">
            <a:off x="-569055" y="1705907"/>
            <a:ext cx="2293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owth relative to vehicle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101" name="グループ化 191"/>
          <p:cNvGrpSpPr/>
          <p:nvPr/>
        </p:nvGrpSpPr>
        <p:grpSpPr>
          <a:xfrm>
            <a:off x="3875298" y="3315503"/>
            <a:ext cx="805020" cy="418448"/>
            <a:chOff x="4232990" y="3934553"/>
            <a:chExt cx="805019" cy="548113"/>
          </a:xfrm>
        </p:grpSpPr>
        <p:sp>
          <p:nvSpPr>
            <p:cNvPr id="102" name="Rectangle 79"/>
            <p:cNvSpPr>
              <a:spLocks noChangeArrowheads="1"/>
            </p:cNvSpPr>
            <p:nvPr/>
          </p:nvSpPr>
          <p:spPr bwMode="auto">
            <a:xfrm>
              <a:off x="4512225" y="3934553"/>
              <a:ext cx="525784" cy="2822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vehicle</a:t>
              </a:r>
            </a:p>
          </p:txBody>
        </p:sp>
        <p:sp>
          <p:nvSpPr>
            <p:cNvPr id="103" name="Rectangle 82"/>
            <p:cNvSpPr>
              <a:spLocks noChangeArrowheads="1"/>
            </p:cNvSpPr>
            <p:nvPr/>
          </p:nvSpPr>
          <p:spPr bwMode="auto">
            <a:xfrm>
              <a:off x="4512225" y="4200468"/>
              <a:ext cx="320601" cy="2821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err="1" smtClean="0">
                  <a:latin typeface="Helvetica" panose="020B0604020202020204" pitchFamily="34" charset="0"/>
                  <a:cs typeface="Helvetica" panose="020B0604020202020204" pitchFamily="34" charset="0"/>
                </a:rPr>
                <a:t>Dox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104" name="グループ化 185"/>
            <p:cNvGrpSpPr/>
            <p:nvPr/>
          </p:nvGrpSpPr>
          <p:grpSpPr>
            <a:xfrm>
              <a:off x="4232990" y="4022228"/>
              <a:ext cx="160283" cy="425199"/>
              <a:chOff x="4685714" y="1679575"/>
              <a:chExt cx="103188" cy="355467"/>
            </a:xfrm>
          </p:grpSpPr>
          <p:sp>
            <p:nvSpPr>
              <p:cNvPr id="105" name="Rectangle 77"/>
              <p:cNvSpPr>
                <a:spLocks noChangeArrowheads="1"/>
              </p:cNvSpPr>
              <p:nvPr/>
            </p:nvSpPr>
            <p:spPr bwMode="auto">
              <a:xfrm>
                <a:off x="4692064" y="1685925"/>
                <a:ext cx="90488" cy="10318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" name="Freeform 78"/>
              <p:cNvSpPr>
                <a:spLocks noEditPoints="1"/>
              </p:cNvSpPr>
              <p:nvPr/>
            </p:nvSpPr>
            <p:spPr bwMode="auto">
              <a:xfrm>
                <a:off x="4685714" y="1679575"/>
                <a:ext cx="103188" cy="117475"/>
              </a:xfrm>
              <a:custGeom>
                <a:avLst/>
                <a:gdLst>
                  <a:gd name="T0" fmla="*/ 0 w 768"/>
                  <a:gd name="T1" fmla="*/ 48 h 752"/>
                  <a:gd name="T2" fmla="*/ 48 w 768"/>
                  <a:gd name="T3" fmla="*/ 0 h 752"/>
                  <a:gd name="T4" fmla="*/ 720 w 768"/>
                  <a:gd name="T5" fmla="*/ 0 h 752"/>
                  <a:gd name="T6" fmla="*/ 768 w 768"/>
                  <a:gd name="T7" fmla="*/ 48 h 752"/>
                  <a:gd name="T8" fmla="*/ 768 w 768"/>
                  <a:gd name="T9" fmla="*/ 704 h 752"/>
                  <a:gd name="T10" fmla="*/ 720 w 768"/>
                  <a:gd name="T11" fmla="*/ 752 h 752"/>
                  <a:gd name="T12" fmla="*/ 48 w 768"/>
                  <a:gd name="T13" fmla="*/ 752 h 752"/>
                  <a:gd name="T14" fmla="*/ 0 w 768"/>
                  <a:gd name="T15" fmla="*/ 704 h 752"/>
                  <a:gd name="T16" fmla="*/ 0 w 768"/>
                  <a:gd name="T17" fmla="*/ 48 h 752"/>
                  <a:gd name="T18" fmla="*/ 96 w 768"/>
                  <a:gd name="T19" fmla="*/ 704 h 752"/>
                  <a:gd name="T20" fmla="*/ 48 w 768"/>
                  <a:gd name="T21" fmla="*/ 656 h 752"/>
                  <a:gd name="T22" fmla="*/ 720 w 768"/>
                  <a:gd name="T23" fmla="*/ 656 h 752"/>
                  <a:gd name="T24" fmla="*/ 672 w 768"/>
                  <a:gd name="T25" fmla="*/ 704 h 752"/>
                  <a:gd name="T26" fmla="*/ 672 w 768"/>
                  <a:gd name="T27" fmla="*/ 48 h 752"/>
                  <a:gd name="T28" fmla="*/ 720 w 768"/>
                  <a:gd name="T29" fmla="*/ 96 h 752"/>
                  <a:gd name="T30" fmla="*/ 48 w 768"/>
                  <a:gd name="T31" fmla="*/ 96 h 752"/>
                  <a:gd name="T32" fmla="*/ 96 w 768"/>
                  <a:gd name="T33" fmla="*/ 48 h 752"/>
                  <a:gd name="T34" fmla="*/ 96 w 768"/>
                  <a:gd name="T35" fmla="*/ 704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768" h="75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720" y="0"/>
                    </a:lnTo>
                    <a:cubicBezTo>
                      <a:pt x="747" y="0"/>
                      <a:pt x="768" y="22"/>
                      <a:pt x="768" y="48"/>
                    </a:cubicBezTo>
                    <a:lnTo>
                      <a:pt x="768" y="704"/>
                    </a:lnTo>
                    <a:cubicBezTo>
                      <a:pt x="768" y="731"/>
                      <a:pt x="747" y="752"/>
                      <a:pt x="720" y="752"/>
                    </a:cubicBezTo>
                    <a:lnTo>
                      <a:pt x="48" y="752"/>
                    </a:lnTo>
                    <a:cubicBezTo>
                      <a:pt x="22" y="752"/>
                      <a:pt x="0" y="731"/>
                      <a:pt x="0" y="704"/>
                    </a:cubicBezTo>
                    <a:lnTo>
                      <a:pt x="0" y="48"/>
                    </a:lnTo>
                    <a:close/>
                    <a:moveTo>
                      <a:pt x="96" y="704"/>
                    </a:moveTo>
                    <a:lnTo>
                      <a:pt x="48" y="656"/>
                    </a:lnTo>
                    <a:lnTo>
                      <a:pt x="720" y="656"/>
                    </a:lnTo>
                    <a:lnTo>
                      <a:pt x="672" y="704"/>
                    </a:lnTo>
                    <a:lnTo>
                      <a:pt x="672" y="48"/>
                    </a:lnTo>
                    <a:lnTo>
                      <a:pt x="72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0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" name="Rectangle 80"/>
              <p:cNvSpPr>
                <a:spLocks noChangeArrowheads="1"/>
              </p:cNvSpPr>
              <p:nvPr/>
            </p:nvSpPr>
            <p:spPr bwMode="auto">
              <a:xfrm>
                <a:off x="4692064" y="1911598"/>
                <a:ext cx="90488" cy="10318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" name="Freeform 81"/>
              <p:cNvSpPr>
                <a:spLocks noEditPoints="1"/>
              </p:cNvSpPr>
              <p:nvPr/>
            </p:nvSpPr>
            <p:spPr bwMode="auto">
              <a:xfrm>
                <a:off x="4685714" y="1917565"/>
                <a:ext cx="103188" cy="117477"/>
              </a:xfrm>
              <a:custGeom>
                <a:avLst/>
                <a:gdLst>
                  <a:gd name="T0" fmla="*/ 0 w 768"/>
                  <a:gd name="T1" fmla="*/ 48 h 752"/>
                  <a:gd name="T2" fmla="*/ 48 w 768"/>
                  <a:gd name="T3" fmla="*/ 0 h 752"/>
                  <a:gd name="T4" fmla="*/ 720 w 768"/>
                  <a:gd name="T5" fmla="*/ 0 h 752"/>
                  <a:gd name="T6" fmla="*/ 768 w 768"/>
                  <a:gd name="T7" fmla="*/ 48 h 752"/>
                  <a:gd name="T8" fmla="*/ 768 w 768"/>
                  <a:gd name="T9" fmla="*/ 704 h 752"/>
                  <a:gd name="T10" fmla="*/ 720 w 768"/>
                  <a:gd name="T11" fmla="*/ 752 h 752"/>
                  <a:gd name="T12" fmla="*/ 48 w 768"/>
                  <a:gd name="T13" fmla="*/ 752 h 752"/>
                  <a:gd name="T14" fmla="*/ 0 w 768"/>
                  <a:gd name="T15" fmla="*/ 704 h 752"/>
                  <a:gd name="T16" fmla="*/ 0 w 768"/>
                  <a:gd name="T17" fmla="*/ 48 h 752"/>
                  <a:gd name="T18" fmla="*/ 96 w 768"/>
                  <a:gd name="T19" fmla="*/ 704 h 752"/>
                  <a:gd name="T20" fmla="*/ 48 w 768"/>
                  <a:gd name="T21" fmla="*/ 656 h 752"/>
                  <a:gd name="T22" fmla="*/ 720 w 768"/>
                  <a:gd name="T23" fmla="*/ 656 h 752"/>
                  <a:gd name="T24" fmla="*/ 672 w 768"/>
                  <a:gd name="T25" fmla="*/ 704 h 752"/>
                  <a:gd name="T26" fmla="*/ 672 w 768"/>
                  <a:gd name="T27" fmla="*/ 48 h 752"/>
                  <a:gd name="T28" fmla="*/ 720 w 768"/>
                  <a:gd name="T29" fmla="*/ 96 h 752"/>
                  <a:gd name="T30" fmla="*/ 48 w 768"/>
                  <a:gd name="T31" fmla="*/ 96 h 752"/>
                  <a:gd name="T32" fmla="*/ 96 w 768"/>
                  <a:gd name="T33" fmla="*/ 48 h 752"/>
                  <a:gd name="T34" fmla="*/ 96 w 768"/>
                  <a:gd name="T35" fmla="*/ 704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768" h="75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720" y="0"/>
                    </a:lnTo>
                    <a:cubicBezTo>
                      <a:pt x="747" y="0"/>
                      <a:pt x="768" y="22"/>
                      <a:pt x="768" y="48"/>
                    </a:cubicBezTo>
                    <a:lnTo>
                      <a:pt x="768" y="704"/>
                    </a:lnTo>
                    <a:cubicBezTo>
                      <a:pt x="768" y="731"/>
                      <a:pt x="747" y="752"/>
                      <a:pt x="720" y="752"/>
                    </a:cubicBezTo>
                    <a:lnTo>
                      <a:pt x="48" y="752"/>
                    </a:lnTo>
                    <a:cubicBezTo>
                      <a:pt x="22" y="752"/>
                      <a:pt x="0" y="731"/>
                      <a:pt x="0" y="704"/>
                    </a:cubicBezTo>
                    <a:lnTo>
                      <a:pt x="0" y="48"/>
                    </a:lnTo>
                    <a:close/>
                    <a:moveTo>
                      <a:pt x="96" y="704"/>
                    </a:moveTo>
                    <a:lnTo>
                      <a:pt x="48" y="656"/>
                    </a:lnTo>
                    <a:lnTo>
                      <a:pt x="720" y="656"/>
                    </a:lnTo>
                    <a:lnTo>
                      <a:pt x="672" y="704"/>
                    </a:lnTo>
                    <a:lnTo>
                      <a:pt x="672" y="48"/>
                    </a:lnTo>
                    <a:lnTo>
                      <a:pt x="720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0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109" name="グループ化 208"/>
          <p:cNvGrpSpPr/>
          <p:nvPr/>
        </p:nvGrpSpPr>
        <p:grpSpPr>
          <a:xfrm>
            <a:off x="919701" y="3464554"/>
            <a:ext cx="256480" cy="1787444"/>
            <a:chOff x="993100" y="1479175"/>
            <a:chExt cx="256479" cy="1787444"/>
          </a:xfrm>
        </p:grpSpPr>
        <p:sp>
          <p:nvSpPr>
            <p:cNvPr id="110" name="Rectangle 65"/>
            <p:cNvSpPr>
              <a:spLocks noChangeArrowheads="1"/>
            </p:cNvSpPr>
            <p:nvPr/>
          </p:nvSpPr>
          <p:spPr bwMode="auto">
            <a:xfrm>
              <a:off x="1142180" y="3051175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</a:t>
              </a:r>
            </a:p>
          </p:txBody>
        </p:sp>
        <p:sp>
          <p:nvSpPr>
            <p:cNvPr id="111" name="Rectangle 66"/>
            <p:cNvSpPr>
              <a:spLocks noChangeArrowheads="1"/>
            </p:cNvSpPr>
            <p:nvPr/>
          </p:nvSpPr>
          <p:spPr bwMode="auto">
            <a:xfrm>
              <a:off x="993100" y="272895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12" name="Rectangle 67"/>
            <p:cNvSpPr>
              <a:spLocks noChangeArrowheads="1"/>
            </p:cNvSpPr>
            <p:nvPr/>
          </p:nvSpPr>
          <p:spPr bwMode="auto">
            <a:xfrm>
              <a:off x="993100" y="241201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4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13" name="Rectangle 68"/>
            <p:cNvSpPr>
              <a:spLocks noChangeArrowheads="1"/>
            </p:cNvSpPr>
            <p:nvPr/>
          </p:nvSpPr>
          <p:spPr bwMode="auto">
            <a:xfrm>
              <a:off x="993100" y="2109880"/>
              <a:ext cx="2564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6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14" name="Rectangle 69"/>
            <p:cNvSpPr>
              <a:spLocks noChangeArrowheads="1"/>
            </p:cNvSpPr>
            <p:nvPr/>
          </p:nvSpPr>
          <p:spPr bwMode="auto">
            <a:xfrm>
              <a:off x="993100" y="1786067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.8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15" name="Rectangle 70"/>
            <p:cNvSpPr>
              <a:spLocks noChangeArrowheads="1"/>
            </p:cNvSpPr>
            <p:nvPr/>
          </p:nvSpPr>
          <p:spPr bwMode="auto">
            <a:xfrm>
              <a:off x="1142180" y="1479175"/>
              <a:ext cx="998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16" name="グループ化 215"/>
          <p:cNvGrpSpPr/>
          <p:nvPr/>
        </p:nvGrpSpPr>
        <p:grpSpPr>
          <a:xfrm>
            <a:off x="1610096" y="5320540"/>
            <a:ext cx="2118027" cy="215444"/>
            <a:chOff x="1734584" y="3277904"/>
            <a:chExt cx="2118027" cy="215444"/>
          </a:xfrm>
        </p:grpSpPr>
        <p:sp>
          <p:nvSpPr>
            <p:cNvPr id="117" name="Rectangle 71"/>
            <p:cNvSpPr>
              <a:spLocks noChangeArrowheads="1"/>
            </p:cNvSpPr>
            <p:nvPr/>
          </p:nvSpPr>
          <p:spPr bwMode="auto">
            <a:xfrm>
              <a:off x="1734584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24</a:t>
              </a: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 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18" name="Rectangle 72"/>
            <p:cNvSpPr>
              <a:spLocks noChangeArrowheads="1"/>
            </p:cNvSpPr>
            <p:nvPr/>
          </p:nvSpPr>
          <p:spPr bwMode="auto">
            <a:xfrm>
              <a:off x="2676584" y="3277904"/>
              <a:ext cx="23083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48</a:t>
              </a:r>
            </a:p>
          </p:txBody>
        </p:sp>
        <p:sp>
          <p:nvSpPr>
            <p:cNvPr id="119" name="Rectangle 73"/>
            <p:cNvSpPr>
              <a:spLocks noChangeArrowheads="1"/>
            </p:cNvSpPr>
            <p:nvPr/>
          </p:nvSpPr>
          <p:spPr bwMode="auto">
            <a:xfrm>
              <a:off x="3621779" y="3277904"/>
              <a:ext cx="23083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72</a:t>
              </a:r>
            </a:p>
          </p:txBody>
        </p:sp>
      </p:grpSp>
      <p:grpSp>
        <p:nvGrpSpPr>
          <p:cNvPr id="120" name="グループ化 219"/>
          <p:cNvGrpSpPr/>
          <p:nvPr/>
        </p:nvGrpSpPr>
        <p:grpSpPr>
          <a:xfrm>
            <a:off x="5884839" y="2744504"/>
            <a:ext cx="2066730" cy="215444"/>
            <a:chOff x="1734584" y="3277904"/>
            <a:chExt cx="2066731" cy="215444"/>
          </a:xfrm>
        </p:grpSpPr>
        <p:sp>
          <p:nvSpPr>
            <p:cNvPr id="121" name="Rectangle 71"/>
            <p:cNvSpPr>
              <a:spLocks noChangeArrowheads="1"/>
            </p:cNvSpPr>
            <p:nvPr/>
          </p:nvSpPr>
          <p:spPr bwMode="auto">
            <a:xfrm>
              <a:off x="1734584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24</a:t>
              </a:r>
            </a:p>
          </p:txBody>
        </p:sp>
        <p:sp>
          <p:nvSpPr>
            <p:cNvPr id="122" name="Rectangle 72"/>
            <p:cNvSpPr>
              <a:spLocks noChangeArrowheads="1"/>
            </p:cNvSpPr>
            <p:nvPr/>
          </p:nvSpPr>
          <p:spPr bwMode="auto">
            <a:xfrm>
              <a:off x="2676584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48</a:t>
              </a:r>
            </a:p>
          </p:txBody>
        </p:sp>
        <p:sp>
          <p:nvSpPr>
            <p:cNvPr id="123" name="Rectangle 73"/>
            <p:cNvSpPr>
              <a:spLocks noChangeArrowheads="1"/>
            </p:cNvSpPr>
            <p:nvPr/>
          </p:nvSpPr>
          <p:spPr bwMode="auto">
            <a:xfrm>
              <a:off x="3621779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72</a:t>
              </a:r>
            </a:p>
          </p:txBody>
        </p:sp>
      </p:grpSp>
      <p:grpSp>
        <p:nvGrpSpPr>
          <p:cNvPr id="124" name="グループ化 223"/>
          <p:cNvGrpSpPr/>
          <p:nvPr/>
        </p:nvGrpSpPr>
        <p:grpSpPr>
          <a:xfrm>
            <a:off x="5831089" y="5320540"/>
            <a:ext cx="2066730" cy="215444"/>
            <a:chOff x="1734584" y="3277904"/>
            <a:chExt cx="2066731" cy="215444"/>
          </a:xfrm>
        </p:grpSpPr>
        <p:sp>
          <p:nvSpPr>
            <p:cNvPr id="125" name="Rectangle 71"/>
            <p:cNvSpPr>
              <a:spLocks noChangeArrowheads="1"/>
            </p:cNvSpPr>
            <p:nvPr/>
          </p:nvSpPr>
          <p:spPr bwMode="auto">
            <a:xfrm>
              <a:off x="1734584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24</a:t>
              </a:r>
            </a:p>
          </p:txBody>
        </p:sp>
        <p:sp>
          <p:nvSpPr>
            <p:cNvPr id="126" name="Rectangle 72"/>
            <p:cNvSpPr>
              <a:spLocks noChangeArrowheads="1"/>
            </p:cNvSpPr>
            <p:nvPr/>
          </p:nvSpPr>
          <p:spPr bwMode="auto">
            <a:xfrm>
              <a:off x="2676584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48</a:t>
              </a:r>
            </a:p>
          </p:txBody>
        </p:sp>
        <p:sp>
          <p:nvSpPr>
            <p:cNvPr id="127" name="Rectangle 73"/>
            <p:cNvSpPr>
              <a:spLocks noChangeArrowheads="1"/>
            </p:cNvSpPr>
            <p:nvPr/>
          </p:nvSpPr>
          <p:spPr bwMode="auto">
            <a:xfrm>
              <a:off x="3621779" y="327790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72</a:t>
              </a:r>
            </a:p>
          </p:txBody>
        </p:sp>
      </p:grpSp>
      <p:sp>
        <p:nvSpPr>
          <p:cNvPr id="128" name="テキスト ボックス 227"/>
          <p:cNvSpPr txBox="1"/>
          <p:nvPr/>
        </p:nvSpPr>
        <p:spPr>
          <a:xfrm rot="16200000">
            <a:off x="-506834" y="4156815"/>
            <a:ext cx="2293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owth relative to vehicle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9" name="テキスト ボックス 228"/>
          <p:cNvSpPr txBox="1"/>
          <p:nvPr/>
        </p:nvSpPr>
        <p:spPr>
          <a:xfrm rot="16200000">
            <a:off x="3652608" y="1782286"/>
            <a:ext cx="2293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owth relative to vehicle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0" name="テキスト ボックス 229"/>
          <p:cNvSpPr txBox="1"/>
          <p:nvPr/>
        </p:nvSpPr>
        <p:spPr>
          <a:xfrm rot="16200000">
            <a:off x="3673381" y="4286382"/>
            <a:ext cx="2293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owth relative to vehicle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131" name="グループ化 230"/>
          <p:cNvGrpSpPr/>
          <p:nvPr/>
        </p:nvGrpSpPr>
        <p:grpSpPr>
          <a:xfrm>
            <a:off x="5049797" y="1058660"/>
            <a:ext cx="256480" cy="1787444"/>
            <a:chOff x="993100" y="1479175"/>
            <a:chExt cx="256479" cy="1787444"/>
          </a:xfrm>
        </p:grpSpPr>
        <p:sp>
          <p:nvSpPr>
            <p:cNvPr id="132" name="Rectangle 65"/>
            <p:cNvSpPr>
              <a:spLocks noChangeArrowheads="1"/>
            </p:cNvSpPr>
            <p:nvPr/>
          </p:nvSpPr>
          <p:spPr bwMode="auto">
            <a:xfrm>
              <a:off x="1142180" y="3051175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</a:t>
              </a:r>
            </a:p>
          </p:txBody>
        </p:sp>
        <p:sp>
          <p:nvSpPr>
            <p:cNvPr id="133" name="Rectangle 66"/>
            <p:cNvSpPr>
              <a:spLocks noChangeArrowheads="1"/>
            </p:cNvSpPr>
            <p:nvPr/>
          </p:nvSpPr>
          <p:spPr bwMode="auto">
            <a:xfrm>
              <a:off x="993100" y="272895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4" name="Rectangle 67"/>
            <p:cNvSpPr>
              <a:spLocks noChangeArrowheads="1"/>
            </p:cNvSpPr>
            <p:nvPr/>
          </p:nvSpPr>
          <p:spPr bwMode="auto">
            <a:xfrm>
              <a:off x="993100" y="241201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4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5" name="Rectangle 68"/>
            <p:cNvSpPr>
              <a:spLocks noChangeArrowheads="1"/>
            </p:cNvSpPr>
            <p:nvPr/>
          </p:nvSpPr>
          <p:spPr bwMode="auto">
            <a:xfrm>
              <a:off x="993100" y="2109880"/>
              <a:ext cx="2564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6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" name="Rectangle 69"/>
            <p:cNvSpPr>
              <a:spLocks noChangeArrowheads="1"/>
            </p:cNvSpPr>
            <p:nvPr/>
          </p:nvSpPr>
          <p:spPr bwMode="auto">
            <a:xfrm>
              <a:off x="993100" y="1786067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.8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7" name="Rectangle 70"/>
            <p:cNvSpPr>
              <a:spLocks noChangeArrowheads="1"/>
            </p:cNvSpPr>
            <p:nvPr/>
          </p:nvSpPr>
          <p:spPr bwMode="auto">
            <a:xfrm>
              <a:off x="1142180" y="1479175"/>
              <a:ext cx="998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38" name="グループ化 237"/>
          <p:cNvGrpSpPr/>
          <p:nvPr/>
        </p:nvGrpSpPr>
        <p:grpSpPr>
          <a:xfrm>
            <a:off x="5079808" y="3583896"/>
            <a:ext cx="256480" cy="1787444"/>
            <a:chOff x="993100" y="1479175"/>
            <a:chExt cx="256479" cy="1787444"/>
          </a:xfrm>
        </p:grpSpPr>
        <p:sp>
          <p:nvSpPr>
            <p:cNvPr id="139" name="Rectangle 65"/>
            <p:cNvSpPr>
              <a:spLocks noChangeArrowheads="1"/>
            </p:cNvSpPr>
            <p:nvPr/>
          </p:nvSpPr>
          <p:spPr bwMode="auto">
            <a:xfrm>
              <a:off x="1142180" y="3051175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</a:t>
              </a:r>
            </a:p>
          </p:txBody>
        </p:sp>
        <p:sp>
          <p:nvSpPr>
            <p:cNvPr id="140" name="Rectangle 66"/>
            <p:cNvSpPr>
              <a:spLocks noChangeArrowheads="1"/>
            </p:cNvSpPr>
            <p:nvPr/>
          </p:nvSpPr>
          <p:spPr bwMode="auto">
            <a:xfrm>
              <a:off x="993100" y="272895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1" name="Rectangle 67"/>
            <p:cNvSpPr>
              <a:spLocks noChangeArrowheads="1"/>
            </p:cNvSpPr>
            <p:nvPr/>
          </p:nvSpPr>
          <p:spPr bwMode="auto">
            <a:xfrm>
              <a:off x="993100" y="2412010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4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2" name="Rectangle 68"/>
            <p:cNvSpPr>
              <a:spLocks noChangeArrowheads="1"/>
            </p:cNvSpPr>
            <p:nvPr/>
          </p:nvSpPr>
          <p:spPr bwMode="auto">
            <a:xfrm>
              <a:off x="993100" y="2109880"/>
              <a:ext cx="2564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6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3" name="Rectangle 69"/>
            <p:cNvSpPr>
              <a:spLocks noChangeArrowheads="1"/>
            </p:cNvSpPr>
            <p:nvPr/>
          </p:nvSpPr>
          <p:spPr bwMode="auto">
            <a:xfrm>
              <a:off x="993100" y="1786067"/>
              <a:ext cx="2495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0.8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4" name="Rectangle 70"/>
            <p:cNvSpPr>
              <a:spLocks noChangeArrowheads="1"/>
            </p:cNvSpPr>
            <p:nvPr/>
          </p:nvSpPr>
          <p:spPr bwMode="auto">
            <a:xfrm>
              <a:off x="1142180" y="1479175"/>
              <a:ext cx="998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sp>
        <p:nvSpPr>
          <p:cNvPr id="145" name="テキスト ボックス 244"/>
          <p:cNvSpPr txBox="1"/>
          <p:nvPr/>
        </p:nvSpPr>
        <p:spPr>
          <a:xfrm>
            <a:off x="2370196" y="2856366"/>
            <a:ext cx="7849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Hour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6" name="テキスト ボックス 245"/>
          <p:cNvSpPr txBox="1"/>
          <p:nvPr/>
        </p:nvSpPr>
        <p:spPr>
          <a:xfrm>
            <a:off x="2374428" y="5424044"/>
            <a:ext cx="7849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Hour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7" name="テキスト ボックス 246"/>
          <p:cNvSpPr txBox="1"/>
          <p:nvPr/>
        </p:nvSpPr>
        <p:spPr>
          <a:xfrm>
            <a:off x="6584732" y="2856366"/>
            <a:ext cx="7849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Hour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8" name="テキスト ボックス 247"/>
          <p:cNvSpPr txBox="1"/>
          <p:nvPr/>
        </p:nvSpPr>
        <p:spPr>
          <a:xfrm>
            <a:off x="6560167" y="5424044"/>
            <a:ext cx="7849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Hours</a:t>
            </a:r>
            <a:endParaRPr kumimoji="1"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795894" y="685755"/>
            <a:ext cx="348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Helvetica" pitchFamily="34" charset="0"/>
                <a:cs typeface="Helvetica" pitchFamily="34" charset="0"/>
              </a:rPr>
              <a:t>A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795894" y="3187655"/>
            <a:ext cx="348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Helvetica" pitchFamily="34" charset="0"/>
                <a:cs typeface="Helvetica" pitchFamily="34" charset="0"/>
              </a:rPr>
              <a:t>B</a:t>
            </a:r>
            <a:endParaRPr lang="en-US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1740203" y="1115342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2678987" y="1789654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3629963" y="2111400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5887854" y="961242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6826638" y="1136001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7769147" y="1161402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1745622" y="3714949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2684406" y="4440063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3626915" y="4812611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5914609" y="3554076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6853393" y="3948977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7778968" y="4219921"/>
            <a:ext cx="4148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/>
              <a:t>**</a:t>
            </a:r>
            <a:endParaRPr kumimoji="1"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4768110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Rectangle 220"/>
          <p:cNvSpPr>
            <a:spLocks noChangeArrowheads="1"/>
          </p:cNvSpPr>
          <p:nvPr/>
        </p:nvSpPr>
        <p:spPr bwMode="auto">
          <a:xfrm>
            <a:off x="1848669" y="1139899"/>
            <a:ext cx="290513" cy="32146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2" name="Freeform 221"/>
          <p:cNvSpPr>
            <a:spLocks noEditPoints="1"/>
          </p:cNvSpPr>
          <p:nvPr/>
        </p:nvSpPr>
        <p:spPr bwMode="auto">
          <a:xfrm>
            <a:off x="1842716" y="1131962"/>
            <a:ext cx="302419" cy="3228975"/>
          </a:xfrm>
          <a:custGeom>
            <a:avLst/>
            <a:gdLst>
              <a:gd name="T0" fmla="*/ 0 w 2736"/>
              <a:gd name="T1" fmla="*/ 48 h 21952"/>
              <a:gd name="T2" fmla="*/ 48 w 2736"/>
              <a:gd name="T3" fmla="*/ 0 h 21952"/>
              <a:gd name="T4" fmla="*/ 2688 w 2736"/>
              <a:gd name="T5" fmla="*/ 0 h 21952"/>
              <a:gd name="T6" fmla="*/ 2736 w 2736"/>
              <a:gd name="T7" fmla="*/ 48 h 21952"/>
              <a:gd name="T8" fmla="*/ 2736 w 2736"/>
              <a:gd name="T9" fmla="*/ 21904 h 21952"/>
              <a:gd name="T10" fmla="*/ 2688 w 2736"/>
              <a:gd name="T11" fmla="*/ 21952 h 21952"/>
              <a:gd name="T12" fmla="*/ 48 w 2736"/>
              <a:gd name="T13" fmla="*/ 21952 h 21952"/>
              <a:gd name="T14" fmla="*/ 0 w 2736"/>
              <a:gd name="T15" fmla="*/ 21904 h 21952"/>
              <a:gd name="T16" fmla="*/ 0 w 2736"/>
              <a:gd name="T17" fmla="*/ 48 h 21952"/>
              <a:gd name="T18" fmla="*/ 96 w 2736"/>
              <a:gd name="T19" fmla="*/ 21904 h 21952"/>
              <a:gd name="T20" fmla="*/ 48 w 2736"/>
              <a:gd name="T21" fmla="*/ 21856 h 21952"/>
              <a:gd name="T22" fmla="*/ 2688 w 2736"/>
              <a:gd name="T23" fmla="*/ 21856 h 21952"/>
              <a:gd name="T24" fmla="*/ 2640 w 2736"/>
              <a:gd name="T25" fmla="*/ 21904 h 21952"/>
              <a:gd name="T26" fmla="*/ 2640 w 2736"/>
              <a:gd name="T27" fmla="*/ 48 h 21952"/>
              <a:gd name="T28" fmla="*/ 2688 w 2736"/>
              <a:gd name="T29" fmla="*/ 96 h 21952"/>
              <a:gd name="T30" fmla="*/ 48 w 2736"/>
              <a:gd name="T31" fmla="*/ 96 h 21952"/>
              <a:gd name="T32" fmla="*/ 96 w 2736"/>
              <a:gd name="T33" fmla="*/ 48 h 21952"/>
              <a:gd name="T34" fmla="*/ 96 w 2736"/>
              <a:gd name="T35" fmla="*/ 21904 h 219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736" h="21952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2688" y="0"/>
                </a:lnTo>
                <a:cubicBezTo>
                  <a:pt x="2715" y="0"/>
                  <a:pt x="2736" y="22"/>
                  <a:pt x="2736" y="48"/>
                </a:cubicBezTo>
                <a:lnTo>
                  <a:pt x="2736" y="21904"/>
                </a:lnTo>
                <a:cubicBezTo>
                  <a:pt x="2736" y="21931"/>
                  <a:pt x="2715" y="21952"/>
                  <a:pt x="2688" y="21952"/>
                </a:cubicBezTo>
                <a:lnTo>
                  <a:pt x="48" y="21952"/>
                </a:lnTo>
                <a:cubicBezTo>
                  <a:pt x="22" y="21952"/>
                  <a:pt x="0" y="21931"/>
                  <a:pt x="0" y="21904"/>
                </a:cubicBezTo>
                <a:lnTo>
                  <a:pt x="0" y="48"/>
                </a:lnTo>
                <a:close/>
                <a:moveTo>
                  <a:pt x="96" y="21904"/>
                </a:moveTo>
                <a:lnTo>
                  <a:pt x="48" y="21856"/>
                </a:lnTo>
                <a:lnTo>
                  <a:pt x="2688" y="21856"/>
                </a:lnTo>
                <a:lnTo>
                  <a:pt x="2640" y="21904"/>
                </a:lnTo>
                <a:lnTo>
                  <a:pt x="2640" y="48"/>
                </a:lnTo>
                <a:lnTo>
                  <a:pt x="2688" y="96"/>
                </a:lnTo>
                <a:lnTo>
                  <a:pt x="48" y="96"/>
                </a:lnTo>
                <a:lnTo>
                  <a:pt x="96" y="48"/>
                </a:lnTo>
                <a:lnTo>
                  <a:pt x="96" y="2190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3" name="Rectangle 222"/>
          <p:cNvSpPr>
            <a:spLocks noChangeArrowheads="1"/>
          </p:cNvSpPr>
          <p:nvPr/>
        </p:nvSpPr>
        <p:spPr bwMode="auto">
          <a:xfrm>
            <a:off x="3888210" y="1139899"/>
            <a:ext cx="291703" cy="32146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4" name="Freeform 223"/>
          <p:cNvSpPr>
            <a:spLocks noEditPoints="1"/>
          </p:cNvSpPr>
          <p:nvPr/>
        </p:nvSpPr>
        <p:spPr bwMode="auto">
          <a:xfrm>
            <a:off x="3883448" y="1131962"/>
            <a:ext cx="301228" cy="3228975"/>
          </a:xfrm>
          <a:custGeom>
            <a:avLst/>
            <a:gdLst>
              <a:gd name="T0" fmla="*/ 0 w 2736"/>
              <a:gd name="T1" fmla="*/ 48 h 21952"/>
              <a:gd name="T2" fmla="*/ 48 w 2736"/>
              <a:gd name="T3" fmla="*/ 0 h 21952"/>
              <a:gd name="T4" fmla="*/ 2688 w 2736"/>
              <a:gd name="T5" fmla="*/ 0 h 21952"/>
              <a:gd name="T6" fmla="*/ 2736 w 2736"/>
              <a:gd name="T7" fmla="*/ 48 h 21952"/>
              <a:gd name="T8" fmla="*/ 2736 w 2736"/>
              <a:gd name="T9" fmla="*/ 21904 h 21952"/>
              <a:gd name="T10" fmla="*/ 2688 w 2736"/>
              <a:gd name="T11" fmla="*/ 21952 h 21952"/>
              <a:gd name="T12" fmla="*/ 48 w 2736"/>
              <a:gd name="T13" fmla="*/ 21952 h 21952"/>
              <a:gd name="T14" fmla="*/ 0 w 2736"/>
              <a:gd name="T15" fmla="*/ 21904 h 21952"/>
              <a:gd name="T16" fmla="*/ 0 w 2736"/>
              <a:gd name="T17" fmla="*/ 48 h 21952"/>
              <a:gd name="T18" fmla="*/ 96 w 2736"/>
              <a:gd name="T19" fmla="*/ 21904 h 21952"/>
              <a:gd name="T20" fmla="*/ 48 w 2736"/>
              <a:gd name="T21" fmla="*/ 21856 h 21952"/>
              <a:gd name="T22" fmla="*/ 2688 w 2736"/>
              <a:gd name="T23" fmla="*/ 21856 h 21952"/>
              <a:gd name="T24" fmla="*/ 2640 w 2736"/>
              <a:gd name="T25" fmla="*/ 21904 h 21952"/>
              <a:gd name="T26" fmla="*/ 2640 w 2736"/>
              <a:gd name="T27" fmla="*/ 48 h 21952"/>
              <a:gd name="T28" fmla="*/ 2688 w 2736"/>
              <a:gd name="T29" fmla="*/ 96 h 21952"/>
              <a:gd name="T30" fmla="*/ 48 w 2736"/>
              <a:gd name="T31" fmla="*/ 96 h 21952"/>
              <a:gd name="T32" fmla="*/ 96 w 2736"/>
              <a:gd name="T33" fmla="*/ 48 h 21952"/>
              <a:gd name="T34" fmla="*/ 96 w 2736"/>
              <a:gd name="T35" fmla="*/ 21904 h 219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736" h="21952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2688" y="0"/>
                </a:lnTo>
                <a:cubicBezTo>
                  <a:pt x="2715" y="0"/>
                  <a:pt x="2736" y="22"/>
                  <a:pt x="2736" y="48"/>
                </a:cubicBezTo>
                <a:lnTo>
                  <a:pt x="2736" y="21904"/>
                </a:lnTo>
                <a:cubicBezTo>
                  <a:pt x="2736" y="21931"/>
                  <a:pt x="2715" y="21952"/>
                  <a:pt x="2688" y="21952"/>
                </a:cubicBezTo>
                <a:lnTo>
                  <a:pt x="48" y="21952"/>
                </a:lnTo>
                <a:cubicBezTo>
                  <a:pt x="22" y="21952"/>
                  <a:pt x="0" y="21931"/>
                  <a:pt x="0" y="21904"/>
                </a:cubicBezTo>
                <a:lnTo>
                  <a:pt x="0" y="48"/>
                </a:lnTo>
                <a:close/>
                <a:moveTo>
                  <a:pt x="96" y="21904"/>
                </a:moveTo>
                <a:lnTo>
                  <a:pt x="48" y="21856"/>
                </a:lnTo>
                <a:lnTo>
                  <a:pt x="2688" y="21856"/>
                </a:lnTo>
                <a:lnTo>
                  <a:pt x="2640" y="21904"/>
                </a:lnTo>
                <a:lnTo>
                  <a:pt x="2640" y="48"/>
                </a:lnTo>
                <a:lnTo>
                  <a:pt x="2688" y="96"/>
                </a:lnTo>
                <a:lnTo>
                  <a:pt x="48" y="96"/>
                </a:lnTo>
                <a:lnTo>
                  <a:pt x="96" y="48"/>
                </a:lnTo>
                <a:lnTo>
                  <a:pt x="96" y="2190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5" name="Rectangle 224"/>
          <p:cNvSpPr>
            <a:spLocks noChangeArrowheads="1"/>
          </p:cNvSpPr>
          <p:nvPr/>
        </p:nvSpPr>
        <p:spPr bwMode="auto">
          <a:xfrm>
            <a:off x="5927750" y="1139899"/>
            <a:ext cx="291703" cy="32146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6" name="Freeform 225"/>
          <p:cNvSpPr>
            <a:spLocks noEditPoints="1"/>
          </p:cNvSpPr>
          <p:nvPr/>
        </p:nvSpPr>
        <p:spPr bwMode="auto">
          <a:xfrm>
            <a:off x="5922988" y="1131962"/>
            <a:ext cx="301228" cy="3228975"/>
          </a:xfrm>
          <a:custGeom>
            <a:avLst/>
            <a:gdLst>
              <a:gd name="T0" fmla="*/ 0 w 1368"/>
              <a:gd name="T1" fmla="*/ 24 h 10976"/>
              <a:gd name="T2" fmla="*/ 24 w 1368"/>
              <a:gd name="T3" fmla="*/ 0 h 10976"/>
              <a:gd name="T4" fmla="*/ 1344 w 1368"/>
              <a:gd name="T5" fmla="*/ 0 h 10976"/>
              <a:gd name="T6" fmla="*/ 1368 w 1368"/>
              <a:gd name="T7" fmla="*/ 24 h 10976"/>
              <a:gd name="T8" fmla="*/ 1368 w 1368"/>
              <a:gd name="T9" fmla="*/ 10952 h 10976"/>
              <a:gd name="T10" fmla="*/ 1344 w 1368"/>
              <a:gd name="T11" fmla="*/ 10976 h 10976"/>
              <a:gd name="T12" fmla="*/ 24 w 1368"/>
              <a:gd name="T13" fmla="*/ 10976 h 10976"/>
              <a:gd name="T14" fmla="*/ 0 w 1368"/>
              <a:gd name="T15" fmla="*/ 10952 h 10976"/>
              <a:gd name="T16" fmla="*/ 0 w 1368"/>
              <a:gd name="T17" fmla="*/ 24 h 10976"/>
              <a:gd name="T18" fmla="*/ 48 w 1368"/>
              <a:gd name="T19" fmla="*/ 10952 h 10976"/>
              <a:gd name="T20" fmla="*/ 24 w 1368"/>
              <a:gd name="T21" fmla="*/ 10928 h 10976"/>
              <a:gd name="T22" fmla="*/ 1344 w 1368"/>
              <a:gd name="T23" fmla="*/ 10928 h 10976"/>
              <a:gd name="T24" fmla="*/ 1320 w 1368"/>
              <a:gd name="T25" fmla="*/ 10952 h 10976"/>
              <a:gd name="T26" fmla="*/ 1320 w 1368"/>
              <a:gd name="T27" fmla="*/ 24 h 10976"/>
              <a:gd name="T28" fmla="*/ 1344 w 1368"/>
              <a:gd name="T29" fmla="*/ 48 h 10976"/>
              <a:gd name="T30" fmla="*/ 24 w 1368"/>
              <a:gd name="T31" fmla="*/ 48 h 10976"/>
              <a:gd name="T32" fmla="*/ 48 w 1368"/>
              <a:gd name="T33" fmla="*/ 24 h 10976"/>
              <a:gd name="T34" fmla="*/ 48 w 1368"/>
              <a:gd name="T35" fmla="*/ 10952 h 109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368" h="109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344" y="0"/>
                </a:lnTo>
                <a:cubicBezTo>
                  <a:pt x="1358" y="0"/>
                  <a:pt x="1368" y="11"/>
                  <a:pt x="1368" y="24"/>
                </a:cubicBezTo>
                <a:lnTo>
                  <a:pt x="1368" y="10952"/>
                </a:lnTo>
                <a:cubicBezTo>
                  <a:pt x="1368" y="10966"/>
                  <a:pt x="1358" y="10976"/>
                  <a:pt x="1344" y="10976"/>
                </a:cubicBezTo>
                <a:lnTo>
                  <a:pt x="24" y="10976"/>
                </a:lnTo>
                <a:cubicBezTo>
                  <a:pt x="11" y="10976"/>
                  <a:pt x="0" y="10966"/>
                  <a:pt x="0" y="10952"/>
                </a:cubicBezTo>
                <a:lnTo>
                  <a:pt x="0" y="24"/>
                </a:lnTo>
                <a:close/>
                <a:moveTo>
                  <a:pt x="48" y="10952"/>
                </a:moveTo>
                <a:lnTo>
                  <a:pt x="24" y="10928"/>
                </a:lnTo>
                <a:lnTo>
                  <a:pt x="1344" y="10928"/>
                </a:lnTo>
                <a:lnTo>
                  <a:pt x="1320" y="10952"/>
                </a:lnTo>
                <a:lnTo>
                  <a:pt x="1320" y="24"/>
                </a:lnTo>
                <a:lnTo>
                  <a:pt x="1344" y="48"/>
                </a:lnTo>
                <a:lnTo>
                  <a:pt x="24" y="48"/>
                </a:lnTo>
                <a:lnTo>
                  <a:pt x="48" y="24"/>
                </a:lnTo>
                <a:lnTo>
                  <a:pt x="48" y="1095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7" name="Rectangle 226"/>
          <p:cNvSpPr>
            <a:spLocks noChangeArrowheads="1"/>
          </p:cNvSpPr>
          <p:nvPr/>
        </p:nvSpPr>
        <p:spPr bwMode="auto">
          <a:xfrm>
            <a:off x="2216573" y="1489149"/>
            <a:ext cx="291703" cy="2865438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8" name="Freeform 227"/>
          <p:cNvSpPr>
            <a:spLocks noEditPoints="1"/>
          </p:cNvSpPr>
          <p:nvPr/>
        </p:nvSpPr>
        <p:spPr bwMode="auto">
          <a:xfrm>
            <a:off x="2211810" y="1482799"/>
            <a:ext cx="301228" cy="2878138"/>
          </a:xfrm>
          <a:custGeom>
            <a:avLst/>
            <a:gdLst>
              <a:gd name="T0" fmla="*/ 0 w 2736"/>
              <a:gd name="T1" fmla="*/ 48 h 19568"/>
              <a:gd name="T2" fmla="*/ 48 w 2736"/>
              <a:gd name="T3" fmla="*/ 0 h 19568"/>
              <a:gd name="T4" fmla="*/ 2688 w 2736"/>
              <a:gd name="T5" fmla="*/ 0 h 19568"/>
              <a:gd name="T6" fmla="*/ 2736 w 2736"/>
              <a:gd name="T7" fmla="*/ 48 h 19568"/>
              <a:gd name="T8" fmla="*/ 2736 w 2736"/>
              <a:gd name="T9" fmla="*/ 19520 h 19568"/>
              <a:gd name="T10" fmla="*/ 2688 w 2736"/>
              <a:gd name="T11" fmla="*/ 19568 h 19568"/>
              <a:gd name="T12" fmla="*/ 48 w 2736"/>
              <a:gd name="T13" fmla="*/ 19568 h 19568"/>
              <a:gd name="T14" fmla="*/ 0 w 2736"/>
              <a:gd name="T15" fmla="*/ 19520 h 19568"/>
              <a:gd name="T16" fmla="*/ 0 w 2736"/>
              <a:gd name="T17" fmla="*/ 48 h 19568"/>
              <a:gd name="T18" fmla="*/ 96 w 2736"/>
              <a:gd name="T19" fmla="*/ 19520 h 19568"/>
              <a:gd name="T20" fmla="*/ 48 w 2736"/>
              <a:gd name="T21" fmla="*/ 19472 h 19568"/>
              <a:gd name="T22" fmla="*/ 2688 w 2736"/>
              <a:gd name="T23" fmla="*/ 19472 h 19568"/>
              <a:gd name="T24" fmla="*/ 2640 w 2736"/>
              <a:gd name="T25" fmla="*/ 19520 h 19568"/>
              <a:gd name="T26" fmla="*/ 2640 w 2736"/>
              <a:gd name="T27" fmla="*/ 48 h 19568"/>
              <a:gd name="T28" fmla="*/ 2688 w 2736"/>
              <a:gd name="T29" fmla="*/ 96 h 19568"/>
              <a:gd name="T30" fmla="*/ 48 w 2736"/>
              <a:gd name="T31" fmla="*/ 96 h 19568"/>
              <a:gd name="T32" fmla="*/ 96 w 2736"/>
              <a:gd name="T33" fmla="*/ 48 h 19568"/>
              <a:gd name="T34" fmla="*/ 96 w 2736"/>
              <a:gd name="T35" fmla="*/ 19520 h 195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736" h="1956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2688" y="0"/>
                </a:lnTo>
                <a:cubicBezTo>
                  <a:pt x="2715" y="0"/>
                  <a:pt x="2736" y="22"/>
                  <a:pt x="2736" y="48"/>
                </a:cubicBezTo>
                <a:lnTo>
                  <a:pt x="2736" y="19520"/>
                </a:lnTo>
                <a:cubicBezTo>
                  <a:pt x="2736" y="19547"/>
                  <a:pt x="2715" y="19568"/>
                  <a:pt x="2688" y="19568"/>
                </a:cubicBezTo>
                <a:lnTo>
                  <a:pt x="48" y="19568"/>
                </a:lnTo>
                <a:cubicBezTo>
                  <a:pt x="22" y="19568"/>
                  <a:pt x="0" y="19547"/>
                  <a:pt x="0" y="19520"/>
                </a:cubicBezTo>
                <a:lnTo>
                  <a:pt x="0" y="48"/>
                </a:lnTo>
                <a:close/>
                <a:moveTo>
                  <a:pt x="96" y="19520"/>
                </a:moveTo>
                <a:lnTo>
                  <a:pt x="48" y="19472"/>
                </a:lnTo>
                <a:lnTo>
                  <a:pt x="2688" y="19472"/>
                </a:lnTo>
                <a:lnTo>
                  <a:pt x="2640" y="19520"/>
                </a:lnTo>
                <a:lnTo>
                  <a:pt x="2640" y="48"/>
                </a:lnTo>
                <a:lnTo>
                  <a:pt x="2688" y="96"/>
                </a:lnTo>
                <a:lnTo>
                  <a:pt x="48" y="96"/>
                </a:lnTo>
                <a:lnTo>
                  <a:pt x="96" y="48"/>
                </a:lnTo>
                <a:lnTo>
                  <a:pt x="96" y="1952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9" name="Rectangle 228"/>
          <p:cNvSpPr>
            <a:spLocks noChangeArrowheads="1"/>
          </p:cNvSpPr>
          <p:nvPr/>
        </p:nvSpPr>
        <p:spPr bwMode="auto">
          <a:xfrm>
            <a:off x="4257303" y="2857575"/>
            <a:ext cx="290513" cy="1497013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0" name="Freeform 229"/>
          <p:cNvSpPr>
            <a:spLocks noEditPoints="1"/>
          </p:cNvSpPr>
          <p:nvPr/>
        </p:nvSpPr>
        <p:spPr bwMode="auto">
          <a:xfrm>
            <a:off x="4251350" y="2849637"/>
            <a:ext cx="302419" cy="1511300"/>
          </a:xfrm>
          <a:custGeom>
            <a:avLst/>
            <a:gdLst>
              <a:gd name="T0" fmla="*/ 0 w 2736"/>
              <a:gd name="T1" fmla="*/ 48 h 10272"/>
              <a:gd name="T2" fmla="*/ 48 w 2736"/>
              <a:gd name="T3" fmla="*/ 0 h 10272"/>
              <a:gd name="T4" fmla="*/ 2688 w 2736"/>
              <a:gd name="T5" fmla="*/ 0 h 10272"/>
              <a:gd name="T6" fmla="*/ 2736 w 2736"/>
              <a:gd name="T7" fmla="*/ 48 h 10272"/>
              <a:gd name="T8" fmla="*/ 2736 w 2736"/>
              <a:gd name="T9" fmla="*/ 10224 h 10272"/>
              <a:gd name="T10" fmla="*/ 2688 w 2736"/>
              <a:gd name="T11" fmla="*/ 10272 h 10272"/>
              <a:gd name="T12" fmla="*/ 48 w 2736"/>
              <a:gd name="T13" fmla="*/ 10272 h 10272"/>
              <a:gd name="T14" fmla="*/ 0 w 2736"/>
              <a:gd name="T15" fmla="*/ 10224 h 10272"/>
              <a:gd name="T16" fmla="*/ 0 w 2736"/>
              <a:gd name="T17" fmla="*/ 48 h 10272"/>
              <a:gd name="T18" fmla="*/ 96 w 2736"/>
              <a:gd name="T19" fmla="*/ 10224 h 10272"/>
              <a:gd name="T20" fmla="*/ 48 w 2736"/>
              <a:gd name="T21" fmla="*/ 10176 h 10272"/>
              <a:gd name="T22" fmla="*/ 2688 w 2736"/>
              <a:gd name="T23" fmla="*/ 10176 h 10272"/>
              <a:gd name="T24" fmla="*/ 2640 w 2736"/>
              <a:gd name="T25" fmla="*/ 10224 h 10272"/>
              <a:gd name="T26" fmla="*/ 2640 w 2736"/>
              <a:gd name="T27" fmla="*/ 48 h 10272"/>
              <a:gd name="T28" fmla="*/ 2688 w 2736"/>
              <a:gd name="T29" fmla="*/ 96 h 10272"/>
              <a:gd name="T30" fmla="*/ 48 w 2736"/>
              <a:gd name="T31" fmla="*/ 96 h 10272"/>
              <a:gd name="T32" fmla="*/ 96 w 2736"/>
              <a:gd name="T33" fmla="*/ 48 h 10272"/>
              <a:gd name="T34" fmla="*/ 96 w 2736"/>
              <a:gd name="T35" fmla="*/ 10224 h 102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736" h="10272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2688" y="0"/>
                </a:lnTo>
                <a:cubicBezTo>
                  <a:pt x="2715" y="0"/>
                  <a:pt x="2736" y="22"/>
                  <a:pt x="2736" y="48"/>
                </a:cubicBezTo>
                <a:lnTo>
                  <a:pt x="2736" y="10224"/>
                </a:lnTo>
                <a:cubicBezTo>
                  <a:pt x="2736" y="10251"/>
                  <a:pt x="2715" y="10272"/>
                  <a:pt x="2688" y="10272"/>
                </a:cubicBezTo>
                <a:lnTo>
                  <a:pt x="48" y="10272"/>
                </a:lnTo>
                <a:cubicBezTo>
                  <a:pt x="22" y="10272"/>
                  <a:pt x="0" y="10251"/>
                  <a:pt x="0" y="10224"/>
                </a:cubicBezTo>
                <a:lnTo>
                  <a:pt x="0" y="48"/>
                </a:lnTo>
                <a:close/>
                <a:moveTo>
                  <a:pt x="96" y="10224"/>
                </a:moveTo>
                <a:lnTo>
                  <a:pt x="48" y="10176"/>
                </a:lnTo>
                <a:lnTo>
                  <a:pt x="2688" y="10176"/>
                </a:lnTo>
                <a:lnTo>
                  <a:pt x="2640" y="10224"/>
                </a:lnTo>
                <a:lnTo>
                  <a:pt x="2640" y="48"/>
                </a:lnTo>
                <a:lnTo>
                  <a:pt x="2688" y="96"/>
                </a:lnTo>
                <a:lnTo>
                  <a:pt x="48" y="96"/>
                </a:lnTo>
                <a:lnTo>
                  <a:pt x="96" y="48"/>
                </a:lnTo>
                <a:lnTo>
                  <a:pt x="96" y="1022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1" name="Rectangle 230"/>
          <p:cNvSpPr>
            <a:spLocks noChangeArrowheads="1"/>
          </p:cNvSpPr>
          <p:nvPr/>
        </p:nvSpPr>
        <p:spPr bwMode="auto">
          <a:xfrm>
            <a:off x="6296844" y="3637037"/>
            <a:ext cx="292894" cy="717550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2" name="Freeform 231"/>
          <p:cNvSpPr>
            <a:spLocks noEditPoints="1"/>
          </p:cNvSpPr>
          <p:nvPr/>
        </p:nvSpPr>
        <p:spPr bwMode="auto">
          <a:xfrm>
            <a:off x="6292081" y="3629099"/>
            <a:ext cx="303609" cy="731838"/>
          </a:xfrm>
          <a:custGeom>
            <a:avLst/>
            <a:gdLst>
              <a:gd name="T0" fmla="*/ 0 w 1376"/>
              <a:gd name="T1" fmla="*/ 24 h 2488"/>
              <a:gd name="T2" fmla="*/ 24 w 1376"/>
              <a:gd name="T3" fmla="*/ 0 h 2488"/>
              <a:gd name="T4" fmla="*/ 1352 w 1376"/>
              <a:gd name="T5" fmla="*/ 0 h 2488"/>
              <a:gd name="T6" fmla="*/ 1376 w 1376"/>
              <a:gd name="T7" fmla="*/ 24 h 2488"/>
              <a:gd name="T8" fmla="*/ 1376 w 1376"/>
              <a:gd name="T9" fmla="*/ 2464 h 2488"/>
              <a:gd name="T10" fmla="*/ 1352 w 1376"/>
              <a:gd name="T11" fmla="*/ 2488 h 2488"/>
              <a:gd name="T12" fmla="*/ 24 w 1376"/>
              <a:gd name="T13" fmla="*/ 2488 h 2488"/>
              <a:gd name="T14" fmla="*/ 0 w 1376"/>
              <a:gd name="T15" fmla="*/ 2464 h 2488"/>
              <a:gd name="T16" fmla="*/ 0 w 1376"/>
              <a:gd name="T17" fmla="*/ 24 h 2488"/>
              <a:gd name="T18" fmla="*/ 48 w 1376"/>
              <a:gd name="T19" fmla="*/ 2464 h 2488"/>
              <a:gd name="T20" fmla="*/ 24 w 1376"/>
              <a:gd name="T21" fmla="*/ 2440 h 2488"/>
              <a:gd name="T22" fmla="*/ 1352 w 1376"/>
              <a:gd name="T23" fmla="*/ 2440 h 2488"/>
              <a:gd name="T24" fmla="*/ 1328 w 1376"/>
              <a:gd name="T25" fmla="*/ 2464 h 2488"/>
              <a:gd name="T26" fmla="*/ 1328 w 1376"/>
              <a:gd name="T27" fmla="*/ 24 h 2488"/>
              <a:gd name="T28" fmla="*/ 1352 w 1376"/>
              <a:gd name="T29" fmla="*/ 48 h 2488"/>
              <a:gd name="T30" fmla="*/ 24 w 1376"/>
              <a:gd name="T31" fmla="*/ 48 h 2488"/>
              <a:gd name="T32" fmla="*/ 48 w 1376"/>
              <a:gd name="T33" fmla="*/ 24 h 2488"/>
              <a:gd name="T34" fmla="*/ 48 w 1376"/>
              <a:gd name="T35" fmla="*/ 2464 h 24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376" h="2488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352" y="0"/>
                </a:lnTo>
                <a:cubicBezTo>
                  <a:pt x="1366" y="0"/>
                  <a:pt x="1376" y="11"/>
                  <a:pt x="1376" y="24"/>
                </a:cubicBezTo>
                <a:lnTo>
                  <a:pt x="1376" y="2464"/>
                </a:lnTo>
                <a:cubicBezTo>
                  <a:pt x="1376" y="2478"/>
                  <a:pt x="1366" y="2488"/>
                  <a:pt x="1352" y="2488"/>
                </a:cubicBezTo>
                <a:lnTo>
                  <a:pt x="24" y="2488"/>
                </a:lnTo>
                <a:cubicBezTo>
                  <a:pt x="11" y="2488"/>
                  <a:pt x="0" y="2478"/>
                  <a:pt x="0" y="2464"/>
                </a:cubicBezTo>
                <a:lnTo>
                  <a:pt x="0" y="24"/>
                </a:lnTo>
                <a:close/>
                <a:moveTo>
                  <a:pt x="48" y="2464"/>
                </a:moveTo>
                <a:lnTo>
                  <a:pt x="24" y="2440"/>
                </a:lnTo>
                <a:lnTo>
                  <a:pt x="1352" y="2440"/>
                </a:lnTo>
                <a:lnTo>
                  <a:pt x="1328" y="2464"/>
                </a:lnTo>
                <a:lnTo>
                  <a:pt x="1328" y="24"/>
                </a:lnTo>
                <a:lnTo>
                  <a:pt x="1352" y="48"/>
                </a:lnTo>
                <a:lnTo>
                  <a:pt x="24" y="48"/>
                </a:lnTo>
                <a:lnTo>
                  <a:pt x="48" y="24"/>
                </a:lnTo>
                <a:lnTo>
                  <a:pt x="48" y="246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3" name="Freeform 232"/>
          <p:cNvSpPr>
            <a:spLocks noEditPoints="1"/>
          </p:cNvSpPr>
          <p:nvPr/>
        </p:nvSpPr>
        <p:spPr bwMode="auto">
          <a:xfrm>
            <a:off x="2588047" y="1849513"/>
            <a:ext cx="4370784" cy="2505075"/>
          </a:xfrm>
          <a:custGeom>
            <a:avLst/>
            <a:gdLst>
              <a:gd name="T0" fmla="*/ 0 w 3671"/>
              <a:gd name="T1" fmla="*/ 0 h 1578"/>
              <a:gd name="T2" fmla="*/ 244 w 3671"/>
              <a:gd name="T3" fmla="*/ 0 h 1578"/>
              <a:gd name="T4" fmla="*/ 244 w 3671"/>
              <a:gd name="T5" fmla="*/ 1578 h 1578"/>
              <a:gd name="T6" fmla="*/ 0 w 3671"/>
              <a:gd name="T7" fmla="*/ 1578 h 1578"/>
              <a:gd name="T8" fmla="*/ 0 w 3671"/>
              <a:gd name="T9" fmla="*/ 0 h 1578"/>
              <a:gd name="T10" fmla="*/ 1713 w 3671"/>
              <a:gd name="T11" fmla="*/ 404 h 1578"/>
              <a:gd name="T12" fmla="*/ 1958 w 3671"/>
              <a:gd name="T13" fmla="*/ 404 h 1578"/>
              <a:gd name="T14" fmla="*/ 1958 w 3671"/>
              <a:gd name="T15" fmla="*/ 1578 h 1578"/>
              <a:gd name="T16" fmla="*/ 1713 w 3671"/>
              <a:gd name="T17" fmla="*/ 1578 h 1578"/>
              <a:gd name="T18" fmla="*/ 1713 w 3671"/>
              <a:gd name="T19" fmla="*/ 404 h 1578"/>
              <a:gd name="T20" fmla="*/ 3426 w 3671"/>
              <a:gd name="T21" fmla="*/ 1240 h 1578"/>
              <a:gd name="T22" fmla="*/ 3671 w 3671"/>
              <a:gd name="T23" fmla="*/ 1240 h 1578"/>
              <a:gd name="T24" fmla="*/ 3671 w 3671"/>
              <a:gd name="T25" fmla="*/ 1578 h 1578"/>
              <a:gd name="T26" fmla="*/ 3426 w 3671"/>
              <a:gd name="T27" fmla="*/ 1578 h 1578"/>
              <a:gd name="T28" fmla="*/ 3426 w 3671"/>
              <a:gd name="T29" fmla="*/ 1240 h 15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671" h="1578">
                <a:moveTo>
                  <a:pt x="0" y="0"/>
                </a:moveTo>
                <a:lnTo>
                  <a:pt x="244" y="0"/>
                </a:lnTo>
                <a:lnTo>
                  <a:pt x="244" y="1578"/>
                </a:lnTo>
                <a:lnTo>
                  <a:pt x="0" y="1578"/>
                </a:lnTo>
                <a:lnTo>
                  <a:pt x="0" y="0"/>
                </a:lnTo>
                <a:close/>
                <a:moveTo>
                  <a:pt x="1713" y="404"/>
                </a:moveTo>
                <a:lnTo>
                  <a:pt x="1958" y="404"/>
                </a:lnTo>
                <a:lnTo>
                  <a:pt x="1958" y="1578"/>
                </a:lnTo>
                <a:lnTo>
                  <a:pt x="1713" y="1578"/>
                </a:lnTo>
                <a:lnTo>
                  <a:pt x="1713" y="404"/>
                </a:lnTo>
                <a:close/>
                <a:moveTo>
                  <a:pt x="3426" y="1240"/>
                </a:moveTo>
                <a:lnTo>
                  <a:pt x="3671" y="1240"/>
                </a:lnTo>
                <a:lnTo>
                  <a:pt x="3671" y="1578"/>
                </a:lnTo>
                <a:lnTo>
                  <a:pt x="3426" y="1578"/>
                </a:lnTo>
                <a:lnTo>
                  <a:pt x="3426" y="1240"/>
                </a:lnTo>
                <a:close/>
              </a:path>
            </a:pathLst>
          </a:custGeom>
          <a:pattFill prst="pct20">
            <a:fgClr>
              <a:srgbClr val="000000"/>
            </a:fgClr>
            <a:bgClr>
              <a:schemeClr val="bg1"/>
            </a:bgClr>
          </a:pattFill>
          <a:ln>
            <a:solidFill>
              <a:srgbClr val="000000"/>
            </a:solidFill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4" name="Freeform 233"/>
          <p:cNvSpPr>
            <a:spLocks noEditPoints="1"/>
          </p:cNvSpPr>
          <p:nvPr/>
        </p:nvSpPr>
        <p:spPr bwMode="auto">
          <a:xfrm>
            <a:off x="2588047" y="1849513"/>
            <a:ext cx="4370784" cy="2505075"/>
          </a:xfrm>
          <a:custGeom>
            <a:avLst/>
            <a:gdLst>
              <a:gd name="T0" fmla="*/ 0 w 3671"/>
              <a:gd name="T1" fmla="*/ 0 h 1578"/>
              <a:gd name="T2" fmla="*/ 244 w 3671"/>
              <a:gd name="T3" fmla="*/ 0 h 1578"/>
              <a:gd name="T4" fmla="*/ 244 w 3671"/>
              <a:gd name="T5" fmla="*/ 1578 h 1578"/>
              <a:gd name="T6" fmla="*/ 0 w 3671"/>
              <a:gd name="T7" fmla="*/ 1578 h 1578"/>
              <a:gd name="T8" fmla="*/ 0 w 3671"/>
              <a:gd name="T9" fmla="*/ 0 h 1578"/>
              <a:gd name="T10" fmla="*/ 1713 w 3671"/>
              <a:gd name="T11" fmla="*/ 404 h 1578"/>
              <a:gd name="T12" fmla="*/ 1958 w 3671"/>
              <a:gd name="T13" fmla="*/ 404 h 1578"/>
              <a:gd name="T14" fmla="*/ 1958 w 3671"/>
              <a:gd name="T15" fmla="*/ 1578 h 1578"/>
              <a:gd name="T16" fmla="*/ 1713 w 3671"/>
              <a:gd name="T17" fmla="*/ 1578 h 1578"/>
              <a:gd name="T18" fmla="*/ 1713 w 3671"/>
              <a:gd name="T19" fmla="*/ 404 h 1578"/>
              <a:gd name="T20" fmla="*/ 3426 w 3671"/>
              <a:gd name="T21" fmla="*/ 1240 h 1578"/>
              <a:gd name="T22" fmla="*/ 3671 w 3671"/>
              <a:gd name="T23" fmla="*/ 1240 h 1578"/>
              <a:gd name="T24" fmla="*/ 3671 w 3671"/>
              <a:gd name="T25" fmla="*/ 1578 h 1578"/>
              <a:gd name="T26" fmla="*/ 3426 w 3671"/>
              <a:gd name="T27" fmla="*/ 1578 h 1578"/>
              <a:gd name="T28" fmla="*/ 3426 w 3671"/>
              <a:gd name="T29" fmla="*/ 1240 h 15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671" h="1578">
                <a:moveTo>
                  <a:pt x="0" y="0"/>
                </a:moveTo>
                <a:lnTo>
                  <a:pt x="244" y="0"/>
                </a:lnTo>
                <a:lnTo>
                  <a:pt x="244" y="1578"/>
                </a:lnTo>
                <a:lnTo>
                  <a:pt x="0" y="1578"/>
                </a:lnTo>
                <a:lnTo>
                  <a:pt x="0" y="0"/>
                </a:lnTo>
                <a:close/>
                <a:moveTo>
                  <a:pt x="1713" y="404"/>
                </a:moveTo>
                <a:lnTo>
                  <a:pt x="1958" y="404"/>
                </a:lnTo>
                <a:lnTo>
                  <a:pt x="1958" y="1578"/>
                </a:lnTo>
                <a:lnTo>
                  <a:pt x="1713" y="1578"/>
                </a:lnTo>
                <a:lnTo>
                  <a:pt x="1713" y="404"/>
                </a:lnTo>
                <a:close/>
                <a:moveTo>
                  <a:pt x="3426" y="1240"/>
                </a:moveTo>
                <a:lnTo>
                  <a:pt x="3671" y="1240"/>
                </a:lnTo>
                <a:lnTo>
                  <a:pt x="3671" y="1578"/>
                </a:lnTo>
                <a:lnTo>
                  <a:pt x="3426" y="1578"/>
                </a:lnTo>
                <a:lnTo>
                  <a:pt x="3426" y="1240"/>
                </a:lnTo>
                <a:close/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5" name="Freeform 234"/>
          <p:cNvSpPr>
            <a:spLocks noEditPoints="1"/>
          </p:cNvSpPr>
          <p:nvPr/>
        </p:nvSpPr>
        <p:spPr bwMode="auto">
          <a:xfrm>
            <a:off x="2953569" y="1506613"/>
            <a:ext cx="301228" cy="2854325"/>
          </a:xfrm>
          <a:custGeom>
            <a:avLst/>
            <a:gdLst>
              <a:gd name="T0" fmla="*/ 0 w 2736"/>
              <a:gd name="T1" fmla="*/ 48 h 19408"/>
              <a:gd name="T2" fmla="*/ 48 w 2736"/>
              <a:gd name="T3" fmla="*/ 0 h 19408"/>
              <a:gd name="T4" fmla="*/ 2688 w 2736"/>
              <a:gd name="T5" fmla="*/ 0 h 19408"/>
              <a:gd name="T6" fmla="*/ 2736 w 2736"/>
              <a:gd name="T7" fmla="*/ 48 h 19408"/>
              <a:gd name="T8" fmla="*/ 2736 w 2736"/>
              <a:gd name="T9" fmla="*/ 19360 h 19408"/>
              <a:gd name="T10" fmla="*/ 2688 w 2736"/>
              <a:gd name="T11" fmla="*/ 19408 h 19408"/>
              <a:gd name="T12" fmla="*/ 48 w 2736"/>
              <a:gd name="T13" fmla="*/ 19408 h 19408"/>
              <a:gd name="T14" fmla="*/ 0 w 2736"/>
              <a:gd name="T15" fmla="*/ 19360 h 19408"/>
              <a:gd name="T16" fmla="*/ 0 w 2736"/>
              <a:gd name="T17" fmla="*/ 48 h 19408"/>
              <a:gd name="T18" fmla="*/ 96 w 2736"/>
              <a:gd name="T19" fmla="*/ 19360 h 19408"/>
              <a:gd name="T20" fmla="*/ 48 w 2736"/>
              <a:gd name="T21" fmla="*/ 19312 h 19408"/>
              <a:gd name="T22" fmla="*/ 2688 w 2736"/>
              <a:gd name="T23" fmla="*/ 19312 h 19408"/>
              <a:gd name="T24" fmla="*/ 2640 w 2736"/>
              <a:gd name="T25" fmla="*/ 19360 h 19408"/>
              <a:gd name="T26" fmla="*/ 2640 w 2736"/>
              <a:gd name="T27" fmla="*/ 48 h 19408"/>
              <a:gd name="T28" fmla="*/ 2688 w 2736"/>
              <a:gd name="T29" fmla="*/ 96 h 19408"/>
              <a:gd name="T30" fmla="*/ 48 w 2736"/>
              <a:gd name="T31" fmla="*/ 96 h 19408"/>
              <a:gd name="T32" fmla="*/ 96 w 2736"/>
              <a:gd name="T33" fmla="*/ 48 h 19408"/>
              <a:gd name="T34" fmla="*/ 96 w 2736"/>
              <a:gd name="T35" fmla="*/ 19360 h 19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736" h="1940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2688" y="0"/>
                </a:lnTo>
                <a:cubicBezTo>
                  <a:pt x="2715" y="0"/>
                  <a:pt x="2736" y="22"/>
                  <a:pt x="2736" y="48"/>
                </a:cubicBezTo>
                <a:lnTo>
                  <a:pt x="2736" y="19360"/>
                </a:lnTo>
                <a:cubicBezTo>
                  <a:pt x="2736" y="19387"/>
                  <a:pt x="2715" y="19408"/>
                  <a:pt x="2688" y="19408"/>
                </a:cubicBezTo>
                <a:lnTo>
                  <a:pt x="48" y="19408"/>
                </a:lnTo>
                <a:cubicBezTo>
                  <a:pt x="22" y="19408"/>
                  <a:pt x="0" y="19387"/>
                  <a:pt x="0" y="19360"/>
                </a:cubicBezTo>
                <a:lnTo>
                  <a:pt x="0" y="48"/>
                </a:lnTo>
                <a:close/>
                <a:moveTo>
                  <a:pt x="96" y="19360"/>
                </a:moveTo>
                <a:lnTo>
                  <a:pt x="48" y="19312"/>
                </a:lnTo>
                <a:lnTo>
                  <a:pt x="2688" y="19312"/>
                </a:lnTo>
                <a:lnTo>
                  <a:pt x="2640" y="19360"/>
                </a:lnTo>
                <a:lnTo>
                  <a:pt x="2640" y="48"/>
                </a:lnTo>
                <a:lnTo>
                  <a:pt x="2688" y="96"/>
                </a:lnTo>
                <a:lnTo>
                  <a:pt x="48" y="96"/>
                </a:lnTo>
                <a:lnTo>
                  <a:pt x="96" y="48"/>
                </a:lnTo>
                <a:lnTo>
                  <a:pt x="96" y="1936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6" name="Freeform 235"/>
          <p:cNvSpPr>
            <a:spLocks noEditPoints="1"/>
          </p:cNvSpPr>
          <p:nvPr/>
        </p:nvSpPr>
        <p:spPr bwMode="auto">
          <a:xfrm>
            <a:off x="4993110" y="2517849"/>
            <a:ext cx="301228" cy="1843088"/>
          </a:xfrm>
          <a:custGeom>
            <a:avLst/>
            <a:gdLst>
              <a:gd name="T0" fmla="*/ 0 w 1368"/>
              <a:gd name="T1" fmla="*/ 24 h 6264"/>
              <a:gd name="T2" fmla="*/ 24 w 1368"/>
              <a:gd name="T3" fmla="*/ 0 h 6264"/>
              <a:gd name="T4" fmla="*/ 1344 w 1368"/>
              <a:gd name="T5" fmla="*/ 0 h 6264"/>
              <a:gd name="T6" fmla="*/ 1368 w 1368"/>
              <a:gd name="T7" fmla="*/ 24 h 6264"/>
              <a:gd name="T8" fmla="*/ 1368 w 1368"/>
              <a:gd name="T9" fmla="*/ 6240 h 6264"/>
              <a:gd name="T10" fmla="*/ 1344 w 1368"/>
              <a:gd name="T11" fmla="*/ 6264 h 6264"/>
              <a:gd name="T12" fmla="*/ 24 w 1368"/>
              <a:gd name="T13" fmla="*/ 6264 h 6264"/>
              <a:gd name="T14" fmla="*/ 0 w 1368"/>
              <a:gd name="T15" fmla="*/ 6240 h 6264"/>
              <a:gd name="T16" fmla="*/ 0 w 1368"/>
              <a:gd name="T17" fmla="*/ 24 h 6264"/>
              <a:gd name="T18" fmla="*/ 48 w 1368"/>
              <a:gd name="T19" fmla="*/ 6240 h 6264"/>
              <a:gd name="T20" fmla="*/ 24 w 1368"/>
              <a:gd name="T21" fmla="*/ 6216 h 6264"/>
              <a:gd name="T22" fmla="*/ 1344 w 1368"/>
              <a:gd name="T23" fmla="*/ 6216 h 6264"/>
              <a:gd name="T24" fmla="*/ 1320 w 1368"/>
              <a:gd name="T25" fmla="*/ 6240 h 6264"/>
              <a:gd name="T26" fmla="*/ 1320 w 1368"/>
              <a:gd name="T27" fmla="*/ 24 h 6264"/>
              <a:gd name="T28" fmla="*/ 1344 w 1368"/>
              <a:gd name="T29" fmla="*/ 48 h 6264"/>
              <a:gd name="T30" fmla="*/ 24 w 1368"/>
              <a:gd name="T31" fmla="*/ 48 h 6264"/>
              <a:gd name="T32" fmla="*/ 48 w 1368"/>
              <a:gd name="T33" fmla="*/ 24 h 6264"/>
              <a:gd name="T34" fmla="*/ 48 w 1368"/>
              <a:gd name="T35" fmla="*/ 6240 h 62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368" h="626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344" y="0"/>
                </a:lnTo>
                <a:cubicBezTo>
                  <a:pt x="1358" y="0"/>
                  <a:pt x="1368" y="11"/>
                  <a:pt x="1368" y="24"/>
                </a:cubicBezTo>
                <a:lnTo>
                  <a:pt x="1368" y="6240"/>
                </a:lnTo>
                <a:cubicBezTo>
                  <a:pt x="1368" y="6254"/>
                  <a:pt x="1358" y="6264"/>
                  <a:pt x="1344" y="6264"/>
                </a:cubicBezTo>
                <a:lnTo>
                  <a:pt x="24" y="6264"/>
                </a:lnTo>
                <a:cubicBezTo>
                  <a:pt x="11" y="6264"/>
                  <a:pt x="0" y="6254"/>
                  <a:pt x="0" y="6240"/>
                </a:cubicBezTo>
                <a:lnTo>
                  <a:pt x="0" y="24"/>
                </a:lnTo>
                <a:close/>
                <a:moveTo>
                  <a:pt x="48" y="6240"/>
                </a:moveTo>
                <a:lnTo>
                  <a:pt x="24" y="6216"/>
                </a:lnTo>
                <a:lnTo>
                  <a:pt x="1344" y="6216"/>
                </a:lnTo>
                <a:lnTo>
                  <a:pt x="1320" y="6240"/>
                </a:lnTo>
                <a:lnTo>
                  <a:pt x="1320" y="24"/>
                </a:lnTo>
                <a:lnTo>
                  <a:pt x="1344" y="48"/>
                </a:lnTo>
                <a:lnTo>
                  <a:pt x="24" y="48"/>
                </a:lnTo>
                <a:lnTo>
                  <a:pt x="48" y="24"/>
                </a:lnTo>
                <a:lnTo>
                  <a:pt x="48" y="624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7" name="Freeform 236"/>
          <p:cNvSpPr>
            <a:spLocks noEditPoints="1"/>
          </p:cNvSpPr>
          <p:nvPr/>
        </p:nvSpPr>
        <p:spPr bwMode="auto">
          <a:xfrm>
            <a:off x="7032650" y="3502099"/>
            <a:ext cx="302419" cy="858838"/>
          </a:xfrm>
          <a:custGeom>
            <a:avLst/>
            <a:gdLst>
              <a:gd name="T0" fmla="*/ 0 w 1368"/>
              <a:gd name="T1" fmla="*/ 24 h 2920"/>
              <a:gd name="T2" fmla="*/ 24 w 1368"/>
              <a:gd name="T3" fmla="*/ 0 h 2920"/>
              <a:gd name="T4" fmla="*/ 1344 w 1368"/>
              <a:gd name="T5" fmla="*/ 0 h 2920"/>
              <a:gd name="T6" fmla="*/ 1368 w 1368"/>
              <a:gd name="T7" fmla="*/ 24 h 2920"/>
              <a:gd name="T8" fmla="*/ 1368 w 1368"/>
              <a:gd name="T9" fmla="*/ 2896 h 2920"/>
              <a:gd name="T10" fmla="*/ 1344 w 1368"/>
              <a:gd name="T11" fmla="*/ 2920 h 2920"/>
              <a:gd name="T12" fmla="*/ 24 w 1368"/>
              <a:gd name="T13" fmla="*/ 2920 h 2920"/>
              <a:gd name="T14" fmla="*/ 0 w 1368"/>
              <a:gd name="T15" fmla="*/ 2896 h 2920"/>
              <a:gd name="T16" fmla="*/ 0 w 1368"/>
              <a:gd name="T17" fmla="*/ 24 h 2920"/>
              <a:gd name="T18" fmla="*/ 48 w 1368"/>
              <a:gd name="T19" fmla="*/ 2896 h 2920"/>
              <a:gd name="T20" fmla="*/ 24 w 1368"/>
              <a:gd name="T21" fmla="*/ 2872 h 2920"/>
              <a:gd name="T22" fmla="*/ 1344 w 1368"/>
              <a:gd name="T23" fmla="*/ 2872 h 2920"/>
              <a:gd name="T24" fmla="*/ 1320 w 1368"/>
              <a:gd name="T25" fmla="*/ 2896 h 2920"/>
              <a:gd name="T26" fmla="*/ 1320 w 1368"/>
              <a:gd name="T27" fmla="*/ 24 h 2920"/>
              <a:gd name="T28" fmla="*/ 1344 w 1368"/>
              <a:gd name="T29" fmla="*/ 48 h 2920"/>
              <a:gd name="T30" fmla="*/ 24 w 1368"/>
              <a:gd name="T31" fmla="*/ 48 h 2920"/>
              <a:gd name="T32" fmla="*/ 48 w 1368"/>
              <a:gd name="T33" fmla="*/ 24 h 2920"/>
              <a:gd name="T34" fmla="*/ 48 w 1368"/>
              <a:gd name="T35" fmla="*/ 2896 h 29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368" h="2920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1344" y="0"/>
                </a:lnTo>
                <a:cubicBezTo>
                  <a:pt x="1358" y="0"/>
                  <a:pt x="1368" y="11"/>
                  <a:pt x="1368" y="24"/>
                </a:cubicBezTo>
                <a:lnTo>
                  <a:pt x="1368" y="2896"/>
                </a:lnTo>
                <a:cubicBezTo>
                  <a:pt x="1368" y="2910"/>
                  <a:pt x="1358" y="2920"/>
                  <a:pt x="1344" y="2920"/>
                </a:cubicBezTo>
                <a:lnTo>
                  <a:pt x="24" y="2920"/>
                </a:lnTo>
                <a:cubicBezTo>
                  <a:pt x="11" y="2920"/>
                  <a:pt x="0" y="2910"/>
                  <a:pt x="0" y="2896"/>
                </a:cubicBezTo>
                <a:lnTo>
                  <a:pt x="0" y="24"/>
                </a:lnTo>
                <a:close/>
                <a:moveTo>
                  <a:pt x="48" y="2896"/>
                </a:moveTo>
                <a:lnTo>
                  <a:pt x="24" y="2872"/>
                </a:lnTo>
                <a:lnTo>
                  <a:pt x="1344" y="2872"/>
                </a:lnTo>
                <a:lnTo>
                  <a:pt x="1320" y="2896"/>
                </a:lnTo>
                <a:lnTo>
                  <a:pt x="1320" y="24"/>
                </a:lnTo>
                <a:lnTo>
                  <a:pt x="1344" y="48"/>
                </a:lnTo>
                <a:lnTo>
                  <a:pt x="24" y="48"/>
                </a:lnTo>
                <a:lnTo>
                  <a:pt x="48" y="24"/>
                </a:lnTo>
                <a:lnTo>
                  <a:pt x="48" y="289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8" name="Freeform 237"/>
          <p:cNvSpPr>
            <a:spLocks noEditPoints="1"/>
          </p:cNvSpPr>
          <p:nvPr/>
        </p:nvSpPr>
        <p:spPr bwMode="auto">
          <a:xfrm>
            <a:off x="2329682" y="1439937"/>
            <a:ext cx="67865" cy="96838"/>
          </a:xfrm>
          <a:custGeom>
            <a:avLst/>
            <a:gdLst>
              <a:gd name="T0" fmla="*/ 33 w 57"/>
              <a:gd name="T1" fmla="*/ 31 h 61"/>
              <a:gd name="T2" fmla="*/ 33 w 57"/>
              <a:gd name="T3" fmla="*/ 57 h 61"/>
              <a:gd name="T4" fmla="*/ 24 w 57"/>
              <a:gd name="T5" fmla="*/ 57 h 61"/>
              <a:gd name="T6" fmla="*/ 24 w 57"/>
              <a:gd name="T7" fmla="*/ 31 h 61"/>
              <a:gd name="T8" fmla="*/ 33 w 57"/>
              <a:gd name="T9" fmla="*/ 31 h 61"/>
              <a:gd name="T10" fmla="*/ 24 w 57"/>
              <a:gd name="T11" fmla="*/ 31 h 61"/>
              <a:gd name="T12" fmla="*/ 24 w 57"/>
              <a:gd name="T13" fmla="*/ 5 h 61"/>
              <a:gd name="T14" fmla="*/ 33 w 57"/>
              <a:gd name="T15" fmla="*/ 5 h 61"/>
              <a:gd name="T16" fmla="*/ 33 w 57"/>
              <a:gd name="T17" fmla="*/ 31 h 61"/>
              <a:gd name="T18" fmla="*/ 24 w 57"/>
              <a:gd name="T19" fmla="*/ 31 h 61"/>
              <a:gd name="T20" fmla="*/ 0 w 57"/>
              <a:gd name="T21" fmla="*/ 52 h 61"/>
              <a:gd name="T22" fmla="*/ 57 w 57"/>
              <a:gd name="T23" fmla="*/ 52 h 61"/>
              <a:gd name="T24" fmla="*/ 57 w 57"/>
              <a:gd name="T25" fmla="*/ 61 h 61"/>
              <a:gd name="T26" fmla="*/ 0 w 57"/>
              <a:gd name="T27" fmla="*/ 61 h 61"/>
              <a:gd name="T28" fmla="*/ 0 w 57"/>
              <a:gd name="T29" fmla="*/ 52 h 61"/>
              <a:gd name="T30" fmla="*/ 0 w 57"/>
              <a:gd name="T31" fmla="*/ 0 h 61"/>
              <a:gd name="T32" fmla="*/ 57 w 57"/>
              <a:gd name="T33" fmla="*/ 0 h 61"/>
              <a:gd name="T34" fmla="*/ 57 w 57"/>
              <a:gd name="T35" fmla="*/ 9 h 61"/>
              <a:gd name="T36" fmla="*/ 0 w 57"/>
              <a:gd name="T37" fmla="*/ 9 h 61"/>
              <a:gd name="T38" fmla="*/ 0 w 57"/>
              <a:gd name="T39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7" h="61">
                <a:moveTo>
                  <a:pt x="33" y="31"/>
                </a:moveTo>
                <a:lnTo>
                  <a:pt x="33" y="57"/>
                </a:lnTo>
                <a:lnTo>
                  <a:pt x="24" y="57"/>
                </a:lnTo>
                <a:lnTo>
                  <a:pt x="24" y="31"/>
                </a:lnTo>
                <a:lnTo>
                  <a:pt x="33" y="31"/>
                </a:lnTo>
                <a:close/>
                <a:moveTo>
                  <a:pt x="24" y="31"/>
                </a:moveTo>
                <a:lnTo>
                  <a:pt x="24" y="5"/>
                </a:lnTo>
                <a:lnTo>
                  <a:pt x="33" y="5"/>
                </a:lnTo>
                <a:lnTo>
                  <a:pt x="33" y="31"/>
                </a:lnTo>
                <a:lnTo>
                  <a:pt x="24" y="31"/>
                </a:lnTo>
                <a:close/>
                <a:moveTo>
                  <a:pt x="0" y="52"/>
                </a:moveTo>
                <a:lnTo>
                  <a:pt x="57" y="52"/>
                </a:lnTo>
                <a:lnTo>
                  <a:pt x="57" y="61"/>
                </a:lnTo>
                <a:lnTo>
                  <a:pt x="0" y="61"/>
                </a:lnTo>
                <a:lnTo>
                  <a:pt x="0" y="52"/>
                </a:lnTo>
                <a:close/>
                <a:moveTo>
                  <a:pt x="0" y="0"/>
                </a:moveTo>
                <a:lnTo>
                  <a:pt x="57" y="0"/>
                </a:lnTo>
                <a:lnTo>
                  <a:pt x="57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9" name="Freeform 238"/>
          <p:cNvSpPr>
            <a:spLocks noEditPoints="1"/>
          </p:cNvSpPr>
          <p:nvPr/>
        </p:nvSpPr>
        <p:spPr bwMode="auto">
          <a:xfrm>
            <a:off x="4370413" y="2784549"/>
            <a:ext cx="66675" cy="146050"/>
          </a:xfrm>
          <a:custGeom>
            <a:avLst/>
            <a:gdLst>
              <a:gd name="T0" fmla="*/ 32 w 56"/>
              <a:gd name="T1" fmla="*/ 46 h 92"/>
              <a:gd name="T2" fmla="*/ 32 w 56"/>
              <a:gd name="T3" fmla="*/ 87 h 92"/>
              <a:gd name="T4" fmla="*/ 23 w 56"/>
              <a:gd name="T5" fmla="*/ 87 h 92"/>
              <a:gd name="T6" fmla="*/ 23 w 56"/>
              <a:gd name="T7" fmla="*/ 46 h 92"/>
              <a:gd name="T8" fmla="*/ 32 w 56"/>
              <a:gd name="T9" fmla="*/ 46 h 92"/>
              <a:gd name="T10" fmla="*/ 23 w 56"/>
              <a:gd name="T11" fmla="*/ 46 h 92"/>
              <a:gd name="T12" fmla="*/ 23 w 56"/>
              <a:gd name="T13" fmla="*/ 4 h 92"/>
              <a:gd name="T14" fmla="*/ 32 w 56"/>
              <a:gd name="T15" fmla="*/ 4 h 92"/>
              <a:gd name="T16" fmla="*/ 32 w 56"/>
              <a:gd name="T17" fmla="*/ 46 h 92"/>
              <a:gd name="T18" fmla="*/ 23 w 56"/>
              <a:gd name="T19" fmla="*/ 46 h 92"/>
              <a:gd name="T20" fmla="*/ 0 w 56"/>
              <a:gd name="T21" fmla="*/ 83 h 92"/>
              <a:gd name="T22" fmla="*/ 56 w 56"/>
              <a:gd name="T23" fmla="*/ 83 h 92"/>
              <a:gd name="T24" fmla="*/ 56 w 56"/>
              <a:gd name="T25" fmla="*/ 92 h 92"/>
              <a:gd name="T26" fmla="*/ 0 w 56"/>
              <a:gd name="T27" fmla="*/ 92 h 92"/>
              <a:gd name="T28" fmla="*/ 0 w 56"/>
              <a:gd name="T29" fmla="*/ 83 h 92"/>
              <a:gd name="T30" fmla="*/ 0 w 56"/>
              <a:gd name="T31" fmla="*/ 0 h 92"/>
              <a:gd name="T32" fmla="*/ 56 w 56"/>
              <a:gd name="T33" fmla="*/ 0 h 92"/>
              <a:gd name="T34" fmla="*/ 56 w 56"/>
              <a:gd name="T35" fmla="*/ 9 h 92"/>
              <a:gd name="T36" fmla="*/ 0 w 56"/>
              <a:gd name="T37" fmla="*/ 9 h 92"/>
              <a:gd name="T38" fmla="*/ 0 w 56"/>
              <a:gd name="T39" fmla="*/ 0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6" h="92">
                <a:moveTo>
                  <a:pt x="32" y="46"/>
                </a:moveTo>
                <a:lnTo>
                  <a:pt x="32" y="87"/>
                </a:lnTo>
                <a:lnTo>
                  <a:pt x="23" y="87"/>
                </a:lnTo>
                <a:lnTo>
                  <a:pt x="23" y="46"/>
                </a:lnTo>
                <a:lnTo>
                  <a:pt x="32" y="46"/>
                </a:lnTo>
                <a:close/>
                <a:moveTo>
                  <a:pt x="23" y="46"/>
                </a:moveTo>
                <a:lnTo>
                  <a:pt x="23" y="4"/>
                </a:lnTo>
                <a:lnTo>
                  <a:pt x="32" y="4"/>
                </a:lnTo>
                <a:lnTo>
                  <a:pt x="32" y="46"/>
                </a:lnTo>
                <a:lnTo>
                  <a:pt x="23" y="46"/>
                </a:lnTo>
                <a:close/>
                <a:moveTo>
                  <a:pt x="0" y="83"/>
                </a:moveTo>
                <a:lnTo>
                  <a:pt x="56" y="83"/>
                </a:lnTo>
                <a:lnTo>
                  <a:pt x="56" y="92"/>
                </a:lnTo>
                <a:lnTo>
                  <a:pt x="0" y="92"/>
                </a:lnTo>
                <a:lnTo>
                  <a:pt x="0" y="83"/>
                </a:lnTo>
                <a:close/>
                <a:moveTo>
                  <a:pt x="0" y="0"/>
                </a:moveTo>
                <a:lnTo>
                  <a:pt x="56" y="0"/>
                </a:lnTo>
                <a:lnTo>
                  <a:pt x="56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0" name="Freeform 239"/>
          <p:cNvSpPr>
            <a:spLocks noEditPoints="1"/>
          </p:cNvSpPr>
          <p:nvPr/>
        </p:nvSpPr>
        <p:spPr bwMode="auto">
          <a:xfrm>
            <a:off x="6409954" y="3311599"/>
            <a:ext cx="66675" cy="647700"/>
          </a:xfrm>
          <a:custGeom>
            <a:avLst/>
            <a:gdLst>
              <a:gd name="T0" fmla="*/ 33 w 56"/>
              <a:gd name="T1" fmla="*/ 205 h 408"/>
              <a:gd name="T2" fmla="*/ 33 w 56"/>
              <a:gd name="T3" fmla="*/ 403 h 408"/>
              <a:gd name="T4" fmla="*/ 24 w 56"/>
              <a:gd name="T5" fmla="*/ 403 h 408"/>
              <a:gd name="T6" fmla="*/ 24 w 56"/>
              <a:gd name="T7" fmla="*/ 205 h 408"/>
              <a:gd name="T8" fmla="*/ 33 w 56"/>
              <a:gd name="T9" fmla="*/ 205 h 408"/>
              <a:gd name="T10" fmla="*/ 24 w 56"/>
              <a:gd name="T11" fmla="*/ 205 h 408"/>
              <a:gd name="T12" fmla="*/ 24 w 56"/>
              <a:gd name="T13" fmla="*/ 4 h 408"/>
              <a:gd name="T14" fmla="*/ 33 w 56"/>
              <a:gd name="T15" fmla="*/ 4 h 408"/>
              <a:gd name="T16" fmla="*/ 33 w 56"/>
              <a:gd name="T17" fmla="*/ 205 h 408"/>
              <a:gd name="T18" fmla="*/ 24 w 56"/>
              <a:gd name="T19" fmla="*/ 205 h 408"/>
              <a:gd name="T20" fmla="*/ 0 w 56"/>
              <a:gd name="T21" fmla="*/ 399 h 408"/>
              <a:gd name="T22" fmla="*/ 56 w 56"/>
              <a:gd name="T23" fmla="*/ 399 h 408"/>
              <a:gd name="T24" fmla="*/ 56 w 56"/>
              <a:gd name="T25" fmla="*/ 408 h 408"/>
              <a:gd name="T26" fmla="*/ 0 w 56"/>
              <a:gd name="T27" fmla="*/ 408 h 408"/>
              <a:gd name="T28" fmla="*/ 0 w 56"/>
              <a:gd name="T29" fmla="*/ 399 h 408"/>
              <a:gd name="T30" fmla="*/ 0 w 56"/>
              <a:gd name="T31" fmla="*/ 0 h 408"/>
              <a:gd name="T32" fmla="*/ 56 w 56"/>
              <a:gd name="T33" fmla="*/ 0 h 408"/>
              <a:gd name="T34" fmla="*/ 56 w 56"/>
              <a:gd name="T35" fmla="*/ 9 h 408"/>
              <a:gd name="T36" fmla="*/ 0 w 56"/>
              <a:gd name="T37" fmla="*/ 9 h 408"/>
              <a:gd name="T38" fmla="*/ 0 w 56"/>
              <a:gd name="T39" fmla="*/ 0 h 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6" h="408">
                <a:moveTo>
                  <a:pt x="33" y="205"/>
                </a:moveTo>
                <a:lnTo>
                  <a:pt x="33" y="403"/>
                </a:lnTo>
                <a:lnTo>
                  <a:pt x="24" y="403"/>
                </a:lnTo>
                <a:lnTo>
                  <a:pt x="24" y="205"/>
                </a:lnTo>
                <a:lnTo>
                  <a:pt x="33" y="205"/>
                </a:lnTo>
                <a:close/>
                <a:moveTo>
                  <a:pt x="24" y="205"/>
                </a:moveTo>
                <a:lnTo>
                  <a:pt x="24" y="4"/>
                </a:lnTo>
                <a:lnTo>
                  <a:pt x="33" y="4"/>
                </a:lnTo>
                <a:lnTo>
                  <a:pt x="33" y="205"/>
                </a:lnTo>
                <a:lnTo>
                  <a:pt x="24" y="205"/>
                </a:lnTo>
                <a:close/>
                <a:moveTo>
                  <a:pt x="0" y="399"/>
                </a:moveTo>
                <a:lnTo>
                  <a:pt x="56" y="399"/>
                </a:lnTo>
                <a:lnTo>
                  <a:pt x="56" y="408"/>
                </a:lnTo>
                <a:lnTo>
                  <a:pt x="0" y="408"/>
                </a:lnTo>
                <a:lnTo>
                  <a:pt x="0" y="399"/>
                </a:lnTo>
                <a:close/>
                <a:moveTo>
                  <a:pt x="0" y="0"/>
                </a:moveTo>
                <a:lnTo>
                  <a:pt x="56" y="0"/>
                </a:lnTo>
                <a:lnTo>
                  <a:pt x="56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1" name="Freeform 240"/>
          <p:cNvSpPr>
            <a:spLocks noEditPoints="1"/>
          </p:cNvSpPr>
          <p:nvPr/>
        </p:nvSpPr>
        <p:spPr bwMode="auto">
          <a:xfrm>
            <a:off x="2701157" y="1676474"/>
            <a:ext cx="64294" cy="349250"/>
          </a:xfrm>
          <a:custGeom>
            <a:avLst/>
            <a:gdLst>
              <a:gd name="T0" fmla="*/ 32 w 54"/>
              <a:gd name="T1" fmla="*/ 109 h 220"/>
              <a:gd name="T2" fmla="*/ 32 w 54"/>
              <a:gd name="T3" fmla="*/ 216 h 220"/>
              <a:gd name="T4" fmla="*/ 23 w 54"/>
              <a:gd name="T5" fmla="*/ 216 h 220"/>
              <a:gd name="T6" fmla="*/ 23 w 54"/>
              <a:gd name="T7" fmla="*/ 109 h 220"/>
              <a:gd name="T8" fmla="*/ 32 w 54"/>
              <a:gd name="T9" fmla="*/ 109 h 220"/>
              <a:gd name="T10" fmla="*/ 23 w 54"/>
              <a:gd name="T11" fmla="*/ 109 h 220"/>
              <a:gd name="T12" fmla="*/ 23 w 54"/>
              <a:gd name="T13" fmla="*/ 4 h 220"/>
              <a:gd name="T14" fmla="*/ 32 w 54"/>
              <a:gd name="T15" fmla="*/ 4 h 220"/>
              <a:gd name="T16" fmla="*/ 32 w 54"/>
              <a:gd name="T17" fmla="*/ 109 h 220"/>
              <a:gd name="T18" fmla="*/ 23 w 54"/>
              <a:gd name="T19" fmla="*/ 109 h 220"/>
              <a:gd name="T20" fmla="*/ 0 w 54"/>
              <a:gd name="T21" fmla="*/ 212 h 220"/>
              <a:gd name="T22" fmla="*/ 54 w 54"/>
              <a:gd name="T23" fmla="*/ 212 h 220"/>
              <a:gd name="T24" fmla="*/ 54 w 54"/>
              <a:gd name="T25" fmla="*/ 220 h 220"/>
              <a:gd name="T26" fmla="*/ 0 w 54"/>
              <a:gd name="T27" fmla="*/ 220 h 220"/>
              <a:gd name="T28" fmla="*/ 0 w 54"/>
              <a:gd name="T29" fmla="*/ 212 h 220"/>
              <a:gd name="T30" fmla="*/ 0 w 54"/>
              <a:gd name="T31" fmla="*/ 0 h 220"/>
              <a:gd name="T32" fmla="*/ 54 w 54"/>
              <a:gd name="T33" fmla="*/ 0 h 220"/>
              <a:gd name="T34" fmla="*/ 54 w 54"/>
              <a:gd name="T35" fmla="*/ 8 h 220"/>
              <a:gd name="T36" fmla="*/ 0 w 54"/>
              <a:gd name="T37" fmla="*/ 8 h 220"/>
              <a:gd name="T38" fmla="*/ 0 w 54"/>
              <a:gd name="T39" fmla="*/ 0 h 2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4" h="220">
                <a:moveTo>
                  <a:pt x="32" y="109"/>
                </a:moveTo>
                <a:lnTo>
                  <a:pt x="32" y="216"/>
                </a:lnTo>
                <a:lnTo>
                  <a:pt x="23" y="216"/>
                </a:lnTo>
                <a:lnTo>
                  <a:pt x="23" y="109"/>
                </a:lnTo>
                <a:lnTo>
                  <a:pt x="32" y="109"/>
                </a:lnTo>
                <a:close/>
                <a:moveTo>
                  <a:pt x="23" y="109"/>
                </a:moveTo>
                <a:lnTo>
                  <a:pt x="23" y="4"/>
                </a:lnTo>
                <a:lnTo>
                  <a:pt x="32" y="4"/>
                </a:lnTo>
                <a:lnTo>
                  <a:pt x="32" y="109"/>
                </a:lnTo>
                <a:lnTo>
                  <a:pt x="23" y="109"/>
                </a:lnTo>
                <a:close/>
                <a:moveTo>
                  <a:pt x="0" y="212"/>
                </a:moveTo>
                <a:lnTo>
                  <a:pt x="54" y="212"/>
                </a:lnTo>
                <a:lnTo>
                  <a:pt x="54" y="220"/>
                </a:lnTo>
                <a:lnTo>
                  <a:pt x="0" y="220"/>
                </a:lnTo>
                <a:lnTo>
                  <a:pt x="0" y="212"/>
                </a:lnTo>
                <a:close/>
                <a:moveTo>
                  <a:pt x="0" y="0"/>
                </a:moveTo>
                <a:lnTo>
                  <a:pt x="54" y="0"/>
                </a:lnTo>
                <a:lnTo>
                  <a:pt x="54" y="8"/>
                </a:lnTo>
                <a:lnTo>
                  <a:pt x="0" y="8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2" name="Freeform 241"/>
          <p:cNvSpPr>
            <a:spLocks noEditPoints="1"/>
          </p:cNvSpPr>
          <p:nvPr/>
        </p:nvSpPr>
        <p:spPr bwMode="auto">
          <a:xfrm>
            <a:off x="4740697" y="2349575"/>
            <a:ext cx="65484" cy="284163"/>
          </a:xfrm>
          <a:custGeom>
            <a:avLst/>
            <a:gdLst>
              <a:gd name="T0" fmla="*/ 32 w 55"/>
              <a:gd name="T1" fmla="*/ 89 h 179"/>
              <a:gd name="T2" fmla="*/ 32 w 55"/>
              <a:gd name="T3" fmla="*/ 174 h 179"/>
              <a:gd name="T4" fmla="*/ 24 w 55"/>
              <a:gd name="T5" fmla="*/ 174 h 179"/>
              <a:gd name="T6" fmla="*/ 24 w 55"/>
              <a:gd name="T7" fmla="*/ 89 h 179"/>
              <a:gd name="T8" fmla="*/ 32 w 55"/>
              <a:gd name="T9" fmla="*/ 89 h 179"/>
              <a:gd name="T10" fmla="*/ 24 w 55"/>
              <a:gd name="T11" fmla="*/ 89 h 179"/>
              <a:gd name="T12" fmla="*/ 24 w 55"/>
              <a:gd name="T13" fmla="*/ 4 h 179"/>
              <a:gd name="T14" fmla="*/ 32 w 55"/>
              <a:gd name="T15" fmla="*/ 4 h 179"/>
              <a:gd name="T16" fmla="*/ 32 w 55"/>
              <a:gd name="T17" fmla="*/ 89 h 179"/>
              <a:gd name="T18" fmla="*/ 24 w 55"/>
              <a:gd name="T19" fmla="*/ 89 h 179"/>
              <a:gd name="T20" fmla="*/ 0 w 55"/>
              <a:gd name="T21" fmla="*/ 170 h 179"/>
              <a:gd name="T22" fmla="*/ 55 w 55"/>
              <a:gd name="T23" fmla="*/ 170 h 179"/>
              <a:gd name="T24" fmla="*/ 55 w 55"/>
              <a:gd name="T25" fmla="*/ 179 h 179"/>
              <a:gd name="T26" fmla="*/ 0 w 55"/>
              <a:gd name="T27" fmla="*/ 179 h 179"/>
              <a:gd name="T28" fmla="*/ 0 w 55"/>
              <a:gd name="T29" fmla="*/ 170 h 179"/>
              <a:gd name="T30" fmla="*/ 0 w 55"/>
              <a:gd name="T31" fmla="*/ 0 h 179"/>
              <a:gd name="T32" fmla="*/ 55 w 55"/>
              <a:gd name="T33" fmla="*/ 0 h 179"/>
              <a:gd name="T34" fmla="*/ 55 w 55"/>
              <a:gd name="T35" fmla="*/ 8 h 179"/>
              <a:gd name="T36" fmla="*/ 0 w 55"/>
              <a:gd name="T37" fmla="*/ 8 h 179"/>
              <a:gd name="T38" fmla="*/ 0 w 55"/>
              <a:gd name="T39" fmla="*/ 0 h 1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5" h="179">
                <a:moveTo>
                  <a:pt x="32" y="89"/>
                </a:moveTo>
                <a:lnTo>
                  <a:pt x="32" y="174"/>
                </a:lnTo>
                <a:lnTo>
                  <a:pt x="24" y="174"/>
                </a:lnTo>
                <a:lnTo>
                  <a:pt x="24" y="89"/>
                </a:lnTo>
                <a:lnTo>
                  <a:pt x="32" y="89"/>
                </a:lnTo>
                <a:close/>
                <a:moveTo>
                  <a:pt x="24" y="89"/>
                </a:moveTo>
                <a:lnTo>
                  <a:pt x="24" y="4"/>
                </a:lnTo>
                <a:lnTo>
                  <a:pt x="32" y="4"/>
                </a:lnTo>
                <a:lnTo>
                  <a:pt x="32" y="89"/>
                </a:lnTo>
                <a:lnTo>
                  <a:pt x="24" y="89"/>
                </a:lnTo>
                <a:close/>
                <a:moveTo>
                  <a:pt x="0" y="170"/>
                </a:moveTo>
                <a:lnTo>
                  <a:pt x="55" y="170"/>
                </a:lnTo>
                <a:lnTo>
                  <a:pt x="55" y="179"/>
                </a:lnTo>
                <a:lnTo>
                  <a:pt x="0" y="179"/>
                </a:lnTo>
                <a:lnTo>
                  <a:pt x="0" y="170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8"/>
                </a:lnTo>
                <a:lnTo>
                  <a:pt x="0" y="8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3" name="Freeform 242"/>
          <p:cNvSpPr>
            <a:spLocks noEditPoints="1"/>
          </p:cNvSpPr>
          <p:nvPr/>
        </p:nvSpPr>
        <p:spPr bwMode="auto">
          <a:xfrm>
            <a:off x="6780238" y="3764037"/>
            <a:ext cx="65484" cy="107950"/>
          </a:xfrm>
          <a:custGeom>
            <a:avLst/>
            <a:gdLst>
              <a:gd name="T0" fmla="*/ 33 w 55"/>
              <a:gd name="T1" fmla="*/ 34 h 68"/>
              <a:gd name="T2" fmla="*/ 33 w 55"/>
              <a:gd name="T3" fmla="*/ 63 h 68"/>
              <a:gd name="T4" fmla="*/ 24 w 55"/>
              <a:gd name="T5" fmla="*/ 63 h 68"/>
              <a:gd name="T6" fmla="*/ 24 w 55"/>
              <a:gd name="T7" fmla="*/ 34 h 68"/>
              <a:gd name="T8" fmla="*/ 33 w 55"/>
              <a:gd name="T9" fmla="*/ 34 h 68"/>
              <a:gd name="T10" fmla="*/ 24 w 55"/>
              <a:gd name="T11" fmla="*/ 34 h 68"/>
              <a:gd name="T12" fmla="*/ 24 w 55"/>
              <a:gd name="T13" fmla="*/ 4 h 68"/>
              <a:gd name="T14" fmla="*/ 33 w 55"/>
              <a:gd name="T15" fmla="*/ 4 h 68"/>
              <a:gd name="T16" fmla="*/ 33 w 55"/>
              <a:gd name="T17" fmla="*/ 34 h 68"/>
              <a:gd name="T18" fmla="*/ 24 w 55"/>
              <a:gd name="T19" fmla="*/ 34 h 68"/>
              <a:gd name="T20" fmla="*/ 0 w 55"/>
              <a:gd name="T21" fmla="*/ 59 h 68"/>
              <a:gd name="T22" fmla="*/ 55 w 55"/>
              <a:gd name="T23" fmla="*/ 59 h 68"/>
              <a:gd name="T24" fmla="*/ 55 w 55"/>
              <a:gd name="T25" fmla="*/ 68 h 68"/>
              <a:gd name="T26" fmla="*/ 0 w 55"/>
              <a:gd name="T27" fmla="*/ 68 h 68"/>
              <a:gd name="T28" fmla="*/ 0 w 55"/>
              <a:gd name="T29" fmla="*/ 59 h 68"/>
              <a:gd name="T30" fmla="*/ 0 w 55"/>
              <a:gd name="T31" fmla="*/ 0 h 68"/>
              <a:gd name="T32" fmla="*/ 55 w 55"/>
              <a:gd name="T33" fmla="*/ 0 h 68"/>
              <a:gd name="T34" fmla="*/ 55 w 55"/>
              <a:gd name="T35" fmla="*/ 8 h 68"/>
              <a:gd name="T36" fmla="*/ 0 w 55"/>
              <a:gd name="T37" fmla="*/ 8 h 68"/>
              <a:gd name="T38" fmla="*/ 0 w 55"/>
              <a:gd name="T39" fmla="*/ 0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5" h="68">
                <a:moveTo>
                  <a:pt x="33" y="34"/>
                </a:moveTo>
                <a:lnTo>
                  <a:pt x="33" y="63"/>
                </a:lnTo>
                <a:lnTo>
                  <a:pt x="24" y="63"/>
                </a:lnTo>
                <a:lnTo>
                  <a:pt x="24" y="34"/>
                </a:lnTo>
                <a:lnTo>
                  <a:pt x="33" y="34"/>
                </a:lnTo>
                <a:close/>
                <a:moveTo>
                  <a:pt x="24" y="34"/>
                </a:moveTo>
                <a:lnTo>
                  <a:pt x="24" y="4"/>
                </a:lnTo>
                <a:lnTo>
                  <a:pt x="33" y="4"/>
                </a:lnTo>
                <a:lnTo>
                  <a:pt x="33" y="34"/>
                </a:lnTo>
                <a:lnTo>
                  <a:pt x="24" y="34"/>
                </a:lnTo>
                <a:close/>
                <a:moveTo>
                  <a:pt x="0" y="59"/>
                </a:moveTo>
                <a:lnTo>
                  <a:pt x="55" y="59"/>
                </a:lnTo>
                <a:lnTo>
                  <a:pt x="55" y="68"/>
                </a:lnTo>
                <a:lnTo>
                  <a:pt x="0" y="68"/>
                </a:lnTo>
                <a:lnTo>
                  <a:pt x="0" y="59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8"/>
                </a:lnTo>
                <a:lnTo>
                  <a:pt x="0" y="8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4" name="Freeform 243"/>
          <p:cNvSpPr>
            <a:spLocks noEditPoints="1"/>
          </p:cNvSpPr>
          <p:nvPr/>
        </p:nvSpPr>
        <p:spPr bwMode="auto">
          <a:xfrm>
            <a:off x="3071441" y="1339925"/>
            <a:ext cx="65484" cy="347663"/>
          </a:xfrm>
          <a:custGeom>
            <a:avLst/>
            <a:gdLst>
              <a:gd name="T0" fmla="*/ 31 w 55"/>
              <a:gd name="T1" fmla="*/ 109 h 219"/>
              <a:gd name="T2" fmla="*/ 31 w 55"/>
              <a:gd name="T3" fmla="*/ 215 h 219"/>
              <a:gd name="T4" fmla="*/ 22 w 55"/>
              <a:gd name="T5" fmla="*/ 215 h 219"/>
              <a:gd name="T6" fmla="*/ 22 w 55"/>
              <a:gd name="T7" fmla="*/ 109 h 219"/>
              <a:gd name="T8" fmla="*/ 31 w 55"/>
              <a:gd name="T9" fmla="*/ 109 h 219"/>
              <a:gd name="T10" fmla="*/ 22 w 55"/>
              <a:gd name="T11" fmla="*/ 109 h 219"/>
              <a:gd name="T12" fmla="*/ 22 w 55"/>
              <a:gd name="T13" fmla="*/ 4 h 219"/>
              <a:gd name="T14" fmla="*/ 31 w 55"/>
              <a:gd name="T15" fmla="*/ 4 h 219"/>
              <a:gd name="T16" fmla="*/ 31 w 55"/>
              <a:gd name="T17" fmla="*/ 109 h 219"/>
              <a:gd name="T18" fmla="*/ 22 w 55"/>
              <a:gd name="T19" fmla="*/ 109 h 219"/>
              <a:gd name="T20" fmla="*/ 0 w 55"/>
              <a:gd name="T21" fmla="*/ 210 h 219"/>
              <a:gd name="T22" fmla="*/ 55 w 55"/>
              <a:gd name="T23" fmla="*/ 210 h 219"/>
              <a:gd name="T24" fmla="*/ 55 w 55"/>
              <a:gd name="T25" fmla="*/ 219 h 219"/>
              <a:gd name="T26" fmla="*/ 0 w 55"/>
              <a:gd name="T27" fmla="*/ 219 h 219"/>
              <a:gd name="T28" fmla="*/ 0 w 55"/>
              <a:gd name="T29" fmla="*/ 210 h 219"/>
              <a:gd name="T30" fmla="*/ 0 w 55"/>
              <a:gd name="T31" fmla="*/ 0 h 219"/>
              <a:gd name="T32" fmla="*/ 55 w 55"/>
              <a:gd name="T33" fmla="*/ 0 h 219"/>
              <a:gd name="T34" fmla="*/ 55 w 55"/>
              <a:gd name="T35" fmla="*/ 8 h 219"/>
              <a:gd name="T36" fmla="*/ 0 w 55"/>
              <a:gd name="T37" fmla="*/ 8 h 219"/>
              <a:gd name="T38" fmla="*/ 0 w 55"/>
              <a:gd name="T39" fmla="*/ 0 h 2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5" h="219">
                <a:moveTo>
                  <a:pt x="31" y="109"/>
                </a:moveTo>
                <a:lnTo>
                  <a:pt x="31" y="215"/>
                </a:lnTo>
                <a:lnTo>
                  <a:pt x="22" y="215"/>
                </a:lnTo>
                <a:lnTo>
                  <a:pt x="22" y="109"/>
                </a:lnTo>
                <a:lnTo>
                  <a:pt x="31" y="109"/>
                </a:lnTo>
                <a:close/>
                <a:moveTo>
                  <a:pt x="22" y="109"/>
                </a:moveTo>
                <a:lnTo>
                  <a:pt x="22" y="4"/>
                </a:lnTo>
                <a:lnTo>
                  <a:pt x="31" y="4"/>
                </a:lnTo>
                <a:lnTo>
                  <a:pt x="31" y="109"/>
                </a:lnTo>
                <a:lnTo>
                  <a:pt x="22" y="109"/>
                </a:lnTo>
                <a:close/>
                <a:moveTo>
                  <a:pt x="0" y="210"/>
                </a:moveTo>
                <a:lnTo>
                  <a:pt x="55" y="210"/>
                </a:lnTo>
                <a:lnTo>
                  <a:pt x="55" y="219"/>
                </a:lnTo>
                <a:lnTo>
                  <a:pt x="0" y="219"/>
                </a:lnTo>
                <a:lnTo>
                  <a:pt x="0" y="210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8"/>
                </a:lnTo>
                <a:lnTo>
                  <a:pt x="0" y="8"/>
                </a:lnTo>
                <a:lnTo>
                  <a:pt x="0" y="0"/>
                </a:lnTo>
                <a:close/>
              </a:path>
            </a:pathLst>
          </a:custGeom>
          <a:solidFill>
            <a:srgbClr val="595959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5" name="Freeform 244"/>
          <p:cNvSpPr>
            <a:spLocks noEditPoints="1"/>
          </p:cNvSpPr>
          <p:nvPr/>
        </p:nvSpPr>
        <p:spPr bwMode="auto">
          <a:xfrm>
            <a:off x="5110981" y="2511500"/>
            <a:ext cx="65484" cy="28575"/>
          </a:xfrm>
          <a:custGeom>
            <a:avLst/>
            <a:gdLst>
              <a:gd name="T0" fmla="*/ 31 w 55"/>
              <a:gd name="T1" fmla="*/ 9 h 18"/>
              <a:gd name="T2" fmla="*/ 31 w 55"/>
              <a:gd name="T3" fmla="*/ 13 h 18"/>
              <a:gd name="T4" fmla="*/ 22 w 55"/>
              <a:gd name="T5" fmla="*/ 13 h 18"/>
              <a:gd name="T6" fmla="*/ 22 w 55"/>
              <a:gd name="T7" fmla="*/ 9 h 18"/>
              <a:gd name="T8" fmla="*/ 31 w 55"/>
              <a:gd name="T9" fmla="*/ 9 h 18"/>
              <a:gd name="T10" fmla="*/ 22 w 55"/>
              <a:gd name="T11" fmla="*/ 9 h 18"/>
              <a:gd name="T12" fmla="*/ 22 w 55"/>
              <a:gd name="T13" fmla="*/ 4 h 18"/>
              <a:gd name="T14" fmla="*/ 31 w 55"/>
              <a:gd name="T15" fmla="*/ 4 h 18"/>
              <a:gd name="T16" fmla="*/ 31 w 55"/>
              <a:gd name="T17" fmla="*/ 9 h 18"/>
              <a:gd name="T18" fmla="*/ 22 w 55"/>
              <a:gd name="T19" fmla="*/ 9 h 18"/>
              <a:gd name="T20" fmla="*/ 0 w 55"/>
              <a:gd name="T21" fmla="*/ 9 h 18"/>
              <a:gd name="T22" fmla="*/ 55 w 55"/>
              <a:gd name="T23" fmla="*/ 9 h 18"/>
              <a:gd name="T24" fmla="*/ 55 w 55"/>
              <a:gd name="T25" fmla="*/ 18 h 18"/>
              <a:gd name="T26" fmla="*/ 0 w 55"/>
              <a:gd name="T27" fmla="*/ 18 h 18"/>
              <a:gd name="T28" fmla="*/ 0 w 55"/>
              <a:gd name="T29" fmla="*/ 9 h 18"/>
              <a:gd name="T30" fmla="*/ 0 w 55"/>
              <a:gd name="T31" fmla="*/ 0 h 18"/>
              <a:gd name="T32" fmla="*/ 55 w 55"/>
              <a:gd name="T33" fmla="*/ 0 h 18"/>
              <a:gd name="T34" fmla="*/ 55 w 55"/>
              <a:gd name="T35" fmla="*/ 9 h 18"/>
              <a:gd name="T36" fmla="*/ 0 w 55"/>
              <a:gd name="T37" fmla="*/ 9 h 18"/>
              <a:gd name="T38" fmla="*/ 0 w 55"/>
              <a:gd name="T39" fmla="*/ 0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5" h="18">
                <a:moveTo>
                  <a:pt x="31" y="9"/>
                </a:moveTo>
                <a:lnTo>
                  <a:pt x="31" y="13"/>
                </a:lnTo>
                <a:lnTo>
                  <a:pt x="22" y="13"/>
                </a:lnTo>
                <a:lnTo>
                  <a:pt x="22" y="9"/>
                </a:lnTo>
                <a:lnTo>
                  <a:pt x="31" y="9"/>
                </a:lnTo>
                <a:close/>
                <a:moveTo>
                  <a:pt x="22" y="9"/>
                </a:moveTo>
                <a:lnTo>
                  <a:pt x="22" y="4"/>
                </a:lnTo>
                <a:lnTo>
                  <a:pt x="31" y="4"/>
                </a:lnTo>
                <a:lnTo>
                  <a:pt x="31" y="9"/>
                </a:lnTo>
                <a:lnTo>
                  <a:pt x="22" y="9"/>
                </a:lnTo>
                <a:close/>
                <a:moveTo>
                  <a:pt x="0" y="9"/>
                </a:moveTo>
                <a:lnTo>
                  <a:pt x="55" y="9"/>
                </a:lnTo>
                <a:lnTo>
                  <a:pt x="55" y="18"/>
                </a:lnTo>
                <a:lnTo>
                  <a:pt x="0" y="18"/>
                </a:lnTo>
                <a:lnTo>
                  <a:pt x="0" y="9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6" name="Freeform 245"/>
          <p:cNvSpPr>
            <a:spLocks noEditPoints="1"/>
          </p:cNvSpPr>
          <p:nvPr/>
        </p:nvSpPr>
        <p:spPr bwMode="auto">
          <a:xfrm>
            <a:off x="7150522" y="3432250"/>
            <a:ext cx="65484" cy="157163"/>
          </a:xfrm>
          <a:custGeom>
            <a:avLst/>
            <a:gdLst>
              <a:gd name="T0" fmla="*/ 32 w 55"/>
              <a:gd name="T1" fmla="*/ 48 h 99"/>
              <a:gd name="T2" fmla="*/ 32 w 55"/>
              <a:gd name="T3" fmla="*/ 94 h 99"/>
              <a:gd name="T4" fmla="*/ 23 w 55"/>
              <a:gd name="T5" fmla="*/ 94 h 99"/>
              <a:gd name="T6" fmla="*/ 23 w 55"/>
              <a:gd name="T7" fmla="*/ 48 h 99"/>
              <a:gd name="T8" fmla="*/ 32 w 55"/>
              <a:gd name="T9" fmla="*/ 48 h 99"/>
              <a:gd name="T10" fmla="*/ 23 w 55"/>
              <a:gd name="T11" fmla="*/ 48 h 99"/>
              <a:gd name="T12" fmla="*/ 23 w 55"/>
              <a:gd name="T13" fmla="*/ 4 h 99"/>
              <a:gd name="T14" fmla="*/ 32 w 55"/>
              <a:gd name="T15" fmla="*/ 4 h 99"/>
              <a:gd name="T16" fmla="*/ 32 w 55"/>
              <a:gd name="T17" fmla="*/ 48 h 99"/>
              <a:gd name="T18" fmla="*/ 23 w 55"/>
              <a:gd name="T19" fmla="*/ 48 h 99"/>
              <a:gd name="T20" fmla="*/ 0 w 55"/>
              <a:gd name="T21" fmla="*/ 90 h 99"/>
              <a:gd name="T22" fmla="*/ 55 w 55"/>
              <a:gd name="T23" fmla="*/ 90 h 99"/>
              <a:gd name="T24" fmla="*/ 55 w 55"/>
              <a:gd name="T25" fmla="*/ 99 h 99"/>
              <a:gd name="T26" fmla="*/ 0 w 55"/>
              <a:gd name="T27" fmla="*/ 99 h 99"/>
              <a:gd name="T28" fmla="*/ 0 w 55"/>
              <a:gd name="T29" fmla="*/ 90 h 99"/>
              <a:gd name="T30" fmla="*/ 0 w 55"/>
              <a:gd name="T31" fmla="*/ 0 h 99"/>
              <a:gd name="T32" fmla="*/ 55 w 55"/>
              <a:gd name="T33" fmla="*/ 0 h 99"/>
              <a:gd name="T34" fmla="*/ 55 w 55"/>
              <a:gd name="T35" fmla="*/ 8 h 99"/>
              <a:gd name="T36" fmla="*/ 0 w 55"/>
              <a:gd name="T37" fmla="*/ 8 h 99"/>
              <a:gd name="T38" fmla="*/ 0 w 55"/>
              <a:gd name="T39" fmla="*/ 0 h 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55" h="99">
                <a:moveTo>
                  <a:pt x="32" y="48"/>
                </a:moveTo>
                <a:lnTo>
                  <a:pt x="32" y="94"/>
                </a:lnTo>
                <a:lnTo>
                  <a:pt x="23" y="94"/>
                </a:lnTo>
                <a:lnTo>
                  <a:pt x="23" y="48"/>
                </a:lnTo>
                <a:lnTo>
                  <a:pt x="32" y="48"/>
                </a:lnTo>
                <a:close/>
                <a:moveTo>
                  <a:pt x="23" y="48"/>
                </a:moveTo>
                <a:lnTo>
                  <a:pt x="23" y="4"/>
                </a:lnTo>
                <a:lnTo>
                  <a:pt x="32" y="4"/>
                </a:lnTo>
                <a:lnTo>
                  <a:pt x="32" y="48"/>
                </a:lnTo>
                <a:lnTo>
                  <a:pt x="23" y="48"/>
                </a:lnTo>
                <a:close/>
                <a:moveTo>
                  <a:pt x="0" y="90"/>
                </a:moveTo>
                <a:lnTo>
                  <a:pt x="55" y="90"/>
                </a:lnTo>
                <a:lnTo>
                  <a:pt x="55" y="99"/>
                </a:lnTo>
                <a:lnTo>
                  <a:pt x="0" y="99"/>
                </a:lnTo>
                <a:lnTo>
                  <a:pt x="0" y="90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8"/>
                </a:lnTo>
                <a:lnTo>
                  <a:pt x="0" y="8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7" name="Rectangle 246"/>
          <p:cNvSpPr>
            <a:spLocks noChangeArrowheads="1"/>
          </p:cNvSpPr>
          <p:nvPr/>
        </p:nvSpPr>
        <p:spPr bwMode="auto">
          <a:xfrm>
            <a:off x="1523629" y="1139899"/>
            <a:ext cx="10715" cy="3214688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8" name="Freeform 247"/>
          <p:cNvSpPr>
            <a:spLocks noEditPoints="1"/>
          </p:cNvSpPr>
          <p:nvPr/>
        </p:nvSpPr>
        <p:spPr bwMode="auto">
          <a:xfrm>
            <a:off x="1486719" y="1131962"/>
            <a:ext cx="41672" cy="3228975"/>
          </a:xfrm>
          <a:custGeom>
            <a:avLst/>
            <a:gdLst>
              <a:gd name="T0" fmla="*/ 0 w 35"/>
              <a:gd name="T1" fmla="*/ 2025 h 2034"/>
              <a:gd name="T2" fmla="*/ 35 w 35"/>
              <a:gd name="T3" fmla="*/ 2025 h 2034"/>
              <a:gd name="T4" fmla="*/ 35 w 35"/>
              <a:gd name="T5" fmla="*/ 2034 h 2034"/>
              <a:gd name="T6" fmla="*/ 0 w 35"/>
              <a:gd name="T7" fmla="*/ 2034 h 2034"/>
              <a:gd name="T8" fmla="*/ 0 w 35"/>
              <a:gd name="T9" fmla="*/ 2025 h 2034"/>
              <a:gd name="T10" fmla="*/ 0 w 35"/>
              <a:gd name="T11" fmla="*/ 1620 h 2034"/>
              <a:gd name="T12" fmla="*/ 35 w 35"/>
              <a:gd name="T13" fmla="*/ 1620 h 2034"/>
              <a:gd name="T14" fmla="*/ 35 w 35"/>
              <a:gd name="T15" fmla="*/ 1629 h 2034"/>
              <a:gd name="T16" fmla="*/ 0 w 35"/>
              <a:gd name="T17" fmla="*/ 1629 h 2034"/>
              <a:gd name="T18" fmla="*/ 0 w 35"/>
              <a:gd name="T19" fmla="*/ 1620 h 2034"/>
              <a:gd name="T20" fmla="*/ 0 w 35"/>
              <a:gd name="T21" fmla="*/ 1216 h 2034"/>
              <a:gd name="T22" fmla="*/ 35 w 35"/>
              <a:gd name="T23" fmla="*/ 1216 h 2034"/>
              <a:gd name="T24" fmla="*/ 35 w 35"/>
              <a:gd name="T25" fmla="*/ 1225 h 2034"/>
              <a:gd name="T26" fmla="*/ 0 w 35"/>
              <a:gd name="T27" fmla="*/ 1225 h 2034"/>
              <a:gd name="T28" fmla="*/ 0 w 35"/>
              <a:gd name="T29" fmla="*/ 1216 h 2034"/>
              <a:gd name="T30" fmla="*/ 0 w 35"/>
              <a:gd name="T31" fmla="*/ 811 h 2034"/>
              <a:gd name="T32" fmla="*/ 35 w 35"/>
              <a:gd name="T33" fmla="*/ 811 h 2034"/>
              <a:gd name="T34" fmla="*/ 35 w 35"/>
              <a:gd name="T35" fmla="*/ 820 h 2034"/>
              <a:gd name="T36" fmla="*/ 0 w 35"/>
              <a:gd name="T37" fmla="*/ 820 h 2034"/>
              <a:gd name="T38" fmla="*/ 0 w 35"/>
              <a:gd name="T39" fmla="*/ 811 h 2034"/>
              <a:gd name="T40" fmla="*/ 0 w 35"/>
              <a:gd name="T41" fmla="*/ 405 h 2034"/>
              <a:gd name="T42" fmla="*/ 35 w 35"/>
              <a:gd name="T43" fmla="*/ 405 h 2034"/>
              <a:gd name="T44" fmla="*/ 35 w 35"/>
              <a:gd name="T45" fmla="*/ 414 h 2034"/>
              <a:gd name="T46" fmla="*/ 0 w 35"/>
              <a:gd name="T47" fmla="*/ 414 h 2034"/>
              <a:gd name="T48" fmla="*/ 0 w 35"/>
              <a:gd name="T49" fmla="*/ 405 h 2034"/>
              <a:gd name="T50" fmla="*/ 0 w 35"/>
              <a:gd name="T51" fmla="*/ 0 h 2034"/>
              <a:gd name="T52" fmla="*/ 35 w 35"/>
              <a:gd name="T53" fmla="*/ 0 h 2034"/>
              <a:gd name="T54" fmla="*/ 35 w 35"/>
              <a:gd name="T55" fmla="*/ 9 h 2034"/>
              <a:gd name="T56" fmla="*/ 0 w 35"/>
              <a:gd name="T57" fmla="*/ 9 h 2034"/>
              <a:gd name="T58" fmla="*/ 0 w 35"/>
              <a:gd name="T59" fmla="*/ 0 h 20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35" h="2034">
                <a:moveTo>
                  <a:pt x="0" y="2025"/>
                </a:moveTo>
                <a:lnTo>
                  <a:pt x="35" y="2025"/>
                </a:lnTo>
                <a:lnTo>
                  <a:pt x="35" y="2034"/>
                </a:lnTo>
                <a:lnTo>
                  <a:pt x="0" y="2034"/>
                </a:lnTo>
                <a:lnTo>
                  <a:pt x="0" y="2025"/>
                </a:lnTo>
                <a:close/>
                <a:moveTo>
                  <a:pt x="0" y="1620"/>
                </a:moveTo>
                <a:lnTo>
                  <a:pt x="35" y="1620"/>
                </a:lnTo>
                <a:lnTo>
                  <a:pt x="35" y="1629"/>
                </a:lnTo>
                <a:lnTo>
                  <a:pt x="0" y="1629"/>
                </a:lnTo>
                <a:lnTo>
                  <a:pt x="0" y="1620"/>
                </a:lnTo>
                <a:close/>
                <a:moveTo>
                  <a:pt x="0" y="1216"/>
                </a:moveTo>
                <a:lnTo>
                  <a:pt x="35" y="1216"/>
                </a:lnTo>
                <a:lnTo>
                  <a:pt x="35" y="1225"/>
                </a:lnTo>
                <a:lnTo>
                  <a:pt x="0" y="1225"/>
                </a:lnTo>
                <a:lnTo>
                  <a:pt x="0" y="1216"/>
                </a:lnTo>
                <a:close/>
                <a:moveTo>
                  <a:pt x="0" y="811"/>
                </a:moveTo>
                <a:lnTo>
                  <a:pt x="35" y="811"/>
                </a:lnTo>
                <a:lnTo>
                  <a:pt x="35" y="820"/>
                </a:lnTo>
                <a:lnTo>
                  <a:pt x="0" y="820"/>
                </a:lnTo>
                <a:lnTo>
                  <a:pt x="0" y="811"/>
                </a:lnTo>
                <a:close/>
                <a:moveTo>
                  <a:pt x="0" y="405"/>
                </a:moveTo>
                <a:lnTo>
                  <a:pt x="35" y="405"/>
                </a:lnTo>
                <a:lnTo>
                  <a:pt x="35" y="414"/>
                </a:lnTo>
                <a:lnTo>
                  <a:pt x="0" y="414"/>
                </a:lnTo>
                <a:lnTo>
                  <a:pt x="0" y="405"/>
                </a:lnTo>
                <a:close/>
                <a:moveTo>
                  <a:pt x="0" y="0"/>
                </a:moveTo>
                <a:lnTo>
                  <a:pt x="35" y="0"/>
                </a:lnTo>
                <a:lnTo>
                  <a:pt x="35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9" name="Rectangle 248"/>
          <p:cNvSpPr>
            <a:spLocks noChangeArrowheads="1"/>
          </p:cNvSpPr>
          <p:nvPr/>
        </p:nvSpPr>
        <p:spPr bwMode="auto">
          <a:xfrm>
            <a:off x="1528391" y="4346649"/>
            <a:ext cx="6119813" cy="14288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0" name="Rectangle 249"/>
          <p:cNvSpPr>
            <a:spLocks noChangeArrowheads="1"/>
          </p:cNvSpPr>
          <p:nvPr/>
        </p:nvSpPr>
        <p:spPr bwMode="auto">
          <a:xfrm>
            <a:off x="1293273" y="4235525"/>
            <a:ext cx="1282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</a:p>
        </p:txBody>
      </p:sp>
      <p:sp>
        <p:nvSpPr>
          <p:cNvPr id="251" name="Rectangle 250"/>
          <p:cNvSpPr>
            <a:spLocks noChangeArrowheads="1"/>
          </p:cNvSpPr>
          <p:nvPr/>
        </p:nvSpPr>
        <p:spPr bwMode="auto">
          <a:xfrm>
            <a:off x="1140386" y="3558722"/>
            <a:ext cx="3208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.2</a:t>
            </a:r>
            <a:endParaRPr kumimoji="0" lang="ja-JP" altLang="ja-JP" b="1" i="0" u="none" strike="noStrike" cap="none" normalizeH="0" baseline="0" dirty="0" smtClean="0">
              <a:ln>
                <a:noFill/>
              </a:ln>
              <a:effectLst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2" name="Rectangle 251"/>
          <p:cNvSpPr>
            <a:spLocks noChangeArrowheads="1"/>
          </p:cNvSpPr>
          <p:nvPr/>
        </p:nvSpPr>
        <p:spPr bwMode="auto">
          <a:xfrm>
            <a:off x="1140386" y="2918959"/>
            <a:ext cx="3208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.4</a:t>
            </a:r>
            <a:endParaRPr kumimoji="0" lang="ja-JP" altLang="ja-JP" b="1" i="0" u="none" strike="noStrike" cap="none" normalizeH="0" baseline="0" dirty="0" smtClean="0">
              <a:ln>
                <a:noFill/>
              </a:ln>
              <a:effectLst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3" name="Rectangle 252"/>
          <p:cNvSpPr>
            <a:spLocks noChangeArrowheads="1"/>
          </p:cNvSpPr>
          <p:nvPr/>
        </p:nvSpPr>
        <p:spPr bwMode="auto">
          <a:xfrm>
            <a:off x="1140386" y="2276022"/>
            <a:ext cx="3208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.6</a:t>
            </a:r>
            <a:endParaRPr kumimoji="0" lang="ja-JP" altLang="ja-JP" b="1" i="0" u="none" strike="noStrike" cap="none" normalizeH="0" baseline="0" dirty="0" smtClean="0">
              <a:ln>
                <a:noFill/>
              </a:ln>
              <a:effectLst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4" name="Rectangle 253"/>
          <p:cNvSpPr>
            <a:spLocks noChangeArrowheads="1"/>
          </p:cNvSpPr>
          <p:nvPr/>
        </p:nvSpPr>
        <p:spPr bwMode="auto">
          <a:xfrm>
            <a:off x="1140386" y="1633084"/>
            <a:ext cx="32088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.8</a:t>
            </a:r>
            <a:endParaRPr kumimoji="0" lang="ja-JP" altLang="ja-JP" b="1" i="0" u="none" strike="noStrike" cap="none" normalizeH="0" baseline="0" dirty="0" smtClean="0">
              <a:ln>
                <a:noFill/>
              </a:ln>
              <a:effectLst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5" name="Rectangle 254"/>
          <p:cNvSpPr>
            <a:spLocks noChangeArrowheads="1"/>
          </p:cNvSpPr>
          <p:nvPr/>
        </p:nvSpPr>
        <p:spPr bwMode="auto">
          <a:xfrm>
            <a:off x="1293273" y="1024013"/>
            <a:ext cx="1154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</a:p>
        </p:txBody>
      </p:sp>
      <p:sp>
        <p:nvSpPr>
          <p:cNvPr id="256" name="Rectangle 255"/>
          <p:cNvSpPr>
            <a:spLocks noChangeArrowheads="1"/>
          </p:cNvSpPr>
          <p:nvPr/>
        </p:nvSpPr>
        <p:spPr bwMode="auto">
          <a:xfrm>
            <a:off x="2443954" y="4467300"/>
            <a:ext cx="24365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24</a:t>
            </a:r>
          </a:p>
        </p:txBody>
      </p:sp>
      <p:sp>
        <p:nvSpPr>
          <p:cNvPr id="257" name="Rectangle 256"/>
          <p:cNvSpPr>
            <a:spLocks noChangeArrowheads="1"/>
          </p:cNvSpPr>
          <p:nvPr/>
        </p:nvSpPr>
        <p:spPr bwMode="auto">
          <a:xfrm>
            <a:off x="4483495" y="4467300"/>
            <a:ext cx="24365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48</a:t>
            </a:r>
          </a:p>
        </p:txBody>
      </p:sp>
      <p:sp>
        <p:nvSpPr>
          <p:cNvPr id="258" name="Rectangle 257"/>
          <p:cNvSpPr>
            <a:spLocks noChangeArrowheads="1"/>
          </p:cNvSpPr>
          <p:nvPr/>
        </p:nvSpPr>
        <p:spPr bwMode="auto">
          <a:xfrm>
            <a:off x="6531762" y="4467300"/>
            <a:ext cx="2308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72</a:t>
            </a:r>
          </a:p>
        </p:txBody>
      </p:sp>
      <p:sp>
        <p:nvSpPr>
          <p:cNvPr id="259" name="Rectangle 258"/>
          <p:cNvSpPr>
            <a:spLocks noChangeArrowheads="1"/>
          </p:cNvSpPr>
          <p:nvPr/>
        </p:nvSpPr>
        <p:spPr bwMode="auto">
          <a:xfrm>
            <a:off x="6331090" y="1505887"/>
            <a:ext cx="162097" cy="21745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0" name="Rectangle 259"/>
          <p:cNvSpPr>
            <a:spLocks noChangeArrowheads="1"/>
          </p:cNvSpPr>
          <p:nvPr/>
        </p:nvSpPr>
        <p:spPr bwMode="auto">
          <a:xfrm>
            <a:off x="6622592" y="1474281"/>
            <a:ext cx="14281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  <a:r>
              <a:rPr kumimoji="0" lang="ja-JP" altLang="ja-JP" sz="16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ontrol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0" lang="ja-JP" altLang="ja-JP" sz="1600" b="0" i="0" u="none" strike="noStrike" cap="none" normalizeH="0" baseline="0" dirty="0" smtClean="0">
                <a:ln>
                  <a:noFill/>
                </a:ln>
                <a:effectLst/>
                <a:latin typeface="Helvetica" panose="020B0604020202020204" pitchFamily="34" charset="0"/>
                <a:cs typeface="Helvetica" panose="020B0604020202020204" pitchFamily="34" charset="0"/>
              </a:rPr>
              <a:t>(vehicle)</a:t>
            </a:r>
          </a:p>
        </p:txBody>
      </p:sp>
      <p:sp>
        <p:nvSpPr>
          <p:cNvPr id="261" name="Rectangle 260"/>
          <p:cNvSpPr>
            <a:spLocks noChangeArrowheads="1"/>
          </p:cNvSpPr>
          <p:nvPr/>
        </p:nvSpPr>
        <p:spPr bwMode="auto">
          <a:xfrm>
            <a:off x="6331090" y="1795836"/>
            <a:ext cx="162097" cy="217453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2" name="Rectangle 261"/>
          <p:cNvSpPr>
            <a:spLocks noChangeArrowheads="1"/>
          </p:cNvSpPr>
          <p:nvPr/>
        </p:nvSpPr>
        <p:spPr bwMode="auto">
          <a:xfrm>
            <a:off x="6622592" y="1763259"/>
            <a:ext cx="61565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HC-1</a:t>
            </a:r>
            <a:endParaRPr kumimoji="0" lang="ja-JP" altLang="ja-JP" sz="1600" b="0" i="0" u="none" strike="noStrike" cap="none" normalizeH="0" baseline="0" dirty="0" smtClean="0">
              <a:ln>
                <a:noFill/>
              </a:ln>
              <a:effectLst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3" name="Rectangle 262"/>
          <p:cNvSpPr>
            <a:spLocks noChangeArrowheads="1"/>
          </p:cNvSpPr>
          <p:nvPr/>
        </p:nvSpPr>
        <p:spPr bwMode="auto">
          <a:xfrm>
            <a:off x="6331090" y="2068093"/>
            <a:ext cx="162097" cy="217453"/>
          </a:xfrm>
          <a:prstGeom prst="rect">
            <a:avLst/>
          </a:prstGeom>
          <a:pattFill prst="pct20">
            <a:fgClr>
              <a:schemeClr val="tx1"/>
            </a:fgClr>
            <a:bgClr>
              <a:schemeClr val="bg1"/>
            </a:bgClr>
          </a:pattFill>
          <a:ln w="142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4" name="Rectangle 263"/>
          <p:cNvSpPr>
            <a:spLocks noChangeArrowheads="1"/>
          </p:cNvSpPr>
          <p:nvPr/>
        </p:nvSpPr>
        <p:spPr bwMode="auto">
          <a:xfrm>
            <a:off x="6622592" y="2059543"/>
            <a:ext cx="193272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HC-1+Empty vector</a:t>
            </a:r>
            <a:endParaRPr kumimoji="0" lang="ja-JP" altLang="ja-JP" sz="1600" b="0" i="0" u="none" strike="noStrike" cap="none" normalizeH="0" baseline="0" dirty="0" smtClean="0">
              <a:ln>
                <a:noFill/>
              </a:ln>
              <a:effectLst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5" name="Freeform 264"/>
          <p:cNvSpPr>
            <a:spLocks noEditPoints="1"/>
          </p:cNvSpPr>
          <p:nvPr/>
        </p:nvSpPr>
        <p:spPr bwMode="auto">
          <a:xfrm>
            <a:off x="6320460" y="2358042"/>
            <a:ext cx="183356" cy="253101"/>
          </a:xfrm>
          <a:custGeom>
            <a:avLst/>
            <a:gdLst>
              <a:gd name="T0" fmla="*/ 0 w 376"/>
              <a:gd name="T1" fmla="*/ 24 h 384"/>
              <a:gd name="T2" fmla="*/ 24 w 376"/>
              <a:gd name="T3" fmla="*/ 0 h 384"/>
              <a:gd name="T4" fmla="*/ 352 w 376"/>
              <a:gd name="T5" fmla="*/ 0 h 384"/>
              <a:gd name="T6" fmla="*/ 376 w 376"/>
              <a:gd name="T7" fmla="*/ 24 h 384"/>
              <a:gd name="T8" fmla="*/ 376 w 376"/>
              <a:gd name="T9" fmla="*/ 360 h 384"/>
              <a:gd name="T10" fmla="*/ 352 w 376"/>
              <a:gd name="T11" fmla="*/ 384 h 384"/>
              <a:gd name="T12" fmla="*/ 24 w 376"/>
              <a:gd name="T13" fmla="*/ 384 h 384"/>
              <a:gd name="T14" fmla="*/ 0 w 376"/>
              <a:gd name="T15" fmla="*/ 360 h 384"/>
              <a:gd name="T16" fmla="*/ 0 w 376"/>
              <a:gd name="T17" fmla="*/ 24 h 384"/>
              <a:gd name="T18" fmla="*/ 48 w 376"/>
              <a:gd name="T19" fmla="*/ 360 h 384"/>
              <a:gd name="T20" fmla="*/ 24 w 376"/>
              <a:gd name="T21" fmla="*/ 336 h 384"/>
              <a:gd name="T22" fmla="*/ 352 w 376"/>
              <a:gd name="T23" fmla="*/ 336 h 384"/>
              <a:gd name="T24" fmla="*/ 328 w 376"/>
              <a:gd name="T25" fmla="*/ 360 h 384"/>
              <a:gd name="T26" fmla="*/ 328 w 376"/>
              <a:gd name="T27" fmla="*/ 24 h 384"/>
              <a:gd name="T28" fmla="*/ 352 w 376"/>
              <a:gd name="T29" fmla="*/ 48 h 384"/>
              <a:gd name="T30" fmla="*/ 24 w 376"/>
              <a:gd name="T31" fmla="*/ 48 h 384"/>
              <a:gd name="T32" fmla="*/ 48 w 376"/>
              <a:gd name="T33" fmla="*/ 24 h 384"/>
              <a:gd name="T34" fmla="*/ 48 w 376"/>
              <a:gd name="T35" fmla="*/ 360 h 3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76" h="38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352" y="0"/>
                </a:lnTo>
                <a:cubicBezTo>
                  <a:pt x="366" y="0"/>
                  <a:pt x="376" y="11"/>
                  <a:pt x="376" y="24"/>
                </a:cubicBezTo>
                <a:lnTo>
                  <a:pt x="376" y="360"/>
                </a:lnTo>
                <a:cubicBezTo>
                  <a:pt x="376" y="374"/>
                  <a:pt x="366" y="384"/>
                  <a:pt x="352" y="384"/>
                </a:cubicBezTo>
                <a:lnTo>
                  <a:pt x="24" y="384"/>
                </a:lnTo>
                <a:cubicBezTo>
                  <a:pt x="11" y="384"/>
                  <a:pt x="0" y="374"/>
                  <a:pt x="0" y="360"/>
                </a:cubicBezTo>
                <a:lnTo>
                  <a:pt x="0" y="24"/>
                </a:lnTo>
                <a:close/>
                <a:moveTo>
                  <a:pt x="48" y="360"/>
                </a:moveTo>
                <a:lnTo>
                  <a:pt x="24" y="336"/>
                </a:lnTo>
                <a:lnTo>
                  <a:pt x="352" y="336"/>
                </a:lnTo>
                <a:lnTo>
                  <a:pt x="328" y="360"/>
                </a:lnTo>
                <a:lnTo>
                  <a:pt x="328" y="24"/>
                </a:lnTo>
                <a:lnTo>
                  <a:pt x="352" y="48"/>
                </a:lnTo>
                <a:lnTo>
                  <a:pt x="24" y="48"/>
                </a:lnTo>
                <a:lnTo>
                  <a:pt x="48" y="24"/>
                </a:lnTo>
                <a:lnTo>
                  <a:pt x="48" y="36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6" name="Rectangle 265"/>
          <p:cNvSpPr>
            <a:spLocks noChangeArrowheads="1"/>
          </p:cNvSpPr>
          <p:nvPr/>
        </p:nvSpPr>
        <p:spPr bwMode="auto">
          <a:xfrm>
            <a:off x="6622592" y="2360379"/>
            <a:ext cx="13855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KHC-1+USP18</a:t>
            </a:r>
            <a:endParaRPr kumimoji="0" lang="ja-JP" altLang="ja-JP" sz="1600" b="0" i="0" u="none" strike="noStrike" cap="none" normalizeH="0" baseline="0" dirty="0" smtClean="0">
              <a:ln>
                <a:noFill/>
              </a:ln>
              <a:effectLst/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7" name="テキスト ボックス 57"/>
          <p:cNvSpPr txBox="1"/>
          <p:nvPr/>
        </p:nvSpPr>
        <p:spPr>
          <a:xfrm rot="16200000">
            <a:off x="-964097" y="2459457"/>
            <a:ext cx="3813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owth with IFNB relative to vehicle</a:t>
            </a:r>
            <a:endParaRPr kumimoji="1" lang="ja-JP" altLang="en-US" sz="16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8" name="左大かっこ 58"/>
          <p:cNvSpPr/>
          <p:nvPr/>
        </p:nvSpPr>
        <p:spPr>
          <a:xfrm rot="5400000">
            <a:off x="2646216" y="628580"/>
            <a:ext cx="196796" cy="1056084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9" name="左大かっこ 59"/>
          <p:cNvSpPr/>
          <p:nvPr/>
        </p:nvSpPr>
        <p:spPr>
          <a:xfrm rot="5400000">
            <a:off x="4712415" y="1775765"/>
            <a:ext cx="196796" cy="1056084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0" name="左大かっこ 60"/>
          <p:cNvSpPr/>
          <p:nvPr/>
        </p:nvSpPr>
        <p:spPr>
          <a:xfrm rot="5400000">
            <a:off x="6747324" y="2619386"/>
            <a:ext cx="196796" cy="1056084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1" name="テキスト ボックス 61"/>
          <p:cNvSpPr txBox="1"/>
          <p:nvPr/>
        </p:nvSpPr>
        <p:spPr>
          <a:xfrm>
            <a:off x="2474741" y="699378"/>
            <a:ext cx="742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Helvetica" panose="020B0604020202020204" pitchFamily="34" charset="0"/>
                <a:cs typeface="Helvetica" panose="020B0604020202020204" pitchFamily="34" charset="0"/>
              </a:rPr>
              <a:t>N.S.</a:t>
            </a:r>
            <a:endParaRPr kumimoji="1" lang="ja-JP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2" name="テキスト ボックス 62"/>
          <p:cNvSpPr txBox="1"/>
          <p:nvPr/>
        </p:nvSpPr>
        <p:spPr>
          <a:xfrm>
            <a:off x="4527567" y="1867841"/>
            <a:ext cx="782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Helvetica" panose="020B0604020202020204" pitchFamily="34" charset="0"/>
                <a:cs typeface="Helvetica" panose="020B0604020202020204" pitchFamily="34" charset="0"/>
              </a:rPr>
              <a:t>N.S.</a:t>
            </a:r>
            <a:endParaRPr kumimoji="1" lang="ja-JP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3" name="テキスト ボックス 63"/>
          <p:cNvSpPr txBox="1"/>
          <p:nvPr/>
        </p:nvSpPr>
        <p:spPr>
          <a:xfrm>
            <a:off x="6574965" y="2709821"/>
            <a:ext cx="730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Helvetica" panose="020B0604020202020204" pitchFamily="34" charset="0"/>
                <a:cs typeface="Helvetica" panose="020B0604020202020204" pitchFamily="34" charset="0"/>
              </a:rPr>
              <a:t>N.S.</a:t>
            </a:r>
            <a:endParaRPr kumimoji="1" lang="ja-JP" alt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4" name="テキスト ボックス 1"/>
          <p:cNvSpPr txBox="1"/>
          <p:nvPr/>
        </p:nvSpPr>
        <p:spPr>
          <a:xfrm>
            <a:off x="3982485" y="4637868"/>
            <a:ext cx="1232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Hours</a:t>
            </a:r>
            <a:endParaRPr kumimoji="1" lang="ja-JP" altLang="en-US" sz="2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667298" y="5447494"/>
            <a:ext cx="811970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4</a:t>
            </a:r>
            <a:r>
              <a:rPr lang="en-US" dirty="0"/>
              <a:t>: USP18 null leiomyosarcoma cell line KHC-1 with restored USP18 expression did not affect response to </a:t>
            </a:r>
            <a:r>
              <a:rPr lang="en-US" dirty="0" err="1"/>
              <a:t>IFN</a:t>
            </a:r>
            <a:r>
              <a:rPr lang="en-US" dirty="0" err="1">
                <a:latin typeface="Symbol" charset="2"/>
                <a:cs typeface="Symbol" charset="2"/>
              </a:rPr>
              <a:t>b</a:t>
            </a:r>
            <a:r>
              <a:rPr lang="en-US" dirty="0"/>
              <a:t> (500Units/ml).  Results expressed as fold relative to vehicle treated cells. (N.S. = not significant).</a:t>
            </a:r>
          </a:p>
        </p:txBody>
      </p:sp>
    </p:spTree>
    <p:extLst>
      <p:ext uri="{BB962C8B-B14F-4D97-AF65-F5344CB8AC3E}">
        <p14:creationId xmlns:p14="http://schemas.microsoft.com/office/powerpoint/2010/main" val="4151585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839</Words>
  <Application>Microsoft Macintosh PowerPoint</Application>
  <PresentationFormat>On-screen Show (4:3)</PresentationFormat>
  <Paragraphs>330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Supplementary Table 2: Immunohistochemical staining of USP18 in clinical leiomyosarcoma samples.</vt:lpstr>
      <vt:lpstr>PowerPoint Presentation</vt:lpstr>
      <vt:lpstr>Supplementary Figure 2: USP18 null leiomyosarcoma cell lines are sensitive to treatment with the JAK2-STAT3 inhibitor, JSI-124. A: Immunoblot analysis of pSTAT3, STAT3, CDK4 and USP18 levels in KHC-1 cells with and without stably restored USP18 activity. B: Growth analysis of KHC-1 cells with JAK2-STAT3 inhibitor, JSI-124.  Similar effects were seen in KHC-2 cells (data not shown). Validation of JSI-124 repression of JAK2-STAT3 pathway C: Immunoblot analyses of phosphorylated JAK2 (pJAK2), JAK2, and actin with relative level of pJAK2/JAK2 calculated relative to control. D: Immunoblot analysis of phosphorylated STAT3 (pSTAT3), STAT3, cyclin D1 and actin levels. </vt:lpstr>
      <vt:lpstr>PowerPoint Presentation</vt:lpstr>
      <vt:lpstr>PowerPoint Presentation</vt:lpstr>
    </vt:vector>
  </TitlesOfParts>
  <Company>Dartmouth Medical Sch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Freemantle</dc:creator>
  <cp:lastModifiedBy>Sarah Freemantle</cp:lastModifiedBy>
  <cp:revision>10</cp:revision>
  <dcterms:created xsi:type="dcterms:W3CDTF">2014-04-29T13:31:34Z</dcterms:created>
  <dcterms:modified xsi:type="dcterms:W3CDTF">2015-10-13T15:22:46Z</dcterms:modified>
</cp:coreProperties>
</file>